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848EA-0B9C-40C7-823F-25A290FC62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F68CF-6FCF-4512-B0F5-C90E33EB7C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1D715-945E-4DB9-A316-B7054AB53F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AB6AD-6A82-46DA-A2A6-D06425D820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2347F-5B3D-4291-B06F-C3755B9317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96A94-0F8A-48BC-92C4-C491E062B5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828E2-4385-4E60-9329-FA5C3BE33C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8BB51-BBC6-4AFF-B708-FC6565474E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5F1D7-2818-4BF6-B917-66E0851595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0FBFC-CD76-4BFE-B414-5350B57868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3A01D-D72C-4489-BA65-603F144E8C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C6CA8-A3CB-4D5D-8BA5-6D0ADAC91F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2B2C2A-F901-4167-B883-EFDEC10439F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0" y="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1905120" y="4881240"/>
            <a:ext cx="594360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Figure S6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Unique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F. virguliforme genes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There are 11,403 genes common to all fiv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Fusarium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species and 1,332 genes unique to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F. virguliform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at E ≤ 10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-9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. The numbers in the light blue circle are the number of genes of a species that showed similarity (E ≤ 10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-9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) to genes of at least one specie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7"/>
          <p:cNvGrpSpPr/>
          <p:nvPr/>
        </p:nvGrpSpPr>
        <p:grpSpPr>
          <a:xfrm>
            <a:off x="2362320" y="762120"/>
            <a:ext cx="4190760" cy="3657600"/>
            <a:chOff x="2362320" y="762120"/>
            <a:chExt cx="4190760" cy="3657600"/>
          </a:xfrm>
        </p:grpSpPr>
        <p:sp>
          <p:nvSpPr>
            <p:cNvPr id="44" name="AutoShape 6"/>
            <p:cNvSpPr/>
            <p:nvPr/>
          </p:nvSpPr>
          <p:spPr>
            <a:xfrm>
              <a:off x="2362320" y="762120"/>
              <a:ext cx="4190760" cy="3657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8"/>
            <p:cNvSpPr/>
            <p:nvPr/>
          </p:nvSpPr>
          <p:spPr>
            <a:xfrm>
              <a:off x="3052800" y="2940120"/>
              <a:ext cx="1346040" cy="1285920"/>
            </a:xfrm>
            <a:custGeom>
              <a:avLst/>
              <a:gdLst>
                <a:gd name="textAreaLeft" fmla="*/ 0 w 1346040"/>
                <a:gd name="textAreaRight" fmla="*/ 1346400 w 1346040"/>
                <a:gd name="textAreaTop" fmla="*/ 0 h 1285920"/>
                <a:gd name="textAreaBottom" fmla="*/ 1286280 h 1285920"/>
              </a:gdLst>
              <a:ahLst/>
              <a:rect l="textAreaLeft" t="textAreaTop" r="textAreaRight" b="textAreaBottom"/>
              <a:pathLst>
                <a:path w="3568" h="3438">
                  <a:moveTo>
                    <a:pt x="3568" y="1065"/>
                  </a:moveTo>
                  <a:cubicBezTo>
                    <a:pt x="2921" y="2377"/>
                    <a:pt x="1742" y="3438"/>
                    <a:pt x="935" y="3433"/>
                  </a:cubicBezTo>
                  <a:cubicBezTo>
                    <a:pt x="129" y="3429"/>
                    <a:pt x="0" y="2361"/>
                    <a:pt x="647" y="1049"/>
                  </a:cubicBezTo>
                  <a:cubicBezTo>
                    <a:pt x="827" y="685"/>
                    <a:pt x="1055" y="326"/>
                    <a:pt x="1315" y="0"/>
                  </a:cubicBezTo>
                </a:path>
              </a:pathLst>
            </a:custGeom>
            <a:solidFill>
              <a:srgbClr val="0070c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Freeform 9"/>
            <p:cNvSpPr/>
            <p:nvPr/>
          </p:nvSpPr>
          <p:spPr>
            <a:xfrm>
              <a:off x="3133800" y="2930400"/>
              <a:ext cx="1272960" cy="1301760"/>
            </a:xfrm>
            <a:custGeom>
              <a:avLst/>
              <a:gdLst>
                <a:gd name="textAreaLeft" fmla="*/ 0 w 1272960"/>
                <a:gd name="textAreaRight" fmla="*/ 1273320 w 1272960"/>
                <a:gd name="textAreaTop" fmla="*/ 0 h 1301760"/>
                <a:gd name="textAreaBottom" fmla="*/ 1301760 h 1301760"/>
              </a:gdLst>
              <a:ahLst/>
              <a:rect l="textAreaLeft" t="textAreaTop" r="textAreaRight" b="textAreaBottom"/>
              <a:pathLst>
                <a:path w="3377" h="3478">
                  <a:moveTo>
                    <a:pt x="3364" y="1069"/>
                  </a:moveTo>
                  <a:cubicBezTo>
                    <a:pt x="3369" y="1072"/>
                    <a:pt x="3373" y="1076"/>
                    <a:pt x="3375" y="1082"/>
                  </a:cubicBezTo>
                  <a:cubicBezTo>
                    <a:pt x="3377" y="1087"/>
                    <a:pt x="3376" y="1093"/>
                    <a:pt x="3373" y="1098"/>
                  </a:cubicBezTo>
                  <a:lnTo>
                    <a:pt x="3246" y="1341"/>
                  </a:lnTo>
                  <a:lnTo>
                    <a:pt x="3107" y="1578"/>
                  </a:lnTo>
                  <a:lnTo>
                    <a:pt x="2958" y="1806"/>
                  </a:lnTo>
                  <a:lnTo>
                    <a:pt x="2801" y="2025"/>
                  </a:lnTo>
                  <a:lnTo>
                    <a:pt x="2636" y="2234"/>
                  </a:lnTo>
                  <a:lnTo>
                    <a:pt x="2466" y="2429"/>
                  </a:lnTo>
                  <a:lnTo>
                    <a:pt x="2291" y="2613"/>
                  </a:lnTo>
                  <a:lnTo>
                    <a:pt x="2113" y="2782"/>
                  </a:lnTo>
                  <a:lnTo>
                    <a:pt x="1932" y="2936"/>
                  </a:lnTo>
                  <a:lnTo>
                    <a:pt x="1751" y="3072"/>
                  </a:lnTo>
                  <a:lnTo>
                    <a:pt x="1571" y="3191"/>
                  </a:lnTo>
                  <a:lnTo>
                    <a:pt x="1393" y="3292"/>
                  </a:lnTo>
                  <a:lnTo>
                    <a:pt x="1217" y="3372"/>
                  </a:lnTo>
                  <a:lnTo>
                    <a:pt x="1046" y="3430"/>
                  </a:lnTo>
                  <a:lnTo>
                    <a:pt x="881" y="3466"/>
                  </a:lnTo>
                  <a:lnTo>
                    <a:pt x="801" y="3475"/>
                  </a:lnTo>
                  <a:lnTo>
                    <a:pt x="722" y="3478"/>
                  </a:lnTo>
                  <a:lnTo>
                    <a:pt x="647" y="3475"/>
                  </a:lnTo>
                  <a:lnTo>
                    <a:pt x="575" y="3465"/>
                  </a:lnTo>
                  <a:lnTo>
                    <a:pt x="445" y="3427"/>
                  </a:lnTo>
                  <a:cubicBezTo>
                    <a:pt x="444" y="3427"/>
                    <a:pt x="443" y="3426"/>
                    <a:pt x="441" y="3425"/>
                  </a:cubicBezTo>
                  <a:lnTo>
                    <a:pt x="330" y="3366"/>
                  </a:lnTo>
                  <a:cubicBezTo>
                    <a:pt x="329" y="3366"/>
                    <a:pt x="328" y="3365"/>
                    <a:pt x="327" y="3364"/>
                  </a:cubicBezTo>
                  <a:lnTo>
                    <a:pt x="232" y="3283"/>
                  </a:lnTo>
                  <a:cubicBezTo>
                    <a:pt x="231" y="3282"/>
                    <a:pt x="230" y="3281"/>
                    <a:pt x="229" y="3280"/>
                  </a:cubicBezTo>
                  <a:lnTo>
                    <a:pt x="151" y="3180"/>
                  </a:lnTo>
                  <a:cubicBezTo>
                    <a:pt x="150" y="3179"/>
                    <a:pt x="149" y="3177"/>
                    <a:pt x="149" y="3176"/>
                  </a:cubicBezTo>
                  <a:lnTo>
                    <a:pt x="87" y="3056"/>
                  </a:lnTo>
                  <a:cubicBezTo>
                    <a:pt x="86" y="3055"/>
                    <a:pt x="86" y="3054"/>
                    <a:pt x="85" y="3053"/>
                  </a:cubicBezTo>
                  <a:lnTo>
                    <a:pt x="40" y="2915"/>
                  </a:lnTo>
                  <a:lnTo>
                    <a:pt x="11" y="2759"/>
                  </a:lnTo>
                  <a:lnTo>
                    <a:pt x="0" y="2587"/>
                  </a:lnTo>
                  <a:lnTo>
                    <a:pt x="6" y="2402"/>
                  </a:lnTo>
                  <a:lnTo>
                    <a:pt x="30" y="2203"/>
                  </a:lnTo>
                  <a:lnTo>
                    <a:pt x="72" y="1993"/>
                  </a:lnTo>
                  <a:lnTo>
                    <a:pt x="130" y="1774"/>
                  </a:lnTo>
                  <a:lnTo>
                    <a:pt x="206" y="1545"/>
                  </a:lnTo>
                  <a:lnTo>
                    <a:pt x="301" y="1308"/>
                  </a:lnTo>
                  <a:lnTo>
                    <a:pt x="414" y="1063"/>
                  </a:lnTo>
                  <a:lnTo>
                    <a:pt x="559" y="790"/>
                  </a:lnTo>
                  <a:lnTo>
                    <a:pt x="719" y="522"/>
                  </a:lnTo>
                  <a:lnTo>
                    <a:pt x="895" y="262"/>
                  </a:lnTo>
                  <a:lnTo>
                    <a:pt x="1084" y="11"/>
                  </a:lnTo>
                  <a:cubicBezTo>
                    <a:pt x="1091" y="3"/>
                    <a:pt x="1101" y="0"/>
                    <a:pt x="1111" y="4"/>
                  </a:cubicBezTo>
                  <a:lnTo>
                    <a:pt x="3364" y="1069"/>
                  </a:lnTo>
                  <a:close/>
                  <a:moveTo>
                    <a:pt x="1092" y="43"/>
                  </a:moveTo>
                  <a:lnTo>
                    <a:pt x="1118" y="36"/>
                  </a:lnTo>
                  <a:lnTo>
                    <a:pt x="930" y="285"/>
                  </a:lnTo>
                  <a:lnTo>
                    <a:pt x="756" y="544"/>
                  </a:lnTo>
                  <a:lnTo>
                    <a:pt x="596" y="810"/>
                  </a:lnTo>
                  <a:lnTo>
                    <a:pt x="453" y="1081"/>
                  </a:lnTo>
                  <a:lnTo>
                    <a:pt x="340" y="1323"/>
                  </a:lnTo>
                  <a:lnTo>
                    <a:pt x="247" y="1558"/>
                  </a:lnTo>
                  <a:lnTo>
                    <a:pt x="171" y="1785"/>
                  </a:lnTo>
                  <a:lnTo>
                    <a:pt x="113" y="2002"/>
                  </a:lnTo>
                  <a:lnTo>
                    <a:pt x="73" y="2208"/>
                  </a:lnTo>
                  <a:lnTo>
                    <a:pt x="49" y="2403"/>
                  </a:lnTo>
                  <a:lnTo>
                    <a:pt x="43" y="2584"/>
                  </a:lnTo>
                  <a:lnTo>
                    <a:pt x="53" y="2752"/>
                  </a:lnTo>
                  <a:lnTo>
                    <a:pt x="81" y="2902"/>
                  </a:lnTo>
                  <a:lnTo>
                    <a:pt x="126" y="3040"/>
                  </a:lnTo>
                  <a:lnTo>
                    <a:pt x="124" y="3037"/>
                  </a:lnTo>
                  <a:lnTo>
                    <a:pt x="186" y="3157"/>
                  </a:lnTo>
                  <a:lnTo>
                    <a:pt x="184" y="3153"/>
                  </a:lnTo>
                  <a:lnTo>
                    <a:pt x="262" y="3253"/>
                  </a:lnTo>
                  <a:lnTo>
                    <a:pt x="259" y="3250"/>
                  </a:lnTo>
                  <a:lnTo>
                    <a:pt x="354" y="3331"/>
                  </a:lnTo>
                  <a:lnTo>
                    <a:pt x="350" y="3329"/>
                  </a:lnTo>
                  <a:lnTo>
                    <a:pt x="461" y="3388"/>
                  </a:lnTo>
                  <a:lnTo>
                    <a:pt x="457" y="3386"/>
                  </a:lnTo>
                  <a:lnTo>
                    <a:pt x="582" y="3422"/>
                  </a:lnTo>
                  <a:lnTo>
                    <a:pt x="648" y="3432"/>
                  </a:lnTo>
                  <a:lnTo>
                    <a:pt x="721" y="3435"/>
                  </a:lnTo>
                  <a:lnTo>
                    <a:pt x="796" y="3432"/>
                  </a:lnTo>
                  <a:lnTo>
                    <a:pt x="872" y="3425"/>
                  </a:lnTo>
                  <a:lnTo>
                    <a:pt x="1033" y="3389"/>
                  </a:lnTo>
                  <a:lnTo>
                    <a:pt x="1200" y="3333"/>
                  </a:lnTo>
                  <a:lnTo>
                    <a:pt x="1372" y="3255"/>
                  </a:lnTo>
                  <a:lnTo>
                    <a:pt x="1548" y="3156"/>
                  </a:lnTo>
                  <a:lnTo>
                    <a:pt x="1726" y="3038"/>
                  </a:lnTo>
                  <a:lnTo>
                    <a:pt x="1905" y="2903"/>
                  </a:lnTo>
                  <a:lnTo>
                    <a:pt x="2084" y="2751"/>
                  </a:lnTo>
                  <a:lnTo>
                    <a:pt x="2260" y="2584"/>
                  </a:lnTo>
                  <a:lnTo>
                    <a:pt x="2433" y="2401"/>
                  </a:lnTo>
                  <a:lnTo>
                    <a:pt x="2603" y="2207"/>
                  </a:lnTo>
                  <a:lnTo>
                    <a:pt x="2766" y="2000"/>
                  </a:lnTo>
                  <a:lnTo>
                    <a:pt x="2923" y="1783"/>
                  </a:lnTo>
                  <a:lnTo>
                    <a:pt x="3070" y="1557"/>
                  </a:lnTo>
                  <a:lnTo>
                    <a:pt x="3209" y="1322"/>
                  </a:lnTo>
                  <a:lnTo>
                    <a:pt x="3336" y="1079"/>
                  </a:lnTo>
                  <a:lnTo>
                    <a:pt x="3345" y="1108"/>
                  </a:lnTo>
                  <a:lnTo>
                    <a:pt x="1092" y="43"/>
                  </a:lnTo>
                  <a:close/>
                </a:path>
              </a:pathLst>
            </a:custGeom>
            <a:solidFill>
              <a:srgbClr val="385d8a"/>
            </a:solidFill>
            <a:ln w="0">
              <a:solidFill>
                <a:srgbClr val="385d8a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10"/>
            <p:cNvSpPr/>
            <p:nvPr/>
          </p:nvSpPr>
          <p:spPr>
            <a:xfrm>
              <a:off x="4376880" y="2819520"/>
              <a:ext cx="1244520" cy="1539720"/>
            </a:xfrm>
            <a:custGeom>
              <a:avLst/>
              <a:gdLst>
                <a:gd name="textAreaLeft" fmla="*/ 0 w 1244520"/>
                <a:gd name="textAreaRight" fmla="*/ 1244880 w 1244520"/>
                <a:gd name="textAreaTop" fmla="*/ 0 h 1539720"/>
                <a:gd name="textAreaBottom" fmla="*/ 1540080 h 1539720"/>
              </a:gdLst>
              <a:ahLst/>
              <a:rect l="textAreaLeft" t="textAreaTop" r="textAreaRight" b="textAreaBottom"/>
              <a:pathLst>
                <a:path w="3305" h="4115">
                  <a:moveTo>
                    <a:pt x="1735" y="0"/>
                  </a:moveTo>
                  <a:cubicBezTo>
                    <a:pt x="2732" y="1165"/>
                    <a:pt x="3305" y="2688"/>
                    <a:pt x="3015" y="3402"/>
                  </a:cubicBezTo>
                  <a:cubicBezTo>
                    <a:pt x="2726" y="4115"/>
                    <a:pt x="1683" y="3749"/>
                    <a:pt x="686" y="2583"/>
                  </a:cubicBezTo>
                  <a:cubicBezTo>
                    <a:pt x="435" y="2289"/>
                    <a:pt x="201" y="1961"/>
                    <a:pt x="0" y="1619"/>
                  </a:cubicBezTo>
                </a:path>
              </a:pathLst>
            </a:custGeom>
            <a:solidFill>
              <a:srgbClr val="00b05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11"/>
            <p:cNvSpPr/>
            <p:nvPr/>
          </p:nvSpPr>
          <p:spPr>
            <a:xfrm>
              <a:off x="4367160" y="2811600"/>
              <a:ext cx="1182600" cy="1423800"/>
            </a:xfrm>
            <a:custGeom>
              <a:avLst/>
              <a:gdLst>
                <a:gd name="textAreaLeft" fmla="*/ 0 w 1182600"/>
                <a:gd name="textAreaRight" fmla="*/ 1182960 w 1182600"/>
                <a:gd name="textAreaTop" fmla="*/ 0 h 1423800"/>
                <a:gd name="textAreaBottom" fmla="*/ 1424160 h 1423800"/>
              </a:gdLst>
              <a:ahLst/>
              <a:rect l="textAreaLeft" t="textAreaTop" r="textAreaRight" b="textAreaBottom"/>
              <a:pathLst>
                <a:path w="3135" h="3807">
                  <a:moveTo>
                    <a:pt x="1744" y="6"/>
                  </a:moveTo>
                  <a:cubicBezTo>
                    <a:pt x="1748" y="2"/>
                    <a:pt x="1754" y="0"/>
                    <a:pt x="1760" y="0"/>
                  </a:cubicBezTo>
                  <a:cubicBezTo>
                    <a:pt x="1766" y="1"/>
                    <a:pt x="1771" y="3"/>
                    <a:pt x="1775" y="8"/>
                  </a:cubicBezTo>
                  <a:lnTo>
                    <a:pt x="1957" y="230"/>
                  </a:lnTo>
                  <a:lnTo>
                    <a:pt x="2129" y="460"/>
                  </a:lnTo>
                  <a:lnTo>
                    <a:pt x="2289" y="694"/>
                  </a:lnTo>
                  <a:lnTo>
                    <a:pt x="2438" y="933"/>
                  </a:lnTo>
                  <a:lnTo>
                    <a:pt x="2574" y="1172"/>
                  </a:lnTo>
                  <a:lnTo>
                    <a:pt x="2697" y="1412"/>
                  </a:lnTo>
                  <a:lnTo>
                    <a:pt x="2806" y="1650"/>
                  </a:lnTo>
                  <a:lnTo>
                    <a:pt x="2901" y="1883"/>
                  </a:lnTo>
                  <a:lnTo>
                    <a:pt x="2981" y="2112"/>
                  </a:lnTo>
                  <a:lnTo>
                    <a:pt x="3044" y="2335"/>
                  </a:lnTo>
                  <a:lnTo>
                    <a:pt x="3091" y="2548"/>
                  </a:lnTo>
                  <a:lnTo>
                    <a:pt x="3123" y="2751"/>
                  </a:lnTo>
                  <a:lnTo>
                    <a:pt x="3135" y="2943"/>
                  </a:lnTo>
                  <a:lnTo>
                    <a:pt x="3129" y="3121"/>
                  </a:lnTo>
                  <a:lnTo>
                    <a:pt x="3104" y="3284"/>
                  </a:lnTo>
                  <a:cubicBezTo>
                    <a:pt x="3103" y="3285"/>
                    <a:pt x="3103" y="3286"/>
                    <a:pt x="3103" y="3287"/>
                  </a:cubicBezTo>
                  <a:lnTo>
                    <a:pt x="3059" y="3430"/>
                  </a:lnTo>
                  <a:lnTo>
                    <a:pt x="3029" y="3496"/>
                  </a:lnTo>
                  <a:lnTo>
                    <a:pt x="2994" y="3555"/>
                  </a:lnTo>
                  <a:lnTo>
                    <a:pt x="2955" y="3608"/>
                  </a:lnTo>
                  <a:lnTo>
                    <a:pt x="2912" y="3655"/>
                  </a:lnTo>
                  <a:lnTo>
                    <a:pt x="2864" y="3696"/>
                  </a:lnTo>
                  <a:lnTo>
                    <a:pt x="2813" y="3730"/>
                  </a:lnTo>
                  <a:lnTo>
                    <a:pt x="2758" y="3758"/>
                  </a:lnTo>
                  <a:lnTo>
                    <a:pt x="2700" y="3780"/>
                  </a:lnTo>
                  <a:cubicBezTo>
                    <a:pt x="2699" y="3781"/>
                    <a:pt x="2698" y="3781"/>
                    <a:pt x="2697" y="3781"/>
                  </a:cubicBezTo>
                  <a:lnTo>
                    <a:pt x="2576" y="3805"/>
                  </a:lnTo>
                  <a:cubicBezTo>
                    <a:pt x="2574" y="3806"/>
                    <a:pt x="2573" y="3806"/>
                    <a:pt x="2572" y="3806"/>
                  </a:cubicBezTo>
                  <a:lnTo>
                    <a:pt x="2438" y="3807"/>
                  </a:lnTo>
                  <a:cubicBezTo>
                    <a:pt x="2436" y="3807"/>
                    <a:pt x="2435" y="3807"/>
                    <a:pt x="2434" y="3807"/>
                  </a:cubicBezTo>
                  <a:lnTo>
                    <a:pt x="2290" y="3785"/>
                  </a:lnTo>
                  <a:lnTo>
                    <a:pt x="2133" y="3739"/>
                  </a:lnTo>
                  <a:lnTo>
                    <a:pt x="1969" y="3672"/>
                  </a:lnTo>
                  <a:lnTo>
                    <a:pt x="1799" y="3582"/>
                  </a:lnTo>
                  <a:lnTo>
                    <a:pt x="1622" y="3473"/>
                  </a:lnTo>
                  <a:lnTo>
                    <a:pt x="1441" y="3342"/>
                  </a:lnTo>
                  <a:lnTo>
                    <a:pt x="1256" y="3190"/>
                  </a:lnTo>
                  <a:lnTo>
                    <a:pt x="1069" y="3019"/>
                  </a:lnTo>
                  <a:lnTo>
                    <a:pt x="881" y="2828"/>
                  </a:lnTo>
                  <a:lnTo>
                    <a:pt x="694" y="2619"/>
                  </a:lnTo>
                  <a:lnTo>
                    <a:pt x="508" y="2391"/>
                  </a:lnTo>
                  <a:lnTo>
                    <a:pt x="330" y="2153"/>
                  </a:lnTo>
                  <a:lnTo>
                    <a:pt x="163" y="1906"/>
                  </a:lnTo>
                  <a:lnTo>
                    <a:pt x="5" y="1652"/>
                  </a:lnTo>
                  <a:cubicBezTo>
                    <a:pt x="0" y="1643"/>
                    <a:pt x="1" y="1632"/>
                    <a:pt x="9" y="1625"/>
                  </a:cubicBezTo>
                  <a:lnTo>
                    <a:pt x="1744" y="6"/>
                  </a:lnTo>
                  <a:close/>
                  <a:moveTo>
                    <a:pt x="38" y="1656"/>
                  </a:moveTo>
                  <a:lnTo>
                    <a:pt x="42" y="1629"/>
                  </a:lnTo>
                  <a:lnTo>
                    <a:pt x="198" y="1882"/>
                  </a:lnTo>
                  <a:lnTo>
                    <a:pt x="365" y="2128"/>
                  </a:lnTo>
                  <a:lnTo>
                    <a:pt x="541" y="2364"/>
                  </a:lnTo>
                  <a:lnTo>
                    <a:pt x="725" y="2590"/>
                  </a:lnTo>
                  <a:lnTo>
                    <a:pt x="912" y="2798"/>
                  </a:lnTo>
                  <a:lnTo>
                    <a:pt x="1098" y="2988"/>
                  </a:lnTo>
                  <a:lnTo>
                    <a:pt x="1283" y="3157"/>
                  </a:lnTo>
                  <a:lnTo>
                    <a:pt x="1466" y="3307"/>
                  </a:lnTo>
                  <a:lnTo>
                    <a:pt x="1645" y="3436"/>
                  </a:lnTo>
                  <a:lnTo>
                    <a:pt x="1818" y="3545"/>
                  </a:lnTo>
                  <a:lnTo>
                    <a:pt x="1986" y="3633"/>
                  </a:lnTo>
                  <a:lnTo>
                    <a:pt x="2145" y="3698"/>
                  </a:lnTo>
                  <a:lnTo>
                    <a:pt x="2297" y="3742"/>
                  </a:lnTo>
                  <a:lnTo>
                    <a:pt x="2441" y="3764"/>
                  </a:lnTo>
                  <a:lnTo>
                    <a:pt x="2437" y="3764"/>
                  </a:lnTo>
                  <a:lnTo>
                    <a:pt x="2571" y="3763"/>
                  </a:lnTo>
                  <a:lnTo>
                    <a:pt x="2567" y="3764"/>
                  </a:lnTo>
                  <a:lnTo>
                    <a:pt x="2688" y="3740"/>
                  </a:lnTo>
                  <a:lnTo>
                    <a:pt x="2685" y="3740"/>
                  </a:lnTo>
                  <a:lnTo>
                    <a:pt x="2739" y="3720"/>
                  </a:lnTo>
                  <a:lnTo>
                    <a:pt x="2790" y="3695"/>
                  </a:lnTo>
                  <a:lnTo>
                    <a:pt x="2837" y="3663"/>
                  </a:lnTo>
                  <a:lnTo>
                    <a:pt x="2881" y="3626"/>
                  </a:lnTo>
                  <a:lnTo>
                    <a:pt x="2920" y="3583"/>
                  </a:lnTo>
                  <a:lnTo>
                    <a:pt x="2957" y="3534"/>
                  </a:lnTo>
                  <a:lnTo>
                    <a:pt x="2990" y="3479"/>
                  </a:lnTo>
                  <a:lnTo>
                    <a:pt x="3018" y="3417"/>
                  </a:lnTo>
                  <a:lnTo>
                    <a:pt x="3062" y="3274"/>
                  </a:lnTo>
                  <a:lnTo>
                    <a:pt x="3061" y="3277"/>
                  </a:lnTo>
                  <a:lnTo>
                    <a:pt x="3086" y="3120"/>
                  </a:lnTo>
                  <a:lnTo>
                    <a:pt x="3092" y="2946"/>
                  </a:lnTo>
                  <a:lnTo>
                    <a:pt x="3080" y="2758"/>
                  </a:lnTo>
                  <a:lnTo>
                    <a:pt x="3050" y="2557"/>
                  </a:lnTo>
                  <a:lnTo>
                    <a:pt x="3003" y="2346"/>
                  </a:lnTo>
                  <a:lnTo>
                    <a:pt x="2940" y="2126"/>
                  </a:lnTo>
                  <a:lnTo>
                    <a:pt x="2862" y="1900"/>
                  </a:lnTo>
                  <a:lnTo>
                    <a:pt x="2767" y="1667"/>
                  </a:lnTo>
                  <a:lnTo>
                    <a:pt x="2659" y="1431"/>
                  </a:lnTo>
                  <a:lnTo>
                    <a:pt x="2537" y="1193"/>
                  </a:lnTo>
                  <a:lnTo>
                    <a:pt x="2401" y="956"/>
                  </a:lnTo>
                  <a:lnTo>
                    <a:pt x="2254" y="719"/>
                  </a:lnTo>
                  <a:lnTo>
                    <a:pt x="2094" y="485"/>
                  </a:lnTo>
                  <a:lnTo>
                    <a:pt x="1924" y="257"/>
                  </a:lnTo>
                  <a:lnTo>
                    <a:pt x="1742" y="35"/>
                  </a:lnTo>
                  <a:lnTo>
                    <a:pt x="1773" y="37"/>
                  </a:lnTo>
                  <a:lnTo>
                    <a:pt x="38" y="1656"/>
                  </a:lnTo>
                  <a:close/>
                </a:path>
              </a:pathLst>
            </a:custGeom>
            <a:solidFill>
              <a:srgbClr val="385d8a"/>
            </a:solidFill>
            <a:ln w="0">
              <a:solidFill>
                <a:srgbClr val="385d8a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12"/>
            <p:cNvSpPr/>
            <p:nvPr/>
          </p:nvSpPr>
          <p:spPr>
            <a:xfrm>
              <a:off x="3865680" y="858960"/>
              <a:ext cx="961920" cy="1439640"/>
            </a:xfrm>
            <a:custGeom>
              <a:avLst/>
              <a:gdLst>
                <a:gd name="textAreaLeft" fmla="*/ 0 w 961920"/>
                <a:gd name="textAreaRight" fmla="*/ 962280 w 961920"/>
                <a:gd name="textAreaTop" fmla="*/ 0 h 1439640"/>
                <a:gd name="textAreaBottom" fmla="*/ 1439640 h 1439640"/>
              </a:gdLst>
              <a:ahLst/>
              <a:rect l="textAreaLeft" t="textAreaTop" r="textAreaRight" b="textAreaBottom"/>
              <a:pathLst>
                <a:path w="2551" h="3850">
                  <a:moveTo>
                    <a:pt x="188" y="3850"/>
                  </a:moveTo>
                  <a:cubicBezTo>
                    <a:pt x="0" y="2392"/>
                    <a:pt x="363" y="861"/>
                    <a:pt x="998" y="430"/>
                  </a:cubicBezTo>
                  <a:cubicBezTo>
                    <a:pt x="1634" y="0"/>
                    <a:pt x="2301" y="832"/>
                    <a:pt x="2489" y="2289"/>
                  </a:cubicBezTo>
                  <a:cubicBezTo>
                    <a:pt x="2539" y="2672"/>
                    <a:pt x="2551" y="3075"/>
                    <a:pt x="2526" y="3470"/>
                  </a:cubicBezTo>
                </a:path>
              </a:pathLst>
            </a:custGeom>
            <a:solidFill>
              <a:srgbClr val="f79646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3"/>
            <p:cNvSpPr/>
            <p:nvPr/>
          </p:nvSpPr>
          <p:spPr>
            <a:xfrm>
              <a:off x="3909960" y="968400"/>
              <a:ext cx="922320" cy="1339920"/>
            </a:xfrm>
            <a:custGeom>
              <a:avLst/>
              <a:gdLst>
                <a:gd name="textAreaLeft" fmla="*/ 0 w 922320"/>
                <a:gd name="textAreaRight" fmla="*/ 922680 w 922320"/>
                <a:gd name="textAreaTop" fmla="*/ 0 h 1339920"/>
                <a:gd name="textAreaBottom" fmla="*/ 1340280 h 1339920"/>
              </a:gdLst>
              <a:ahLst/>
              <a:rect l="textAreaLeft" t="textAreaTop" r="textAreaRight" b="textAreaBottom"/>
              <a:pathLst>
                <a:path w="2447" h="3582">
                  <a:moveTo>
                    <a:pt x="77" y="3581"/>
                  </a:moveTo>
                  <a:cubicBezTo>
                    <a:pt x="71" y="3582"/>
                    <a:pt x="64" y="3581"/>
                    <a:pt x="59" y="3577"/>
                  </a:cubicBezTo>
                  <a:cubicBezTo>
                    <a:pt x="54" y="3573"/>
                    <a:pt x="50" y="3567"/>
                    <a:pt x="50" y="3560"/>
                  </a:cubicBezTo>
                  <a:lnTo>
                    <a:pt x="21" y="3286"/>
                  </a:lnTo>
                  <a:lnTo>
                    <a:pt x="5" y="3011"/>
                  </a:lnTo>
                  <a:lnTo>
                    <a:pt x="0" y="2738"/>
                  </a:lnTo>
                  <a:lnTo>
                    <a:pt x="7" y="2468"/>
                  </a:lnTo>
                  <a:lnTo>
                    <a:pt x="27" y="2204"/>
                  </a:lnTo>
                  <a:lnTo>
                    <a:pt x="56" y="1946"/>
                  </a:lnTo>
                  <a:lnTo>
                    <a:pt x="96" y="1697"/>
                  </a:lnTo>
                  <a:lnTo>
                    <a:pt x="146" y="1458"/>
                  </a:lnTo>
                  <a:lnTo>
                    <a:pt x="206" y="1230"/>
                  </a:lnTo>
                  <a:lnTo>
                    <a:pt x="276" y="1017"/>
                  </a:lnTo>
                  <a:lnTo>
                    <a:pt x="354" y="820"/>
                  </a:lnTo>
                  <a:lnTo>
                    <a:pt x="441" y="638"/>
                  </a:lnTo>
                  <a:lnTo>
                    <a:pt x="536" y="476"/>
                  </a:lnTo>
                  <a:lnTo>
                    <a:pt x="639" y="334"/>
                  </a:lnTo>
                  <a:lnTo>
                    <a:pt x="694" y="271"/>
                  </a:lnTo>
                  <a:lnTo>
                    <a:pt x="750" y="214"/>
                  </a:lnTo>
                  <a:lnTo>
                    <a:pt x="809" y="163"/>
                  </a:lnTo>
                  <a:lnTo>
                    <a:pt x="869" y="118"/>
                  </a:lnTo>
                  <a:lnTo>
                    <a:pt x="931" y="80"/>
                  </a:lnTo>
                  <a:lnTo>
                    <a:pt x="992" y="50"/>
                  </a:lnTo>
                  <a:lnTo>
                    <a:pt x="1054" y="27"/>
                  </a:lnTo>
                  <a:lnTo>
                    <a:pt x="1117" y="11"/>
                  </a:lnTo>
                  <a:lnTo>
                    <a:pt x="1178" y="2"/>
                  </a:lnTo>
                  <a:lnTo>
                    <a:pt x="1241" y="0"/>
                  </a:lnTo>
                  <a:lnTo>
                    <a:pt x="1302" y="6"/>
                  </a:lnTo>
                  <a:lnTo>
                    <a:pt x="1363" y="18"/>
                  </a:lnTo>
                  <a:lnTo>
                    <a:pt x="1424" y="37"/>
                  </a:lnTo>
                  <a:lnTo>
                    <a:pt x="1483" y="62"/>
                  </a:lnTo>
                  <a:lnTo>
                    <a:pt x="1541" y="94"/>
                  </a:lnTo>
                  <a:lnTo>
                    <a:pt x="1599" y="132"/>
                  </a:lnTo>
                  <a:lnTo>
                    <a:pt x="1709" y="226"/>
                  </a:lnTo>
                  <a:lnTo>
                    <a:pt x="1814" y="343"/>
                  </a:lnTo>
                  <a:lnTo>
                    <a:pt x="1915" y="482"/>
                  </a:lnTo>
                  <a:lnTo>
                    <a:pt x="2008" y="642"/>
                  </a:lnTo>
                  <a:lnTo>
                    <a:pt x="2095" y="822"/>
                  </a:lnTo>
                  <a:lnTo>
                    <a:pt x="2174" y="1022"/>
                  </a:lnTo>
                  <a:lnTo>
                    <a:pt x="2244" y="1239"/>
                  </a:lnTo>
                  <a:lnTo>
                    <a:pt x="2306" y="1474"/>
                  </a:lnTo>
                  <a:lnTo>
                    <a:pt x="2357" y="1726"/>
                  </a:lnTo>
                  <a:lnTo>
                    <a:pt x="2398" y="1993"/>
                  </a:lnTo>
                  <a:lnTo>
                    <a:pt x="2428" y="2285"/>
                  </a:lnTo>
                  <a:lnTo>
                    <a:pt x="2445" y="2581"/>
                  </a:lnTo>
                  <a:lnTo>
                    <a:pt x="2447" y="2880"/>
                  </a:lnTo>
                  <a:lnTo>
                    <a:pt x="2435" y="3178"/>
                  </a:lnTo>
                  <a:cubicBezTo>
                    <a:pt x="2435" y="3190"/>
                    <a:pt x="2427" y="3199"/>
                    <a:pt x="2415" y="3201"/>
                  </a:cubicBezTo>
                  <a:lnTo>
                    <a:pt x="77" y="3581"/>
                  </a:lnTo>
                  <a:close/>
                  <a:moveTo>
                    <a:pt x="2408" y="3154"/>
                  </a:moveTo>
                  <a:lnTo>
                    <a:pt x="2387" y="3176"/>
                  </a:lnTo>
                  <a:lnTo>
                    <a:pt x="2399" y="2881"/>
                  </a:lnTo>
                  <a:lnTo>
                    <a:pt x="2398" y="2584"/>
                  </a:lnTo>
                  <a:lnTo>
                    <a:pt x="2381" y="2290"/>
                  </a:lnTo>
                  <a:lnTo>
                    <a:pt x="2351" y="2000"/>
                  </a:lnTo>
                  <a:lnTo>
                    <a:pt x="2310" y="1735"/>
                  </a:lnTo>
                  <a:lnTo>
                    <a:pt x="2259" y="1487"/>
                  </a:lnTo>
                  <a:lnTo>
                    <a:pt x="2199" y="1254"/>
                  </a:lnTo>
                  <a:lnTo>
                    <a:pt x="2129" y="1039"/>
                  </a:lnTo>
                  <a:lnTo>
                    <a:pt x="2052" y="843"/>
                  </a:lnTo>
                  <a:lnTo>
                    <a:pt x="1967" y="667"/>
                  </a:lnTo>
                  <a:lnTo>
                    <a:pt x="1876" y="511"/>
                  </a:lnTo>
                  <a:lnTo>
                    <a:pt x="1779" y="375"/>
                  </a:lnTo>
                  <a:lnTo>
                    <a:pt x="1678" y="263"/>
                  </a:lnTo>
                  <a:lnTo>
                    <a:pt x="1572" y="172"/>
                  </a:lnTo>
                  <a:lnTo>
                    <a:pt x="1518" y="136"/>
                  </a:lnTo>
                  <a:lnTo>
                    <a:pt x="1464" y="106"/>
                  </a:lnTo>
                  <a:lnTo>
                    <a:pt x="1409" y="82"/>
                  </a:lnTo>
                  <a:lnTo>
                    <a:pt x="1354" y="65"/>
                  </a:lnTo>
                  <a:lnTo>
                    <a:pt x="1297" y="53"/>
                  </a:lnTo>
                  <a:lnTo>
                    <a:pt x="1242" y="48"/>
                  </a:lnTo>
                  <a:lnTo>
                    <a:pt x="1185" y="49"/>
                  </a:lnTo>
                  <a:lnTo>
                    <a:pt x="1128" y="58"/>
                  </a:lnTo>
                  <a:lnTo>
                    <a:pt x="1071" y="72"/>
                  </a:lnTo>
                  <a:lnTo>
                    <a:pt x="1013" y="93"/>
                  </a:lnTo>
                  <a:lnTo>
                    <a:pt x="956" y="121"/>
                  </a:lnTo>
                  <a:lnTo>
                    <a:pt x="898" y="157"/>
                  </a:lnTo>
                  <a:lnTo>
                    <a:pt x="840" y="200"/>
                  </a:lnTo>
                  <a:lnTo>
                    <a:pt x="785" y="247"/>
                  </a:lnTo>
                  <a:lnTo>
                    <a:pt x="731" y="302"/>
                  </a:lnTo>
                  <a:lnTo>
                    <a:pt x="678" y="363"/>
                  </a:lnTo>
                  <a:lnTo>
                    <a:pt x="577" y="501"/>
                  </a:lnTo>
                  <a:lnTo>
                    <a:pt x="484" y="659"/>
                  </a:lnTo>
                  <a:lnTo>
                    <a:pt x="399" y="837"/>
                  </a:lnTo>
                  <a:lnTo>
                    <a:pt x="321" y="1032"/>
                  </a:lnTo>
                  <a:lnTo>
                    <a:pt x="253" y="1243"/>
                  </a:lnTo>
                  <a:lnTo>
                    <a:pt x="193" y="1467"/>
                  </a:lnTo>
                  <a:lnTo>
                    <a:pt x="143" y="1704"/>
                  </a:lnTo>
                  <a:lnTo>
                    <a:pt x="103" y="1951"/>
                  </a:lnTo>
                  <a:lnTo>
                    <a:pt x="74" y="2207"/>
                  </a:lnTo>
                  <a:lnTo>
                    <a:pt x="55" y="2469"/>
                  </a:lnTo>
                  <a:lnTo>
                    <a:pt x="48" y="2737"/>
                  </a:lnTo>
                  <a:lnTo>
                    <a:pt x="52" y="3008"/>
                  </a:lnTo>
                  <a:lnTo>
                    <a:pt x="68" y="3281"/>
                  </a:lnTo>
                  <a:lnTo>
                    <a:pt x="97" y="3555"/>
                  </a:lnTo>
                  <a:lnTo>
                    <a:pt x="70" y="3534"/>
                  </a:lnTo>
                  <a:lnTo>
                    <a:pt x="2408" y="3154"/>
                  </a:lnTo>
                  <a:close/>
                </a:path>
              </a:pathLst>
            </a:custGeom>
            <a:solidFill>
              <a:srgbClr val="385d8a"/>
            </a:solidFill>
            <a:ln w="0">
              <a:solidFill>
                <a:srgbClr val="385d8a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14"/>
            <p:cNvSpPr/>
            <p:nvPr/>
          </p:nvSpPr>
          <p:spPr>
            <a:xfrm rot="229200">
              <a:off x="2505240" y="1854360"/>
              <a:ext cx="1401480" cy="1172880"/>
            </a:xfrm>
            <a:custGeom>
              <a:avLst/>
              <a:gdLst>
                <a:gd name="textAreaLeft" fmla="*/ 0 w 1401480"/>
                <a:gd name="textAreaRight" fmla="*/ 1401840 w 1401480"/>
                <a:gd name="textAreaTop" fmla="*/ 0 h 1172880"/>
                <a:gd name="textAreaBottom" fmla="*/ 1173240 h 1172880"/>
              </a:gdLst>
              <a:ahLst/>
              <a:rect l="textAreaLeft" t="textAreaTop" r="textAreaRight" b="textAreaBottom"/>
              <a:pathLst>
                <a:path w="3718" h="3136">
                  <a:moveTo>
                    <a:pt x="3338" y="3136"/>
                  </a:moveTo>
                  <a:cubicBezTo>
                    <a:pt x="1861" y="2895"/>
                    <a:pt x="472" y="2051"/>
                    <a:pt x="236" y="1252"/>
                  </a:cubicBezTo>
                  <a:cubicBezTo>
                    <a:pt x="0" y="453"/>
                    <a:pt x="1005" y="0"/>
                    <a:pt x="2481" y="241"/>
                  </a:cubicBezTo>
                  <a:cubicBezTo>
                    <a:pt x="2895" y="309"/>
                    <a:pt x="3319" y="428"/>
                    <a:pt x="3718" y="588"/>
                  </a:cubicBezTo>
                </a:path>
              </a:pathLst>
            </a:custGeom>
            <a:solidFill>
              <a:srgbClr val="c0504d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5"/>
            <p:cNvSpPr/>
            <p:nvPr/>
          </p:nvSpPr>
          <p:spPr>
            <a:xfrm rot="219600">
              <a:off x="2590560" y="1910880"/>
              <a:ext cx="1342800" cy="1123920"/>
            </a:xfrm>
            <a:custGeom>
              <a:avLst/>
              <a:gdLst>
                <a:gd name="textAreaLeft" fmla="*/ 0 w 1342800"/>
                <a:gd name="textAreaRight" fmla="*/ 1342800 w 1342800"/>
                <a:gd name="textAreaTop" fmla="*/ 0 h 1123920"/>
                <a:gd name="textAreaBottom" fmla="*/ 1124280 h 1123920"/>
              </a:gdLst>
              <a:ahLst/>
              <a:rect l="textAreaLeft" t="textAreaTop" r="textAreaRight" b="textAreaBottom"/>
              <a:pathLst>
                <a:path w="3560" h="3004">
                  <a:moveTo>
                    <a:pt x="3179" y="2985"/>
                  </a:moveTo>
                  <a:cubicBezTo>
                    <a:pt x="3178" y="2990"/>
                    <a:pt x="3175" y="2995"/>
                    <a:pt x="3170" y="2999"/>
                  </a:cubicBezTo>
                  <a:cubicBezTo>
                    <a:pt x="3165" y="3002"/>
                    <a:pt x="3159" y="3004"/>
                    <a:pt x="3154" y="3002"/>
                  </a:cubicBezTo>
                  <a:lnTo>
                    <a:pt x="2878" y="2950"/>
                  </a:lnTo>
                  <a:lnTo>
                    <a:pt x="2605" y="2885"/>
                  </a:lnTo>
                  <a:lnTo>
                    <a:pt x="2336" y="2807"/>
                  </a:lnTo>
                  <a:lnTo>
                    <a:pt x="2076" y="2718"/>
                  </a:lnTo>
                  <a:lnTo>
                    <a:pt x="1824" y="2618"/>
                  </a:lnTo>
                  <a:lnTo>
                    <a:pt x="1581" y="2510"/>
                  </a:lnTo>
                  <a:lnTo>
                    <a:pt x="1349" y="2392"/>
                  </a:lnTo>
                  <a:lnTo>
                    <a:pt x="1131" y="2267"/>
                  </a:lnTo>
                  <a:lnTo>
                    <a:pt x="927" y="2135"/>
                  </a:lnTo>
                  <a:lnTo>
                    <a:pt x="739" y="1999"/>
                  </a:lnTo>
                  <a:lnTo>
                    <a:pt x="569" y="1856"/>
                  </a:lnTo>
                  <a:lnTo>
                    <a:pt x="418" y="1711"/>
                  </a:lnTo>
                  <a:lnTo>
                    <a:pt x="286" y="1562"/>
                  </a:lnTo>
                  <a:lnTo>
                    <a:pt x="178" y="1410"/>
                  </a:lnTo>
                  <a:lnTo>
                    <a:pt x="133" y="1333"/>
                  </a:lnTo>
                  <a:lnTo>
                    <a:pt x="94" y="1257"/>
                  </a:lnTo>
                  <a:lnTo>
                    <a:pt x="61" y="1181"/>
                  </a:lnTo>
                  <a:lnTo>
                    <a:pt x="35" y="1104"/>
                  </a:lnTo>
                  <a:lnTo>
                    <a:pt x="16" y="1029"/>
                  </a:lnTo>
                  <a:lnTo>
                    <a:pt x="4" y="955"/>
                  </a:lnTo>
                  <a:lnTo>
                    <a:pt x="0" y="884"/>
                  </a:lnTo>
                  <a:lnTo>
                    <a:pt x="2" y="814"/>
                  </a:lnTo>
                  <a:lnTo>
                    <a:pt x="11" y="747"/>
                  </a:lnTo>
                  <a:lnTo>
                    <a:pt x="28" y="681"/>
                  </a:lnTo>
                  <a:lnTo>
                    <a:pt x="50" y="619"/>
                  </a:lnTo>
                  <a:lnTo>
                    <a:pt x="80" y="559"/>
                  </a:lnTo>
                  <a:lnTo>
                    <a:pt x="115" y="502"/>
                  </a:lnTo>
                  <a:lnTo>
                    <a:pt x="158" y="447"/>
                  </a:lnTo>
                  <a:lnTo>
                    <a:pt x="257" y="347"/>
                  </a:lnTo>
                  <a:cubicBezTo>
                    <a:pt x="258" y="347"/>
                    <a:pt x="259" y="346"/>
                    <a:pt x="260" y="345"/>
                  </a:cubicBezTo>
                  <a:lnTo>
                    <a:pt x="381" y="259"/>
                  </a:lnTo>
                  <a:lnTo>
                    <a:pt x="527" y="184"/>
                  </a:lnTo>
                  <a:lnTo>
                    <a:pt x="691" y="120"/>
                  </a:lnTo>
                  <a:lnTo>
                    <a:pt x="874" y="69"/>
                  </a:lnTo>
                  <a:lnTo>
                    <a:pt x="1075" y="32"/>
                  </a:lnTo>
                  <a:lnTo>
                    <a:pt x="1291" y="9"/>
                  </a:lnTo>
                  <a:lnTo>
                    <a:pt x="1525" y="0"/>
                  </a:lnTo>
                  <a:lnTo>
                    <a:pt x="1771" y="6"/>
                  </a:lnTo>
                  <a:lnTo>
                    <a:pt x="2031" y="28"/>
                  </a:lnTo>
                  <a:lnTo>
                    <a:pt x="2303" y="65"/>
                  </a:lnTo>
                  <a:lnTo>
                    <a:pt x="2616" y="126"/>
                  </a:lnTo>
                  <a:lnTo>
                    <a:pt x="2930" y="205"/>
                  </a:lnTo>
                  <a:lnTo>
                    <a:pt x="3241" y="301"/>
                  </a:lnTo>
                  <a:lnTo>
                    <a:pt x="3545" y="413"/>
                  </a:lnTo>
                  <a:cubicBezTo>
                    <a:pt x="3554" y="417"/>
                    <a:pt x="3560" y="427"/>
                    <a:pt x="3559" y="437"/>
                  </a:cubicBezTo>
                  <a:lnTo>
                    <a:pt x="3179" y="2985"/>
                  </a:lnTo>
                  <a:close/>
                  <a:moveTo>
                    <a:pt x="3516" y="430"/>
                  </a:moveTo>
                  <a:lnTo>
                    <a:pt x="3530" y="453"/>
                  </a:lnTo>
                  <a:lnTo>
                    <a:pt x="3228" y="342"/>
                  </a:lnTo>
                  <a:lnTo>
                    <a:pt x="2919" y="246"/>
                  </a:lnTo>
                  <a:lnTo>
                    <a:pt x="2608" y="167"/>
                  </a:lnTo>
                  <a:lnTo>
                    <a:pt x="2298" y="108"/>
                  </a:lnTo>
                  <a:lnTo>
                    <a:pt x="2028" y="71"/>
                  </a:lnTo>
                  <a:lnTo>
                    <a:pt x="1770" y="49"/>
                  </a:lnTo>
                  <a:lnTo>
                    <a:pt x="1526" y="43"/>
                  </a:lnTo>
                  <a:lnTo>
                    <a:pt x="1296" y="52"/>
                  </a:lnTo>
                  <a:lnTo>
                    <a:pt x="1082" y="74"/>
                  </a:lnTo>
                  <a:lnTo>
                    <a:pt x="885" y="110"/>
                  </a:lnTo>
                  <a:lnTo>
                    <a:pt x="706" y="159"/>
                  </a:lnTo>
                  <a:lnTo>
                    <a:pt x="546" y="221"/>
                  </a:lnTo>
                  <a:lnTo>
                    <a:pt x="406" y="294"/>
                  </a:lnTo>
                  <a:lnTo>
                    <a:pt x="285" y="380"/>
                  </a:lnTo>
                  <a:lnTo>
                    <a:pt x="288" y="378"/>
                  </a:lnTo>
                  <a:lnTo>
                    <a:pt x="191" y="474"/>
                  </a:lnTo>
                  <a:lnTo>
                    <a:pt x="152" y="525"/>
                  </a:lnTo>
                  <a:lnTo>
                    <a:pt x="119" y="578"/>
                  </a:lnTo>
                  <a:lnTo>
                    <a:pt x="90" y="634"/>
                  </a:lnTo>
                  <a:lnTo>
                    <a:pt x="69" y="692"/>
                  </a:lnTo>
                  <a:lnTo>
                    <a:pt x="54" y="752"/>
                  </a:lnTo>
                  <a:lnTo>
                    <a:pt x="45" y="815"/>
                  </a:lnTo>
                  <a:lnTo>
                    <a:pt x="43" y="881"/>
                  </a:lnTo>
                  <a:lnTo>
                    <a:pt x="47" y="948"/>
                  </a:lnTo>
                  <a:lnTo>
                    <a:pt x="57" y="1018"/>
                  </a:lnTo>
                  <a:lnTo>
                    <a:pt x="76" y="1091"/>
                  </a:lnTo>
                  <a:lnTo>
                    <a:pt x="100" y="1164"/>
                  </a:lnTo>
                  <a:lnTo>
                    <a:pt x="131" y="1238"/>
                  </a:lnTo>
                  <a:lnTo>
                    <a:pt x="170" y="1312"/>
                  </a:lnTo>
                  <a:lnTo>
                    <a:pt x="213" y="1385"/>
                  </a:lnTo>
                  <a:lnTo>
                    <a:pt x="318" y="1533"/>
                  </a:lnTo>
                  <a:lnTo>
                    <a:pt x="447" y="1680"/>
                  </a:lnTo>
                  <a:lnTo>
                    <a:pt x="596" y="1823"/>
                  </a:lnTo>
                  <a:lnTo>
                    <a:pt x="764" y="1964"/>
                  </a:lnTo>
                  <a:lnTo>
                    <a:pt x="950" y="2100"/>
                  </a:lnTo>
                  <a:lnTo>
                    <a:pt x="1152" y="2230"/>
                  </a:lnTo>
                  <a:lnTo>
                    <a:pt x="1368" y="2354"/>
                  </a:lnTo>
                  <a:lnTo>
                    <a:pt x="1598" y="2471"/>
                  </a:lnTo>
                  <a:lnTo>
                    <a:pt x="1839" y="2579"/>
                  </a:lnTo>
                  <a:lnTo>
                    <a:pt x="2089" y="2677"/>
                  </a:lnTo>
                  <a:lnTo>
                    <a:pt x="2348" y="2766"/>
                  </a:lnTo>
                  <a:lnTo>
                    <a:pt x="2614" y="2844"/>
                  </a:lnTo>
                  <a:lnTo>
                    <a:pt x="2885" y="2909"/>
                  </a:lnTo>
                  <a:lnTo>
                    <a:pt x="3161" y="2961"/>
                  </a:lnTo>
                  <a:lnTo>
                    <a:pt x="3136" y="2978"/>
                  </a:lnTo>
                  <a:lnTo>
                    <a:pt x="3516" y="430"/>
                  </a:lnTo>
                  <a:close/>
                </a:path>
              </a:pathLst>
            </a:custGeom>
            <a:solidFill>
              <a:srgbClr val="385d8a"/>
            </a:solidFill>
            <a:ln w="0">
              <a:solidFill>
                <a:srgbClr val="385d8a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6"/>
            <p:cNvSpPr/>
            <p:nvPr/>
          </p:nvSpPr>
          <p:spPr>
            <a:xfrm>
              <a:off x="4776840" y="1944720"/>
              <a:ext cx="1523880" cy="990720"/>
            </a:xfrm>
            <a:custGeom>
              <a:avLst/>
              <a:gdLst>
                <a:gd name="textAreaLeft" fmla="*/ 0 w 1523880"/>
                <a:gd name="textAreaRight" fmla="*/ 1524240 w 1523880"/>
                <a:gd name="textAreaTop" fmla="*/ 0 h 990720"/>
                <a:gd name="textAreaBottom" fmla="*/ 991080 h 990720"/>
              </a:gdLst>
              <a:ahLst/>
              <a:rect l="textAreaLeft" t="textAreaTop" r="textAreaRight" b="textAreaBottom"/>
              <a:pathLst>
                <a:path w="4043" h="2648">
                  <a:moveTo>
                    <a:pt x="0" y="558"/>
                  </a:moveTo>
                  <a:cubicBezTo>
                    <a:pt x="1375" y="30"/>
                    <a:pt x="2937" y="0"/>
                    <a:pt x="3490" y="491"/>
                  </a:cubicBezTo>
                  <a:cubicBezTo>
                    <a:pt x="4043" y="983"/>
                    <a:pt x="3376" y="1809"/>
                    <a:pt x="2002" y="2337"/>
                  </a:cubicBezTo>
                  <a:cubicBezTo>
                    <a:pt x="1655" y="2470"/>
                    <a:pt x="1282" y="2576"/>
                    <a:pt x="908" y="2648"/>
                  </a:cubicBezTo>
                </a:path>
              </a:pathLst>
            </a:custGeom>
            <a:solidFill>
              <a:srgbClr val="ff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17"/>
            <p:cNvSpPr/>
            <p:nvPr/>
          </p:nvSpPr>
          <p:spPr>
            <a:xfrm>
              <a:off x="4768920" y="1989000"/>
              <a:ext cx="1404720" cy="954360"/>
            </a:xfrm>
            <a:custGeom>
              <a:avLst/>
              <a:gdLst>
                <a:gd name="textAreaLeft" fmla="*/ 0 w 1404720"/>
                <a:gd name="textAreaRight" fmla="*/ 1404720 w 1404720"/>
                <a:gd name="textAreaTop" fmla="*/ 0 h 954360"/>
                <a:gd name="textAreaBottom" fmla="*/ 954720 h 954360"/>
              </a:gdLst>
              <a:ahLst/>
              <a:rect l="textAreaLeft" t="textAreaTop" r="textAreaRight" b="textAreaBottom"/>
              <a:pathLst>
                <a:path w="3727" h="2550">
                  <a:moveTo>
                    <a:pt x="2" y="446"/>
                  </a:moveTo>
                  <a:cubicBezTo>
                    <a:pt x="0" y="441"/>
                    <a:pt x="0" y="434"/>
                    <a:pt x="2" y="429"/>
                  </a:cubicBezTo>
                  <a:cubicBezTo>
                    <a:pt x="4" y="424"/>
                    <a:pt x="9" y="419"/>
                    <a:pt x="14" y="417"/>
                  </a:cubicBezTo>
                  <a:lnTo>
                    <a:pt x="274" y="324"/>
                  </a:lnTo>
                  <a:lnTo>
                    <a:pt x="537" y="242"/>
                  </a:lnTo>
                  <a:lnTo>
                    <a:pt x="801" y="173"/>
                  </a:lnTo>
                  <a:lnTo>
                    <a:pt x="1065" y="115"/>
                  </a:lnTo>
                  <a:lnTo>
                    <a:pt x="1325" y="68"/>
                  </a:lnTo>
                  <a:lnTo>
                    <a:pt x="1582" y="33"/>
                  </a:lnTo>
                  <a:lnTo>
                    <a:pt x="1832" y="11"/>
                  </a:lnTo>
                  <a:lnTo>
                    <a:pt x="2073" y="0"/>
                  </a:lnTo>
                  <a:lnTo>
                    <a:pt x="2307" y="2"/>
                  </a:lnTo>
                  <a:lnTo>
                    <a:pt x="2528" y="15"/>
                  </a:lnTo>
                  <a:lnTo>
                    <a:pt x="2736" y="41"/>
                  </a:lnTo>
                  <a:lnTo>
                    <a:pt x="2930" y="79"/>
                  </a:lnTo>
                  <a:lnTo>
                    <a:pt x="3107" y="129"/>
                  </a:lnTo>
                  <a:lnTo>
                    <a:pt x="3267" y="191"/>
                  </a:lnTo>
                  <a:lnTo>
                    <a:pt x="3407" y="266"/>
                  </a:lnTo>
                  <a:cubicBezTo>
                    <a:pt x="3408" y="266"/>
                    <a:pt x="3408" y="267"/>
                    <a:pt x="3409" y="267"/>
                  </a:cubicBezTo>
                  <a:lnTo>
                    <a:pt x="3524" y="353"/>
                  </a:lnTo>
                  <a:lnTo>
                    <a:pt x="3574" y="402"/>
                  </a:lnTo>
                  <a:lnTo>
                    <a:pt x="3618" y="453"/>
                  </a:lnTo>
                  <a:lnTo>
                    <a:pt x="3653" y="506"/>
                  </a:lnTo>
                  <a:lnTo>
                    <a:pt x="3681" y="560"/>
                  </a:lnTo>
                  <a:lnTo>
                    <a:pt x="3703" y="616"/>
                  </a:lnTo>
                  <a:lnTo>
                    <a:pt x="3718" y="673"/>
                  </a:lnTo>
                  <a:lnTo>
                    <a:pt x="3726" y="732"/>
                  </a:lnTo>
                  <a:lnTo>
                    <a:pt x="3727" y="792"/>
                  </a:lnTo>
                  <a:lnTo>
                    <a:pt x="3721" y="853"/>
                  </a:lnTo>
                  <a:lnTo>
                    <a:pt x="3709" y="914"/>
                  </a:lnTo>
                  <a:lnTo>
                    <a:pt x="3691" y="977"/>
                  </a:lnTo>
                  <a:lnTo>
                    <a:pt x="3665" y="1040"/>
                  </a:lnTo>
                  <a:lnTo>
                    <a:pt x="3635" y="1103"/>
                  </a:lnTo>
                  <a:lnTo>
                    <a:pt x="3598" y="1166"/>
                  </a:lnTo>
                  <a:lnTo>
                    <a:pt x="3508" y="1292"/>
                  </a:lnTo>
                  <a:lnTo>
                    <a:pt x="3393" y="1420"/>
                  </a:lnTo>
                  <a:lnTo>
                    <a:pt x="3258" y="1546"/>
                  </a:lnTo>
                  <a:lnTo>
                    <a:pt x="3102" y="1670"/>
                  </a:lnTo>
                  <a:lnTo>
                    <a:pt x="2926" y="1792"/>
                  </a:lnTo>
                  <a:lnTo>
                    <a:pt x="2730" y="1911"/>
                  </a:lnTo>
                  <a:lnTo>
                    <a:pt x="2514" y="2024"/>
                  </a:lnTo>
                  <a:lnTo>
                    <a:pt x="2282" y="2134"/>
                  </a:lnTo>
                  <a:lnTo>
                    <a:pt x="2032" y="2236"/>
                  </a:lnTo>
                  <a:lnTo>
                    <a:pt x="1766" y="2332"/>
                  </a:lnTo>
                  <a:lnTo>
                    <a:pt x="1493" y="2415"/>
                  </a:lnTo>
                  <a:lnTo>
                    <a:pt x="1215" y="2488"/>
                  </a:lnTo>
                  <a:lnTo>
                    <a:pt x="934" y="2548"/>
                  </a:lnTo>
                  <a:cubicBezTo>
                    <a:pt x="924" y="2550"/>
                    <a:pt x="914" y="2545"/>
                    <a:pt x="910" y="2536"/>
                  </a:cubicBezTo>
                  <a:lnTo>
                    <a:pt x="2" y="446"/>
                  </a:lnTo>
                  <a:close/>
                  <a:moveTo>
                    <a:pt x="949" y="2519"/>
                  </a:moveTo>
                  <a:lnTo>
                    <a:pt x="925" y="2507"/>
                  </a:lnTo>
                  <a:lnTo>
                    <a:pt x="1204" y="2447"/>
                  </a:lnTo>
                  <a:lnTo>
                    <a:pt x="1480" y="2374"/>
                  </a:lnTo>
                  <a:lnTo>
                    <a:pt x="1751" y="2291"/>
                  </a:lnTo>
                  <a:lnTo>
                    <a:pt x="2015" y="2197"/>
                  </a:lnTo>
                  <a:lnTo>
                    <a:pt x="2263" y="2095"/>
                  </a:lnTo>
                  <a:lnTo>
                    <a:pt x="2495" y="1987"/>
                  </a:lnTo>
                  <a:lnTo>
                    <a:pt x="2707" y="1874"/>
                  </a:lnTo>
                  <a:lnTo>
                    <a:pt x="2901" y="1757"/>
                  </a:lnTo>
                  <a:lnTo>
                    <a:pt x="3075" y="1637"/>
                  </a:lnTo>
                  <a:lnTo>
                    <a:pt x="3229" y="1515"/>
                  </a:lnTo>
                  <a:lnTo>
                    <a:pt x="3362" y="1391"/>
                  </a:lnTo>
                  <a:lnTo>
                    <a:pt x="3473" y="1267"/>
                  </a:lnTo>
                  <a:lnTo>
                    <a:pt x="3561" y="1145"/>
                  </a:lnTo>
                  <a:lnTo>
                    <a:pt x="3596" y="1084"/>
                  </a:lnTo>
                  <a:lnTo>
                    <a:pt x="3626" y="1023"/>
                  </a:lnTo>
                  <a:lnTo>
                    <a:pt x="3650" y="964"/>
                  </a:lnTo>
                  <a:lnTo>
                    <a:pt x="3667" y="907"/>
                  </a:lnTo>
                  <a:lnTo>
                    <a:pt x="3678" y="848"/>
                  </a:lnTo>
                  <a:lnTo>
                    <a:pt x="3684" y="793"/>
                  </a:lnTo>
                  <a:lnTo>
                    <a:pt x="3683" y="737"/>
                  </a:lnTo>
                  <a:lnTo>
                    <a:pt x="3677" y="684"/>
                  </a:lnTo>
                  <a:lnTo>
                    <a:pt x="3664" y="631"/>
                  </a:lnTo>
                  <a:lnTo>
                    <a:pt x="3644" y="579"/>
                  </a:lnTo>
                  <a:lnTo>
                    <a:pt x="3618" y="529"/>
                  </a:lnTo>
                  <a:lnTo>
                    <a:pt x="3585" y="480"/>
                  </a:lnTo>
                  <a:lnTo>
                    <a:pt x="3545" y="433"/>
                  </a:lnTo>
                  <a:lnTo>
                    <a:pt x="3499" y="388"/>
                  </a:lnTo>
                  <a:lnTo>
                    <a:pt x="3384" y="302"/>
                  </a:lnTo>
                  <a:lnTo>
                    <a:pt x="3386" y="303"/>
                  </a:lnTo>
                  <a:lnTo>
                    <a:pt x="3252" y="230"/>
                  </a:lnTo>
                  <a:lnTo>
                    <a:pt x="3096" y="170"/>
                  </a:lnTo>
                  <a:lnTo>
                    <a:pt x="2922" y="120"/>
                  </a:lnTo>
                  <a:lnTo>
                    <a:pt x="2731" y="84"/>
                  </a:lnTo>
                  <a:lnTo>
                    <a:pt x="2525" y="58"/>
                  </a:lnTo>
                  <a:lnTo>
                    <a:pt x="2306" y="45"/>
                  </a:lnTo>
                  <a:lnTo>
                    <a:pt x="2075" y="43"/>
                  </a:lnTo>
                  <a:lnTo>
                    <a:pt x="1835" y="54"/>
                  </a:lnTo>
                  <a:lnTo>
                    <a:pt x="1587" y="76"/>
                  </a:lnTo>
                  <a:lnTo>
                    <a:pt x="1332" y="110"/>
                  </a:lnTo>
                  <a:lnTo>
                    <a:pt x="1074" y="156"/>
                  </a:lnTo>
                  <a:lnTo>
                    <a:pt x="812" y="214"/>
                  </a:lnTo>
                  <a:lnTo>
                    <a:pt x="550" y="283"/>
                  </a:lnTo>
                  <a:lnTo>
                    <a:pt x="289" y="365"/>
                  </a:lnTo>
                  <a:lnTo>
                    <a:pt x="29" y="458"/>
                  </a:lnTo>
                  <a:lnTo>
                    <a:pt x="41" y="429"/>
                  </a:lnTo>
                  <a:lnTo>
                    <a:pt x="949" y="2519"/>
                  </a:lnTo>
                  <a:close/>
                </a:path>
              </a:pathLst>
            </a:custGeom>
            <a:solidFill>
              <a:srgbClr val="385d8a"/>
            </a:solidFill>
            <a:ln w="0">
              <a:solidFill>
                <a:srgbClr val="385d8a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18"/>
            <p:cNvSpPr/>
            <p:nvPr/>
          </p:nvSpPr>
          <p:spPr>
            <a:xfrm>
              <a:off x="3579840" y="2006640"/>
              <a:ext cx="1520640" cy="1413000"/>
            </a:xfrm>
            <a:custGeom>
              <a:avLst/>
              <a:gdLst>
                <a:gd name="textAreaLeft" fmla="*/ 0 w 1520640"/>
                <a:gd name="textAreaRight" fmla="*/ 1521000 w 1520640"/>
                <a:gd name="textAreaTop" fmla="*/ 0 h 1413000"/>
                <a:gd name="textAreaBottom" fmla="*/ 1413360 h 1413000"/>
              </a:gdLst>
              <a:ahLst/>
              <a:rect l="textAreaLeft" t="textAreaTop" r="textAreaRight" b="textAreaBottom"/>
              <a:pathLst>
                <a:path w="4032" h="3776">
                  <a:moveTo>
                    <a:pt x="0" y="1888"/>
                  </a:moveTo>
                  <a:cubicBezTo>
                    <a:pt x="0" y="846"/>
                    <a:pt x="903" y="0"/>
                    <a:pt x="2016" y="0"/>
                  </a:cubicBezTo>
                  <a:cubicBezTo>
                    <a:pt x="2016" y="0"/>
                    <a:pt x="2016" y="0"/>
                    <a:pt x="2016" y="0"/>
                  </a:cubicBezTo>
                  <a:cubicBezTo>
                    <a:pt x="3130" y="0"/>
                    <a:pt x="4032" y="846"/>
                    <a:pt x="4032" y="1888"/>
                  </a:cubicBezTo>
                  <a:cubicBezTo>
                    <a:pt x="4032" y="1888"/>
                    <a:pt x="4032" y="1888"/>
                    <a:pt x="4032" y="1888"/>
                  </a:cubicBezTo>
                  <a:cubicBezTo>
                    <a:pt x="4032" y="2931"/>
                    <a:pt x="3130" y="3776"/>
                    <a:pt x="2016" y="3776"/>
                  </a:cubicBezTo>
                  <a:cubicBezTo>
                    <a:pt x="2016" y="3776"/>
                    <a:pt x="2016" y="3776"/>
                    <a:pt x="2016" y="3776"/>
                  </a:cubicBezTo>
                  <a:cubicBezTo>
                    <a:pt x="903" y="3776"/>
                    <a:pt x="0" y="2931"/>
                    <a:pt x="0" y="1888"/>
                  </a:cubicBezTo>
                  <a:cubicBezTo>
                    <a:pt x="0" y="1888"/>
                    <a:pt x="0" y="1888"/>
                    <a:pt x="0" y="1888"/>
                  </a:cubicBezTo>
                  <a:close/>
                </a:path>
              </a:pathLst>
            </a:custGeom>
            <a:solidFill>
              <a:srgbClr val="00b0f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9"/>
            <p:cNvSpPr/>
            <p:nvPr/>
          </p:nvSpPr>
          <p:spPr>
            <a:xfrm>
              <a:off x="3571920" y="1998720"/>
              <a:ext cx="1536480" cy="1430280"/>
            </a:xfrm>
            <a:custGeom>
              <a:avLst/>
              <a:gdLst>
                <a:gd name="textAreaLeft" fmla="*/ 0 w 1536480"/>
                <a:gd name="textAreaRight" fmla="*/ 1536840 w 1536480"/>
                <a:gd name="textAreaTop" fmla="*/ 0 h 1430280"/>
                <a:gd name="textAreaBottom" fmla="*/ 1430640 h 1430280"/>
              </a:gdLst>
              <a:ahLst/>
              <a:rect l="textAreaLeft" t="textAreaTop" r="textAreaRight" b="textAreaBottom"/>
              <a:pathLst>
                <a:path w="968" h="901">
                  <a:moveTo>
                    <a:pt x="0" y="451"/>
                  </a:moveTo>
                  <a:lnTo>
                    <a:pt x="2" y="405"/>
                  </a:lnTo>
                  <a:lnTo>
                    <a:pt x="10" y="360"/>
                  </a:lnTo>
                  <a:lnTo>
                    <a:pt x="21" y="317"/>
                  </a:lnTo>
                  <a:lnTo>
                    <a:pt x="38" y="275"/>
                  </a:lnTo>
                  <a:lnTo>
                    <a:pt x="58" y="236"/>
                  </a:lnTo>
                  <a:lnTo>
                    <a:pt x="82" y="199"/>
                  </a:lnTo>
                  <a:lnTo>
                    <a:pt x="110" y="164"/>
                  </a:lnTo>
                  <a:lnTo>
                    <a:pt x="142" y="132"/>
                  </a:lnTo>
                  <a:lnTo>
                    <a:pt x="176" y="103"/>
                  </a:lnTo>
                  <a:lnTo>
                    <a:pt x="213" y="77"/>
                  </a:lnTo>
                  <a:lnTo>
                    <a:pt x="253" y="54"/>
                  </a:lnTo>
                  <a:lnTo>
                    <a:pt x="295" y="35"/>
                  </a:lnTo>
                  <a:lnTo>
                    <a:pt x="340" y="20"/>
                  </a:lnTo>
                  <a:lnTo>
                    <a:pt x="386" y="9"/>
                  </a:lnTo>
                  <a:lnTo>
                    <a:pt x="434" y="2"/>
                  </a:lnTo>
                  <a:lnTo>
                    <a:pt x="484" y="0"/>
                  </a:lnTo>
                  <a:lnTo>
                    <a:pt x="533" y="2"/>
                  </a:lnTo>
                  <a:lnTo>
                    <a:pt x="581" y="9"/>
                  </a:lnTo>
                  <a:lnTo>
                    <a:pt x="628" y="20"/>
                  </a:lnTo>
                  <a:lnTo>
                    <a:pt x="672" y="35"/>
                  </a:lnTo>
                  <a:lnTo>
                    <a:pt x="714" y="54"/>
                  </a:lnTo>
                  <a:lnTo>
                    <a:pt x="754" y="77"/>
                  </a:lnTo>
                  <a:lnTo>
                    <a:pt x="792" y="102"/>
                  </a:lnTo>
                  <a:lnTo>
                    <a:pt x="826" y="131"/>
                  </a:lnTo>
                  <a:lnTo>
                    <a:pt x="858" y="163"/>
                  </a:lnTo>
                  <a:lnTo>
                    <a:pt x="885" y="198"/>
                  </a:lnTo>
                  <a:lnTo>
                    <a:pt x="910" y="235"/>
                  </a:lnTo>
                  <a:lnTo>
                    <a:pt x="930" y="274"/>
                  </a:lnTo>
                  <a:lnTo>
                    <a:pt x="946" y="316"/>
                  </a:lnTo>
                  <a:lnTo>
                    <a:pt x="959" y="359"/>
                  </a:lnTo>
                  <a:lnTo>
                    <a:pt x="966" y="404"/>
                  </a:lnTo>
                  <a:lnTo>
                    <a:pt x="968" y="450"/>
                  </a:lnTo>
                  <a:lnTo>
                    <a:pt x="966" y="496"/>
                  </a:lnTo>
                  <a:lnTo>
                    <a:pt x="959" y="541"/>
                  </a:lnTo>
                  <a:lnTo>
                    <a:pt x="947" y="584"/>
                  </a:lnTo>
                  <a:lnTo>
                    <a:pt x="930" y="626"/>
                  </a:lnTo>
                  <a:lnTo>
                    <a:pt x="910" y="665"/>
                  </a:lnTo>
                  <a:lnTo>
                    <a:pt x="886" y="702"/>
                  </a:lnTo>
                  <a:lnTo>
                    <a:pt x="858" y="737"/>
                  </a:lnTo>
                  <a:lnTo>
                    <a:pt x="827" y="769"/>
                  </a:lnTo>
                  <a:lnTo>
                    <a:pt x="792" y="798"/>
                  </a:lnTo>
                  <a:lnTo>
                    <a:pt x="755" y="824"/>
                  </a:lnTo>
                  <a:lnTo>
                    <a:pt x="715" y="846"/>
                  </a:lnTo>
                  <a:lnTo>
                    <a:pt x="673" y="866"/>
                  </a:lnTo>
                  <a:lnTo>
                    <a:pt x="628" y="881"/>
                  </a:lnTo>
                  <a:lnTo>
                    <a:pt x="582" y="892"/>
                  </a:lnTo>
                  <a:lnTo>
                    <a:pt x="534" y="899"/>
                  </a:lnTo>
                  <a:lnTo>
                    <a:pt x="484" y="901"/>
                  </a:lnTo>
                  <a:lnTo>
                    <a:pt x="435" y="899"/>
                  </a:lnTo>
                  <a:lnTo>
                    <a:pt x="387" y="892"/>
                  </a:lnTo>
                  <a:lnTo>
                    <a:pt x="341" y="881"/>
                  </a:lnTo>
                  <a:lnTo>
                    <a:pt x="296" y="866"/>
                  </a:lnTo>
                  <a:lnTo>
                    <a:pt x="254" y="847"/>
                  </a:lnTo>
                  <a:lnTo>
                    <a:pt x="214" y="824"/>
                  </a:lnTo>
                  <a:lnTo>
                    <a:pt x="176" y="798"/>
                  </a:lnTo>
                  <a:lnTo>
                    <a:pt x="142" y="769"/>
                  </a:lnTo>
                  <a:lnTo>
                    <a:pt x="110" y="737"/>
                  </a:lnTo>
                  <a:lnTo>
                    <a:pt x="83" y="703"/>
                  </a:lnTo>
                  <a:lnTo>
                    <a:pt x="58" y="666"/>
                  </a:lnTo>
                  <a:lnTo>
                    <a:pt x="38" y="626"/>
                  </a:lnTo>
                  <a:lnTo>
                    <a:pt x="22" y="585"/>
                  </a:lnTo>
                  <a:lnTo>
                    <a:pt x="10" y="542"/>
                  </a:lnTo>
                  <a:lnTo>
                    <a:pt x="2" y="497"/>
                  </a:lnTo>
                  <a:lnTo>
                    <a:pt x="0" y="451"/>
                  </a:lnTo>
                  <a:close/>
                  <a:moveTo>
                    <a:pt x="13" y="495"/>
                  </a:moveTo>
                  <a:lnTo>
                    <a:pt x="21" y="539"/>
                  </a:lnTo>
                  <a:lnTo>
                    <a:pt x="32" y="581"/>
                  </a:lnTo>
                  <a:lnTo>
                    <a:pt x="48" y="621"/>
                  </a:lnTo>
                  <a:lnTo>
                    <a:pt x="68" y="659"/>
                  </a:lnTo>
                  <a:lnTo>
                    <a:pt x="91" y="696"/>
                  </a:lnTo>
                  <a:lnTo>
                    <a:pt x="119" y="730"/>
                  </a:lnTo>
                  <a:lnTo>
                    <a:pt x="149" y="761"/>
                  </a:lnTo>
                  <a:lnTo>
                    <a:pt x="183" y="789"/>
                  </a:lnTo>
                  <a:lnTo>
                    <a:pt x="219" y="815"/>
                  </a:lnTo>
                  <a:lnTo>
                    <a:pt x="258" y="837"/>
                  </a:lnTo>
                  <a:lnTo>
                    <a:pt x="299" y="855"/>
                  </a:lnTo>
                  <a:lnTo>
                    <a:pt x="343" y="870"/>
                  </a:lnTo>
                  <a:lnTo>
                    <a:pt x="388" y="881"/>
                  </a:lnTo>
                  <a:lnTo>
                    <a:pt x="435" y="887"/>
                  </a:lnTo>
                  <a:lnTo>
                    <a:pt x="484" y="890"/>
                  </a:lnTo>
                  <a:lnTo>
                    <a:pt x="532" y="887"/>
                  </a:lnTo>
                  <a:lnTo>
                    <a:pt x="579" y="881"/>
                  </a:lnTo>
                  <a:lnTo>
                    <a:pt x="625" y="870"/>
                  </a:lnTo>
                  <a:lnTo>
                    <a:pt x="668" y="855"/>
                  </a:lnTo>
                  <a:lnTo>
                    <a:pt x="709" y="837"/>
                  </a:lnTo>
                  <a:lnTo>
                    <a:pt x="748" y="815"/>
                  </a:lnTo>
                  <a:lnTo>
                    <a:pt x="785" y="789"/>
                  </a:lnTo>
                  <a:lnTo>
                    <a:pt x="818" y="761"/>
                  </a:lnTo>
                  <a:lnTo>
                    <a:pt x="849" y="730"/>
                  </a:lnTo>
                  <a:lnTo>
                    <a:pt x="876" y="696"/>
                  </a:lnTo>
                  <a:lnTo>
                    <a:pt x="900" y="660"/>
                  </a:lnTo>
                  <a:lnTo>
                    <a:pt x="920" y="622"/>
                  </a:lnTo>
                  <a:lnTo>
                    <a:pt x="935" y="581"/>
                  </a:lnTo>
                  <a:lnTo>
                    <a:pt x="947" y="539"/>
                  </a:lnTo>
                  <a:lnTo>
                    <a:pt x="954" y="496"/>
                  </a:lnTo>
                  <a:lnTo>
                    <a:pt x="957" y="451"/>
                  </a:lnTo>
                  <a:lnTo>
                    <a:pt x="955" y="406"/>
                  </a:lnTo>
                  <a:lnTo>
                    <a:pt x="947" y="362"/>
                  </a:lnTo>
                  <a:lnTo>
                    <a:pt x="936" y="320"/>
                  </a:lnTo>
                  <a:lnTo>
                    <a:pt x="920" y="280"/>
                  </a:lnTo>
                  <a:lnTo>
                    <a:pt x="900" y="241"/>
                  </a:lnTo>
                  <a:lnTo>
                    <a:pt x="877" y="205"/>
                  </a:lnTo>
                  <a:lnTo>
                    <a:pt x="849" y="171"/>
                  </a:lnTo>
                  <a:lnTo>
                    <a:pt x="819" y="140"/>
                  </a:lnTo>
                  <a:lnTo>
                    <a:pt x="785" y="112"/>
                  </a:lnTo>
                  <a:lnTo>
                    <a:pt x="749" y="86"/>
                  </a:lnTo>
                  <a:lnTo>
                    <a:pt x="710" y="64"/>
                  </a:lnTo>
                  <a:lnTo>
                    <a:pt x="669" y="46"/>
                  </a:lnTo>
                  <a:lnTo>
                    <a:pt x="625" y="31"/>
                  </a:lnTo>
                  <a:lnTo>
                    <a:pt x="580" y="20"/>
                  </a:lnTo>
                  <a:lnTo>
                    <a:pt x="533" y="13"/>
                  </a:lnTo>
                  <a:lnTo>
                    <a:pt x="484" y="11"/>
                  </a:lnTo>
                  <a:lnTo>
                    <a:pt x="436" y="13"/>
                  </a:lnTo>
                  <a:lnTo>
                    <a:pt x="389" y="20"/>
                  </a:lnTo>
                  <a:lnTo>
                    <a:pt x="344" y="31"/>
                  </a:lnTo>
                  <a:lnTo>
                    <a:pt x="300" y="45"/>
                  </a:lnTo>
                  <a:lnTo>
                    <a:pt x="259" y="64"/>
                  </a:lnTo>
                  <a:lnTo>
                    <a:pt x="220" y="86"/>
                  </a:lnTo>
                  <a:lnTo>
                    <a:pt x="183" y="111"/>
                  </a:lnTo>
                  <a:lnTo>
                    <a:pt x="150" y="140"/>
                  </a:lnTo>
                  <a:lnTo>
                    <a:pt x="119" y="171"/>
                  </a:lnTo>
                  <a:lnTo>
                    <a:pt x="92" y="205"/>
                  </a:lnTo>
                  <a:lnTo>
                    <a:pt x="68" y="241"/>
                  </a:lnTo>
                  <a:lnTo>
                    <a:pt x="48" y="279"/>
                  </a:lnTo>
                  <a:lnTo>
                    <a:pt x="33" y="320"/>
                  </a:lnTo>
                  <a:lnTo>
                    <a:pt x="21" y="362"/>
                  </a:lnTo>
                  <a:lnTo>
                    <a:pt x="13" y="405"/>
                  </a:lnTo>
                  <a:lnTo>
                    <a:pt x="11" y="450"/>
                  </a:lnTo>
                  <a:lnTo>
                    <a:pt x="13" y="495"/>
                  </a:lnTo>
                  <a:close/>
                </a:path>
              </a:pathLst>
            </a:custGeom>
            <a:solidFill>
              <a:srgbClr val="92d050"/>
            </a:solidFill>
            <a:ln w="0">
              <a:solidFill>
                <a:srgbClr val="92d05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20"/>
            <p:cNvSpPr/>
            <p:nvPr/>
          </p:nvSpPr>
          <p:spPr>
            <a:xfrm>
              <a:off x="3844800" y="2239920"/>
              <a:ext cx="965160" cy="939960"/>
            </a:xfrm>
            <a:custGeom>
              <a:avLst/>
              <a:gdLst>
                <a:gd name="textAreaLeft" fmla="*/ 0 w 965160"/>
                <a:gd name="textAreaRight" fmla="*/ 965520 w 965160"/>
                <a:gd name="textAreaTop" fmla="*/ 0 h 939960"/>
                <a:gd name="textAreaBottom" fmla="*/ 940320 h 939960"/>
              </a:gdLst>
              <a:ahLst/>
              <a:rect l="textAreaLeft" t="textAreaTop" r="textAreaRight" b="textAreaBottom"/>
              <a:pathLst>
                <a:path w="2560" h="2512">
                  <a:moveTo>
                    <a:pt x="0" y="1256"/>
                  </a:moveTo>
                  <a:cubicBezTo>
                    <a:pt x="0" y="563"/>
                    <a:pt x="574" y="0"/>
                    <a:pt x="1280" y="0"/>
                  </a:cubicBezTo>
                  <a:cubicBezTo>
                    <a:pt x="1280" y="0"/>
                    <a:pt x="1280" y="0"/>
                    <a:pt x="1280" y="0"/>
                  </a:cubicBezTo>
                  <a:cubicBezTo>
                    <a:pt x="1987" y="0"/>
                    <a:pt x="2560" y="563"/>
                    <a:pt x="2560" y="1256"/>
                  </a:cubicBezTo>
                  <a:cubicBezTo>
                    <a:pt x="2560" y="1256"/>
                    <a:pt x="2560" y="1256"/>
                    <a:pt x="2560" y="1256"/>
                  </a:cubicBezTo>
                  <a:cubicBezTo>
                    <a:pt x="2560" y="1950"/>
                    <a:pt x="1987" y="2512"/>
                    <a:pt x="1280" y="2512"/>
                  </a:cubicBezTo>
                  <a:cubicBezTo>
                    <a:pt x="1280" y="2512"/>
                    <a:pt x="1280" y="2512"/>
                    <a:pt x="1280" y="2512"/>
                  </a:cubicBezTo>
                  <a:cubicBezTo>
                    <a:pt x="574" y="2512"/>
                    <a:pt x="0" y="1950"/>
                    <a:pt x="0" y="1256"/>
                  </a:cubicBezTo>
                  <a:cubicBezTo>
                    <a:pt x="0" y="1256"/>
                    <a:pt x="0" y="1256"/>
                    <a:pt x="0" y="1256"/>
                  </a:cubicBezTo>
                  <a:close/>
                </a:path>
              </a:pathLst>
            </a:custGeom>
            <a:solidFill>
              <a:srgbClr val="ffc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21"/>
            <p:cNvSpPr/>
            <p:nvPr/>
          </p:nvSpPr>
          <p:spPr>
            <a:xfrm>
              <a:off x="3836880" y="2232000"/>
              <a:ext cx="982800" cy="957240"/>
            </a:xfrm>
            <a:custGeom>
              <a:avLst/>
              <a:gdLst>
                <a:gd name="textAreaLeft" fmla="*/ 0 w 982800"/>
                <a:gd name="textAreaRight" fmla="*/ 983160 w 982800"/>
                <a:gd name="textAreaTop" fmla="*/ 0 h 957240"/>
                <a:gd name="textAreaBottom" fmla="*/ 957600 h 957240"/>
              </a:gdLst>
              <a:ahLst/>
              <a:rect l="textAreaLeft" t="textAreaTop" r="textAreaRight" b="textAreaBottom"/>
              <a:pathLst>
                <a:path w="619" h="603">
                  <a:moveTo>
                    <a:pt x="0" y="302"/>
                  </a:moveTo>
                  <a:lnTo>
                    <a:pt x="2" y="271"/>
                  </a:lnTo>
                  <a:lnTo>
                    <a:pt x="6" y="241"/>
                  </a:lnTo>
                  <a:lnTo>
                    <a:pt x="14" y="212"/>
                  </a:lnTo>
                  <a:lnTo>
                    <a:pt x="24" y="184"/>
                  </a:lnTo>
                  <a:lnTo>
                    <a:pt x="37" y="158"/>
                  </a:lnTo>
                  <a:lnTo>
                    <a:pt x="53" y="133"/>
                  </a:lnTo>
                  <a:lnTo>
                    <a:pt x="70" y="110"/>
                  </a:lnTo>
                  <a:lnTo>
                    <a:pt x="90" y="88"/>
                  </a:lnTo>
                  <a:lnTo>
                    <a:pt x="113" y="69"/>
                  </a:lnTo>
                  <a:lnTo>
                    <a:pt x="136" y="52"/>
                  </a:lnTo>
                  <a:lnTo>
                    <a:pt x="162" y="37"/>
                  </a:lnTo>
                  <a:lnTo>
                    <a:pt x="189" y="24"/>
                  </a:lnTo>
                  <a:lnTo>
                    <a:pt x="217" y="14"/>
                  </a:lnTo>
                  <a:lnTo>
                    <a:pt x="247" y="6"/>
                  </a:lnTo>
                  <a:lnTo>
                    <a:pt x="278" y="1"/>
                  </a:lnTo>
                  <a:lnTo>
                    <a:pt x="309" y="0"/>
                  </a:lnTo>
                  <a:lnTo>
                    <a:pt x="341" y="1"/>
                  </a:lnTo>
                  <a:lnTo>
                    <a:pt x="372" y="6"/>
                  </a:lnTo>
                  <a:lnTo>
                    <a:pt x="401" y="13"/>
                  </a:lnTo>
                  <a:lnTo>
                    <a:pt x="430" y="24"/>
                  </a:lnTo>
                  <a:lnTo>
                    <a:pt x="457" y="36"/>
                  </a:lnTo>
                  <a:lnTo>
                    <a:pt x="482" y="51"/>
                  </a:lnTo>
                  <a:lnTo>
                    <a:pt x="506" y="69"/>
                  </a:lnTo>
                  <a:lnTo>
                    <a:pt x="528" y="88"/>
                  </a:lnTo>
                  <a:lnTo>
                    <a:pt x="548" y="109"/>
                  </a:lnTo>
                  <a:lnTo>
                    <a:pt x="566" y="133"/>
                  </a:lnTo>
                  <a:lnTo>
                    <a:pt x="582" y="158"/>
                  </a:lnTo>
                  <a:lnTo>
                    <a:pt x="594" y="184"/>
                  </a:lnTo>
                  <a:lnTo>
                    <a:pt x="605" y="212"/>
                  </a:lnTo>
                  <a:lnTo>
                    <a:pt x="613" y="240"/>
                  </a:lnTo>
                  <a:lnTo>
                    <a:pt x="617" y="271"/>
                  </a:lnTo>
                  <a:lnTo>
                    <a:pt x="619" y="301"/>
                  </a:lnTo>
                  <a:lnTo>
                    <a:pt x="617" y="332"/>
                  </a:lnTo>
                  <a:lnTo>
                    <a:pt x="613" y="362"/>
                  </a:lnTo>
                  <a:lnTo>
                    <a:pt x="605" y="391"/>
                  </a:lnTo>
                  <a:lnTo>
                    <a:pt x="595" y="419"/>
                  </a:lnTo>
                  <a:lnTo>
                    <a:pt x="582" y="445"/>
                  </a:lnTo>
                  <a:lnTo>
                    <a:pt x="566" y="470"/>
                  </a:lnTo>
                  <a:lnTo>
                    <a:pt x="549" y="493"/>
                  </a:lnTo>
                  <a:lnTo>
                    <a:pt x="528" y="515"/>
                  </a:lnTo>
                  <a:lnTo>
                    <a:pt x="506" y="534"/>
                  </a:lnTo>
                  <a:lnTo>
                    <a:pt x="483" y="552"/>
                  </a:lnTo>
                  <a:lnTo>
                    <a:pt x="457" y="567"/>
                  </a:lnTo>
                  <a:lnTo>
                    <a:pt x="430" y="579"/>
                  </a:lnTo>
                  <a:lnTo>
                    <a:pt x="402" y="590"/>
                  </a:lnTo>
                  <a:lnTo>
                    <a:pt x="372" y="597"/>
                  </a:lnTo>
                  <a:lnTo>
                    <a:pt x="341" y="602"/>
                  </a:lnTo>
                  <a:lnTo>
                    <a:pt x="310" y="603"/>
                  </a:lnTo>
                  <a:lnTo>
                    <a:pt x="278" y="602"/>
                  </a:lnTo>
                  <a:lnTo>
                    <a:pt x="247" y="597"/>
                  </a:lnTo>
                  <a:lnTo>
                    <a:pt x="218" y="590"/>
                  </a:lnTo>
                  <a:lnTo>
                    <a:pt x="189" y="580"/>
                  </a:lnTo>
                  <a:lnTo>
                    <a:pt x="162" y="567"/>
                  </a:lnTo>
                  <a:lnTo>
                    <a:pt x="137" y="552"/>
                  </a:lnTo>
                  <a:lnTo>
                    <a:pt x="113" y="535"/>
                  </a:lnTo>
                  <a:lnTo>
                    <a:pt x="91" y="515"/>
                  </a:lnTo>
                  <a:lnTo>
                    <a:pt x="71" y="494"/>
                  </a:lnTo>
                  <a:lnTo>
                    <a:pt x="53" y="470"/>
                  </a:lnTo>
                  <a:lnTo>
                    <a:pt x="37" y="446"/>
                  </a:lnTo>
                  <a:lnTo>
                    <a:pt x="24" y="419"/>
                  </a:lnTo>
                  <a:lnTo>
                    <a:pt x="14" y="392"/>
                  </a:lnTo>
                  <a:lnTo>
                    <a:pt x="6" y="363"/>
                  </a:lnTo>
                  <a:lnTo>
                    <a:pt x="2" y="333"/>
                  </a:lnTo>
                  <a:lnTo>
                    <a:pt x="0" y="302"/>
                  </a:lnTo>
                  <a:close/>
                  <a:moveTo>
                    <a:pt x="13" y="331"/>
                  </a:moveTo>
                  <a:lnTo>
                    <a:pt x="17" y="360"/>
                  </a:lnTo>
                  <a:lnTo>
                    <a:pt x="25" y="388"/>
                  </a:lnTo>
                  <a:lnTo>
                    <a:pt x="35" y="414"/>
                  </a:lnTo>
                  <a:lnTo>
                    <a:pt x="47" y="440"/>
                  </a:lnTo>
                  <a:lnTo>
                    <a:pt x="62" y="464"/>
                  </a:lnTo>
                  <a:lnTo>
                    <a:pt x="79" y="486"/>
                  </a:lnTo>
                  <a:lnTo>
                    <a:pt x="98" y="507"/>
                  </a:lnTo>
                  <a:lnTo>
                    <a:pt x="120" y="525"/>
                  </a:lnTo>
                  <a:lnTo>
                    <a:pt x="143" y="542"/>
                  </a:lnTo>
                  <a:lnTo>
                    <a:pt x="167" y="557"/>
                  </a:lnTo>
                  <a:lnTo>
                    <a:pt x="193" y="569"/>
                  </a:lnTo>
                  <a:lnTo>
                    <a:pt x="221" y="579"/>
                  </a:lnTo>
                  <a:lnTo>
                    <a:pt x="249" y="586"/>
                  </a:lnTo>
                  <a:lnTo>
                    <a:pt x="279" y="590"/>
                  </a:lnTo>
                  <a:lnTo>
                    <a:pt x="309" y="592"/>
                  </a:lnTo>
                  <a:lnTo>
                    <a:pt x="340" y="591"/>
                  </a:lnTo>
                  <a:lnTo>
                    <a:pt x="369" y="586"/>
                  </a:lnTo>
                  <a:lnTo>
                    <a:pt x="398" y="579"/>
                  </a:lnTo>
                  <a:lnTo>
                    <a:pt x="425" y="569"/>
                  </a:lnTo>
                  <a:lnTo>
                    <a:pt x="451" y="557"/>
                  </a:lnTo>
                  <a:lnTo>
                    <a:pt x="476" y="543"/>
                  </a:lnTo>
                  <a:lnTo>
                    <a:pt x="499" y="526"/>
                  </a:lnTo>
                  <a:lnTo>
                    <a:pt x="520" y="507"/>
                  </a:lnTo>
                  <a:lnTo>
                    <a:pt x="539" y="486"/>
                  </a:lnTo>
                  <a:lnTo>
                    <a:pt x="556" y="464"/>
                  </a:lnTo>
                  <a:lnTo>
                    <a:pt x="572" y="440"/>
                  </a:lnTo>
                  <a:lnTo>
                    <a:pt x="584" y="415"/>
                  </a:lnTo>
                  <a:lnTo>
                    <a:pt x="594" y="388"/>
                  </a:lnTo>
                  <a:lnTo>
                    <a:pt x="602" y="360"/>
                  </a:lnTo>
                  <a:lnTo>
                    <a:pt x="606" y="331"/>
                  </a:lnTo>
                  <a:lnTo>
                    <a:pt x="608" y="302"/>
                  </a:lnTo>
                  <a:lnTo>
                    <a:pt x="606" y="272"/>
                  </a:lnTo>
                  <a:lnTo>
                    <a:pt x="602" y="243"/>
                  </a:lnTo>
                  <a:lnTo>
                    <a:pt x="594" y="216"/>
                  </a:lnTo>
                  <a:lnTo>
                    <a:pt x="584" y="189"/>
                  </a:lnTo>
                  <a:lnTo>
                    <a:pt x="572" y="164"/>
                  </a:lnTo>
                  <a:lnTo>
                    <a:pt x="557" y="140"/>
                  </a:lnTo>
                  <a:lnTo>
                    <a:pt x="540" y="117"/>
                  </a:lnTo>
                  <a:lnTo>
                    <a:pt x="521" y="96"/>
                  </a:lnTo>
                  <a:lnTo>
                    <a:pt x="499" y="78"/>
                  </a:lnTo>
                  <a:lnTo>
                    <a:pt x="476" y="61"/>
                  </a:lnTo>
                  <a:lnTo>
                    <a:pt x="452" y="46"/>
                  </a:lnTo>
                  <a:lnTo>
                    <a:pt x="426" y="34"/>
                  </a:lnTo>
                  <a:lnTo>
                    <a:pt x="399" y="24"/>
                  </a:lnTo>
                  <a:lnTo>
                    <a:pt x="370" y="17"/>
                  </a:lnTo>
                  <a:lnTo>
                    <a:pt x="340" y="12"/>
                  </a:lnTo>
                  <a:lnTo>
                    <a:pt x="310" y="11"/>
                  </a:lnTo>
                  <a:lnTo>
                    <a:pt x="279" y="12"/>
                  </a:lnTo>
                  <a:lnTo>
                    <a:pt x="250" y="17"/>
                  </a:lnTo>
                  <a:lnTo>
                    <a:pt x="221" y="24"/>
                  </a:lnTo>
                  <a:lnTo>
                    <a:pt x="194" y="34"/>
                  </a:lnTo>
                  <a:lnTo>
                    <a:pt x="168" y="46"/>
                  </a:lnTo>
                  <a:lnTo>
                    <a:pt x="143" y="61"/>
                  </a:lnTo>
                  <a:lnTo>
                    <a:pt x="120" y="77"/>
                  </a:lnTo>
                  <a:lnTo>
                    <a:pt x="99" y="96"/>
                  </a:lnTo>
                  <a:lnTo>
                    <a:pt x="80" y="117"/>
                  </a:lnTo>
                  <a:lnTo>
                    <a:pt x="62" y="139"/>
                  </a:lnTo>
                  <a:lnTo>
                    <a:pt x="47" y="163"/>
                  </a:lnTo>
                  <a:lnTo>
                    <a:pt x="35" y="188"/>
                  </a:lnTo>
                  <a:lnTo>
                    <a:pt x="25" y="215"/>
                  </a:lnTo>
                  <a:lnTo>
                    <a:pt x="17" y="243"/>
                  </a:lnTo>
                  <a:lnTo>
                    <a:pt x="13" y="272"/>
                  </a:lnTo>
                  <a:lnTo>
                    <a:pt x="11" y="301"/>
                  </a:lnTo>
                  <a:lnTo>
                    <a:pt x="13" y="331"/>
                  </a:lnTo>
                  <a:close/>
                </a:path>
              </a:pathLst>
            </a:cu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22"/>
            <p:cNvSpPr/>
            <p:nvPr/>
          </p:nvSpPr>
          <p:spPr>
            <a:xfrm>
              <a:off x="4145040" y="2633760"/>
              <a:ext cx="52956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5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1,043</a:t>
              </a: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3"/>
            <p:cNvSpPr/>
            <p:nvPr/>
          </p:nvSpPr>
          <p:spPr>
            <a:xfrm>
              <a:off x="4231800" y="1784520"/>
              <a:ext cx="3787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,598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4"/>
            <p:cNvSpPr/>
            <p:nvPr/>
          </p:nvSpPr>
          <p:spPr>
            <a:xfrm>
              <a:off x="5164200" y="2324160"/>
              <a:ext cx="181080" cy="365040"/>
            </a:xfrm>
            <a:custGeom>
              <a:avLst/>
              <a:gdLst>
                <a:gd name="textAreaLeft" fmla="*/ 0 w 181080"/>
                <a:gd name="textAreaRight" fmla="*/ 181440 w 181080"/>
                <a:gd name="textAreaTop" fmla="*/ 0 h 365040"/>
                <a:gd name="textAreaBottom" fmla="*/ 365040 h 365040"/>
              </a:gdLst>
              <a:ahLst/>
              <a:rect l="textAreaLeft" t="textAreaTop" r="textAreaRight" b="textAreaBottom"/>
              <a:pathLst>
                <a:path w="479" h="978">
                  <a:moveTo>
                    <a:pt x="73" y="208"/>
                  </a:moveTo>
                  <a:cubicBezTo>
                    <a:pt x="69" y="209"/>
                    <a:pt x="65" y="210"/>
                    <a:pt x="63" y="210"/>
                  </a:cubicBezTo>
                  <a:cubicBezTo>
                    <a:pt x="60" y="210"/>
                    <a:pt x="58" y="210"/>
                    <a:pt x="56" y="210"/>
                  </a:cubicBezTo>
                  <a:cubicBezTo>
                    <a:pt x="54" y="209"/>
                    <a:pt x="53" y="209"/>
                    <a:pt x="52" y="208"/>
                  </a:cubicBezTo>
                  <a:cubicBezTo>
                    <a:pt x="51" y="207"/>
                    <a:pt x="50" y="206"/>
                    <a:pt x="50" y="205"/>
                  </a:cubicBezTo>
                  <a:lnTo>
                    <a:pt x="17" y="58"/>
                  </a:lnTo>
                  <a:cubicBezTo>
                    <a:pt x="17" y="57"/>
                    <a:pt x="17" y="56"/>
                    <a:pt x="17" y="55"/>
                  </a:cubicBezTo>
                  <a:cubicBezTo>
                    <a:pt x="18" y="54"/>
                    <a:pt x="19" y="52"/>
                    <a:pt x="20" y="51"/>
                  </a:cubicBezTo>
                  <a:cubicBezTo>
                    <a:pt x="22" y="50"/>
                    <a:pt x="24" y="49"/>
                    <a:pt x="26" y="48"/>
                  </a:cubicBezTo>
                  <a:cubicBezTo>
                    <a:pt x="29" y="47"/>
                    <a:pt x="32" y="46"/>
                    <a:pt x="36" y="45"/>
                  </a:cubicBezTo>
                  <a:cubicBezTo>
                    <a:pt x="40" y="44"/>
                    <a:pt x="43" y="44"/>
                    <a:pt x="46" y="44"/>
                  </a:cubicBezTo>
                  <a:cubicBezTo>
                    <a:pt x="49" y="43"/>
                    <a:pt x="51" y="43"/>
                    <a:pt x="53" y="44"/>
                  </a:cubicBezTo>
                  <a:cubicBezTo>
                    <a:pt x="55" y="44"/>
                    <a:pt x="56" y="45"/>
                    <a:pt x="57" y="46"/>
                  </a:cubicBezTo>
                  <a:cubicBezTo>
                    <a:pt x="58" y="46"/>
                    <a:pt x="59" y="47"/>
                    <a:pt x="59" y="49"/>
                  </a:cubicBezTo>
                  <a:lnTo>
                    <a:pt x="70" y="98"/>
                  </a:lnTo>
                  <a:lnTo>
                    <a:pt x="243" y="59"/>
                  </a:lnTo>
                  <a:lnTo>
                    <a:pt x="210" y="22"/>
                  </a:lnTo>
                  <a:cubicBezTo>
                    <a:pt x="208" y="19"/>
                    <a:pt x="206" y="17"/>
                    <a:pt x="205" y="15"/>
                  </a:cubicBezTo>
                  <a:cubicBezTo>
                    <a:pt x="205" y="13"/>
                    <a:pt x="205" y="11"/>
                    <a:pt x="206" y="10"/>
                  </a:cubicBezTo>
                  <a:cubicBezTo>
                    <a:pt x="206" y="8"/>
                    <a:pt x="208" y="7"/>
                    <a:pt x="211" y="6"/>
                  </a:cubicBezTo>
                  <a:cubicBezTo>
                    <a:pt x="214" y="5"/>
                    <a:pt x="218" y="4"/>
                    <a:pt x="223" y="3"/>
                  </a:cubicBezTo>
                  <a:cubicBezTo>
                    <a:pt x="226" y="2"/>
                    <a:pt x="229" y="1"/>
                    <a:pt x="231" y="1"/>
                  </a:cubicBezTo>
                  <a:cubicBezTo>
                    <a:pt x="233" y="1"/>
                    <a:pt x="235" y="0"/>
                    <a:pt x="237" y="1"/>
                  </a:cubicBezTo>
                  <a:cubicBezTo>
                    <a:pt x="239" y="1"/>
                    <a:pt x="240" y="1"/>
                    <a:pt x="241" y="2"/>
                  </a:cubicBezTo>
                  <a:cubicBezTo>
                    <a:pt x="242" y="3"/>
                    <a:pt x="244" y="4"/>
                    <a:pt x="245" y="5"/>
                  </a:cubicBezTo>
                  <a:lnTo>
                    <a:pt x="295" y="54"/>
                  </a:lnTo>
                  <a:cubicBezTo>
                    <a:pt x="296" y="55"/>
                    <a:pt x="296" y="56"/>
                    <a:pt x="297" y="56"/>
                  </a:cubicBezTo>
                  <a:cubicBezTo>
                    <a:pt x="298" y="57"/>
                    <a:pt x="298" y="59"/>
                    <a:pt x="299" y="60"/>
                  </a:cubicBezTo>
                  <a:cubicBezTo>
                    <a:pt x="299" y="62"/>
                    <a:pt x="300" y="64"/>
                    <a:pt x="301" y="67"/>
                  </a:cubicBezTo>
                  <a:cubicBezTo>
                    <a:pt x="301" y="69"/>
                    <a:pt x="302" y="73"/>
                    <a:pt x="303" y="77"/>
                  </a:cubicBezTo>
                  <a:cubicBezTo>
                    <a:pt x="304" y="82"/>
                    <a:pt x="305" y="87"/>
                    <a:pt x="306" y="90"/>
                  </a:cubicBezTo>
                  <a:cubicBezTo>
                    <a:pt x="306" y="93"/>
                    <a:pt x="306" y="96"/>
                    <a:pt x="306" y="97"/>
                  </a:cubicBezTo>
                  <a:cubicBezTo>
                    <a:pt x="306" y="99"/>
                    <a:pt x="306" y="100"/>
                    <a:pt x="305" y="101"/>
                  </a:cubicBezTo>
                  <a:cubicBezTo>
                    <a:pt x="304" y="102"/>
                    <a:pt x="303" y="102"/>
                    <a:pt x="302" y="103"/>
                  </a:cubicBezTo>
                  <a:lnTo>
                    <a:pt x="82" y="152"/>
                  </a:lnTo>
                  <a:lnTo>
                    <a:pt x="92" y="195"/>
                  </a:lnTo>
                  <a:cubicBezTo>
                    <a:pt x="92" y="197"/>
                    <a:pt x="92" y="198"/>
                    <a:pt x="91" y="199"/>
                  </a:cubicBezTo>
                  <a:cubicBezTo>
                    <a:pt x="91" y="200"/>
                    <a:pt x="90" y="202"/>
                    <a:pt x="88" y="203"/>
                  </a:cubicBezTo>
                  <a:cubicBezTo>
                    <a:pt x="87" y="204"/>
                    <a:pt x="85" y="205"/>
                    <a:pt x="82" y="206"/>
                  </a:cubicBezTo>
                  <a:cubicBezTo>
                    <a:pt x="80" y="207"/>
                    <a:pt x="76" y="208"/>
                    <a:pt x="73" y="208"/>
                  </a:cubicBezTo>
                  <a:close/>
                  <a:moveTo>
                    <a:pt x="115" y="316"/>
                  </a:moveTo>
                  <a:cubicBezTo>
                    <a:pt x="109" y="317"/>
                    <a:pt x="104" y="318"/>
                    <a:pt x="100" y="318"/>
                  </a:cubicBezTo>
                  <a:cubicBezTo>
                    <a:pt x="95" y="319"/>
                    <a:pt x="91" y="319"/>
                    <a:pt x="86" y="318"/>
                  </a:cubicBezTo>
                  <a:cubicBezTo>
                    <a:pt x="82" y="318"/>
                    <a:pt x="78" y="317"/>
                    <a:pt x="74" y="316"/>
                  </a:cubicBezTo>
                  <a:cubicBezTo>
                    <a:pt x="70" y="315"/>
                    <a:pt x="65" y="314"/>
                    <a:pt x="60" y="312"/>
                  </a:cubicBezTo>
                  <a:lnTo>
                    <a:pt x="15" y="293"/>
                  </a:lnTo>
                  <a:cubicBezTo>
                    <a:pt x="13" y="292"/>
                    <a:pt x="12" y="292"/>
                    <a:pt x="11" y="291"/>
                  </a:cubicBezTo>
                  <a:cubicBezTo>
                    <a:pt x="9" y="290"/>
                    <a:pt x="8" y="288"/>
                    <a:pt x="7" y="287"/>
                  </a:cubicBezTo>
                  <a:cubicBezTo>
                    <a:pt x="6" y="285"/>
                    <a:pt x="6" y="284"/>
                    <a:pt x="5" y="281"/>
                  </a:cubicBezTo>
                  <a:cubicBezTo>
                    <a:pt x="4" y="279"/>
                    <a:pt x="3" y="276"/>
                    <a:pt x="2" y="273"/>
                  </a:cubicBezTo>
                  <a:cubicBezTo>
                    <a:pt x="1" y="269"/>
                    <a:pt x="1" y="265"/>
                    <a:pt x="0" y="263"/>
                  </a:cubicBezTo>
                  <a:cubicBezTo>
                    <a:pt x="0" y="260"/>
                    <a:pt x="0" y="258"/>
                    <a:pt x="1" y="257"/>
                  </a:cubicBezTo>
                  <a:cubicBezTo>
                    <a:pt x="1" y="256"/>
                    <a:pt x="2" y="255"/>
                    <a:pt x="3" y="255"/>
                  </a:cubicBezTo>
                  <a:cubicBezTo>
                    <a:pt x="4" y="254"/>
                    <a:pt x="6" y="254"/>
                    <a:pt x="7" y="255"/>
                  </a:cubicBezTo>
                  <a:lnTo>
                    <a:pt x="70" y="267"/>
                  </a:lnTo>
                  <a:lnTo>
                    <a:pt x="102" y="260"/>
                  </a:lnTo>
                  <a:cubicBezTo>
                    <a:pt x="107" y="259"/>
                    <a:pt x="111" y="258"/>
                    <a:pt x="114" y="259"/>
                  </a:cubicBezTo>
                  <a:cubicBezTo>
                    <a:pt x="117" y="259"/>
                    <a:pt x="120" y="261"/>
                    <a:pt x="122" y="263"/>
                  </a:cubicBezTo>
                  <a:cubicBezTo>
                    <a:pt x="124" y="265"/>
                    <a:pt x="125" y="267"/>
                    <a:pt x="127" y="271"/>
                  </a:cubicBezTo>
                  <a:cubicBezTo>
                    <a:pt x="128" y="274"/>
                    <a:pt x="129" y="278"/>
                    <a:pt x="130" y="283"/>
                  </a:cubicBezTo>
                  <a:cubicBezTo>
                    <a:pt x="131" y="288"/>
                    <a:pt x="132" y="292"/>
                    <a:pt x="132" y="296"/>
                  </a:cubicBezTo>
                  <a:cubicBezTo>
                    <a:pt x="133" y="300"/>
                    <a:pt x="132" y="303"/>
                    <a:pt x="131" y="305"/>
                  </a:cubicBezTo>
                  <a:cubicBezTo>
                    <a:pt x="130" y="308"/>
                    <a:pt x="128" y="310"/>
                    <a:pt x="126" y="312"/>
                  </a:cubicBezTo>
                  <a:cubicBezTo>
                    <a:pt x="123" y="313"/>
                    <a:pt x="119" y="315"/>
                    <a:pt x="115" y="316"/>
                  </a:cubicBezTo>
                  <a:close/>
                  <a:moveTo>
                    <a:pt x="204" y="525"/>
                  </a:moveTo>
                  <a:cubicBezTo>
                    <a:pt x="191" y="528"/>
                    <a:pt x="178" y="528"/>
                    <a:pt x="167" y="525"/>
                  </a:cubicBezTo>
                  <a:cubicBezTo>
                    <a:pt x="155" y="522"/>
                    <a:pt x="145" y="517"/>
                    <a:pt x="136" y="510"/>
                  </a:cubicBezTo>
                  <a:cubicBezTo>
                    <a:pt x="127" y="502"/>
                    <a:pt x="119" y="492"/>
                    <a:pt x="113" y="481"/>
                  </a:cubicBezTo>
                  <a:cubicBezTo>
                    <a:pt x="106" y="469"/>
                    <a:pt x="101" y="455"/>
                    <a:pt x="98" y="441"/>
                  </a:cubicBezTo>
                  <a:cubicBezTo>
                    <a:pt x="96" y="431"/>
                    <a:pt x="95" y="423"/>
                    <a:pt x="94" y="415"/>
                  </a:cubicBezTo>
                  <a:cubicBezTo>
                    <a:pt x="94" y="406"/>
                    <a:pt x="94" y="399"/>
                    <a:pt x="94" y="392"/>
                  </a:cubicBezTo>
                  <a:cubicBezTo>
                    <a:pt x="95" y="386"/>
                    <a:pt x="96" y="380"/>
                    <a:pt x="97" y="376"/>
                  </a:cubicBezTo>
                  <a:cubicBezTo>
                    <a:pt x="98" y="371"/>
                    <a:pt x="99" y="369"/>
                    <a:pt x="100" y="367"/>
                  </a:cubicBezTo>
                  <a:cubicBezTo>
                    <a:pt x="101" y="366"/>
                    <a:pt x="102" y="364"/>
                    <a:pt x="103" y="363"/>
                  </a:cubicBezTo>
                  <a:cubicBezTo>
                    <a:pt x="104" y="363"/>
                    <a:pt x="106" y="362"/>
                    <a:pt x="108" y="361"/>
                  </a:cubicBezTo>
                  <a:cubicBezTo>
                    <a:pt x="109" y="360"/>
                    <a:pt x="112" y="359"/>
                    <a:pt x="114" y="358"/>
                  </a:cubicBezTo>
                  <a:cubicBezTo>
                    <a:pt x="117" y="357"/>
                    <a:pt x="120" y="356"/>
                    <a:pt x="124" y="355"/>
                  </a:cubicBezTo>
                  <a:cubicBezTo>
                    <a:pt x="131" y="354"/>
                    <a:pt x="136" y="354"/>
                    <a:pt x="138" y="354"/>
                  </a:cubicBezTo>
                  <a:cubicBezTo>
                    <a:pt x="141" y="355"/>
                    <a:pt x="143" y="356"/>
                    <a:pt x="143" y="358"/>
                  </a:cubicBezTo>
                  <a:cubicBezTo>
                    <a:pt x="144" y="360"/>
                    <a:pt x="143" y="362"/>
                    <a:pt x="142" y="366"/>
                  </a:cubicBezTo>
                  <a:cubicBezTo>
                    <a:pt x="141" y="370"/>
                    <a:pt x="140" y="374"/>
                    <a:pt x="139" y="380"/>
                  </a:cubicBezTo>
                  <a:cubicBezTo>
                    <a:pt x="138" y="386"/>
                    <a:pt x="138" y="392"/>
                    <a:pt x="137" y="400"/>
                  </a:cubicBezTo>
                  <a:cubicBezTo>
                    <a:pt x="137" y="407"/>
                    <a:pt x="138" y="415"/>
                    <a:pt x="140" y="424"/>
                  </a:cubicBezTo>
                  <a:cubicBezTo>
                    <a:pt x="142" y="432"/>
                    <a:pt x="144" y="438"/>
                    <a:pt x="147" y="444"/>
                  </a:cubicBezTo>
                  <a:cubicBezTo>
                    <a:pt x="150" y="449"/>
                    <a:pt x="154" y="453"/>
                    <a:pt x="158" y="457"/>
                  </a:cubicBezTo>
                  <a:cubicBezTo>
                    <a:pt x="162" y="460"/>
                    <a:pt x="167" y="462"/>
                    <a:pt x="172" y="463"/>
                  </a:cubicBezTo>
                  <a:cubicBezTo>
                    <a:pt x="177" y="464"/>
                    <a:pt x="182" y="464"/>
                    <a:pt x="188" y="463"/>
                  </a:cubicBezTo>
                  <a:cubicBezTo>
                    <a:pt x="194" y="461"/>
                    <a:pt x="199" y="459"/>
                    <a:pt x="203" y="455"/>
                  </a:cubicBezTo>
                  <a:cubicBezTo>
                    <a:pt x="208" y="452"/>
                    <a:pt x="211" y="447"/>
                    <a:pt x="214" y="442"/>
                  </a:cubicBezTo>
                  <a:cubicBezTo>
                    <a:pt x="216" y="436"/>
                    <a:pt x="218" y="430"/>
                    <a:pt x="218" y="422"/>
                  </a:cubicBezTo>
                  <a:cubicBezTo>
                    <a:pt x="218" y="414"/>
                    <a:pt x="217" y="406"/>
                    <a:pt x="215" y="396"/>
                  </a:cubicBezTo>
                  <a:lnTo>
                    <a:pt x="210" y="373"/>
                  </a:lnTo>
                  <a:cubicBezTo>
                    <a:pt x="209" y="371"/>
                    <a:pt x="209" y="369"/>
                    <a:pt x="209" y="368"/>
                  </a:cubicBezTo>
                  <a:cubicBezTo>
                    <a:pt x="210" y="367"/>
                    <a:pt x="210" y="366"/>
                    <a:pt x="212" y="364"/>
                  </a:cubicBezTo>
                  <a:cubicBezTo>
                    <a:pt x="213" y="363"/>
                    <a:pt x="215" y="362"/>
                    <a:pt x="218" y="361"/>
                  </a:cubicBezTo>
                  <a:cubicBezTo>
                    <a:pt x="220" y="360"/>
                    <a:pt x="224" y="359"/>
                    <a:pt x="228" y="358"/>
                  </a:cubicBezTo>
                  <a:cubicBezTo>
                    <a:pt x="232" y="357"/>
                    <a:pt x="235" y="357"/>
                    <a:pt x="238" y="357"/>
                  </a:cubicBezTo>
                  <a:cubicBezTo>
                    <a:pt x="240" y="356"/>
                    <a:pt x="243" y="357"/>
                    <a:pt x="244" y="357"/>
                  </a:cubicBezTo>
                  <a:cubicBezTo>
                    <a:pt x="246" y="357"/>
                    <a:pt x="247" y="358"/>
                    <a:pt x="248" y="359"/>
                  </a:cubicBezTo>
                  <a:cubicBezTo>
                    <a:pt x="248" y="360"/>
                    <a:pt x="249" y="362"/>
                    <a:pt x="249" y="363"/>
                  </a:cubicBezTo>
                  <a:lnTo>
                    <a:pt x="255" y="387"/>
                  </a:lnTo>
                  <a:cubicBezTo>
                    <a:pt x="256" y="394"/>
                    <a:pt x="259" y="401"/>
                    <a:pt x="262" y="407"/>
                  </a:cubicBezTo>
                  <a:cubicBezTo>
                    <a:pt x="265" y="413"/>
                    <a:pt x="269" y="417"/>
                    <a:pt x="274" y="421"/>
                  </a:cubicBezTo>
                  <a:cubicBezTo>
                    <a:pt x="278" y="424"/>
                    <a:pt x="283" y="427"/>
                    <a:pt x="288" y="428"/>
                  </a:cubicBezTo>
                  <a:cubicBezTo>
                    <a:pt x="294" y="429"/>
                    <a:pt x="299" y="429"/>
                    <a:pt x="305" y="427"/>
                  </a:cubicBezTo>
                  <a:cubicBezTo>
                    <a:pt x="310" y="426"/>
                    <a:pt x="314" y="425"/>
                    <a:pt x="317" y="422"/>
                  </a:cubicBezTo>
                  <a:cubicBezTo>
                    <a:pt x="321" y="420"/>
                    <a:pt x="324" y="417"/>
                    <a:pt x="326" y="413"/>
                  </a:cubicBezTo>
                  <a:cubicBezTo>
                    <a:pt x="329" y="409"/>
                    <a:pt x="330" y="405"/>
                    <a:pt x="331" y="400"/>
                  </a:cubicBezTo>
                  <a:cubicBezTo>
                    <a:pt x="332" y="395"/>
                    <a:pt x="331" y="389"/>
                    <a:pt x="330" y="383"/>
                  </a:cubicBezTo>
                  <a:cubicBezTo>
                    <a:pt x="328" y="376"/>
                    <a:pt x="326" y="369"/>
                    <a:pt x="322" y="364"/>
                  </a:cubicBezTo>
                  <a:cubicBezTo>
                    <a:pt x="318" y="358"/>
                    <a:pt x="315" y="353"/>
                    <a:pt x="311" y="348"/>
                  </a:cubicBezTo>
                  <a:cubicBezTo>
                    <a:pt x="308" y="344"/>
                    <a:pt x="304" y="340"/>
                    <a:pt x="301" y="337"/>
                  </a:cubicBezTo>
                  <a:cubicBezTo>
                    <a:pt x="298" y="334"/>
                    <a:pt x="297" y="332"/>
                    <a:pt x="296" y="330"/>
                  </a:cubicBezTo>
                  <a:cubicBezTo>
                    <a:pt x="296" y="329"/>
                    <a:pt x="296" y="328"/>
                    <a:pt x="296" y="327"/>
                  </a:cubicBezTo>
                  <a:cubicBezTo>
                    <a:pt x="297" y="326"/>
                    <a:pt x="297" y="325"/>
                    <a:pt x="299" y="324"/>
                  </a:cubicBezTo>
                  <a:cubicBezTo>
                    <a:pt x="300" y="323"/>
                    <a:pt x="302" y="323"/>
                    <a:pt x="304" y="322"/>
                  </a:cubicBezTo>
                  <a:cubicBezTo>
                    <a:pt x="307" y="321"/>
                    <a:pt x="310" y="320"/>
                    <a:pt x="314" y="319"/>
                  </a:cubicBezTo>
                  <a:cubicBezTo>
                    <a:pt x="318" y="318"/>
                    <a:pt x="321" y="318"/>
                    <a:pt x="323" y="317"/>
                  </a:cubicBezTo>
                  <a:cubicBezTo>
                    <a:pt x="325" y="317"/>
                    <a:pt x="327" y="317"/>
                    <a:pt x="329" y="317"/>
                  </a:cubicBezTo>
                  <a:cubicBezTo>
                    <a:pt x="330" y="317"/>
                    <a:pt x="332" y="317"/>
                    <a:pt x="333" y="318"/>
                  </a:cubicBezTo>
                  <a:cubicBezTo>
                    <a:pt x="334" y="318"/>
                    <a:pt x="336" y="319"/>
                    <a:pt x="337" y="320"/>
                  </a:cubicBezTo>
                  <a:cubicBezTo>
                    <a:pt x="339" y="321"/>
                    <a:pt x="341" y="323"/>
                    <a:pt x="345" y="327"/>
                  </a:cubicBezTo>
                  <a:cubicBezTo>
                    <a:pt x="349" y="331"/>
                    <a:pt x="352" y="335"/>
                    <a:pt x="356" y="341"/>
                  </a:cubicBezTo>
                  <a:cubicBezTo>
                    <a:pt x="360" y="347"/>
                    <a:pt x="364" y="354"/>
                    <a:pt x="367" y="362"/>
                  </a:cubicBezTo>
                  <a:cubicBezTo>
                    <a:pt x="371" y="370"/>
                    <a:pt x="374" y="379"/>
                    <a:pt x="376" y="389"/>
                  </a:cubicBezTo>
                  <a:cubicBezTo>
                    <a:pt x="379" y="402"/>
                    <a:pt x="380" y="414"/>
                    <a:pt x="379" y="424"/>
                  </a:cubicBezTo>
                  <a:cubicBezTo>
                    <a:pt x="379" y="435"/>
                    <a:pt x="376" y="444"/>
                    <a:pt x="372" y="452"/>
                  </a:cubicBezTo>
                  <a:cubicBezTo>
                    <a:pt x="368" y="460"/>
                    <a:pt x="362" y="467"/>
                    <a:pt x="354" y="472"/>
                  </a:cubicBezTo>
                  <a:cubicBezTo>
                    <a:pt x="347" y="478"/>
                    <a:pt x="338" y="482"/>
                    <a:pt x="328" y="484"/>
                  </a:cubicBezTo>
                  <a:cubicBezTo>
                    <a:pt x="319" y="486"/>
                    <a:pt x="312" y="487"/>
                    <a:pt x="304" y="486"/>
                  </a:cubicBezTo>
                  <a:cubicBezTo>
                    <a:pt x="297" y="486"/>
                    <a:pt x="290" y="484"/>
                    <a:pt x="283" y="481"/>
                  </a:cubicBezTo>
                  <a:cubicBezTo>
                    <a:pt x="277" y="478"/>
                    <a:pt x="271" y="475"/>
                    <a:pt x="266" y="469"/>
                  </a:cubicBezTo>
                  <a:cubicBezTo>
                    <a:pt x="261" y="464"/>
                    <a:pt x="257" y="458"/>
                    <a:pt x="253" y="451"/>
                  </a:cubicBezTo>
                  <a:lnTo>
                    <a:pt x="252" y="451"/>
                  </a:lnTo>
                  <a:cubicBezTo>
                    <a:pt x="253" y="460"/>
                    <a:pt x="253" y="469"/>
                    <a:pt x="251" y="478"/>
                  </a:cubicBezTo>
                  <a:cubicBezTo>
                    <a:pt x="249" y="486"/>
                    <a:pt x="246" y="493"/>
                    <a:pt x="241" y="499"/>
                  </a:cubicBezTo>
                  <a:cubicBezTo>
                    <a:pt x="237" y="506"/>
                    <a:pt x="232" y="511"/>
                    <a:pt x="225" y="515"/>
                  </a:cubicBezTo>
                  <a:cubicBezTo>
                    <a:pt x="219" y="520"/>
                    <a:pt x="212" y="523"/>
                    <a:pt x="204" y="525"/>
                  </a:cubicBezTo>
                  <a:close/>
                  <a:moveTo>
                    <a:pt x="253" y="743"/>
                  </a:moveTo>
                  <a:cubicBezTo>
                    <a:pt x="240" y="746"/>
                    <a:pt x="227" y="746"/>
                    <a:pt x="216" y="744"/>
                  </a:cubicBezTo>
                  <a:cubicBezTo>
                    <a:pt x="205" y="741"/>
                    <a:pt x="194" y="736"/>
                    <a:pt x="185" y="728"/>
                  </a:cubicBezTo>
                  <a:cubicBezTo>
                    <a:pt x="176" y="721"/>
                    <a:pt x="169" y="711"/>
                    <a:pt x="162" y="699"/>
                  </a:cubicBezTo>
                  <a:cubicBezTo>
                    <a:pt x="156" y="687"/>
                    <a:pt x="151" y="674"/>
                    <a:pt x="147" y="659"/>
                  </a:cubicBezTo>
                  <a:cubicBezTo>
                    <a:pt x="145" y="650"/>
                    <a:pt x="144" y="641"/>
                    <a:pt x="143" y="633"/>
                  </a:cubicBezTo>
                  <a:cubicBezTo>
                    <a:pt x="143" y="625"/>
                    <a:pt x="143" y="617"/>
                    <a:pt x="144" y="611"/>
                  </a:cubicBezTo>
                  <a:cubicBezTo>
                    <a:pt x="144" y="604"/>
                    <a:pt x="145" y="599"/>
                    <a:pt x="146" y="594"/>
                  </a:cubicBezTo>
                  <a:cubicBezTo>
                    <a:pt x="147" y="590"/>
                    <a:pt x="148" y="587"/>
                    <a:pt x="149" y="586"/>
                  </a:cubicBezTo>
                  <a:cubicBezTo>
                    <a:pt x="150" y="584"/>
                    <a:pt x="151" y="583"/>
                    <a:pt x="152" y="582"/>
                  </a:cubicBezTo>
                  <a:cubicBezTo>
                    <a:pt x="153" y="581"/>
                    <a:pt x="155" y="580"/>
                    <a:pt x="157" y="579"/>
                  </a:cubicBezTo>
                  <a:cubicBezTo>
                    <a:pt x="158" y="578"/>
                    <a:pt x="161" y="577"/>
                    <a:pt x="163" y="577"/>
                  </a:cubicBezTo>
                  <a:cubicBezTo>
                    <a:pt x="166" y="576"/>
                    <a:pt x="170" y="575"/>
                    <a:pt x="174" y="574"/>
                  </a:cubicBezTo>
                  <a:cubicBezTo>
                    <a:pt x="180" y="573"/>
                    <a:pt x="185" y="572"/>
                    <a:pt x="188" y="573"/>
                  </a:cubicBezTo>
                  <a:cubicBezTo>
                    <a:pt x="190" y="573"/>
                    <a:pt x="192" y="574"/>
                    <a:pt x="193" y="577"/>
                  </a:cubicBezTo>
                  <a:cubicBezTo>
                    <a:pt x="193" y="578"/>
                    <a:pt x="192" y="581"/>
                    <a:pt x="191" y="584"/>
                  </a:cubicBezTo>
                  <a:cubicBezTo>
                    <a:pt x="190" y="588"/>
                    <a:pt x="189" y="593"/>
                    <a:pt x="188" y="599"/>
                  </a:cubicBezTo>
                  <a:cubicBezTo>
                    <a:pt x="187" y="604"/>
                    <a:pt x="187" y="611"/>
                    <a:pt x="186" y="618"/>
                  </a:cubicBezTo>
                  <a:cubicBezTo>
                    <a:pt x="186" y="626"/>
                    <a:pt x="187" y="634"/>
                    <a:pt x="189" y="643"/>
                  </a:cubicBezTo>
                  <a:cubicBezTo>
                    <a:pt x="191" y="650"/>
                    <a:pt x="193" y="657"/>
                    <a:pt x="196" y="662"/>
                  </a:cubicBezTo>
                  <a:cubicBezTo>
                    <a:pt x="199" y="667"/>
                    <a:pt x="203" y="672"/>
                    <a:pt x="207" y="675"/>
                  </a:cubicBezTo>
                  <a:cubicBezTo>
                    <a:pt x="211" y="678"/>
                    <a:pt x="216" y="681"/>
                    <a:pt x="221" y="682"/>
                  </a:cubicBezTo>
                  <a:cubicBezTo>
                    <a:pt x="226" y="683"/>
                    <a:pt x="231" y="682"/>
                    <a:pt x="237" y="681"/>
                  </a:cubicBezTo>
                  <a:cubicBezTo>
                    <a:pt x="243" y="680"/>
                    <a:pt x="248" y="677"/>
                    <a:pt x="253" y="674"/>
                  </a:cubicBezTo>
                  <a:cubicBezTo>
                    <a:pt x="257" y="670"/>
                    <a:pt x="260" y="666"/>
                    <a:pt x="263" y="660"/>
                  </a:cubicBezTo>
                  <a:cubicBezTo>
                    <a:pt x="265" y="655"/>
                    <a:pt x="267" y="648"/>
                    <a:pt x="267" y="640"/>
                  </a:cubicBezTo>
                  <a:cubicBezTo>
                    <a:pt x="267" y="633"/>
                    <a:pt x="266" y="624"/>
                    <a:pt x="264" y="614"/>
                  </a:cubicBezTo>
                  <a:lnTo>
                    <a:pt x="259" y="591"/>
                  </a:lnTo>
                  <a:cubicBezTo>
                    <a:pt x="259" y="590"/>
                    <a:pt x="258" y="588"/>
                    <a:pt x="259" y="587"/>
                  </a:cubicBezTo>
                  <a:cubicBezTo>
                    <a:pt x="259" y="585"/>
                    <a:pt x="260" y="584"/>
                    <a:pt x="261" y="583"/>
                  </a:cubicBezTo>
                  <a:cubicBezTo>
                    <a:pt x="262" y="582"/>
                    <a:pt x="264" y="581"/>
                    <a:pt x="267" y="580"/>
                  </a:cubicBezTo>
                  <a:cubicBezTo>
                    <a:pt x="269" y="579"/>
                    <a:pt x="273" y="578"/>
                    <a:pt x="277" y="577"/>
                  </a:cubicBezTo>
                  <a:cubicBezTo>
                    <a:pt x="281" y="576"/>
                    <a:pt x="284" y="575"/>
                    <a:pt x="287" y="575"/>
                  </a:cubicBezTo>
                  <a:cubicBezTo>
                    <a:pt x="290" y="575"/>
                    <a:pt x="292" y="575"/>
                    <a:pt x="293" y="576"/>
                  </a:cubicBezTo>
                  <a:cubicBezTo>
                    <a:pt x="295" y="576"/>
                    <a:pt x="296" y="577"/>
                    <a:pt x="297" y="578"/>
                  </a:cubicBezTo>
                  <a:cubicBezTo>
                    <a:pt x="298" y="579"/>
                    <a:pt x="298" y="580"/>
                    <a:pt x="299" y="582"/>
                  </a:cubicBezTo>
                  <a:lnTo>
                    <a:pt x="304" y="605"/>
                  </a:lnTo>
                  <a:cubicBezTo>
                    <a:pt x="306" y="613"/>
                    <a:pt x="308" y="620"/>
                    <a:pt x="311" y="626"/>
                  </a:cubicBezTo>
                  <a:cubicBezTo>
                    <a:pt x="315" y="631"/>
                    <a:pt x="318" y="636"/>
                    <a:pt x="323" y="639"/>
                  </a:cubicBezTo>
                  <a:cubicBezTo>
                    <a:pt x="327" y="643"/>
                    <a:pt x="332" y="645"/>
                    <a:pt x="337" y="646"/>
                  </a:cubicBezTo>
                  <a:cubicBezTo>
                    <a:pt x="343" y="647"/>
                    <a:pt x="348" y="647"/>
                    <a:pt x="354" y="646"/>
                  </a:cubicBezTo>
                  <a:cubicBezTo>
                    <a:pt x="359" y="645"/>
                    <a:pt x="363" y="643"/>
                    <a:pt x="367" y="641"/>
                  </a:cubicBezTo>
                  <a:cubicBezTo>
                    <a:pt x="370" y="638"/>
                    <a:pt x="373" y="635"/>
                    <a:pt x="376" y="632"/>
                  </a:cubicBezTo>
                  <a:cubicBezTo>
                    <a:pt x="378" y="628"/>
                    <a:pt x="379" y="624"/>
                    <a:pt x="380" y="619"/>
                  </a:cubicBezTo>
                  <a:cubicBezTo>
                    <a:pt x="381" y="614"/>
                    <a:pt x="380" y="608"/>
                    <a:pt x="379" y="602"/>
                  </a:cubicBezTo>
                  <a:cubicBezTo>
                    <a:pt x="377" y="594"/>
                    <a:pt x="375" y="588"/>
                    <a:pt x="371" y="582"/>
                  </a:cubicBezTo>
                  <a:cubicBezTo>
                    <a:pt x="368" y="576"/>
                    <a:pt x="364" y="571"/>
                    <a:pt x="360" y="567"/>
                  </a:cubicBezTo>
                  <a:cubicBezTo>
                    <a:pt x="357" y="562"/>
                    <a:pt x="353" y="559"/>
                    <a:pt x="350" y="556"/>
                  </a:cubicBezTo>
                  <a:cubicBezTo>
                    <a:pt x="347" y="553"/>
                    <a:pt x="346" y="550"/>
                    <a:pt x="345" y="549"/>
                  </a:cubicBezTo>
                  <a:cubicBezTo>
                    <a:pt x="345" y="547"/>
                    <a:pt x="345" y="546"/>
                    <a:pt x="345" y="546"/>
                  </a:cubicBezTo>
                  <a:cubicBezTo>
                    <a:pt x="346" y="545"/>
                    <a:pt x="346" y="544"/>
                    <a:pt x="348" y="543"/>
                  </a:cubicBezTo>
                  <a:cubicBezTo>
                    <a:pt x="349" y="542"/>
                    <a:pt x="351" y="541"/>
                    <a:pt x="353" y="540"/>
                  </a:cubicBezTo>
                  <a:cubicBezTo>
                    <a:pt x="356" y="539"/>
                    <a:pt x="359" y="539"/>
                    <a:pt x="363" y="538"/>
                  </a:cubicBezTo>
                  <a:cubicBezTo>
                    <a:pt x="367" y="537"/>
                    <a:pt x="370" y="536"/>
                    <a:pt x="372" y="536"/>
                  </a:cubicBezTo>
                  <a:cubicBezTo>
                    <a:pt x="374" y="536"/>
                    <a:pt x="376" y="535"/>
                    <a:pt x="378" y="535"/>
                  </a:cubicBezTo>
                  <a:cubicBezTo>
                    <a:pt x="379" y="536"/>
                    <a:pt x="381" y="536"/>
                    <a:pt x="382" y="536"/>
                  </a:cubicBezTo>
                  <a:cubicBezTo>
                    <a:pt x="383" y="536"/>
                    <a:pt x="385" y="537"/>
                    <a:pt x="386" y="538"/>
                  </a:cubicBezTo>
                  <a:cubicBezTo>
                    <a:pt x="388" y="539"/>
                    <a:pt x="391" y="542"/>
                    <a:pt x="394" y="545"/>
                  </a:cubicBezTo>
                  <a:cubicBezTo>
                    <a:pt x="398" y="549"/>
                    <a:pt x="401" y="554"/>
                    <a:pt x="405" y="560"/>
                  </a:cubicBezTo>
                  <a:cubicBezTo>
                    <a:pt x="409" y="566"/>
                    <a:pt x="413" y="573"/>
                    <a:pt x="417" y="581"/>
                  </a:cubicBezTo>
                  <a:cubicBezTo>
                    <a:pt x="420" y="589"/>
                    <a:pt x="423" y="598"/>
                    <a:pt x="425" y="608"/>
                  </a:cubicBezTo>
                  <a:cubicBezTo>
                    <a:pt x="428" y="620"/>
                    <a:pt x="429" y="632"/>
                    <a:pt x="429" y="643"/>
                  </a:cubicBezTo>
                  <a:cubicBezTo>
                    <a:pt x="428" y="653"/>
                    <a:pt x="425" y="663"/>
                    <a:pt x="421" y="671"/>
                  </a:cubicBezTo>
                  <a:cubicBezTo>
                    <a:pt x="417" y="679"/>
                    <a:pt x="411" y="686"/>
                    <a:pt x="404" y="691"/>
                  </a:cubicBezTo>
                  <a:cubicBezTo>
                    <a:pt x="396" y="696"/>
                    <a:pt x="387" y="700"/>
                    <a:pt x="377" y="703"/>
                  </a:cubicBezTo>
                  <a:cubicBezTo>
                    <a:pt x="369" y="704"/>
                    <a:pt x="361" y="705"/>
                    <a:pt x="353" y="705"/>
                  </a:cubicBezTo>
                  <a:cubicBezTo>
                    <a:pt x="346" y="704"/>
                    <a:pt x="339" y="703"/>
                    <a:pt x="333" y="700"/>
                  </a:cubicBezTo>
                  <a:cubicBezTo>
                    <a:pt x="326" y="697"/>
                    <a:pt x="320" y="693"/>
                    <a:pt x="315" y="688"/>
                  </a:cubicBezTo>
                  <a:cubicBezTo>
                    <a:pt x="310" y="683"/>
                    <a:pt x="306" y="677"/>
                    <a:pt x="302" y="669"/>
                  </a:cubicBezTo>
                  <a:lnTo>
                    <a:pt x="301" y="669"/>
                  </a:lnTo>
                  <a:cubicBezTo>
                    <a:pt x="302" y="679"/>
                    <a:pt x="302" y="688"/>
                    <a:pt x="300" y="696"/>
                  </a:cubicBezTo>
                  <a:cubicBezTo>
                    <a:pt x="298" y="704"/>
                    <a:pt x="295" y="712"/>
                    <a:pt x="290" y="718"/>
                  </a:cubicBezTo>
                  <a:cubicBezTo>
                    <a:pt x="286" y="724"/>
                    <a:pt x="281" y="730"/>
                    <a:pt x="275" y="734"/>
                  </a:cubicBezTo>
                  <a:cubicBezTo>
                    <a:pt x="268" y="738"/>
                    <a:pt x="261" y="741"/>
                    <a:pt x="253" y="743"/>
                  </a:cubicBezTo>
                  <a:close/>
                  <a:moveTo>
                    <a:pt x="247" y="976"/>
                  </a:moveTo>
                  <a:cubicBezTo>
                    <a:pt x="243" y="976"/>
                    <a:pt x="239" y="977"/>
                    <a:pt x="236" y="977"/>
                  </a:cubicBezTo>
                  <a:cubicBezTo>
                    <a:pt x="233" y="978"/>
                    <a:pt x="231" y="978"/>
                    <a:pt x="229" y="977"/>
                  </a:cubicBezTo>
                  <a:cubicBezTo>
                    <a:pt x="227" y="977"/>
                    <a:pt x="226" y="976"/>
                    <a:pt x="225" y="975"/>
                  </a:cubicBezTo>
                  <a:cubicBezTo>
                    <a:pt x="224" y="975"/>
                    <a:pt x="223" y="973"/>
                    <a:pt x="223" y="972"/>
                  </a:cubicBezTo>
                  <a:lnTo>
                    <a:pt x="188" y="819"/>
                  </a:lnTo>
                  <a:cubicBezTo>
                    <a:pt x="188" y="816"/>
                    <a:pt x="187" y="813"/>
                    <a:pt x="187" y="811"/>
                  </a:cubicBezTo>
                  <a:cubicBezTo>
                    <a:pt x="187" y="809"/>
                    <a:pt x="188" y="807"/>
                    <a:pt x="189" y="805"/>
                  </a:cubicBezTo>
                  <a:cubicBezTo>
                    <a:pt x="191" y="803"/>
                    <a:pt x="193" y="802"/>
                    <a:pt x="195" y="800"/>
                  </a:cubicBezTo>
                  <a:cubicBezTo>
                    <a:pt x="198" y="799"/>
                    <a:pt x="202" y="798"/>
                    <a:pt x="207" y="797"/>
                  </a:cubicBezTo>
                  <a:cubicBezTo>
                    <a:pt x="212" y="796"/>
                    <a:pt x="215" y="795"/>
                    <a:pt x="219" y="795"/>
                  </a:cubicBezTo>
                  <a:cubicBezTo>
                    <a:pt x="222" y="794"/>
                    <a:pt x="225" y="795"/>
                    <a:pt x="228" y="795"/>
                  </a:cubicBezTo>
                  <a:cubicBezTo>
                    <a:pt x="231" y="796"/>
                    <a:pt x="233" y="796"/>
                    <a:pt x="236" y="798"/>
                  </a:cubicBezTo>
                  <a:cubicBezTo>
                    <a:pt x="239" y="799"/>
                    <a:pt x="242" y="800"/>
                    <a:pt x="246" y="803"/>
                  </a:cubicBezTo>
                  <a:lnTo>
                    <a:pt x="305" y="838"/>
                  </a:lnTo>
                  <a:cubicBezTo>
                    <a:pt x="317" y="845"/>
                    <a:pt x="328" y="850"/>
                    <a:pt x="337" y="854"/>
                  </a:cubicBezTo>
                  <a:cubicBezTo>
                    <a:pt x="346" y="858"/>
                    <a:pt x="354" y="860"/>
                    <a:pt x="361" y="862"/>
                  </a:cubicBezTo>
                  <a:cubicBezTo>
                    <a:pt x="369" y="864"/>
                    <a:pt x="375" y="865"/>
                    <a:pt x="381" y="865"/>
                  </a:cubicBezTo>
                  <a:cubicBezTo>
                    <a:pt x="386" y="865"/>
                    <a:pt x="392" y="864"/>
                    <a:pt x="397" y="863"/>
                  </a:cubicBezTo>
                  <a:cubicBezTo>
                    <a:pt x="401" y="862"/>
                    <a:pt x="405" y="860"/>
                    <a:pt x="409" y="858"/>
                  </a:cubicBezTo>
                  <a:cubicBezTo>
                    <a:pt x="413" y="855"/>
                    <a:pt x="416" y="852"/>
                    <a:pt x="418" y="849"/>
                  </a:cubicBezTo>
                  <a:cubicBezTo>
                    <a:pt x="421" y="846"/>
                    <a:pt x="422" y="841"/>
                    <a:pt x="423" y="837"/>
                  </a:cubicBezTo>
                  <a:cubicBezTo>
                    <a:pt x="424" y="832"/>
                    <a:pt x="424" y="827"/>
                    <a:pt x="422" y="821"/>
                  </a:cubicBezTo>
                  <a:cubicBezTo>
                    <a:pt x="420" y="813"/>
                    <a:pt x="418" y="806"/>
                    <a:pt x="414" y="800"/>
                  </a:cubicBezTo>
                  <a:cubicBezTo>
                    <a:pt x="411" y="795"/>
                    <a:pt x="407" y="790"/>
                    <a:pt x="404" y="785"/>
                  </a:cubicBezTo>
                  <a:cubicBezTo>
                    <a:pt x="400" y="781"/>
                    <a:pt x="397" y="778"/>
                    <a:pt x="394" y="775"/>
                  </a:cubicBezTo>
                  <a:cubicBezTo>
                    <a:pt x="391" y="773"/>
                    <a:pt x="390" y="770"/>
                    <a:pt x="389" y="769"/>
                  </a:cubicBezTo>
                  <a:cubicBezTo>
                    <a:pt x="389" y="767"/>
                    <a:pt x="389" y="766"/>
                    <a:pt x="390" y="765"/>
                  </a:cubicBezTo>
                  <a:cubicBezTo>
                    <a:pt x="390" y="764"/>
                    <a:pt x="392" y="763"/>
                    <a:pt x="393" y="762"/>
                  </a:cubicBezTo>
                  <a:cubicBezTo>
                    <a:pt x="395" y="761"/>
                    <a:pt x="398" y="760"/>
                    <a:pt x="401" y="759"/>
                  </a:cubicBezTo>
                  <a:cubicBezTo>
                    <a:pt x="404" y="758"/>
                    <a:pt x="408" y="757"/>
                    <a:pt x="412" y="756"/>
                  </a:cubicBezTo>
                  <a:cubicBezTo>
                    <a:pt x="416" y="755"/>
                    <a:pt x="418" y="755"/>
                    <a:pt x="420" y="754"/>
                  </a:cubicBezTo>
                  <a:cubicBezTo>
                    <a:pt x="423" y="754"/>
                    <a:pt x="425" y="754"/>
                    <a:pt x="426" y="754"/>
                  </a:cubicBezTo>
                  <a:cubicBezTo>
                    <a:pt x="428" y="754"/>
                    <a:pt x="429" y="754"/>
                    <a:pt x="431" y="755"/>
                  </a:cubicBezTo>
                  <a:cubicBezTo>
                    <a:pt x="432" y="755"/>
                    <a:pt x="434" y="756"/>
                    <a:pt x="436" y="757"/>
                  </a:cubicBezTo>
                  <a:cubicBezTo>
                    <a:pt x="438" y="759"/>
                    <a:pt x="441" y="761"/>
                    <a:pt x="444" y="765"/>
                  </a:cubicBezTo>
                  <a:cubicBezTo>
                    <a:pt x="448" y="769"/>
                    <a:pt x="451" y="774"/>
                    <a:pt x="455" y="781"/>
                  </a:cubicBezTo>
                  <a:cubicBezTo>
                    <a:pt x="459" y="787"/>
                    <a:pt x="463" y="794"/>
                    <a:pt x="466" y="802"/>
                  </a:cubicBezTo>
                  <a:cubicBezTo>
                    <a:pt x="470" y="809"/>
                    <a:pt x="473" y="818"/>
                    <a:pt x="475" y="826"/>
                  </a:cubicBezTo>
                  <a:cubicBezTo>
                    <a:pt x="478" y="840"/>
                    <a:pt x="479" y="853"/>
                    <a:pt x="478" y="864"/>
                  </a:cubicBezTo>
                  <a:cubicBezTo>
                    <a:pt x="476" y="875"/>
                    <a:pt x="473" y="885"/>
                    <a:pt x="469" y="893"/>
                  </a:cubicBezTo>
                  <a:cubicBezTo>
                    <a:pt x="464" y="901"/>
                    <a:pt x="458" y="908"/>
                    <a:pt x="450" y="913"/>
                  </a:cubicBezTo>
                  <a:cubicBezTo>
                    <a:pt x="442" y="919"/>
                    <a:pt x="433" y="922"/>
                    <a:pt x="423" y="925"/>
                  </a:cubicBezTo>
                  <a:cubicBezTo>
                    <a:pt x="415" y="926"/>
                    <a:pt x="406" y="928"/>
                    <a:pt x="397" y="928"/>
                  </a:cubicBezTo>
                  <a:cubicBezTo>
                    <a:pt x="389" y="928"/>
                    <a:pt x="379" y="927"/>
                    <a:pt x="368" y="924"/>
                  </a:cubicBezTo>
                  <a:cubicBezTo>
                    <a:pt x="357" y="921"/>
                    <a:pt x="345" y="916"/>
                    <a:pt x="331" y="909"/>
                  </a:cubicBezTo>
                  <a:cubicBezTo>
                    <a:pt x="317" y="902"/>
                    <a:pt x="301" y="892"/>
                    <a:pt x="282" y="880"/>
                  </a:cubicBezTo>
                  <a:lnTo>
                    <a:pt x="243" y="856"/>
                  </a:lnTo>
                  <a:lnTo>
                    <a:pt x="266" y="961"/>
                  </a:lnTo>
                  <a:cubicBezTo>
                    <a:pt x="267" y="963"/>
                    <a:pt x="266" y="964"/>
                    <a:pt x="266" y="965"/>
                  </a:cubicBezTo>
                  <a:cubicBezTo>
                    <a:pt x="265" y="967"/>
                    <a:pt x="264" y="968"/>
                    <a:pt x="263" y="969"/>
                  </a:cubicBezTo>
                  <a:cubicBezTo>
                    <a:pt x="261" y="970"/>
                    <a:pt x="259" y="972"/>
                    <a:pt x="256" y="973"/>
                  </a:cubicBezTo>
                  <a:cubicBezTo>
                    <a:pt x="254" y="974"/>
                    <a:pt x="250" y="975"/>
                    <a:pt x="247" y="976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5"/>
            <p:cNvSpPr/>
            <p:nvPr/>
          </p:nvSpPr>
          <p:spPr>
            <a:xfrm>
              <a:off x="4681440" y="3286080"/>
              <a:ext cx="311400" cy="303120"/>
            </a:xfrm>
            <a:custGeom>
              <a:avLst/>
              <a:gdLst>
                <a:gd name="textAreaLeft" fmla="*/ 0 w 311400"/>
                <a:gd name="textAreaRight" fmla="*/ 311760 w 311400"/>
                <a:gd name="textAreaTop" fmla="*/ 0 h 303120"/>
                <a:gd name="textAreaBottom" fmla="*/ 303120 h 303120"/>
              </a:gdLst>
              <a:ahLst/>
              <a:rect l="textAreaLeft" t="textAreaTop" r="textAreaRight" b="textAreaBottom"/>
              <a:pathLst>
                <a:path w="826" h="812">
                  <a:moveTo>
                    <a:pt x="563" y="125"/>
                  </a:moveTo>
                  <a:cubicBezTo>
                    <a:pt x="560" y="122"/>
                    <a:pt x="558" y="119"/>
                    <a:pt x="556" y="117"/>
                  </a:cubicBezTo>
                  <a:cubicBezTo>
                    <a:pt x="555" y="115"/>
                    <a:pt x="554" y="113"/>
                    <a:pt x="553" y="111"/>
                  </a:cubicBezTo>
                  <a:cubicBezTo>
                    <a:pt x="553" y="109"/>
                    <a:pt x="553" y="108"/>
                    <a:pt x="553" y="106"/>
                  </a:cubicBezTo>
                  <a:cubicBezTo>
                    <a:pt x="553" y="105"/>
                    <a:pt x="554" y="104"/>
                    <a:pt x="555" y="103"/>
                  </a:cubicBezTo>
                  <a:lnTo>
                    <a:pt x="666" y="2"/>
                  </a:lnTo>
                  <a:cubicBezTo>
                    <a:pt x="667" y="1"/>
                    <a:pt x="668" y="1"/>
                    <a:pt x="669" y="1"/>
                  </a:cubicBezTo>
                  <a:cubicBezTo>
                    <a:pt x="670" y="0"/>
                    <a:pt x="672" y="1"/>
                    <a:pt x="673" y="1"/>
                  </a:cubicBezTo>
                  <a:cubicBezTo>
                    <a:pt x="675" y="2"/>
                    <a:pt x="677" y="3"/>
                    <a:pt x="679" y="5"/>
                  </a:cubicBezTo>
                  <a:cubicBezTo>
                    <a:pt x="681" y="7"/>
                    <a:pt x="684" y="9"/>
                    <a:pt x="686" y="12"/>
                  </a:cubicBezTo>
                  <a:cubicBezTo>
                    <a:pt x="689" y="15"/>
                    <a:pt x="691" y="18"/>
                    <a:pt x="693" y="20"/>
                  </a:cubicBezTo>
                  <a:cubicBezTo>
                    <a:pt x="694" y="22"/>
                    <a:pt x="695" y="24"/>
                    <a:pt x="696" y="26"/>
                  </a:cubicBezTo>
                  <a:cubicBezTo>
                    <a:pt x="697" y="28"/>
                    <a:pt x="697" y="29"/>
                    <a:pt x="697" y="30"/>
                  </a:cubicBezTo>
                  <a:cubicBezTo>
                    <a:pt x="696" y="32"/>
                    <a:pt x="696" y="33"/>
                    <a:pt x="695" y="34"/>
                  </a:cubicBezTo>
                  <a:lnTo>
                    <a:pt x="657" y="68"/>
                  </a:lnTo>
                  <a:lnTo>
                    <a:pt x="777" y="199"/>
                  </a:lnTo>
                  <a:lnTo>
                    <a:pt x="793" y="151"/>
                  </a:lnTo>
                  <a:cubicBezTo>
                    <a:pt x="794" y="148"/>
                    <a:pt x="796" y="146"/>
                    <a:pt x="797" y="144"/>
                  </a:cubicBezTo>
                  <a:cubicBezTo>
                    <a:pt x="798" y="142"/>
                    <a:pt x="800" y="142"/>
                    <a:pt x="801" y="142"/>
                  </a:cubicBezTo>
                  <a:cubicBezTo>
                    <a:pt x="803" y="142"/>
                    <a:pt x="805" y="143"/>
                    <a:pt x="807" y="145"/>
                  </a:cubicBezTo>
                  <a:cubicBezTo>
                    <a:pt x="810" y="147"/>
                    <a:pt x="813" y="149"/>
                    <a:pt x="816" y="153"/>
                  </a:cubicBezTo>
                  <a:cubicBezTo>
                    <a:pt x="819" y="156"/>
                    <a:pt x="820" y="158"/>
                    <a:pt x="822" y="160"/>
                  </a:cubicBezTo>
                  <a:cubicBezTo>
                    <a:pt x="823" y="161"/>
                    <a:pt x="824" y="163"/>
                    <a:pt x="825" y="165"/>
                  </a:cubicBezTo>
                  <a:cubicBezTo>
                    <a:pt x="825" y="166"/>
                    <a:pt x="826" y="168"/>
                    <a:pt x="826" y="169"/>
                  </a:cubicBezTo>
                  <a:cubicBezTo>
                    <a:pt x="826" y="170"/>
                    <a:pt x="825" y="172"/>
                    <a:pt x="825" y="174"/>
                  </a:cubicBezTo>
                  <a:lnTo>
                    <a:pt x="807" y="242"/>
                  </a:lnTo>
                  <a:cubicBezTo>
                    <a:pt x="807" y="242"/>
                    <a:pt x="807" y="243"/>
                    <a:pt x="806" y="244"/>
                  </a:cubicBezTo>
                  <a:cubicBezTo>
                    <a:pt x="806" y="245"/>
                    <a:pt x="805" y="246"/>
                    <a:pt x="804" y="248"/>
                  </a:cubicBezTo>
                  <a:cubicBezTo>
                    <a:pt x="803" y="249"/>
                    <a:pt x="801" y="251"/>
                    <a:pt x="799" y="253"/>
                  </a:cubicBezTo>
                  <a:cubicBezTo>
                    <a:pt x="797" y="254"/>
                    <a:pt x="794" y="257"/>
                    <a:pt x="791" y="260"/>
                  </a:cubicBezTo>
                  <a:cubicBezTo>
                    <a:pt x="787" y="263"/>
                    <a:pt x="784" y="266"/>
                    <a:pt x="781" y="268"/>
                  </a:cubicBezTo>
                  <a:cubicBezTo>
                    <a:pt x="779" y="270"/>
                    <a:pt x="777" y="272"/>
                    <a:pt x="775" y="273"/>
                  </a:cubicBezTo>
                  <a:cubicBezTo>
                    <a:pt x="774" y="273"/>
                    <a:pt x="772" y="274"/>
                    <a:pt x="771" y="273"/>
                  </a:cubicBezTo>
                  <a:cubicBezTo>
                    <a:pt x="770" y="273"/>
                    <a:pt x="769" y="273"/>
                    <a:pt x="769" y="272"/>
                  </a:cubicBezTo>
                  <a:lnTo>
                    <a:pt x="617" y="105"/>
                  </a:lnTo>
                  <a:lnTo>
                    <a:pt x="584" y="135"/>
                  </a:lnTo>
                  <a:cubicBezTo>
                    <a:pt x="583" y="136"/>
                    <a:pt x="582" y="136"/>
                    <a:pt x="580" y="137"/>
                  </a:cubicBezTo>
                  <a:cubicBezTo>
                    <a:pt x="579" y="137"/>
                    <a:pt x="577" y="136"/>
                    <a:pt x="576" y="136"/>
                  </a:cubicBezTo>
                  <a:cubicBezTo>
                    <a:pt x="574" y="135"/>
                    <a:pt x="572" y="134"/>
                    <a:pt x="570" y="132"/>
                  </a:cubicBezTo>
                  <a:cubicBezTo>
                    <a:pt x="568" y="130"/>
                    <a:pt x="566" y="128"/>
                    <a:pt x="563" y="125"/>
                  </a:cubicBezTo>
                  <a:close/>
                  <a:moveTo>
                    <a:pt x="491" y="215"/>
                  </a:moveTo>
                  <a:cubicBezTo>
                    <a:pt x="487" y="210"/>
                    <a:pt x="484" y="206"/>
                    <a:pt x="481" y="203"/>
                  </a:cubicBezTo>
                  <a:cubicBezTo>
                    <a:pt x="478" y="199"/>
                    <a:pt x="476" y="195"/>
                    <a:pt x="474" y="191"/>
                  </a:cubicBezTo>
                  <a:cubicBezTo>
                    <a:pt x="472" y="187"/>
                    <a:pt x="471" y="183"/>
                    <a:pt x="470" y="179"/>
                  </a:cubicBezTo>
                  <a:cubicBezTo>
                    <a:pt x="469" y="175"/>
                    <a:pt x="468" y="170"/>
                    <a:pt x="467" y="165"/>
                  </a:cubicBezTo>
                  <a:lnTo>
                    <a:pt x="461" y="116"/>
                  </a:lnTo>
                  <a:cubicBezTo>
                    <a:pt x="461" y="115"/>
                    <a:pt x="461" y="113"/>
                    <a:pt x="461" y="112"/>
                  </a:cubicBezTo>
                  <a:cubicBezTo>
                    <a:pt x="461" y="110"/>
                    <a:pt x="461" y="109"/>
                    <a:pt x="462" y="107"/>
                  </a:cubicBezTo>
                  <a:cubicBezTo>
                    <a:pt x="463" y="105"/>
                    <a:pt x="464" y="104"/>
                    <a:pt x="466" y="102"/>
                  </a:cubicBezTo>
                  <a:cubicBezTo>
                    <a:pt x="467" y="100"/>
                    <a:pt x="470" y="98"/>
                    <a:pt x="472" y="95"/>
                  </a:cubicBezTo>
                  <a:cubicBezTo>
                    <a:pt x="475" y="93"/>
                    <a:pt x="478" y="90"/>
                    <a:pt x="480" y="89"/>
                  </a:cubicBezTo>
                  <a:cubicBezTo>
                    <a:pt x="482" y="88"/>
                    <a:pt x="484" y="87"/>
                    <a:pt x="485" y="87"/>
                  </a:cubicBezTo>
                  <a:cubicBezTo>
                    <a:pt x="486" y="86"/>
                    <a:pt x="487" y="87"/>
                    <a:pt x="488" y="87"/>
                  </a:cubicBezTo>
                  <a:cubicBezTo>
                    <a:pt x="489" y="88"/>
                    <a:pt x="490" y="89"/>
                    <a:pt x="490" y="91"/>
                  </a:cubicBezTo>
                  <a:lnTo>
                    <a:pt x="511" y="151"/>
                  </a:lnTo>
                  <a:lnTo>
                    <a:pt x="533" y="176"/>
                  </a:lnTo>
                  <a:cubicBezTo>
                    <a:pt x="536" y="179"/>
                    <a:pt x="538" y="183"/>
                    <a:pt x="540" y="186"/>
                  </a:cubicBezTo>
                  <a:cubicBezTo>
                    <a:pt x="541" y="189"/>
                    <a:pt x="541" y="191"/>
                    <a:pt x="540" y="194"/>
                  </a:cubicBezTo>
                  <a:cubicBezTo>
                    <a:pt x="539" y="197"/>
                    <a:pt x="538" y="200"/>
                    <a:pt x="536" y="203"/>
                  </a:cubicBezTo>
                  <a:cubicBezTo>
                    <a:pt x="533" y="205"/>
                    <a:pt x="530" y="209"/>
                    <a:pt x="526" y="212"/>
                  </a:cubicBezTo>
                  <a:cubicBezTo>
                    <a:pt x="523" y="215"/>
                    <a:pt x="519" y="218"/>
                    <a:pt x="516" y="220"/>
                  </a:cubicBezTo>
                  <a:cubicBezTo>
                    <a:pt x="513" y="222"/>
                    <a:pt x="511" y="223"/>
                    <a:pt x="508" y="224"/>
                  </a:cubicBezTo>
                  <a:cubicBezTo>
                    <a:pt x="505" y="224"/>
                    <a:pt x="502" y="224"/>
                    <a:pt x="500" y="222"/>
                  </a:cubicBezTo>
                  <a:cubicBezTo>
                    <a:pt x="497" y="221"/>
                    <a:pt x="494" y="218"/>
                    <a:pt x="491" y="215"/>
                  </a:cubicBezTo>
                  <a:close/>
                  <a:moveTo>
                    <a:pt x="360" y="401"/>
                  </a:moveTo>
                  <a:cubicBezTo>
                    <a:pt x="350" y="390"/>
                    <a:pt x="343" y="379"/>
                    <a:pt x="339" y="367"/>
                  </a:cubicBezTo>
                  <a:cubicBezTo>
                    <a:pt x="335" y="355"/>
                    <a:pt x="334" y="343"/>
                    <a:pt x="335" y="330"/>
                  </a:cubicBezTo>
                  <a:cubicBezTo>
                    <a:pt x="337" y="318"/>
                    <a:pt x="341" y="306"/>
                    <a:pt x="348" y="294"/>
                  </a:cubicBezTo>
                  <a:cubicBezTo>
                    <a:pt x="355" y="282"/>
                    <a:pt x="364" y="271"/>
                    <a:pt x="376" y="260"/>
                  </a:cubicBezTo>
                  <a:cubicBezTo>
                    <a:pt x="382" y="254"/>
                    <a:pt x="389" y="249"/>
                    <a:pt x="395" y="245"/>
                  </a:cubicBezTo>
                  <a:cubicBezTo>
                    <a:pt x="401" y="241"/>
                    <a:pt x="407" y="237"/>
                    <a:pt x="413" y="234"/>
                  </a:cubicBezTo>
                  <a:cubicBezTo>
                    <a:pt x="418" y="231"/>
                    <a:pt x="423" y="229"/>
                    <a:pt x="427" y="228"/>
                  </a:cubicBezTo>
                  <a:cubicBezTo>
                    <a:pt x="431" y="226"/>
                    <a:pt x="434" y="226"/>
                    <a:pt x="435" y="225"/>
                  </a:cubicBezTo>
                  <a:cubicBezTo>
                    <a:pt x="437" y="225"/>
                    <a:pt x="438" y="226"/>
                    <a:pt x="440" y="226"/>
                  </a:cubicBezTo>
                  <a:cubicBezTo>
                    <a:pt x="441" y="227"/>
                    <a:pt x="442" y="228"/>
                    <a:pt x="444" y="229"/>
                  </a:cubicBezTo>
                  <a:cubicBezTo>
                    <a:pt x="445" y="230"/>
                    <a:pt x="447" y="231"/>
                    <a:pt x="449" y="233"/>
                  </a:cubicBezTo>
                  <a:cubicBezTo>
                    <a:pt x="451" y="235"/>
                    <a:pt x="453" y="237"/>
                    <a:pt x="455" y="240"/>
                  </a:cubicBezTo>
                  <a:cubicBezTo>
                    <a:pt x="458" y="243"/>
                    <a:pt x="460" y="245"/>
                    <a:pt x="462" y="248"/>
                  </a:cubicBezTo>
                  <a:cubicBezTo>
                    <a:pt x="463" y="250"/>
                    <a:pt x="465" y="252"/>
                    <a:pt x="465" y="253"/>
                  </a:cubicBezTo>
                  <a:cubicBezTo>
                    <a:pt x="466" y="255"/>
                    <a:pt x="466" y="257"/>
                    <a:pt x="466" y="258"/>
                  </a:cubicBezTo>
                  <a:cubicBezTo>
                    <a:pt x="466" y="259"/>
                    <a:pt x="465" y="260"/>
                    <a:pt x="464" y="260"/>
                  </a:cubicBezTo>
                  <a:cubicBezTo>
                    <a:pt x="463" y="261"/>
                    <a:pt x="461" y="262"/>
                    <a:pt x="458" y="263"/>
                  </a:cubicBezTo>
                  <a:cubicBezTo>
                    <a:pt x="455" y="264"/>
                    <a:pt x="451" y="265"/>
                    <a:pt x="446" y="267"/>
                  </a:cubicBezTo>
                  <a:cubicBezTo>
                    <a:pt x="441" y="268"/>
                    <a:pt x="436" y="271"/>
                    <a:pt x="430" y="274"/>
                  </a:cubicBezTo>
                  <a:cubicBezTo>
                    <a:pt x="424" y="278"/>
                    <a:pt x="417" y="282"/>
                    <a:pt x="410" y="289"/>
                  </a:cubicBezTo>
                  <a:cubicBezTo>
                    <a:pt x="404" y="294"/>
                    <a:pt x="399" y="300"/>
                    <a:pt x="395" y="306"/>
                  </a:cubicBezTo>
                  <a:cubicBezTo>
                    <a:pt x="392" y="311"/>
                    <a:pt x="389" y="317"/>
                    <a:pt x="388" y="323"/>
                  </a:cubicBezTo>
                  <a:cubicBezTo>
                    <a:pt x="387" y="329"/>
                    <a:pt x="388" y="335"/>
                    <a:pt x="390" y="341"/>
                  </a:cubicBezTo>
                  <a:cubicBezTo>
                    <a:pt x="392" y="347"/>
                    <a:pt x="395" y="352"/>
                    <a:pt x="401" y="358"/>
                  </a:cubicBezTo>
                  <a:cubicBezTo>
                    <a:pt x="405" y="363"/>
                    <a:pt x="410" y="367"/>
                    <a:pt x="415" y="369"/>
                  </a:cubicBezTo>
                  <a:cubicBezTo>
                    <a:pt x="420" y="372"/>
                    <a:pt x="426" y="373"/>
                    <a:pt x="432" y="373"/>
                  </a:cubicBezTo>
                  <a:cubicBezTo>
                    <a:pt x="437" y="372"/>
                    <a:pt x="444" y="370"/>
                    <a:pt x="450" y="367"/>
                  </a:cubicBezTo>
                  <a:cubicBezTo>
                    <a:pt x="457" y="363"/>
                    <a:pt x="464" y="358"/>
                    <a:pt x="471" y="351"/>
                  </a:cubicBezTo>
                  <a:cubicBezTo>
                    <a:pt x="477" y="346"/>
                    <a:pt x="482" y="341"/>
                    <a:pt x="487" y="335"/>
                  </a:cubicBezTo>
                  <a:cubicBezTo>
                    <a:pt x="491" y="330"/>
                    <a:pt x="496" y="326"/>
                    <a:pt x="500" y="322"/>
                  </a:cubicBezTo>
                  <a:cubicBezTo>
                    <a:pt x="503" y="319"/>
                    <a:pt x="506" y="318"/>
                    <a:pt x="508" y="318"/>
                  </a:cubicBezTo>
                  <a:cubicBezTo>
                    <a:pt x="511" y="318"/>
                    <a:pt x="514" y="321"/>
                    <a:pt x="518" y="325"/>
                  </a:cubicBezTo>
                  <a:lnTo>
                    <a:pt x="598" y="412"/>
                  </a:lnTo>
                  <a:cubicBezTo>
                    <a:pt x="602" y="416"/>
                    <a:pt x="604" y="420"/>
                    <a:pt x="604" y="423"/>
                  </a:cubicBezTo>
                  <a:cubicBezTo>
                    <a:pt x="604" y="427"/>
                    <a:pt x="602" y="430"/>
                    <a:pt x="598" y="433"/>
                  </a:cubicBezTo>
                  <a:lnTo>
                    <a:pt x="503" y="520"/>
                  </a:lnTo>
                  <a:cubicBezTo>
                    <a:pt x="502" y="521"/>
                    <a:pt x="501" y="522"/>
                    <a:pt x="499" y="522"/>
                  </a:cubicBezTo>
                  <a:cubicBezTo>
                    <a:pt x="498" y="522"/>
                    <a:pt x="496" y="522"/>
                    <a:pt x="495" y="521"/>
                  </a:cubicBezTo>
                  <a:cubicBezTo>
                    <a:pt x="493" y="520"/>
                    <a:pt x="491" y="519"/>
                    <a:pt x="489" y="517"/>
                  </a:cubicBezTo>
                  <a:cubicBezTo>
                    <a:pt x="486" y="515"/>
                    <a:pt x="484" y="512"/>
                    <a:pt x="481" y="509"/>
                  </a:cubicBezTo>
                  <a:cubicBezTo>
                    <a:pt x="475" y="503"/>
                    <a:pt x="472" y="498"/>
                    <a:pt x="470" y="494"/>
                  </a:cubicBezTo>
                  <a:cubicBezTo>
                    <a:pt x="469" y="490"/>
                    <a:pt x="469" y="487"/>
                    <a:pt x="471" y="485"/>
                  </a:cubicBezTo>
                  <a:lnTo>
                    <a:pt x="543" y="420"/>
                  </a:lnTo>
                  <a:lnTo>
                    <a:pt x="503" y="377"/>
                  </a:lnTo>
                  <a:cubicBezTo>
                    <a:pt x="500" y="380"/>
                    <a:pt x="497" y="384"/>
                    <a:pt x="493" y="387"/>
                  </a:cubicBezTo>
                  <a:cubicBezTo>
                    <a:pt x="490" y="391"/>
                    <a:pt x="486" y="394"/>
                    <a:pt x="482" y="398"/>
                  </a:cubicBezTo>
                  <a:cubicBezTo>
                    <a:pt x="471" y="408"/>
                    <a:pt x="460" y="415"/>
                    <a:pt x="449" y="421"/>
                  </a:cubicBezTo>
                  <a:cubicBezTo>
                    <a:pt x="439" y="426"/>
                    <a:pt x="428" y="428"/>
                    <a:pt x="418" y="429"/>
                  </a:cubicBezTo>
                  <a:cubicBezTo>
                    <a:pt x="408" y="429"/>
                    <a:pt x="398" y="427"/>
                    <a:pt x="388" y="422"/>
                  </a:cubicBezTo>
                  <a:cubicBezTo>
                    <a:pt x="378" y="418"/>
                    <a:pt x="369" y="411"/>
                    <a:pt x="360" y="401"/>
                  </a:cubicBezTo>
                  <a:close/>
                  <a:moveTo>
                    <a:pt x="148" y="505"/>
                  </a:moveTo>
                  <a:cubicBezTo>
                    <a:pt x="146" y="502"/>
                    <a:pt x="143" y="499"/>
                    <a:pt x="142" y="497"/>
                  </a:cubicBezTo>
                  <a:cubicBezTo>
                    <a:pt x="140" y="495"/>
                    <a:pt x="139" y="493"/>
                    <a:pt x="138" y="491"/>
                  </a:cubicBezTo>
                  <a:cubicBezTo>
                    <a:pt x="137" y="489"/>
                    <a:pt x="137" y="487"/>
                    <a:pt x="137" y="486"/>
                  </a:cubicBezTo>
                  <a:cubicBezTo>
                    <a:pt x="138" y="485"/>
                    <a:pt x="138" y="484"/>
                    <a:pt x="139" y="483"/>
                  </a:cubicBezTo>
                  <a:lnTo>
                    <a:pt x="255" y="377"/>
                  </a:lnTo>
                  <a:cubicBezTo>
                    <a:pt x="258" y="375"/>
                    <a:pt x="260" y="373"/>
                    <a:pt x="262" y="372"/>
                  </a:cubicBezTo>
                  <a:cubicBezTo>
                    <a:pt x="264" y="371"/>
                    <a:pt x="266" y="370"/>
                    <a:pt x="268" y="371"/>
                  </a:cubicBezTo>
                  <a:cubicBezTo>
                    <a:pt x="270" y="371"/>
                    <a:pt x="273" y="372"/>
                    <a:pt x="275" y="374"/>
                  </a:cubicBezTo>
                  <a:cubicBezTo>
                    <a:pt x="278" y="376"/>
                    <a:pt x="281" y="378"/>
                    <a:pt x="284" y="382"/>
                  </a:cubicBezTo>
                  <a:cubicBezTo>
                    <a:pt x="287" y="386"/>
                    <a:pt x="290" y="389"/>
                    <a:pt x="292" y="391"/>
                  </a:cubicBezTo>
                  <a:cubicBezTo>
                    <a:pt x="293" y="394"/>
                    <a:pt x="295" y="397"/>
                    <a:pt x="296" y="399"/>
                  </a:cubicBezTo>
                  <a:cubicBezTo>
                    <a:pt x="297" y="402"/>
                    <a:pt x="297" y="405"/>
                    <a:pt x="298" y="408"/>
                  </a:cubicBezTo>
                  <a:cubicBezTo>
                    <a:pt x="298" y="411"/>
                    <a:pt x="298" y="414"/>
                    <a:pt x="298" y="419"/>
                  </a:cubicBezTo>
                  <a:lnTo>
                    <a:pt x="297" y="488"/>
                  </a:lnTo>
                  <a:cubicBezTo>
                    <a:pt x="297" y="501"/>
                    <a:pt x="297" y="513"/>
                    <a:pt x="299" y="523"/>
                  </a:cubicBezTo>
                  <a:cubicBezTo>
                    <a:pt x="300" y="533"/>
                    <a:pt x="302" y="541"/>
                    <a:pt x="304" y="548"/>
                  </a:cubicBezTo>
                  <a:cubicBezTo>
                    <a:pt x="306" y="556"/>
                    <a:pt x="308" y="562"/>
                    <a:pt x="311" y="567"/>
                  </a:cubicBezTo>
                  <a:cubicBezTo>
                    <a:pt x="314" y="572"/>
                    <a:pt x="317" y="576"/>
                    <a:pt x="321" y="580"/>
                  </a:cubicBezTo>
                  <a:cubicBezTo>
                    <a:pt x="324" y="583"/>
                    <a:pt x="327" y="586"/>
                    <a:pt x="331" y="588"/>
                  </a:cubicBezTo>
                  <a:cubicBezTo>
                    <a:pt x="335" y="590"/>
                    <a:pt x="339" y="591"/>
                    <a:pt x="343" y="592"/>
                  </a:cubicBezTo>
                  <a:cubicBezTo>
                    <a:pt x="348" y="592"/>
                    <a:pt x="352" y="591"/>
                    <a:pt x="356" y="590"/>
                  </a:cubicBezTo>
                  <a:cubicBezTo>
                    <a:pt x="361" y="588"/>
                    <a:pt x="365" y="585"/>
                    <a:pt x="369" y="581"/>
                  </a:cubicBezTo>
                  <a:cubicBezTo>
                    <a:pt x="376" y="576"/>
                    <a:pt x="380" y="570"/>
                    <a:pt x="384" y="564"/>
                  </a:cubicBezTo>
                  <a:cubicBezTo>
                    <a:pt x="387" y="558"/>
                    <a:pt x="389" y="553"/>
                    <a:pt x="391" y="547"/>
                  </a:cubicBezTo>
                  <a:cubicBezTo>
                    <a:pt x="393" y="542"/>
                    <a:pt x="394" y="538"/>
                    <a:pt x="395" y="534"/>
                  </a:cubicBezTo>
                  <a:cubicBezTo>
                    <a:pt x="396" y="530"/>
                    <a:pt x="397" y="528"/>
                    <a:pt x="399" y="526"/>
                  </a:cubicBezTo>
                  <a:cubicBezTo>
                    <a:pt x="400" y="525"/>
                    <a:pt x="401" y="525"/>
                    <a:pt x="402" y="525"/>
                  </a:cubicBezTo>
                  <a:cubicBezTo>
                    <a:pt x="403" y="525"/>
                    <a:pt x="405" y="526"/>
                    <a:pt x="407" y="527"/>
                  </a:cubicBezTo>
                  <a:cubicBezTo>
                    <a:pt x="408" y="528"/>
                    <a:pt x="410" y="529"/>
                    <a:pt x="413" y="532"/>
                  </a:cubicBezTo>
                  <a:cubicBezTo>
                    <a:pt x="415" y="534"/>
                    <a:pt x="418" y="537"/>
                    <a:pt x="421" y="540"/>
                  </a:cubicBezTo>
                  <a:cubicBezTo>
                    <a:pt x="424" y="543"/>
                    <a:pt x="425" y="545"/>
                    <a:pt x="427" y="546"/>
                  </a:cubicBezTo>
                  <a:cubicBezTo>
                    <a:pt x="428" y="548"/>
                    <a:pt x="429" y="550"/>
                    <a:pt x="430" y="551"/>
                  </a:cubicBezTo>
                  <a:cubicBezTo>
                    <a:pt x="431" y="553"/>
                    <a:pt x="431" y="554"/>
                    <a:pt x="431" y="555"/>
                  </a:cubicBezTo>
                  <a:cubicBezTo>
                    <a:pt x="432" y="557"/>
                    <a:pt x="432" y="559"/>
                    <a:pt x="432" y="561"/>
                  </a:cubicBezTo>
                  <a:cubicBezTo>
                    <a:pt x="431" y="564"/>
                    <a:pt x="431" y="567"/>
                    <a:pt x="429" y="572"/>
                  </a:cubicBezTo>
                  <a:cubicBezTo>
                    <a:pt x="427" y="578"/>
                    <a:pt x="424" y="583"/>
                    <a:pt x="421" y="590"/>
                  </a:cubicBezTo>
                  <a:cubicBezTo>
                    <a:pt x="418" y="596"/>
                    <a:pt x="413" y="603"/>
                    <a:pt x="408" y="610"/>
                  </a:cubicBezTo>
                  <a:cubicBezTo>
                    <a:pt x="403" y="617"/>
                    <a:pt x="398" y="623"/>
                    <a:pt x="391" y="629"/>
                  </a:cubicBezTo>
                  <a:cubicBezTo>
                    <a:pt x="380" y="639"/>
                    <a:pt x="370" y="646"/>
                    <a:pt x="360" y="650"/>
                  </a:cubicBezTo>
                  <a:cubicBezTo>
                    <a:pt x="350" y="655"/>
                    <a:pt x="340" y="657"/>
                    <a:pt x="330" y="657"/>
                  </a:cubicBezTo>
                  <a:cubicBezTo>
                    <a:pt x="321" y="657"/>
                    <a:pt x="312" y="655"/>
                    <a:pt x="303" y="651"/>
                  </a:cubicBezTo>
                  <a:cubicBezTo>
                    <a:pt x="295" y="647"/>
                    <a:pt x="287" y="641"/>
                    <a:pt x="280" y="633"/>
                  </a:cubicBezTo>
                  <a:cubicBezTo>
                    <a:pt x="274" y="627"/>
                    <a:pt x="269" y="620"/>
                    <a:pt x="265" y="612"/>
                  </a:cubicBezTo>
                  <a:cubicBezTo>
                    <a:pt x="260" y="605"/>
                    <a:pt x="256" y="596"/>
                    <a:pt x="254" y="585"/>
                  </a:cubicBezTo>
                  <a:cubicBezTo>
                    <a:pt x="251" y="574"/>
                    <a:pt x="249" y="561"/>
                    <a:pt x="248" y="545"/>
                  </a:cubicBezTo>
                  <a:cubicBezTo>
                    <a:pt x="247" y="530"/>
                    <a:pt x="247" y="511"/>
                    <a:pt x="248" y="488"/>
                  </a:cubicBezTo>
                  <a:lnTo>
                    <a:pt x="250" y="443"/>
                  </a:lnTo>
                  <a:lnTo>
                    <a:pt x="170" y="515"/>
                  </a:lnTo>
                  <a:cubicBezTo>
                    <a:pt x="169" y="516"/>
                    <a:pt x="168" y="517"/>
                    <a:pt x="167" y="517"/>
                  </a:cubicBezTo>
                  <a:cubicBezTo>
                    <a:pt x="165" y="517"/>
                    <a:pt x="164" y="517"/>
                    <a:pt x="162" y="516"/>
                  </a:cubicBezTo>
                  <a:cubicBezTo>
                    <a:pt x="160" y="515"/>
                    <a:pt x="158" y="514"/>
                    <a:pt x="156" y="512"/>
                  </a:cubicBezTo>
                  <a:cubicBezTo>
                    <a:pt x="153" y="510"/>
                    <a:pt x="151" y="508"/>
                    <a:pt x="148" y="505"/>
                  </a:cubicBezTo>
                  <a:close/>
                  <a:moveTo>
                    <a:pt x="56" y="745"/>
                  </a:moveTo>
                  <a:cubicBezTo>
                    <a:pt x="42" y="729"/>
                    <a:pt x="30" y="713"/>
                    <a:pt x="20" y="698"/>
                  </a:cubicBezTo>
                  <a:cubicBezTo>
                    <a:pt x="11" y="682"/>
                    <a:pt x="5" y="667"/>
                    <a:pt x="3" y="653"/>
                  </a:cubicBezTo>
                  <a:cubicBezTo>
                    <a:pt x="0" y="638"/>
                    <a:pt x="2" y="624"/>
                    <a:pt x="7" y="611"/>
                  </a:cubicBezTo>
                  <a:cubicBezTo>
                    <a:pt x="11" y="597"/>
                    <a:pt x="21" y="584"/>
                    <a:pt x="34" y="572"/>
                  </a:cubicBezTo>
                  <a:cubicBezTo>
                    <a:pt x="48" y="559"/>
                    <a:pt x="62" y="551"/>
                    <a:pt x="75" y="548"/>
                  </a:cubicBezTo>
                  <a:cubicBezTo>
                    <a:pt x="88" y="544"/>
                    <a:pt x="102" y="545"/>
                    <a:pt x="115" y="549"/>
                  </a:cubicBezTo>
                  <a:cubicBezTo>
                    <a:pt x="129" y="553"/>
                    <a:pt x="142" y="560"/>
                    <a:pt x="156" y="571"/>
                  </a:cubicBezTo>
                  <a:cubicBezTo>
                    <a:pt x="170" y="582"/>
                    <a:pt x="184" y="595"/>
                    <a:pt x="199" y="612"/>
                  </a:cubicBezTo>
                  <a:cubicBezTo>
                    <a:pt x="214" y="628"/>
                    <a:pt x="226" y="643"/>
                    <a:pt x="235" y="659"/>
                  </a:cubicBezTo>
                  <a:cubicBezTo>
                    <a:pt x="244" y="674"/>
                    <a:pt x="250" y="689"/>
                    <a:pt x="252" y="704"/>
                  </a:cubicBezTo>
                  <a:cubicBezTo>
                    <a:pt x="255" y="718"/>
                    <a:pt x="254" y="732"/>
                    <a:pt x="249" y="746"/>
                  </a:cubicBezTo>
                  <a:cubicBezTo>
                    <a:pt x="244" y="759"/>
                    <a:pt x="235" y="772"/>
                    <a:pt x="221" y="784"/>
                  </a:cubicBezTo>
                  <a:cubicBezTo>
                    <a:pt x="207" y="797"/>
                    <a:pt x="194" y="805"/>
                    <a:pt x="180" y="809"/>
                  </a:cubicBezTo>
                  <a:cubicBezTo>
                    <a:pt x="167" y="812"/>
                    <a:pt x="153" y="812"/>
                    <a:pt x="140" y="808"/>
                  </a:cubicBezTo>
                  <a:cubicBezTo>
                    <a:pt x="127" y="804"/>
                    <a:pt x="113" y="796"/>
                    <a:pt x="99" y="785"/>
                  </a:cubicBezTo>
                  <a:cubicBezTo>
                    <a:pt x="85" y="774"/>
                    <a:pt x="71" y="761"/>
                    <a:pt x="56" y="745"/>
                  </a:cubicBezTo>
                  <a:close/>
                  <a:moveTo>
                    <a:pt x="96" y="705"/>
                  </a:moveTo>
                  <a:cubicBezTo>
                    <a:pt x="105" y="715"/>
                    <a:pt x="112" y="723"/>
                    <a:pt x="120" y="730"/>
                  </a:cubicBezTo>
                  <a:cubicBezTo>
                    <a:pt x="127" y="736"/>
                    <a:pt x="133" y="742"/>
                    <a:pt x="140" y="746"/>
                  </a:cubicBezTo>
                  <a:cubicBezTo>
                    <a:pt x="146" y="751"/>
                    <a:pt x="151" y="754"/>
                    <a:pt x="156" y="756"/>
                  </a:cubicBezTo>
                  <a:cubicBezTo>
                    <a:pt x="161" y="759"/>
                    <a:pt x="166" y="760"/>
                    <a:pt x="170" y="760"/>
                  </a:cubicBezTo>
                  <a:cubicBezTo>
                    <a:pt x="174" y="760"/>
                    <a:pt x="178" y="759"/>
                    <a:pt x="182" y="758"/>
                  </a:cubicBezTo>
                  <a:cubicBezTo>
                    <a:pt x="186" y="756"/>
                    <a:pt x="190" y="754"/>
                    <a:pt x="193" y="750"/>
                  </a:cubicBezTo>
                  <a:cubicBezTo>
                    <a:pt x="199" y="745"/>
                    <a:pt x="203" y="739"/>
                    <a:pt x="204" y="732"/>
                  </a:cubicBezTo>
                  <a:cubicBezTo>
                    <a:pt x="206" y="725"/>
                    <a:pt x="205" y="718"/>
                    <a:pt x="202" y="710"/>
                  </a:cubicBezTo>
                  <a:cubicBezTo>
                    <a:pt x="199" y="702"/>
                    <a:pt x="193" y="693"/>
                    <a:pt x="186" y="683"/>
                  </a:cubicBezTo>
                  <a:cubicBezTo>
                    <a:pt x="179" y="674"/>
                    <a:pt x="170" y="663"/>
                    <a:pt x="160" y="651"/>
                  </a:cubicBezTo>
                  <a:cubicBezTo>
                    <a:pt x="147" y="637"/>
                    <a:pt x="135" y="626"/>
                    <a:pt x="125" y="617"/>
                  </a:cubicBezTo>
                  <a:cubicBezTo>
                    <a:pt x="116" y="609"/>
                    <a:pt x="107" y="603"/>
                    <a:pt x="100" y="600"/>
                  </a:cubicBezTo>
                  <a:cubicBezTo>
                    <a:pt x="92" y="596"/>
                    <a:pt x="85" y="595"/>
                    <a:pt x="79" y="597"/>
                  </a:cubicBezTo>
                  <a:cubicBezTo>
                    <a:pt x="74" y="598"/>
                    <a:pt x="68" y="601"/>
                    <a:pt x="63" y="606"/>
                  </a:cubicBezTo>
                  <a:cubicBezTo>
                    <a:pt x="58" y="610"/>
                    <a:pt x="55" y="614"/>
                    <a:pt x="54" y="618"/>
                  </a:cubicBezTo>
                  <a:cubicBezTo>
                    <a:pt x="52" y="622"/>
                    <a:pt x="51" y="626"/>
                    <a:pt x="51" y="631"/>
                  </a:cubicBezTo>
                  <a:cubicBezTo>
                    <a:pt x="51" y="636"/>
                    <a:pt x="52" y="641"/>
                    <a:pt x="54" y="646"/>
                  </a:cubicBezTo>
                  <a:cubicBezTo>
                    <a:pt x="56" y="652"/>
                    <a:pt x="59" y="657"/>
                    <a:pt x="63" y="663"/>
                  </a:cubicBezTo>
                  <a:cubicBezTo>
                    <a:pt x="66" y="669"/>
                    <a:pt x="71" y="676"/>
                    <a:pt x="77" y="683"/>
                  </a:cubicBezTo>
                  <a:cubicBezTo>
                    <a:pt x="82" y="690"/>
                    <a:pt x="89" y="697"/>
                    <a:pt x="96" y="705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26"/>
            <p:cNvSpPr/>
            <p:nvPr/>
          </p:nvSpPr>
          <p:spPr>
            <a:xfrm>
              <a:off x="3632040" y="3322800"/>
              <a:ext cx="331920" cy="280800"/>
            </a:xfrm>
            <a:custGeom>
              <a:avLst/>
              <a:gdLst>
                <a:gd name="textAreaLeft" fmla="*/ 0 w 331920"/>
                <a:gd name="textAreaRight" fmla="*/ 332280 w 331920"/>
                <a:gd name="textAreaTop" fmla="*/ 0 h 280800"/>
                <a:gd name="textAreaBottom" fmla="*/ 281160 h 280800"/>
              </a:gdLst>
              <a:ahLst/>
              <a:rect l="textAreaLeft" t="textAreaTop" r="textAreaRight" b="textAreaBottom"/>
              <a:pathLst>
                <a:path w="882" h="754">
                  <a:moveTo>
                    <a:pt x="743" y="487"/>
                  </a:moveTo>
                  <a:cubicBezTo>
                    <a:pt x="746" y="484"/>
                    <a:pt x="748" y="482"/>
                    <a:pt x="750" y="480"/>
                  </a:cubicBezTo>
                  <a:cubicBezTo>
                    <a:pt x="752" y="478"/>
                    <a:pt x="754" y="477"/>
                    <a:pt x="756" y="476"/>
                  </a:cubicBezTo>
                  <a:cubicBezTo>
                    <a:pt x="757" y="475"/>
                    <a:pt x="759" y="475"/>
                    <a:pt x="760" y="475"/>
                  </a:cubicBezTo>
                  <a:cubicBezTo>
                    <a:pt x="761" y="475"/>
                    <a:pt x="762" y="476"/>
                    <a:pt x="763" y="476"/>
                  </a:cubicBezTo>
                  <a:lnTo>
                    <a:pt x="880" y="571"/>
                  </a:lnTo>
                  <a:cubicBezTo>
                    <a:pt x="881" y="572"/>
                    <a:pt x="882" y="573"/>
                    <a:pt x="882" y="574"/>
                  </a:cubicBezTo>
                  <a:cubicBezTo>
                    <a:pt x="882" y="575"/>
                    <a:pt x="882" y="577"/>
                    <a:pt x="882" y="578"/>
                  </a:cubicBezTo>
                  <a:cubicBezTo>
                    <a:pt x="881" y="580"/>
                    <a:pt x="880" y="582"/>
                    <a:pt x="879" y="585"/>
                  </a:cubicBezTo>
                  <a:cubicBezTo>
                    <a:pt x="878" y="587"/>
                    <a:pt x="876" y="590"/>
                    <a:pt x="873" y="593"/>
                  </a:cubicBezTo>
                  <a:cubicBezTo>
                    <a:pt x="871" y="596"/>
                    <a:pt x="868" y="599"/>
                    <a:pt x="866" y="600"/>
                  </a:cubicBezTo>
                  <a:cubicBezTo>
                    <a:pt x="864" y="602"/>
                    <a:pt x="863" y="604"/>
                    <a:pt x="861" y="605"/>
                  </a:cubicBezTo>
                  <a:cubicBezTo>
                    <a:pt x="859" y="605"/>
                    <a:pt x="858" y="606"/>
                    <a:pt x="857" y="606"/>
                  </a:cubicBezTo>
                  <a:cubicBezTo>
                    <a:pt x="855" y="606"/>
                    <a:pt x="854" y="605"/>
                    <a:pt x="853" y="605"/>
                  </a:cubicBezTo>
                  <a:lnTo>
                    <a:pt x="814" y="572"/>
                  </a:lnTo>
                  <a:lnTo>
                    <a:pt x="702" y="710"/>
                  </a:lnTo>
                  <a:lnTo>
                    <a:pt x="751" y="719"/>
                  </a:lnTo>
                  <a:cubicBezTo>
                    <a:pt x="755" y="720"/>
                    <a:pt x="757" y="721"/>
                    <a:pt x="759" y="722"/>
                  </a:cubicBezTo>
                  <a:cubicBezTo>
                    <a:pt x="761" y="723"/>
                    <a:pt x="762" y="724"/>
                    <a:pt x="762" y="726"/>
                  </a:cubicBezTo>
                  <a:cubicBezTo>
                    <a:pt x="762" y="728"/>
                    <a:pt x="761" y="730"/>
                    <a:pt x="760" y="732"/>
                  </a:cubicBezTo>
                  <a:cubicBezTo>
                    <a:pt x="758" y="735"/>
                    <a:pt x="756" y="738"/>
                    <a:pt x="753" y="742"/>
                  </a:cubicBezTo>
                  <a:cubicBezTo>
                    <a:pt x="750" y="745"/>
                    <a:pt x="749" y="747"/>
                    <a:pt x="747" y="749"/>
                  </a:cubicBezTo>
                  <a:cubicBezTo>
                    <a:pt x="746" y="750"/>
                    <a:pt x="744" y="752"/>
                    <a:pt x="743" y="752"/>
                  </a:cubicBezTo>
                  <a:cubicBezTo>
                    <a:pt x="741" y="753"/>
                    <a:pt x="740" y="754"/>
                    <a:pt x="739" y="754"/>
                  </a:cubicBezTo>
                  <a:cubicBezTo>
                    <a:pt x="737" y="754"/>
                    <a:pt x="736" y="754"/>
                    <a:pt x="734" y="754"/>
                  </a:cubicBezTo>
                  <a:lnTo>
                    <a:pt x="664" y="746"/>
                  </a:lnTo>
                  <a:cubicBezTo>
                    <a:pt x="663" y="746"/>
                    <a:pt x="662" y="746"/>
                    <a:pt x="661" y="746"/>
                  </a:cubicBezTo>
                  <a:cubicBezTo>
                    <a:pt x="660" y="745"/>
                    <a:pt x="659" y="745"/>
                    <a:pt x="657" y="744"/>
                  </a:cubicBezTo>
                  <a:cubicBezTo>
                    <a:pt x="656" y="743"/>
                    <a:pt x="654" y="742"/>
                    <a:pt x="652" y="740"/>
                  </a:cubicBezTo>
                  <a:cubicBezTo>
                    <a:pt x="650" y="738"/>
                    <a:pt x="647" y="736"/>
                    <a:pt x="644" y="733"/>
                  </a:cubicBezTo>
                  <a:cubicBezTo>
                    <a:pt x="640" y="730"/>
                    <a:pt x="636" y="727"/>
                    <a:pt x="634" y="725"/>
                  </a:cubicBezTo>
                  <a:cubicBezTo>
                    <a:pt x="631" y="723"/>
                    <a:pt x="630" y="721"/>
                    <a:pt x="629" y="719"/>
                  </a:cubicBezTo>
                  <a:cubicBezTo>
                    <a:pt x="628" y="718"/>
                    <a:pt x="627" y="717"/>
                    <a:pt x="627" y="716"/>
                  </a:cubicBezTo>
                  <a:cubicBezTo>
                    <a:pt x="627" y="715"/>
                    <a:pt x="628" y="714"/>
                    <a:pt x="629" y="713"/>
                  </a:cubicBezTo>
                  <a:lnTo>
                    <a:pt x="771" y="538"/>
                  </a:lnTo>
                  <a:lnTo>
                    <a:pt x="736" y="510"/>
                  </a:lnTo>
                  <a:cubicBezTo>
                    <a:pt x="735" y="509"/>
                    <a:pt x="735" y="508"/>
                    <a:pt x="734" y="506"/>
                  </a:cubicBezTo>
                  <a:cubicBezTo>
                    <a:pt x="734" y="505"/>
                    <a:pt x="734" y="504"/>
                    <a:pt x="734" y="502"/>
                  </a:cubicBezTo>
                  <a:cubicBezTo>
                    <a:pt x="735" y="500"/>
                    <a:pt x="736" y="498"/>
                    <a:pt x="737" y="496"/>
                  </a:cubicBezTo>
                  <a:cubicBezTo>
                    <a:pt x="739" y="493"/>
                    <a:pt x="741" y="491"/>
                    <a:pt x="743" y="487"/>
                  </a:cubicBezTo>
                  <a:close/>
                  <a:moveTo>
                    <a:pt x="644" y="429"/>
                  </a:moveTo>
                  <a:cubicBezTo>
                    <a:pt x="647" y="425"/>
                    <a:pt x="651" y="421"/>
                    <a:pt x="654" y="418"/>
                  </a:cubicBezTo>
                  <a:cubicBezTo>
                    <a:pt x="657" y="415"/>
                    <a:pt x="661" y="412"/>
                    <a:pt x="664" y="410"/>
                  </a:cubicBezTo>
                  <a:cubicBezTo>
                    <a:pt x="668" y="407"/>
                    <a:pt x="672" y="405"/>
                    <a:pt x="676" y="403"/>
                  </a:cubicBezTo>
                  <a:cubicBezTo>
                    <a:pt x="680" y="402"/>
                    <a:pt x="684" y="400"/>
                    <a:pt x="689" y="399"/>
                  </a:cubicBezTo>
                  <a:lnTo>
                    <a:pt x="736" y="385"/>
                  </a:lnTo>
                  <a:cubicBezTo>
                    <a:pt x="738" y="385"/>
                    <a:pt x="740" y="385"/>
                    <a:pt x="741" y="385"/>
                  </a:cubicBezTo>
                  <a:cubicBezTo>
                    <a:pt x="743" y="385"/>
                    <a:pt x="744" y="385"/>
                    <a:pt x="746" y="385"/>
                  </a:cubicBezTo>
                  <a:cubicBezTo>
                    <a:pt x="748" y="386"/>
                    <a:pt x="750" y="387"/>
                    <a:pt x="752" y="388"/>
                  </a:cubicBezTo>
                  <a:cubicBezTo>
                    <a:pt x="754" y="389"/>
                    <a:pt x="756" y="391"/>
                    <a:pt x="759" y="394"/>
                  </a:cubicBezTo>
                  <a:cubicBezTo>
                    <a:pt x="762" y="396"/>
                    <a:pt x="765" y="398"/>
                    <a:pt x="766" y="400"/>
                  </a:cubicBezTo>
                  <a:cubicBezTo>
                    <a:pt x="768" y="402"/>
                    <a:pt x="769" y="404"/>
                    <a:pt x="770" y="405"/>
                  </a:cubicBezTo>
                  <a:cubicBezTo>
                    <a:pt x="770" y="406"/>
                    <a:pt x="770" y="407"/>
                    <a:pt x="769" y="408"/>
                  </a:cubicBezTo>
                  <a:cubicBezTo>
                    <a:pt x="769" y="409"/>
                    <a:pt x="768" y="410"/>
                    <a:pt x="766" y="411"/>
                  </a:cubicBezTo>
                  <a:lnTo>
                    <a:pt x="709" y="440"/>
                  </a:lnTo>
                  <a:lnTo>
                    <a:pt x="688" y="465"/>
                  </a:lnTo>
                  <a:cubicBezTo>
                    <a:pt x="685" y="469"/>
                    <a:pt x="682" y="472"/>
                    <a:pt x="680" y="473"/>
                  </a:cubicBezTo>
                  <a:cubicBezTo>
                    <a:pt x="677" y="475"/>
                    <a:pt x="674" y="476"/>
                    <a:pt x="671" y="475"/>
                  </a:cubicBezTo>
                  <a:cubicBezTo>
                    <a:pt x="669" y="475"/>
                    <a:pt x="666" y="474"/>
                    <a:pt x="662" y="472"/>
                  </a:cubicBezTo>
                  <a:cubicBezTo>
                    <a:pt x="659" y="470"/>
                    <a:pt x="656" y="467"/>
                    <a:pt x="652" y="464"/>
                  </a:cubicBezTo>
                  <a:cubicBezTo>
                    <a:pt x="648" y="461"/>
                    <a:pt x="645" y="458"/>
                    <a:pt x="642" y="456"/>
                  </a:cubicBezTo>
                  <a:cubicBezTo>
                    <a:pt x="640" y="453"/>
                    <a:pt x="638" y="450"/>
                    <a:pt x="637" y="448"/>
                  </a:cubicBezTo>
                  <a:cubicBezTo>
                    <a:pt x="637" y="445"/>
                    <a:pt x="637" y="442"/>
                    <a:pt x="638" y="439"/>
                  </a:cubicBezTo>
                  <a:cubicBezTo>
                    <a:pt x="639" y="436"/>
                    <a:pt x="641" y="433"/>
                    <a:pt x="644" y="429"/>
                  </a:cubicBezTo>
                  <a:close/>
                  <a:moveTo>
                    <a:pt x="483" y="276"/>
                  </a:moveTo>
                  <a:cubicBezTo>
                    <a:pt x="485" y="272"/>
                    <a:pt x="487" y="270"/>
                    <a:pt x="489" y="268"/>
                  </a:cubicBezTo>
                  <a:cubicBezTo>
                    <a:pt x="491" y="266"/>
                    <a:pt x="493" y="265"/>
                    <a:pt x="495" y="264"/>
                  </a:cubicBezTo>
                  <a:cubicBezTo>
                    <a:pt x="497" y="263"/>
                    <a:pt x="498" y="263"/>
                    <a:pt x="499" y="263"/>
                  </a:cubicBezTo>
                  <a:cubicBezTo>
                    <a:pt x="500" y="263"/>
                    <a:pt x="501" y="264"/>
                    <a:pt x="502" y="264"/>
                  </a:cubicBezTo>
                  <a:lnTo>
                    <a:pt x="619" y="359"/>
                  </a:lnTo>
                  <a:cubicBezTo>
                    <a:pt x="620" y="360"/>
                    <a:pt x="621" y="361"/>
                    <a:pt x="621" y="362"/>
                  </a:cubicBezTo>
                  <a:cubicBezTo>
                    <a:pt x="621" y="363"/>
                    <a:pt x="621" y="365"/>
                    <a:pt x="621" y="367"/>
                  </a:cubicBezTo>
                  <a:cubicBezTo>
                    <a:pt x="621" y="368"/>
                    <a:pt x="620" y="370"/>
                    <a:pt x="618" y="373"/>
                  </a:cubicBezTo>
                  <a:cubicBezTo>
                    <a:pt x="617" y="375"/>
                    <a:pt x="615" y="378"/>
                    <a:pt x="612" y="381"/>
                  </a:cubicBezTo>
                  <a:cubicBezTo>
                    <a:pt x="610" y="384"/>
                    <a:pt x="608" y="387"/>
                    <a:pt x="606" y="389"/>
                  </a:cubicBezTo>
                  <a:cubicBezTo>
                    <a:pt x="604" y="391"/>
                    <a:pt x="602" y="392"/>
                    <a:pt x="600" y="393"/>
                  </a:cubicBezTo>
                  <a:cubicBezTo>
                    <a:pt x="598" y="394"/>
                    <a:pt x="597" y="394"/>
                    <a:pt x="596" y="394"/>
                  </a:cubicBezTo>
                  <a:cubicBezTo>
                    <a:pt x="594" y="394"/>
                    <a:pt x="593" y="393"/>
                    <a:pt x="592" y="393"/>
                  </a:cubicBezTo>
                  <a:lnTo>
                    <a:pt x="553" y="361"/>
                  </a:lnTo>
                  <a:lnTo>
                    <a:pt x="441" y="498"/>
                  </a:lnTo>
                  <a:lnTo>
                    <a:pt x="490" y="507"/>
                  </a:lnTo>
                  <a:cubicBezTo>
                    <a:pt x="494" y="508"/>
                    <a:pt x="496" y="509"/>
                    <a:pt x="498" y="510"/>
                  </a:cubicBezTo>
                  <a:cubicBezTo>
                    <a:pt x="500" y="511"/>
                    <a:pt x="501" y="512"/>
                    <a:pt x="501" y="514"/>
                  </a:cubicBezTo>
                  <a:cubicBezTo>
                    <a:pt x="501" y="516"/>
                    <a:pt x="501" y="518"/>
                    <a:pt x="499" y="520"/>
                  </a:cubicBezTo>
                  <a:cubicBezTo>
                    <a:pt x="498" y="523"/>
                    <a:pt x="495" y="526"/>
                    <a:pt x="492" y="531"/>
                  </a:cubicBezTo>
                  <a:cubicBezTo>
                    <a:pt x="490" y="533"/>
                    <a:pt x="488" y="535"/>
                    <a:pt x="486" y="537"/>
                  </a:cubicBezTo>
                  <a:cubicBezTo>
                    <a:pt x="485" y="538"/>
                    <a:pt x="483" y="540"/>
                    <a:pt x="482" y="541"/>
                  </a:cubicBezTo>
                  <a:cubicBezTo>
                    <a:pt x="481" y="541"/>
                    <a:pt x="479" y="542"/>
                    <a:pt x="478" y="542"/>
                  </a:cubicBezTo>
                  <a:cubicBezTo>
                    <a:pt x="476" y="542"/>
                    <a:pt x="475" y="542"/>
                    <a:pt x="473" y="542"/>
                  </a:cubicBezTo>
                  <a:lnTo>
                    <a:pt x="403" y="534"/>
                  </a:lnTo>
                  <a:cubicBezTo>
                    <a:pt x="402" y="534"/>
                    <a:pt x="401" y="534"/>
                    <a:pt x="400" y="534"/>
                  </a:cubicBezTo>
                  <a:cubicBezTo>
                    <a:pt x="399" y="533"/>
                    <a:pt x="398" y="533"/>
                    <a:pt x="397" y="532"/>
                  </a:cubicBezTo>
                  <a:cubicBezTo>
                    <a:pt x="395" y="531"/>
                    <a:pt x="393" y="530"/>
                    <a:pt x="391" y="528"/>
                  </a:cubicBezTo>
                  <a:cubicBezTo>
                    <a:pt x="389" y="526"/>
                    <a:pt x="386" y="524"/>
                    <a:pt x="383" y="521"/>
                  </a:cubicBezTo>
                  <a:cubicBezTo>
                    <a:pt x="379" y="518"/>
                    <a:pt x="375" y="515"/>
                    <a:pt x="373" y="513"/>
                  </a:cubicBezTo>
                  <a:cubicBezTo>
                    <a:pt x="371" y="511"/>
                    <a:pt x="369" y="509"/>
                    <a:pt x="368" y="507"/>
                  </a:cubicBezTo>
                  <a:cubicBezTo>
                    <a:pt x="367" y="506"/>
                    <a:pt x="366" y="505"/>
                    <a:pt x="366" y="504"/>
                  </a:cubicBezTo>
                  <a:cubicBezTo>
                    <a:pt x="367" y="503"/>
                    <a:pt x="367" y="502"/>
                    <a:pt x="368" y="501"/>
                  </a:cubicBezTo>
                  <a:lnTo>
                    <a:pt x="510" y="326"/>
                  </a:lnTo>
                  <a:lnTo>
                    <a:pt x="475" y="298"/>
                  </a:lnTo>
                  <a:cubicBezTo>
                    <a:pt x="474" y="297"/>
                    <a:pt x="474" y="296"/>
                    <a:pt x="473" y="295"/>
                  </a:cubicBezTo>
                  <a:cubicBezTo>
                    <a:pt x="473" y="293"/>
                    <a:pt x="473" y="292"/>
                    <a:pt x="474" y="290"/>
                  </a:cubicBezTo>
                  <a:cubicBezTo>
                    <a:pt x="474" y="288"/>
                    <a:pt x="475" y="286"/>
                    <a:pt x="477" y="284"/>
                  </a:cubicBezTo>
                  <a:cubicBezTo>
                    <a:pt x="478" y="281"/>
                    <a:pt x="480" y="279"/>
                    <a:pt x="483" y="276"/>
                  </a:cubicBezTo>
                  <a:close/>
                  <a:moveTo>
                    <a:pt x="306" y="134"/>
                  </a:moveTo>
                  <a:cubicBezTo>
                    <a:pt x="308" y="131"/>
                    <a:pt x="311" y="128"/>
                    <a:pt x="313" y="126"/>
                  </a:cubicBezTo>
                  <a:cubicBezTo>
                    <a:pt x="315" y="124"/>
                    <a:pt x="317" y="123"/>
                    <a:pt x="318" y="122"/>
                  </a:cubicBezTo>
                  <a:cubicBezTo>
                    <a:pt x="320" y="121"/>
                    <a:pt x="322" y="120"/>
                    <a:pt x="323" y="120"/>
                  </a:cubicBezTo>
                  <a:cubicBezTo>
                    <a:pt x="324" y="120"/>
                    <a:pt x="326" y="121"/>
                    <a:pt x="327" y="122"/>
                  </a:cubicBezTo>
                  <a:lnTo>
                    <a:pt x="449" y="221"/>
                  </a:lnTo>
                  <a:cubicBezTo>
                    <a:pt x="451" y="223"/>
                    <a:pt x="453" y="225"/>
                    <a:pt x="454" y="226"/>
                  </a:cubicBezTo>
                  <a:cubicBezTo>
                    <a:pt x="456" y="228"/>
                    <a:pt x="456" y="230"/>
                    <a:pt x="456" y="232"/>
                  </a:cubicBezTo>
                  <a:cubicBezTo>
                    <a:pt x="457" y="235"/>
                    <a:pt x="456" y="237"/>
                    <a:pt x="454" y="240"/>
                  </a:cubicBezTo>
                  <a:cubicBezTo>
                    <a:pt x="453" y="243"/>
                    <a:pt x="451" y="246"/>
                    <a:pt x="448" y="250"/>
                  </a:cubicBezTo>
                  <a:cubicBezTo>
                    <a:pt x="445" y="253"/>
                    <a:pt x="442" y="256"/>
                    <a:pt x="440" y="259"/>
                  </a:cubicBezTo>
                  <a:cubicBezTo>
                    <a:pt x="437" y="261"/>
                    <a:pt x="435" y="263"/>
                    <a:pt x="432" y="264"/>
                  </a:cubicBezTo>
                  <a:cubicBezTo>
                    <a:pt x="430" y="265"/>
                    <a:pt x="427" y="266"/>
                    <a:pt x="424" y="267"/>
                  </a:cubicBezTo>
                  <a:cubicBezTo>
                    <a:pt x="421" y="268"/>
                    <a:pt x="418" y="269"/>
                    <a:pt x="414" y="269"/>
                  </a:cubicBezTo>
                  <a:lnTo>
                    <a:pt x="345" y="279"/>
                  </a:lnTo>
                  <a:cubicBezTo>
                    <a:pt x="331" y="280"/>
                    <a:pt x="320" y="283"/>
                    <a:pt x="310" y="285"/>
                  </a:cubicBezTo>
                  <a:cubicBezTo>
                    <a:pt x="301" y="288"/>
                    <a:pt x="293" y="291"/>
                    <a:pt x="286" y="294"/>
                  </a:cubicBezTo>
                  <a:cubicBezTo>
                    <a:pt x="279" y="297"/>
                    <a:pt x="274" y="300"/>
                    <a:pt x="269" y="304"/>
                  </a:cubicBezTo>
                  <a:cubicBezTo>
                    <a:pt x="265" y="308"/>
                    <a:pt x="261" y="311"/>
                    <a:pt x="258" y="315"/>
                  </a:cubicBezTo>
                  <a:cubicBezTo>
                    <a:pt x="255" y="319"/>
                    <a:pt x="252" y="323"/>
                    <a:pt x="251" y="327"/>
                  </a:cubicBezTo>
                  <a:cubicBezTo>
                    <a:pt x="250" y="331"/>
                    <a:pt x="249" y="335"/>
                    <a:pt x="249" y="340"/>
                  </a:cubicBezTo>
                  <a:cubicBezTo>
                    <a:pt x="250" y="344"/>
                    <a:pt x="251" y="348"/>
                    <a:pt x="253" y="352"/>
                  </a:cubicBezTo>
                  <a:cubicBezTo>
                    <a:pt x="255" y="356"/>
                    <a:pt x="259" y="360"/>
                    <a:pt x="263" y="364"/>
                  </a:cubicBezTo>
                  <a:cubicBezTo>
                    <a:pt x="270" y="369"/>
                    <a:pt x="276" y="373"/>
                    <a:pt x="282" y="375"/>
                  </a:cubicBezTo>
                  <a:cubicBezTo>
                    <a:pt x="289" y="378"/>
                    <a:pt x="295" y="379"/>
                    <a:pt x="300" y="380"/>
                  </a:cubicBezTo>
                  <a:cubicBezTo>
                    <a:pt x="305" y="381"/>
                    <a:pt x="310" y="382"/>
                    <a:pt x="314" y="382"/>
                  </a:cubicBezTo>
                  <a:cubicBezTo>
                    <a:pt x="318" y="383"/>
                    <a:pt x="321" y="384"/>
                    <a:pt x="322" y="385"/>
                  </a:cubicBezTo>
                  <a:cubicBezTo>
                    <a:pt x="323" y="386"/>
                    <a:pt x="323" y="387"/>
                    <a:pt x="324" y="388"/>
                  </a:cubicBezTo>
                  <a:cubicBezTo>
                    <a:pt x="324" y="389"/>
                    <a:pt x="324" y="391"/>
                    <a:pt x="323" y="392"/>
                  </a:cubicBezTo>
                  <a:cubicBezTo>
                    <a:pt x="322" y="394"/>
                    <a:pt x="321" y="397"/>
                    <a:pt x="319" y="399"/>
                  </a:cubicBezTo>
                  <a:cubicBezTo>
                    <a:pt x="317" y="402"/>
                    <a:pt x="315" y="405"/>
                    <a:pt x="312" y="409"/>
                  </a:cubicBezTo>
                  <a:cubicBezTo>
                    <a:pt x="310" y="412"/>
                    <a:pt x="308" y="414"/>
                    <a:pt x="306" y="415"/>
                  </a:cubicBezTo>
                  <a:cubicBezTo>
                    <a:pt x="305" y="417"/>
                    <a:pt x="303" y="418"/>
                    <a:pt x="302" y="419"/>
                  </a:cubicBezTo>
                  <a:cubicBezTo>
                    <a:pt x="301" y="420"/>
                    <a:pt x="299" y="421"/>
                    <a:pt x="298" y="421"/>
                  </a:cubicBezTo>
                  <a:cubicBezTo>
                    <a:pt x="297" y="422"/>
                    <a:pt x="295" y="422"/>
                    <a:pt x="292" y="422"/>
                  </a:cubicBezTo>
                  <a:cubicBezTo>
                    <a:pt x="290" y="423"/>
                    <a:pt x="286" y="422"/>
                    <a:pt x="281" y="421"/>
                  </a:cubicBezTo>
                  <a:cubicBezTo>
                    <a:pt x="275" y="420"/>
                    <a:pt x="269" y="419"/>
                    <a:pt x="262" y="416"/>
                  </a:cubicBezTo>
                  <a:cubicBezTo>
                    <a:pt x="256" y="414"/>
                    <a:pt x="248" y="411"/>
                    <a:pt x="241" y="407"/>
                  </a:cubicBezTo>
                  <a:cubicBezTo>
                    <a:pt x="233" y="403"/>
                    <a:pt x="226" y="398"/>
                    <a:pt x="219" y="392"/>
                  </a:cubicBezTo>
                  <a:cubicBezTo>
                    <a:pt x="208" y="383"/>
                    <a:pt x="200" y="374"/>
                    <a:pt x="194" y="365"/>
                  </a:cubicBezTo>
                  <a:cubicBezTo>
                    <a:pt x="188" y="355"/>
                    <a:pt x="184" y="346"/>
                    <a:pt x="182" y="336"/>
                  </a:cubicBezTo>
                  <a:cubicBezTo>
                    <a:pt x="181" y="327"/>
                    <a:pt x="182" y="318"/>
                    <a:pt x="185" y="309"/>
                  </a:cubicBezTo>
                  <a:cubicBezTo>
                    <a:pt x="187" y="300"/>
                    <a:pt x="192" y="291"/>
                    <a:pt x="199" y="283"/>
                  </a:cubicBezTo>
                  <a:cubicBezTo>
                    <a:pt x="204" y="277"/>
                    <a:pt x="210" y="270"/>
                    <a:pt x="217" y="265"/>
                  </a:cubicBezTo>
                  <a:cubicBezTo>
                    <a:pt x="224" y="259"/>
                    <a:pt x="232" y="254"/>
                    <a:pt x="243" y="250"/>
                  </a:cubicBezTo>
                  <a:cubicBezTo>
                    <a:pt x="253" y="245"/>
                    <a:pt x="266" y="242"/>
                    <a:pt x="281" y="238"/>
                  </a:cubicBezTo>
                  <a:cubicBezTo>
                    <a:pt x="296" y="235"/>
                    <a:pt x="315" y="233"/>
                    <a:pt x="337" y="230"/>
                  </a:cubicBezTo>
                  <a:lnTo>
                    <a:pt x="383" y="225"/>
                  </a:lnTo>
                  <a:lnTo>
                    <a:pt x="299" y="157"/>
                  </a:lnTo>
                  <a:cubicBezTo>
                    <a:pt x="298" y="156"/>
                    <a:pt x="297" y="155"/>
                    <a:pt x="297" y="154"/>
                  </a:cubicBezTo>
                  <a:cubicBezTo>
                    <a:pt x="296" y="152"/>
                    <a:pt x="296" y="151"/>
                    <a:pt x="297" y="149"/>
                  </a:cubicBezTo>
                  <a:cubicBezTo>
                    <a:pt x="297" y="147"/>
                    <a:pt x="298" y="145"/>
                    <a:pt x="300" y="142"/>
                  </a:cubicBezTo>
                  <a:cubicBezTo>
                    <a:pt x="301" y="140"/>
                    <a:pt x="303" y="137"/>
                    <a:pt x="306" y="134"/>
                  </a:cubicBezTo>
                  <a:close/>
                  <a:moveTo>
                    <a:pt x="97" y="29"/>
                  </a:moveTo>
                  <a:cubicBezTo>
                    <a:pt x="105" y="20"/>
                    <a:pt x="113" y="12"/>
                    <a:pt x="123" y="8"/>
                  </a:cubicBezTo>
                  <a:cubicBezTo>
                    <a:pt x="132" y="3"/>
                    <a:pt x="142" y="0"/>
                    <a:pt x="153" y="1"/>
                  </a:cubicBezTo>
                  <a:cubicBezTo>
                    <a:pt x="164" y="1"/>
                    <a:pt x="175" y="3"/>
                    <a:pt x="187" y="8"/>
                  </a:cubicBezTo>
                  <a:cubicBezTo>
                    <a:pt x="198" y="13"/>
                    <a:pt x="211" y="21"/>
                    <a:pt x="223" y="31"/>
                  </a:cubicBezTo>
                  <a:cubicBezTo>
                    <a:pt x="235" y="41"/>
                    <a:pt x="245" y="51"/>
                    <a:pt x="252" y="61"/>
                  </a:cubicBezTo>
                  <a:cubicBezTo>
                    <a:pt x="259" y="70"/>
                    <a:pt x="264" y="80"/>
                    <a:pt x="266" y="90"/>
                  </a:cubicBezTo>
                  <a:cubicBezTo>
                    <a:pt x="268" y="99"/>
                    <a:pt x="268" y="109"/>
                    <a:pt x="266" y="118"/>
                  </a:cubicBezTo>
                  <a:cubicBezTo>
                    <a:pt x="263" y="127"/>
                    <a:pt x="258" y="136"/>
                    <a:pt x="251" y="145"/>
                  </a:cubicBezTo>
                  <a:cubicBezTo>
                    <a:pt x="246" y="151"/>
                    <a:pt x="241" y="156"/>
                    <a:pt x="235" y="160"/>
                  </a:cubicBezTo>
                  <a:cubicBezTo>
                    <a:pt x="229" y="164"/>
                    <a:pt x="222" y="167"/>
                    <a:pt x="215" y="168"/>
                  </a:cubicBezTo>
                  <a:cubicBezTo>
                    <a:pt x="208" y="170"/>
                    <a:pt x="200" y="171"/>
                    <a:pt x="191" y="170"/>
                  </a:cubicBezTo>
                  <a:cubicBezTo>
                    <a:pt x="183" y="170"/>
                    <a:pt x="173" y="169"/>
                    <a:pt x="164" y="167"/>
                  </a:cubicBezTo>
                  <a:cubicBezTo>
                    <a:pt x="167" y="174"/>
                    <a:pt x="169" y="182"/>
                    <a:pt x="171" y="189"/>
                  </a:cubicBezTo>
                  <a:cubicBezTo>
                    <a:pt x="172" y="196"/>
                    <a:pt x="173" y="203"/>
                    <a:pt x="173" y="210"/>
                  </a:cubicBezTo>
                  <a:cubicBezTo>
                    <a:pt x="172" y="217"/>
                    <a:pt x="171" y="223"/>
                    <a:pt x="169" y="230"/>
                  </a:cubicBezTo>
                  <a:cubicBezTo>
                    <a:pt x="166" y="236"/>
                    <a:pt x="163" y="242"/>
                    <a:pt x="158" y="248"/>
                  </a:cubicBezTo>
                  <a:cubicBezTo>
                    <a:pt x="151" y="256"/>
                    <a:pt x="143" y="263"/>
                    <a:pt x="134" y="267"/>
                  </a:cubicBezTo>
                  <a:cubicBezTo>
                    <a:pt x="126" y="272"/>
                    <a:pt x="116" y="274"/>
                    <a:pt x="106" y="275"/>
                  </a:cubicBezTo>
                  <a:cubicBezTo>
                    <a:pt x="96" y="275"/>
                    <a:pt x="86" y="273"/>
                    <a:pt x="75" y="268"/>
                  </a:cubicBezTo>
                  <a:cubicBezTo>
                    <a:pt x="63" y="264"/>
                    <a:pt x="52" y="256"/>
                    <a:pt x="40" y="247"/>
                  </a:cubicBezTo>
                  <a:cubicBezTo>
                    <a:pt x="28" y="237"/>
                    <a:pt x="19" y="228"/>
                    <a:pt x="13" y="219"/>
                  </a:cubicBezTo>
                  <a:cubicBezTo>
                    <a:pt x="7" y="209"/>
                    <a:pt x="3" y="200"/>
                    <a:pt x="1" y="191"/>
                  </a:cubicBezTo>
                  <a:cubicBezTo>
                    <a:pt x="0" y="182"/>
                    <a:pt x="0" y="174"/>
                    <a:pt x="3" y="165"/>
                  </a:cubicBezTo>
                  <a:cubicBezTo>
                    <a:pt x="5" y="157"/>
                    <a:pt x="10" y="149"/>
                    <a:pt x="16" y="141"/>
                  </a:cubicBezTo>
                  <a:cubicBezTo>
                    <a:pt x="20" y="136"/>
                    <a:pt x="25" y="132"/>
                    <a:pt x="31" y="128"/>
                  </a:cubicBezTo>
                  <a:cubicBezTo>
                    <a:pt x="36" y="125"/>
                    <a:pt x="43" y="122"/>
                    <a:pt x="49" y="120"/>
                  </a:cubicBezTo>
                  <a:cubicBezTo>
                    <a:pt x="56" y="118"/>
                    <a:pt x="63" y="117"/>
                    <a:pt x="71" y="117"/>
                  </a:cubicBezTo>
                  <a:cubicBezTo>
                    <a:pt x="78" y="117"/>
                    <a:pt x="86" y="117"/>
                    <a:pt x="94" y="119"/>
                  </a:cubicBezTo>
                  <a:cubicBezTo>
                    <a:pt x="90" y="110"/>
                    <a:pt x="88" y="101"/>
                    <a:pt x="86" y="93"/>
                  </a:cubicBezTo>
                  <a:cubicBezTo>
                    <a:pt x="83" y="85"/>
                    <a:pt x="82" y="77"/>
                    <a:pt x="83" y="70"/>
                  </a:cubicBezTo>
                  <a:cubicBezTo>
                    <a:pt x="83" y="62"/>
                    <a:pt x="84" y="55"/>
                    <a:pt x="86" y="48"/>
                  </a:cubicBezTo>
                  <a:cubicBezTo>
                    <a:pt x="88" y="42"/>
                    <a:pt x="92" y="35"/>
                    <a:pt x="97" y="29"/>
                  </a:cubicBezTo>
                  <a:close/>
                  <a:moveTo>
                    <a:pt x="61" y="171"/>
                  </a:moveTo>
                  <a:cubicBezTo>
                    <a:pt x="58" y="174"/>
                    <a:pt x="55" y="178"/>
                    <a:pt x="54" y="182"/>
                  </a:cubicBezTo>
                  <a:cubicBezTo>
                    <a:pt x="53" y="186"/>
                    <a:pt x="52" y="190"/>
                    <a:pt x="53" y="194"/>
                  </a:cubicBezTo>
                  <a:cubicBezTo>
                    <a:pt x="53" y="198"/>
                    <a:pt x="55" y="202"/>
                    <a:pt x="58" y="206"/>
                  </a:cubicBezTo>
                  <a:cubicBezTo>
                    <a:pt x="60" y="210"/>
                    <a:pt x="64" y="214"/>
                    <a:pt x="68" y="218"/>
                  </a:cubicBezTo>
                  <a:cubicBezTo>
                    <a:pt x="78" y="225"/>
                    <a:pt x="86" y="229"/>
                    <a:pt x="94" y="228"/>
                  </a:cubicBezTo>
                  <a:cubicBezTo>
                    <a:pt x="102" y="227"/>
                    <a:pt x="109" y="223"/>
                    <a:pt x="115" y="216"/>
                  </a:cubicBezTo>
                  <a:cubicBezTo>
                    <a:pt x="118" y="213"/>
                    <a:pt x="120" y="209"/>
                    <a:pt x="121" y="205"/>
                  </a:cubicBezTo>
                  <a:cubicBezTo>
                    <a:pt x="122" y="201"/>
                    <a:pt x="123" y="197"/>
                    <a:pt x="122" y="192"/>
                  </a:cubicBezTo>
                  <a:cubicBezTo>
                    <a:pt x="122" y="188"/>
                    <a:pt x="121" y="183"/>
                    <a:pt x="119" y="177"/>
                  </a:cubicBezTo>
                  <a:cubicBezTo>
                    <a:pt x="118" y="171"/>
                    <a:pt x="115" y="165"/>
                    <a:pt x="112" y="158"/>
                  </a:cubicBezTo>
                  <a:cubicBezTo>
                    <a:pt x="101" y="156"/>
                    <a:pt x="90" y="156"/>
                    <a:pt x="82" y="158"/>
                  </a:cubicBezTo>
                  <a:cubicBezTo>
                    <a:pt x="73" y="160"/>
                    <a:pt x="66" y="164"/>
                    <a:pt x="61" y="171"/>
                  </a:cubicBezTo>
                  <a:close/>
                  <a:moveTo>
                    <a:pt x="142" y="61"/>
                  </a:moveTo>
                  <a:cubicBezTo>
                    <a:pt x="138" y="65"/>
                    <a:pt x="136" y="69"/>
                    <a:pt x="135" y="74"/>
                  </a:cubicBezTo>
                  <a:cubicBezTo>
                    <a:pt x="133" y="78"/>
                    <a:pt x="133" y="83"/>
                    <a:pt x="134" y="88"/>
                  </a:cubicBezTo>
                  <a:cubicBezTo>
                    <a:pt x="134" y="94"/>
                    <a:pt x="135" y="99"/>
                    <a:pt x="138" y="106"/>
                  </a:cubicBezTo>
                  <a:cubicBezTo>
                    <a:pt x="140" y="112"/>
                    <a:pt x="142" y="119"/>
                    <a:pt x="146" y="126"/>
                  </a:cubicBezTo>
                  <a:cubicBezTo>
                    <a:pt x="153" y="128"/>
                    <a:pt x="160" y="129"/>
                    <a:pt x="166" y="129"/>
                  </a:cubicBezTo>
                  <a:cubicBezTo>
                    <a:pt x="172" y="129"/>
                    <a:pt x="177" y="129"/>
                    <a:pt x="182" y="128"/>
                  </a:cubicBezTo>
                  <a:cubicBezTo>
                    <a:pt x="187" y="127"/>
                    <a:pt x="192" y="125"/>
                    <a:pt x="196" y="123"/>
                  </a:cubicBezTo>
                  <a:cubicBezTo>
                    <a:pt x="200" y="121"/>
                    <a:pt x="203" y="118"/>
                    <a:pt x="206" y="114"/>
                  </a:cubicBezTo>
                  <a:cubicBezTo>
                    <a:pt x="213" y="105"/>
                    <a:pt x="216" y="97"/>
                    <a:pt x="214" y="88"/>
                  </a:cubicBezTo>
                  <a:cubicBezTo>
                    <a:pt x="212" y="79"/>
                    <a:pt x="206" y="70"/>
                    <a:pt x="195" y="61"/>
                  </a:cubicBezTo>
                  <a:cubicBezTo>
                    <a:pt x="184" y="52"/>
                    <a:pt x="174" y="48"/>
                    <a:pt x="165" y="48"/>
                  </a:cubicBezTo>
                  <a:cubicBezTo>
                    <a:pt x="156" y="49"/>
                    <a:pt x="148" y="53"/>
                    <a:pt x="142" y="61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27"/>
            <p:cNvSpPr/>
            <p:nvPr/>
          </p:nvSpPr>
          <p:spPr>
            <a:xfrm>
              <a:off x="3300480" y="2371680"/>
              <a:ext cx="166680" cy="236520"/>
            </a:xfrm>
            <a:custGeom>
              <a:avLst/>
              <a:gdLst>
                <a:gd name="textAreaLeft" fmla="*/ 0 w 166680"/>
                <a:gd name="textAreaRight" fmla="*/ 167040 w 166680"/>
                <a:gd name="textAreaTop" fmla="*/ 0 h 236520"/>
                <a:gd name="textAreaBottom" fmla="*/ 236880 h 236520"/>
              </a:gdLst>
              <a:ahLst/>
              <a:rect l="textAreaLeft" t="textAreaTop" r="textAreaRight" b="textAreaBottom"/>
              <a:pathLst>
                <a:path w="442" h="635">
                  <a:moveTo>
                    <a:pt x="77" y="409"/>
                  </a:moveTo>
                  <a:cubicBezTo>
                    <a:pt x="81" y="410"/>
                    <a:pt x="84" y="411"/>
                    <a:pt x="87" y="412"/>
                  </a:cubicBezTo>
                  <a:cubicBezTo>
                    <a:pt x="89" y="413"/>
                    <a:pt x="92" y="415"/>
                    <a:pt x="94" y="416"/>
                  </a:cubicBezTo>
                  <a:cubicBezTo>
                    <a:pt x="97" y="417"/>
                    <a:pt x="99" y="419"/>
                    <a:pt x="101" y="420"/>
                  </a:cubicBezTo>
                  <a:cubicBezTo>
                    <a:pt x="103" y="422"/>
                    <a:pt x="105" y="423"/>
                    <a:pt x="107" y="425"/>
                  </a:cubicBezTo>
                  <a:lnTo>
                    <a:pt x="278" y="575"/>
                  </a:lnTo>
                  <a:cubicBezTo>
                    <a:pt x="279" y="576"/>
                    <a:pt x="280" y="577"/>
                    <a:pt x="281" y="579"/>
                  </a:cubicBezTo>
                  <a:cubicBezTo>
                    <a:pt x="282" y="581"/>
                    <a:pt x="282" y="583"/>
                    <a:pt x="282" y="585"/>
                  </a:cubicBezTo>
                  <a:cubicBezTo>
                    <a:pt x="282" y="588"/>
                    <a:pt x="281" y="591"/>
                    <a:pt x="280" y="594"/>
                  </a:cubicBezTo>
                  <a:cubicBezTo>
                    <a:pt x="279" y="598"/>
                    <a:pt x="278" y="602"/>
                    <a:pt x="276" y="607"/>
                  </a:cubicBezTo>
                  <a:cubicBezTo>
                    <a:pt x="274" y="615"/>
                    <a:pt x="272" y="620"/>
                    <a:pt x="270" y="624"/>
                  </a:cubicBezTo>
                  <a:cubicBezTo>
                    <a:pt x="268" y="628"/>
                    <a:pt x="267" y="631"/>
                    <a:pt x="265" y="633"/>
                  </a:cubicBezTo>
                  <a:cubicBezTo>
                    <a:pt x="263" y="634"/>
                    <a:pt x="262" y="635"/>
                    <a:pt x="260" y="634"/>
                  </a:cubicBezTo>
                  <a:cubicBezTo>
                    <a:pt x="258" y="634"/>
                    <a:pt x="257" y="633"/>
                    <a:pt x="255" y="631"/>
                  </a:cubicBezTo>
                  <a:lnTo>
                    <a:pt x="82" y="474"/>
                  </a:lnTo>
                  <a:lnTo>
                    <a:pt x="46" y="583"/>
                  </a:lnTo>
                  <a:cubicBezTo>
                    <a:pt x="46" y="586"/>
                    <a:pt x="43" y="588"/>
                    <a:pt x="39" y="588"/>
                  </a:cubicBezTo>
                  <a:cubicBezTo>
                    <a:pt x="35" y="588"/>
                    <a:pt x="29" y="587"/>
                    <a:pt x="21" y="584"/>
                  </a:cubicBezTo>
                  <a:cubicBezTo>
                    <a:pt x="17" y="583"/>
                    <a:pt x="13" y="582"/>
                    <a:pt x="10" y="580"/>
                  </a:cubicBezTo>
                  <a:cubicBezTo>
                    <a:pt x="8" y="579"/>
                    <a:pt x="6" y="578"/>
                    <a:pt x="4" y="576"/>
                  </a:cubicBezTo>
                  <a:cubicBezTo>
                    <a:pt x="2" y="575"/>
                    <a:pt x="1" y="574"/>
                    <a:pt x="1" y="572"/>
                  </a:cubicBezTo>
                  <a:cubicBezTo>
                    <a:pt x="0" y="571"/>
                    <a:pt x="0" y="570"/>
                    <a:pt x="1" y="569"/>
                  </a:cubicBezTo>
                  <a:lnTo>
                    <a:pt x="50" y="414"/>
                  </a:lnTo>
                  <a:cubicBezTo>
                    <a:pt x="51" y="412"/>
                    <a:pt x="52" y="410"/>
                    <a:pt x="53" y="408"/>
                  </a:cubicBezTo>
                  <a:cubicBezTo>
                    <a:pt x="54" y="407"/>
                    <a:pt x="55" y="406"/>
                    <a:pt x="57" y="405"/>
                  </a:cubicBezTo>
                  <a:cubicBezTo>
                    <a:pt x="59" y="405"/>
                    <a:pt x="62" y="405"/>
                    <a:pt x="65" y="406"/>
                  </a:cubicBezTo>
                  <a:cubicBezTo>
                    <a:pt x="68" y="406"/>
                    <a:pt x="72" y="407"/>
                    <a:pt x="77" y="409"/>
                  </a:cubicBezTo>
                  <a:close/>
                  <a:moveTo>
                    <a:pt x="311" y="239"/>
                  </a:moveTo>
                  <a:cubicBezTo>
                    <a:pt x="318" y="242"/>
                    <a:pt x="323" y="244"/>
                    <a:pt x="326" y="247"/>
                  </a:cubicBezTo>
                  <a:cubicBezTo>
                    <a:pt x="329" y="249"/>
                    <a:pt x="330" y="252"/>
                    <a:pt x="329" y="254"/>
                  </a:cubicBezTo>
                  <a:lnTo>
                    <a:pt x="322" y="277"/>
                  </a:lnTo>
                  <a:lnTo>
                    <a:pt x="369" y="292"/>
                  </a:lnTo>
                  <a:cubicBezTo>
                    <a:pt x="370" y="293"/>
                    <a:pt x="371" y="293"/>
                    <a:pt x="372" y="295"/>
                  </a:cubicBezTo>
                  <a:cubicBezTo>
                    <a:pt x="373" y="296"/>
                    <a:pt x="373" y="297"/>
                    <a:pt x="373" y="300"/>
                  </a:cubicBezTo>
                  <a:cubicBezTo>
                    <a:pt x="373" y="302"/>
                    <a:pt x="373" y="305"/>
                    <a:pt x="372" y="308"/>
                  </a:cubicBezTo>
                  <a:cubicBezTo>
                    <a:pt x="371" y="311"/>
                    <a:pt x="370" y="315"/>
                    <a:pt x="368" y="321"/>
                  </a:cubicBezTo>
                  <a:cubicBezTo>
                    <a:pt x="367" y="325"/>
                    <a:pt x="365" y="329"/>
                    <a:pt x="364" y="333"/>
                  </a:cubicBezTo>
                  <a:cubicBezTo>
                    <a:pt x="363" y="336"/>
                    <a:pt x="361" y="338"/>
                    <a:pt x="360" y="340"/>
                  </a:cubicBezTo>
                  <a:cubicBezTo>
                    <a:pt x="359" y="342"/>
                    <a:pt x="357" y="343"/>
                    <a:pt x="356" y="343"/>
                  </a:cubicBezTo>
                  <a:cubicBezTo>
                    <a:pt x="355" y="343"/>
                    <a:pt x="354" y="343"/>
                    <a:pt x="352" y="343"/>
                  </a:cubicBezTo>
                  <a:lnTo>
                    <a:pt x="305" y="328"/>
                  </a:lnTo>
                  <a:lnTo>
                    <a:pt x="273" y="427"/>
                  </a:lnTo>
                  <a:cubicBezTo>
                    <a:pt x="273" y="429"/>
                    <a:pt x="272" y="431"/>
                    <a:pt x="271" y="432"/>
                  </a:cubicBezTo>
                  <a:cubicBezTo>
                    <a:pt x="270" y="433"/>
                    <a:pt x="269" y="434"/>
                    <a:pt x="267" y="435"/>
                  </a:cubicBezTo>
                  <a:cubicBezTo>
                    <a:pt x="265" y="435"/>
                    <a:pt x="262" y="435"/>
                    <a:pt x="259" y="435"/>
                  </a:cubicBezTo>
                  <a:cubicBezTo>
                    <a:pt x="255" y="434"/>
                    <a:pt x="251" y="433"/>
                    <a:pt x="246" y="431"/>
                  </a:cubicBezTo>
                  <a:cubicBezTo>
                    <a:pt x="242" y="430"/>
                    <a:pt x="238" y="429"/>
                    <a:pt x="235" y="427"/>
                  </a:cubicBezTo>
                  <a:cubicBezTo>
                    <a:pt x="232" y="426"/>
                    <a:pt x="229" y="425"/>
                    <a:pt x="227" y="424"/>
                  </a:cubicBezTo>
                  <a:cubicBezTo>
                    <a:pt x="224" y="422"/>
                    <a:pt x="222" y="421"/>
                    <a:pt x="220" y="419"/>
                  </a:cubicBezTo>
                  <a:cubicBezTo>
                    <a:pt x="218" y="418"/>
                    <a:pt x="216" y="416"/>
                    <a:pt x="214" y="414"/>
                  </a:cubicBezTo>
                  <a:lnTo>
                    <a:pt x="97" y="287"/>
                  </a:lnTo>
                  <a:cubicBezTo>
                    <a:pt x="97" y="286"/>
                    <a:pt x="96" y="285"/>
                    <a:pt x="95" y="283"/>
                  </a:cubicBezTo>
                  <a:cubicBezTo>
                    <a:pt x="95" y="281"/>
                    <a:pt x="95" y="278"/>
                    <a:pt x="95" y="275"/>
                  </a:cubicBezTo>
                  <a:cubicBezTo>
                    <a:pt x="96" y="272"/>
                    <a:pt x="96" y="269"/>
                    <a:pt x="98" y="264"/>
                  </a:cubicBezTo>
                  <a:cubicBezTo>
                    <a:pt x="99" y="260"/>
                    <a:pt x="100" y="254"/>
                    <a:pt x="102" y="248"/>
                  </a:cubicBezTo>
                  <a:cubicBezTo>
                    <a:pt x="105" y="241"/>
                    <a:pt x="107" y="235"/>
                    <a:pt x="109" y="231"/>
                  </a:cubicBezTo>
                  <a:cubicBezTo>
                    <a:pt x="110" y="226"/>
                    <a:pt x="112" y="222"/>
                    <a:pt x="114" y="220"/>
                  </a:cubicBezTo>
                  <a:cubicBezTo>
                    <a:pt x="116" y="217"/>
                    <a:pt x="117" y="215"/>
                    <a:pt x="119" y="214"/>
                  </a:cubicBezTo>
                  <a:cubicBezTo>
                    <a:pt x="120" y="213"/>
                    <a:pt x="122" y="213"/>
                    <a:pt x="123" y="213"/>
                  </a:cubicBezTo>
                  <a:lnTo>
                    <a:pt x="279" y="264"/>
                  </a:lnTo>
                  <a:lnTo>
                    <a:pt x="287" y="240"/>
                  </a:lnTo>
                  <a:cubicBezTo>
                    <a:pt x="288" y="238"/>
                    <a:pt x="290" y="237"/>
                    <a:pt x="294" y="237"/>
                  </a:cubicBezTo>
                  <a:cubicBezTo>
                    <a:pt x="297" y="236"/>
                    <a:pt x="303" y="237"/>
                    <a:pt x="311" y="239"/>
                  </a:cubicBezTo>
                  <a:close/>
                  <a:moveTo>
                    <a:pt x="144" y="276"/>
                  </a:moveTo>
                  <a:lnTo>
                    <a:pt x="144" y="276"/>
                  </a:lnTo>
                  <a:lnTo>
                    <a:pt x="241" y="383"/>
                  </a:lnTo>
                  <a:lnTo>
                    <a:pt x="263" y="314"/>
                  </a:lnTo>
                  <a:lnTo>
                    <a:pt x="144" y="276"/>
                  </a:lnTo>
                  <a:close/>
                  <a:moveTo>
                    <a:pt x="379" y="26"/>
                  </a:moveTo>
                  <a:cubicBezTo>
                    <a:pt x="386" y="28"/>
                    <a:pt x="391" y="31"/>
                    <a:pt x="394" y="33"/>
                  </a:cubicBezTo>
                  <a:cubicBezTo>
                    <a:pt x="397" y="36"/>
                    <a:pt x="398" y="38"/>
                    <a:pt x="398" y="41"/>
                  </a:cubicBezTo>
                  <a:lnTo>
                    <a:pt x="390" y="64"/>
                  </a:lnTo>
                  <a:lnTo>
                    <a:pt x="437" y="79"/>
                  </a:lnTo>
                  <a:cubicBezTo>
                    <a:pt x="439" y="79"/>
                    <a:pt x="440" y="80"/>
                    <a:pt x="440" y="81"/>
                  </a:cubicBezTo>
                  <a:cubicBezTo>
                    <a:pt x="441" y="82"/>
                    <a:pt x="441" y="84"/>
                    <a:pt x="441" y="86"/>
                  </a:cubicBezTo>
                  <a:cubicBezTo>
                    <a:pt x="442" y="89"/>
                    <a:pt x="441" y="91"/>
                    <a:pt x="440" y="95"/>
                  </a:cubicBezTo>
                  <a:cubicBezTo>
                    <a:pt x="440" y="98"/>
                    <a:pt x="439" y="102"/>
                    <a:pt x="437" y="107"/>
                  </a:cubicBezTo>
                  <a:cubicBezTo>
                    <a:pt x="435" y="112"/>
                    <a:pt x="434" y="116"/>
                    <a:pt x="433" y="119"/>
                  </a:cubicBezTo>
                  <a:cubicBezTo>
                    <a:pt x="431" y="122"/>
                    <a:pt x="430" y="125"/>
                    <a:pt x="429" y="127"/>
                  </a:cubicBezTo>
                  <a:cubicBezTo>
                    <a:pt x="427" y="128"/>
                    <a:pt x="426" y="129"/>
                    <a:pt x="425" y="130"/>
                  </a:cubicBezTo>
                  <a:cubicBezTo>
                    <a:pt x="424" y="130"/>
                    <a:pt x="422" y="130"/>
                    <a:pt x="421" y="130"/>
                  </a:cubicBezTo>
                  <a:lnTo>
                    <a:pt x="374" y="115"/>
                  </a:lnTo>
                  <a:lnTo>
                    <a:pt x="342" y="214"/>
                  </a:lnTo>
                  <a:cubicBezTo>
                    <a:pt x="341" y="216"/>
                    <a:pt x="341" y="218"/>
                    <a:pt x="340" y="219"/>
                  </a:cubicBezTo>
                  <a:cubicBezTo>
                    <a:pt x="339" y="220"/>
                    <a:pt x="337" y="221"/>
                    <a:pt x="335" y="222"/>
                  </a:cubicBezTo>
                  <a:cubicBezTo>
                    <a:pt x="333" y="222"/>
                    <a:pt x="331" y="222"/>
                    <a:pt x="327" y="221"/>
                  </a:cubicBezTo>
                  <a:cubicBezTo>
                    <a:pt x="324" y="221"/>
                    <a:pt x="320" y="220"/>
                    <a:pt x="314" y="218"/>
                  </a:cubicBezTo>
                  <a:cubicBezTo>
                    <a:pt x="310" y="217"/>
                    <a:pt x="307" y="215"/>
                    <a:pt x="303" y="214"/>
                  </a:cubicBezTo>
                  <a:cubicBezTo>
                    <a:pt x="300" y="213"/>
                    <a:pt x="298" y="212"/>
                    <a:pt x="295" y="210"/>
                  </a:cubicBezTo>
                  <a:cubicBezTo>
                    <a:pt x="293" y="209"/>
                    <a:pt x="291" y="208"/>
                    <a:pt x="289" y="206"/>
                  </a:cubicBezTo>
                  <a:cubicBezTo>
                    <a:pt x="287" y="205"/>
                    <a:pt x="285" y="203"/>
                    <a:pt x="282" y="201"/>
                  </a:cubicBezTo>
                  <a:lnTo>
                    <a:pt x="166" y="74"/>
                  </a:lnTo>
                  <a:cubicBezTo>
                    <a:pt x="165" y="73"/>
                    <a:pt x="164" y="71"/>
                    <a:pt x="164" y="70"/>
                  </a:cubicBezTo>
                  <a:cubicBezTo>
                    <a:pt x="164" y="68"/>
                    <a:pt x="164" y="65"/>
                    <a:pt x="164" y="62"/>
                  </a:cubicBezTo>
                  <a:cubicBezTo>
                    <a:pt x="164" y="59"/>
                    <a:pt x="165" y="55"/>
                    <a:pt x="166" y="51"/>
                  </a:cubicBezTo>
                  <a:cubicBezTo>
                    <a:pt x="167" y="46"/>
                    <a:pt x="169" y="41"/>
                    <a:pt x="171" y="35"/>
                  </a:cubicBezTo>
                  <a:cubicBezTo>
                    <a:pt x="173" y="28"/>
                    <a:pt x="175" y="22"/>
                    <a:pt x="177" y="17"/>
                  </a:cubicBezTo>
                  <a:cubicBezTo>
                    <a:pt x="179" y="13"/>
                    <a:pt x="181" y="9"/>
                    <a:pt x="182" y="6"/>
                  </a:cubicBezTo>
                  <a:cubicBezTo>
                    <a:pt x="184" y="4"/>
                    <a:pt x="186" y="2"/>
                    <a:pt x="187" y="1"/>
                  </a:cubicBezTo>
                  <a:cubicBezTo>
                    <a:pt x="189" y="0"/>
                    <a:pt x="190" y="0"/>
                    <a:pt x="192" y="0"/>
                  </a:cubicBezTo>
                  <a:lnTo>
                    <a:pt x="348" y="50"/>
                  </a:lnTo>
                  <a:lnTo>
                    <a:pt x="355" y="27"/>
                  </a:lnTo>
                  <a:cubicBezTo>
                    <a:pt x="356" y="25"/>
                    <a:pt x="358" y="24"/>
                    <a:pt x="362" y="23"/>
                  </a:cubicBezTo>
                  <a:cubicBezTo>
                    <a:pt x="366" y="23"/>
                    <a:pt x="372" y="24"/>
                    <a:pt x="379" y="26"/>
                  </a:cubicBezTo>
                  <a:close/>
                  <a:moveTo>
                    <a:pt x="212" y="63"/>
                  </a:moveTo>
                  <a:lnTo>
                    <a:pt x="212" y="63"/>
                  </a:lnTo>
                  <a:lnTo>
                    <a:pt x="310" y="170"/>
                  </a:lnTo>
                  <a:lnTo>
                    <a:pt x="332" y="101"/>
                  </a:lnTo>
                  <a:lnTo>
                    <a:pt x="212" y="6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28"/>
            <p:cNvSpPr/>
            <p:nvPr/>
          </p:nvSpPr>
          <p:spPr>
            <a:xfrm>
              <a:off x="3654360" y="2363760"/>
              <a:ext cx="201600" cy="361800"/>
            </a:xfrm>
            <a:custGeom>
              <a:avLst/>
              <a:gdLst>
                <a:gd name="textAreaLeft" fmla="*/ 0 w 201600"/>
                <a:gd name="textAreaRight" fmla="*/ 201960 w 201600"/>
                <a:gd name="textAreaTop" fmla="*/ 0 h 361800"/>
                <a:gd name="textAreaBottom" fmla="*/ 361800 h 361800"/>
              </a:gdLst>
              <a:ahLst/>
              <a:rect l="textAreaLeft" t="textAreaTop" r="textAreaRight" b="textAreaBottom"/>
              <a:pathLst>
                <a:path w="538" h="968">
                  <a:moveTo>
                    <a:pt x="224" y="789"/>
                  </a:moveTo>
                  <a:cubicBezTo>
                    <a:pt x="236" y="793"/>
                    <a:pt x="246" y="799"/>
                    <a:pt x="254" y="807"/>
                  </a:cubicBezTo>
                  <a:cubicBezTo>
                    <a:pt x="262" y="814"/>
                    <a:pt x="268" y="823"/>
                    <a:pt x="272" y="833"/>
                  </a:cubicBezTo>
                  <a:cubicBezTo>
                    <a:pt x="276" y="843"/>
                    <a:pt x="278" y="854"/>
                    <a:pt x="278" y="867"/>
                  </a:cubicBezTo>
                  <a:cubicBezTo>
                    <a:pt x="278" y="879"/>
                    <a:pt x="275" y="893"/>
                    <a:pt x="270" y="907"/>
                  </a:cubicBezTo>
                  <a:cubicBezTo>
                    <a:pt x="267" y="915"/>
                    <a:pt x="264" y="923"/>
                    <a:pt x="260" y="930"/>
                  </a:cubicBezTo>
                  <a:cubicBezTo>
                    <a:pt x="256" y="937"/>
                    <a:pt x="252" y="943"/>
                    <a:pt x="248" y="949"/>
                  </a:cubicBezTo>
                  <a:cubicBezTo>
                    <a:pt x="244" y="954"/>
                    <a:pt x="240" y="958"/>
                    <a:pt x="237" y="961"/>
                  </a:cubicBezTo>
                  <a:cubicBezTo>
                    <a:pt x="234" y="964"/>
                    <a:pt x="231" y="966"/>
                    <a:pt x="230" y="967"/>
                  </a:cubicBezTo>
                  <a:cubicBezTo>
                    <a:pt x="229" y="967"/>
                    <a:pt x="227" y="968"/>
                    <a:pt x="226" y="968"/>
                  </a:cubicBezTo>
                  <a:cubicBezTo>
                    <a:pt x="225" y="968"/>
                    <a:pt x="224" y="968"/>
                    <a:pt x="223" y="968"/>
                  </a:cubicBezTo>
                  <a:cubicBezTo>
                    <a:pt x="221" y="968"/>
                    <a:pt x="219" y="968"/>
                    <a:pt x="217" y="968"/>
                  </a:cubicBezTo>
                  <a:cubicBezTo>
                    <a:pt x="215" y="967"/>
                    <a:pt x="213" y="966"/>
                    <a:pt x="210" y="965"/>
                  </a:cubicBezTo>
                  <a:cubicBezTo>
                    <a:pt x="205" y="964"/>
                    <a:pt x="202" y="962"/>
                    <a:pt x="201" y="961"/>
                  </a:cubicBezTo>
                  <a:cubicBezTo>
                    <a:pt x="199" y="959"/>
                    <a:pt x="199" y="957"/>
                    <a:pt x="199" y="955"/>
                  </a:cubicBezTo>
                  <a:cubicBezTo>
                    <a:pt x="200" y="954"/>
                    <a:pt x="202" y="952"/>
                    <a:pt x="205" y="949"/>
                  </a:cubicBezTo>
                  <a:cubicBezTo>
                    <a:pt x="208" y="946"/>
                    <a:pt x="212" y="943"/>
                    <a:pt x="217" y="938"/>
                  </a:cubicBezTo>
                  <a:cubicBezTo>
                    <a:pt x="221" y="933"/>
                    <a:pt x="226" y="927"/>
                    <a:pt x="230" y="920"/>
                  </a:cubicBezTo>
                  <a:cubicBezTo>
                    <a:pt x="235" y="914"/>
                    <a:pt x="239" y="905"/>
                    <a:pt x="242" y="896"/>
                  </a:cubicBezTo>
                  <a:cubicBezTo>
                    <a:pt x="245" y="887"/>
                    <a:pt x="247" y="879"/>
                    <a:pt x="247" y="871"/>
                  </a:cubicBezTo>
                  <a:cubicBezTo>
                    <a:pt x="247" y="864"/>
                    <a:pt x="246" y="857"/>
                    <a:pt x="244" y="851"/>
                  </a:cubicBezTo>
                  <a:cubicBezTo>
                    <a:pt x="241" y="845"/>
                    <a:pt x="237" y="840"/>
                    <a:pt x="232" y="835"/>
                  </a:cubicBezTo>
                  <a:cubicBezTo>
                    <a:pt x="228" y="831"/>
                    <a:pt x="222" y="828"/>
                    <a:pt x="215" y="825"/>
                  </a:cubicBezTo>
                  <a:cubicBezTo>
                    <a:pt x="208" y="823"/>
                    <a:pt x="201" y="822"/>
                    <a:pt x="194" y="823"/>
                  </a:cubicBezTo>
                  <a:cubicBezTo>
                    <a:pt x="187" y="824"/>
                    <a:pt x="181" y="827"/>
                    <a:pt x="174" y="831"/>
                  </a:cubicBezTo>
                  <a:cubicBezTo>
                    <a:pt x="168" y="835"/>
                    <a:pt x="162" y="841"/>
                    <a:pt x="157" y="848"/>
                  </a:cubicBezTo>
                  <a:cubicBezTo>
                    <a:pt x="152" y="856"/>
                    <a:pt x="148" y="865"/>
                    <a:pt x="144" y="876"/>
                  </a:cubicBezTo>
                  <a:lnTo>
                    <a:pt x="135" y="901"/>
                  </a:lnTo>
                  <a:cubicBezTo>
                    <a:pt x="135" y="902"/>
                    <a:pt x="134" y="903"/>
                    <a:pt x="134" y="904"/>
                  </a:cubicBezTo>
                  <a:cubicBezTo>
                    <a:pt x="133" y="905"/>
                    <a:pt x="132" y="905"/>
                    <a:pt x="130" y="906"/>
                  </a:cubicBezTo>
                  <a:cubicBezTo>
                    <a:pt x="129" y="906"/>
                    <a:pt x="127" y="906"/>
                    <a:pt x="126" y="906"/>
                  </a:cubicBezTo>
                  <a:cubicBezTo>
                    <a:pt x="124" y="906"/>
                    <a:pt x="121" y="905"/>
                    <a:pt x="118" y="904"/>
                  </a:cubicBezTo>
                  <a:cubicBezTo>
                    <a:pt x="116" y="904"/>
                    <a:pt x="114" y="903"/>
                    <a:pt x="112" y="902"/>
                  </a:cubicBezTo>
                  <a:cubicBezTo>
                    <a:pt x="111" y="901"/>
                    <a:pt x="110" y="900"/>
                    <a:pt x="109" y="899"/>
                  </a:cubicBezTo>
                  <a:cubicBezTo>
                    <a:pt x="108" y="898"/>
                    <a:pt x="108" y="896"/>
                    <a:pt x="108" y="895"/>
                  </a:cubicBezTo>
                  <a:cubicBezTo>
                    <a:pt x="108" y="894"/>
                    <a:pt x="108" y="893"/>
                    <a:pt x="108" y="892"/>
                  </a:cubicBezTo>
                  <a:lnTo>
                    <a:pt x="116" y="869"/>
                  </a:lnTo>
                  <a:cubicBezTo>
                    <a:pt x="119" y="861"/>
                    <a:pt x="121" y="852"/>
                    <a:pt x="121" y="845"/>
                  </a:cubicBezTo>
                  <a:cubicBezTo>
                    <a:pt x="121" y="837"/>
                    <a:pt x="120" y="830"/>
                    <a:pt x="117" y="824"/>
                  </a:cubicBezTo>
                  <a:cubicBezTo>
                    <a:pt x="114" y="817"/>
                    <a:pt x="111" y="812"/>
                    <a:pt x="106" y="807"/>
                  </a:cubicBezTo>
                  <a:cubicBezTo>
                    <a:pt x="101" y="802"/>
                    <a:pt x="94" y="799"/>
                    <a:pt x="87" y="796"/>
                  </a:cubicBezTo>
                  <a:cubicBezTo>
                    <a:pt x="82" y="794"/>
                    <a:pt x="76" y="794"/>
                    <a:pt x="71" y="794"/>
                  </a:cubicBezTo>
                  <a:cubicBezTo>
                    <a:pt x="66" y="794"/>
                    <a:pt x="60" y="795"/>
                    <a:pt x="56" y="797"/>
                  </a:cubicBezTo>
                  <a:cubicBezTo>
                    <a:pt x="51" y="799"/>
                    <a:pt x="47" y="803"/>
                    <a:pt x="43" y="807"/>
                  </a:cubicBezTo>
                  <a:cubicBezTo>
                    <a:pt x="39" y="812"/>
                    <a:pt x="36" y="818"/>
                    <a:pt x="33" y="825"/>
                  </a:cubicBezTo>
                  <a:cubicBezTo>
                    <a:pt x="30" y="833"/>
                    <a:pt x="29" y="840"/>
                    <a:pt x="29" y="847"/>
                  </a:cubicBezTo>
                  <a:cubicBezTo>
                    <a:pt x="29" y="855"/>
                    <a:pt x="30" y="861"/>
                    <a:pt x="31" y="867"/>
                  </a:cubicBezTo>
                  <a:cubicBezTo>
                    <a:pt x="32" y="873"/>
                    <a:pt x="33" y="878"/>
                    <a:pt x="34" y="882"/>
                  </a:cubicBezTo>
                  <a:cubicBezTo>
                    <a:pt x="35" y="886"/>
                    <a:pt x="35" y="889"/>
                    <a:pt x="35" y="891"/>
                  </a:cubicBezTo>
                  <a:cubicBezTo>
                    <a:pt x="35" y="891"/>
                    <a:pt x="34" y="892"/>
                    <a:pt x="34" y="893"/>
                  </a:cubicBezTo>
                  <a:cubicBezTo>
                    <a:pt x="33" y="893"/>
                    <a:pt x="32" y="894"/>
                    <a:pt x="31" y="894"/>
                  </a:cubicBezTo>
                  <a:cubicBezTo>
                    <a:pt x="30" y="894"/>
                    <a:pt x="28" y="894"/>
                    <a:pt x="26" y="893"/>
                  </a:cubicBezTo>
                  <a:cubicBezTo>
                    <a:pt x="25" y="893"/>
                    <a:pt x="22" y="892"/>
                    <a:pt x="19" y="891"/>
                  </a:cubicBezTo>
                  <a:cubicBezTo>
                    <a:pt x="17" y="891"/>
                    <a:pt x="16" y="890"/>
                    <a:pt x="14" y="889"/>
                  </a:cubicBezTo>
                  <a:cubicBezTo>
                    <a:pt x="13" y="889"/>
                    <a:pt x="11" y="888"/>
                    <a:pt x="10" y="887"/>
                  </a:cubicBezTo>
                  <a:cubicBezTo>
                    <a:pt x="9" y="886"/>
                    <a:pt x="8" y="886"/>
                    <a:pt x="8" y="885"/>
                  </a:cubicBezTo>
                  <a:cubicBezTo>
                    <a:pt x="7" y="884"/>
                    <a:pt x="6" y="883"/>
                    <a:pt x="5" y="881"/>
                  </a:cubicBezTo>
                  <a:cubicBezTo>
                    <a:pt x="5" y="879"/>
                    <a:pt x="4" y="876"/>
                    <a:pt x="3" y="871"/>
                  </a:cubicBezTo>
                  <a:cubicBezTo>
                    <a:pt x="1" y="867"/>
                    <a:pt x="1" y="861"/>
                    <a:pt x="0" y="855"/>
                  </a:cubicBezTo>
                  <a:cubicBezTo>
                    <a:pt x="0" y="848"/>
                    <a:pt x="0" y="841"/>
                    <a:pt x="1" y="833"/>
                  </a:cubicBezTo>
                  <a:cubicBezTo>
                    <a:pt x="2" y="825"/>
                    <a:pt x="4" y="817"/>
                    <a:pt x="7" y="808"/>
                  </a:cubicBezTo>
                  <a:cubicBezTo>
                    <a:pt x="11" y="796"/>
                    <a:pt x="16" y="786"/>
                    <a:pt x="23" y="778"/>
                  </a:cubicBezTo>
                  <a:cubicBezTo>
                    <a:pt x="29" y="770"/>
                    <a:pt x="36" y="764"/>
                    <a:pt x="43" y="760"/>
                  </a:cubicBezTo>
                  <a:cubicBezTo>
                    <a:pt x="51" y="756"/>
                    <a:pt x="59" y="754"/>
                    <a:pt x="68" y="754"/>
                  </a:cubicBezTo>
                  <a:cubicBezTo>
                    <a:pt x="77" y="753"/>
                    <a:pt x="86" y="755"/>
                    <a:pt x="95" y="758"/>
                  </a:cubicBezTo>
                  <a:cubicBezTo>
                    <a:pt x="104" y="761"/>
                    <a:pt x="111" y="765"/>
                    <a:pt x="117" y="769"/>
                  </a:cubicBezTo>
                  <a:cubicBezTo>
                    <a:pt x="123" y="774"/>
                    <a:pt x="128" y="779"/>
                    <a:pt x="132" y="785"/>
                  </a:cubicBezTo>
                  <a:cubicBezTo>
                    <a:pt x="136" y="791"/>
                    <a:pt x="139" y="798"/>
                    <a:pt x="141" y="805"/>
                  </a:cubicBezTo>
                  <a:cubicBezTo>
                    <a:pt x="143" y="812"/>
                    <a:pt x="143" y="820"/>
                    <a:pt x="142" y="828"/>
                  </a:cubicBezTo>
                  <a:cubicBezTo>
                    <a:pt x="146" y="820"/>
                    <a:pt x="151" y="812"/>
                    <a:pt x="157" y="806"/>
                  </a:cubicBezTo>
                  <a:cubicBezTo>
                    <a:pt x="163" y="800"/>
                    <a:pt x="170" y="795"/>
                    <a:pt x="177" y="792"/>
                  </a:cubicBezTo>
                  <a:cubicBezTo>
                    <a:pt x="184" y="788"/>
                    <a:pt x="192" y="786"/>
                    <a:pt x="200" y="786"/>
                  </a:cubicBezTo>
                  <a:cubicBezTo>
                    <a:pt x="208" y="785"/>
                    <a:pt x="216" y="786"/>
                    <a:pt x="224" y="789"/>
                  </a:cubicBezTo>
                  <a:close/>
                  <a:moveTo>
                    <a:pt x="305" y="702"/>
                  </a:moveTo>
                  <a:cubicBezTo>
                    <a:pt x="309" y="703"/>
                    <a:pt x="313" y="704"/>
                    <a:pt x="316" y="706"/>
                  </a:cubicBezTo>
                  <a:cubicBezTo>
                    <a:pt x="320" y="708"/>
                    <a:pt x="323" y="709"/>
                    <a:pt x="325" y="711"/>
                  </a:cubicBezTo>
                  <a:cubicBezTo>
                    <a:pt x="328" y="713"/>
                    <a:pt x="331" y="716"/>
                    <a:pt x="333" y="718"/>
                  </a:cubicBezTo>
                  <a:cubicBezTo>
                    <a:pt x="336" y="721"/>
                    <a:pt x="338" y="724"/>
                    <a:pt x="341" y="727"/>
                  </a:cubicBezTo>
                  <a:lnTo>
                    <a:pt x="372" y="769"/>
                  </a:lnTo>
                  <a:cubicBezTo>
                    <a:pt x="373" y="770"/>
                    <a:pt x="374" y="771"/>
                    <a:pt x="374" y="772"/>
                  </a:cubicBezTo>
                  <a:cubicBezTo>
                    <a:pt x="374" y="773"/>
                    <a:pt x="375" y="774"/>
                    <a:pt x="375" y="776"/>
                  </a:cubicBezTo>
                  <a:cubicBezTo>
                    <a:pt x="375" y="777"/>
                    <a:pt x="375" y="779"/>
                    <a:pt x="374" y="780"/>
                  </a:cubicBezTo>
                  <a:cubicBezTo>
                    <a:pt x="374" y="782"/>
                    <a:pt x="373" y="784"/>
                    <a:pt x="372" y="787"/>
                  </a:cubicBezTo>
                  <a:cubicBezTo>
                    <a:pt x="372" y="789"/>
                    <a:pt x="371" y="791"/>
                    <a:pt x="370" y="792"/>
                  </a:cubicBezTo>
                  <a:cubicBezTo>
                    <a:pt x="369" y="794"/>
                    <a:pt x="369" y="795"/>
                    <a:pt x="368" y="795"/>
                  </a:cubicBezTo>
                  <a:cubicBezTo>
                    <a:pt x="367" y="796"/>
                    <a:pt x="367" y="796"/>
                    <a:pt x="366" y="796"/>
                  </a:cubicBezTo>
                  <a:cubicBezTo>
                    <a:pt x="365" y="796"/>
                    <a:pt x="364" y="795"/>
                    <a:pt x="363" y="794"/>
                  </a:cubicBezTo>
                  <a:lnTo>
                    <a:pt x="318" y="749"/>
                  </a:lnTo>
                  <a:lnTo>
                    <a:pt x="292" y="740"/>
                  </a:lnTo>
                  <a:cubicBezTo>
                    <a:pt x="288" y="739"/>
                    <a:pt x="286" y="737"/>
                    <a:pt x="284" y="736"/>
                  </a:cubicBezTo>
                  <a:cubicBezTo>
                    <a:pt x="282" y="734"/>
                    <a:pt x="281" y="733"/>
                    <a:pt x="280" y="731"/>
                  </a:cubicBezTo>
                  <a:cubicBezTo>
                    <a:pt x="280" y="729"/>
                    <a:pt x="280" y="726"/>
                    <a:pt x="280" y="724"/>
                  </a:cubicBezTo>
                  <a:cubicBezTo>
                    <a:pt x="281" y="721"/>
                    <a:pt x="281" y="718"/>
                    <a:pt x="283" y="715"/>
                  </a:cubicBezTo>
                  <a:cubicBezTo>
                    <a:pt x="284" y="712"/>
                    <a:pt x="285" y="709"/>
                    <a:pt x="286" y="706"/>
                  </a:cubicBezTo>
                  <a:cubicBezTo>
                    <a:pt x="287" y="704"/>
                    <a:pt x="289" y="703"/>
                    <a:pt x="290" y="701"/>
                  </a:cubicBezTo>
                  <a:cubicBezTo>
                    <a:pt x="292" y="700"/>
                    <a:pt x="294" y="700"/>
                    <a:pt x="296" y="700"/>
                  </a:cubicBezTo>
                  <a:cubicBezTo>
                    <a:pt x="299" y="700"/>
                    <a:pt x="302" y="700"/>
                    <a:pt x="305" y="702"/>
                  </a:cubicBezTo>
                  <a:close/>
                  <a:moveTo>
                    <a:pt x="270" y="445"/>
                  </a:moveTo>
                  <a:cubicBezTo>
                    <a:pt x="281" y="449"/>
                    <a:pt x="292" y="454"/>
                    <a:pt x="303" y="459"/>
                  </a:cubicBezTo>
                  <a:cubicBezTo>
                    <a:pt x="314" y="464"/>
                    <a:pt x="324" y="470"/>
                    <a:pt x="334" y="477"/>
                  </a:cubicBezTo>
                  <a:cubicBezTo>
                    <a:pt x="343" y="484"/>
                    <a:pt x="352" y="492"/>
                    <a:pt x="359" y="500"/>
                  </a:cubicBezTo>
                  <a:cubicBezTo>
                    <a:pt x="367" y="509"/>
                    <a:pt x="372" y="518"/>
                    <a:pt x="376" y="529"/>
                  </a:cubicBezTo>
                  <a:cubicBezTo>
                    <a:pt x="380" y="539"/>
                    <a:pt x="383" y="551"/>
                    <a:pt x="383" y="564"/>
                  </a:cubicBezTo>
                  <a:cubicBezTo>
                    <a:pt x="383" y="576"/>
                    <a:pt x="380" y="590"/>
                    <a:pt x="375" y="605"/>
                  </a:cubicBezTo>
                  <a:cubicBezTo>
                    <a:pt x="373" y="611"/>
                    <a:pt x="371" y="616"/>
                    <a:pt x="368" y="621"/>
                  </a:cubicBezTo>
                  <a:cubicBezTo>
                    <a:pt x="365" y="626"/>
                    <a:pt x="363" y="631"/>
                    <a:pt x="360" y="635"/>
                  </a:cubicBezTo>
                  <a:cubicBezTo>
                    <a:pt x="358" y="639"/>
                    <a:pt x="355" y="642"/>
                    <a:pt x="353" y="644"/>
                  </a:cubicBezTo>
                  <a:cubicBezTo>
                    <a:pt x="351" y="647"/>
                    <a:pt x="349" y="649"/>
                    <a:pt x="347" y="650"/>
                  </a:cubicBezTo>
                  <a:cubicBezTo>
                    <a:pt x="346" y="650"/>
                    <a:pt x="344" y="651"/>
                    <a:pt x="341" y="651"/>
                  </a:cubicBezTo>
                  <a:cubicBezTo>
                    <a:pt x="339" y="651"/>
                    <a:pt x="336" y="650"/>
                    <a:pt x="333" y="649"/>
                  </a:cubicBezTo>
                  <a:cubicBezTo>
                    <a:pt x="330" y="648"/>
                    <a:pt x="328" y="647"/>
                    <a:pt x="326" y="646"/>
                  </a:cubicBezTo>
                  <a:cubicBezTo>
                    <a:pt x="324" y="645"/>
                    <a:pt x="323" y="645"/>
                    <a:pt x="322" y="644"/>
                  </a:cubicBezTo>
                  <a:cubicBezTo>
                    <a:pt x="322" y="643"/>
                    <a:pt x="321" y="642"/>
                    <a:pt x="321" y="641"/>
                  </a:cubicBezTo>
                  <a:cubicBezTo>
                    <a:pt x="321" y="641"/>
                    <a:pt x="321" y="640"/>
                    <a:pt x="321" y="639"/>
                  </a:cubicBezTo>
                  <a:cubicBezTo>
                    <a:pt x="322" y="637"/>
                    <a:pt x="323" y="635"/>
                    <a:pt x="325" y="633"/>
                  </a:cubicBezTo>
                  <a:cubicBezTo>
                    <a:pt x="327" y="631"/>
                    <a:pt x="329" y="628"/>
                    <a:pt x="332" y="624"/>
                  </a:cubicBezTo>
                  <a:cubicBezTo>
                    <a:pt x="334" y="620"/>
                    <a:pt x="337" y="616"/>
                    <a:pt x="340" y="611"/>
                  </a:cubicBezTo>
                  <a:cubicBezTo>
                    <a:pt x="343" y="606"/>
                    <a:pt x="346" y="600"/>
                    <a:pt x="348" y="593"/>
                  </a:cubicBezTo>
                  <a:cubicBezTo>
                    <a:pt x="352" y="580"/>
                    <a:pt x="354" y="568"/>
                    <a:pt x="352" y="557"/>
                  </a:cubicBezTo>
                  <a:cubicBezTo>
                    <a:pt x="350" y="546"/>
                    <a:pt x="346" y="536"/>
                    <a:pt x="340" y="528"/>
                  </a:cubicBezTo>
                  <a:cubicBezTo>
                    <a:pt x="333" y="519"/>
                    <a:pt x="325" y="511"/>
                    <a:pt x="315" y="504"/>
                  </a:cubicBezTo>
                  <a:cubicBezTo>
                    <a:pt x="305" y="498"/>
                    <a:pt x="294" y="492"/>
                    <a:pt x="282" y="488"/>
                  </a:cubicBezTo>
                  <a:cubicBezTo>
                    <a:pt x="284" y="496"/>
                    <a:pt x="284" y="506"/>
                    <a:pt x="284" y="517"/>
                  </a:cubicBezTo>
                  <a:cubicBezTo>
                    <a:pt x="284" y="528"/>
                    <a:pt x="282" y="540"/>
                    <a:pt x="277" y="552"/>
                  </a:cubicBezTo>
                  <a:cubicBezTo>
                    <a:pt x="272" y="567"/>
                    <a:pt x="266" y="578"/>
                    <a:pt x="259" y="586"/>
                  </a:cubicBezTo>
                  <a:cubicBezTo>
                    <a:pt x="252" y="595"/>
                    <a:pt x="243" y="601"/>
                    <a:pt x="235" y="604"/>
                  </a:cubicBezTo>
                  <a:cubicBezTo>
                    <a:pt x="226" y="608"/>
                    <a:pt x="216" y="609"/>
                    <a:pt x="206" y="609"/>
                  </a:cubicBezTo>
                  <a:cubicBezTo>
                    <a:pt x="196" y="608"/>
                    <a:pt x="185" y="606"/>
                    <a:pt x="174" y="602"/>
                  </a:cubicBezTo>
                  <a:cubicBezTo>
                    <a:pt x="163" y="598"/>
                    <a:pt x="153" y="593"/>
                    <a:pt x="143" y="586"/>
                  </a:cubicBezTo>
                  <a:cubicBezTo>
                    <a:pt x="134" y="579"/>
                    <a:pt x="127" y="571"/>
                    <a:pt x="122" y="561"/>
                  </a:cubicBezTo>
                  <a:cubicBezTo>
                    <a:pt x="116" y="551"/>
                    <a:pt x="113" y="540"/>
                    <a:pt x="112" y="528"/>
                  </a:cubicBezTo>
                  <a:cubicBezTo>
                    <a:pt x="111" y="515"/>
                    <a:pt x="113" y="501"/>
                    <a:pt x="119" y="486"/>
                  </a:cubicBezTo>
                  <a:cubicBezTo>
                    <a:pt x="122" y="475"/>
                    <a:pt x="127" y="466"/>
                    <a:pt x="133" y="459"/>
                  </a:cubicBezTo>
                  <a:cubicBezTo>
                    <a:pt x="138" y="451"/>
                    <a:pt x="145" y="446"/>
                    <a:pt x="152" y="441"/>
                  </a:cubicBezTo>
                  <a:cubicBezTo>
                    <a:pt x="159" y="437"/>
                    <a:pt x="167" y="434"/>
                    <a:pt x="176" y="432"/>
                  </a:cubicBezTo>
                  <a:cubicBezTo>
                    <a:pt x="185" y="430"/>
                    <a:pt x="194" y="430"/>
                    <a:pt x="204" y="430"/>
                  </a:cubicBezTo>
                  <a:cubicBezTo>
                    <a:pt x="214" y="431"/>
                    <a:pt x="225" y="433"/>
                    <a:pt x="236" y="435"/>
                  </a:cubicBezTo>
                  <a:cubicBezTo>
                    <a:pt x="247" y="438"/>
                    <a:pt x="258" y="441"/>
                    <a:pt x="270" y="445"/>
                  </a:cubicBezTo>
                  <a:close/>
                  <a:moveTo>
                    <a:pt x="254" y="479"/>
                  </a:moveTo>
                  <a:cubicBezTo>
                    <a:pt x="237" y="473"/>
                    <a:pt x="223" y="469"/>
                    <a:pt x="210" y="467"/>
                  </a:cubicBezTo>
                  <a:cubicBezTo>
                    <a:pt x="198" y="465"/>
                    <a:pt x="187" y="466"/>
                    <a:pt x="178" y="467"/>
                  </a:cubicBezTo>
                  <a:cubicBezTo>
                    <a:pt x="170" y="469"/>
                    <a:pt x="163" y="473"/>
                    <a:pt x="157" y="478"/>
                  </a:cubicBezTo>
                  <a:cubicBezTo>
                    <a:pt x="152" y="483"/>
                    <a:pt x="148" y="490"/>
                    <a:pt x="145" y="499"/>
                  </a:cubicBezTo>
                  <a:cubicBezTo>
                    <a:pt x="142" y="507"/>
                    <a:pt x="141" y="515"/>
                    <a:pt x="142" y="522"/>
                  </a:cubicBezTo>
                  <a:cubicBezTo>
                    <a:pt x="143" y="530"/>
                    <a:pt x="145" y="536"/>
                    <a:pt x="149" y="542"/>
                  </a:cubicBezTo>
                  <a:cubicBezTo>
                    <a:pt x="153" y="548"/>
                    <a:pt x="158" y="553"/>
                    <a:pt x="164" y="557"/>
                  </a:cubicBezTo>
                  <a:cubicBezTo>
                    <a:pt x="170" y="561"/>
                    <a:pt x="177" y="564"/>
                    <a:pt x="184" y="567"/>
                  </a:cubicBezTo>
                  <a:cubicBezTo>
                    <a:pt x="192" y="569"/>
                    <a:pt x="199" y="571"/>
                    <a:pt x="206" y="572"/>
                  </a:cubicBezTo>
                  <a:cubicBezTo>
                    <a:pt x="213" y="572"/>
                    <a:pt x="220" y="571"/>
                    <a:pt x="225" y="569"/>
                  </a:cubicBezTo>
                  <a:cubicBezTo>
                    <a:pt x="231" y="567"/>
                    <a:pt x="236" y="563"/>
                    <a:pt x="241" y="558"/>
                  </a:cubicBezTo>
                  <a:cubicBezTo>
                    <a:pt x="245" y="553"/>
                    <a:pt x="249" y="546"/>
                    <a:pt x="252" y="537"/>
                  </a:cubicBezTo>
                  <a:cubicBezTo>
                    <a:pt x="256" y="527"/>
                    <a:pt x="258" y="517"/>
                    <a:pt x="258" y="507"/>
                  </a:cubicBezTo>
                  <a:cubicBezTo>
                    <a:pt x="258" y="497"/>
                    <a:pt x="257" y="487"/>
                    <a:pt x="254" y="479"/>
                  </a:cubicBezTo>
                  <a:close/>
                  <a:moveTo>
                    <a:pt x="467" y="279"/>
                  </a:moveTo>
                  <a:cubicBezTo>
                    <a:pt x="469" y="279"/>
                    <a:pt x="472" y="280"/>
                    <a:pt x="473" y="281"/>
                  </a:cubicBezTo>
                  <a:cubicBezTo>
                    <a:pt x="475" y="282"/>
                    <a:pt x="476" y="283"/>
                    <a:pt x="477" y="284"/>
                  </a:cubicBezTo>
                  <a:cubicBezTo>
                    <a:pt x="479" y="285"/>
                    <a:pt x="479" y="286"/>
                    <a:pt x="479" y="288"/>
                  </a:cubicBezTo>
                  <a:cubicBezTo>
                    <a:pt x="480" y="289"/>
                    <a:pt x="480" y="290"/>
                    <a:pt x="479" y="291"/>
                  </a:cubicBezTo>
                  <a:lnTo>
                    <a:pt x="430" y="434"/>
                  </a:lnTo>
                  <a:cubicBezTo>
                    <a:pt x="429" y="436"/>
                    <a:pt x="428" y="437"/>
                    <a:pt x="427" y="438"/>
                  </a:cubicBezTo>
                  <a:cubicBezTo>
                    <a:pt x="427" y="440"/>
                    <a:pt x="425" y="441"/>
                    <a:pt x="424" y="441"/>
                  </a:cubicBezTo>
                  <a:cubicBezTo>
                    <a:pt x="423" y="442"/>
                    <a:pt x="421" y="442"/>
                    <a:pt x="419" y="442"/>
                  </a:cubicBezTo>
                  <a:cubicBezTo>
                    <a:pt x="416" y="442"/>
                    <a:pt x="414" y="441"/>
                    <a:pt x="411" y="440"/>
                  </a:cubicBezTo>
                  <a:cubicBezTo>
                    <a:pt x="408" y="439"/>
                    <a:pt x="406" y="438"/>
                    <a:pt x="404" y="437"/>
                  </a:cubicBezTo>
                  <a:cubicBezTo>
                    <a:pt x="402" y="436"/>
                    <a:pt x="401" y="435"/>
                    <a:pt x="399" y="434"/>
                  </a:cubicBezTo>
                  <a:cubicBezTo>
                    <a:pt x="398" y="433"/>
                    <a:pt x="397" y="431"/>
                    <a:pt x="396" y="430"/>
                  </a:cubicBezTo>
                  <a:cubicBezTo>
                    <a:pt x="394" y="428"/>
                    <a:pt x="393" y="426"/>
                    <a:pt x="392" y="424"/>
                  </a:cubicBezTo>
                  <a:lnTo>
                    <a:pt x="357" y="354"/>
                  </a:lnTo>
                  <a:cubicBezTo>
                    <a:pt x="349" y="338"/>
                    <a:pt x="341" y="325"/>
                    <a:pt x="334" y="314"/>
                  </a:cubicBezTo>
                  <a:cubicBezTo>
                    <a:pt x="327" y="304"/>
                    <a:pt x="320" y="295"/>
                    <a:pt x="313" y="288"/>
                  </a:cubicBezTo>
                  <a:cubicBezTo>
                    <a:pt x="307" y="282"/>
                    <a:pt x="300" y="277"/>
                    <a:pt x="294" y="273"/>
                  </a:cubicBezTo>
                  <a:cubicBezTo>
                    <a:pt x="288" y="270"/>
                    <a:pt x="282" y="267"/>
                    <a:pt x="276" y="265"/>
                  </a:cubicBezTo>
                  <a:cubicBezTo>
                    <a:pt x="271" y="263"/>
                    <a:pt x="265" y="262"/>
                    <a:pt x="259" y="262"/>
                  </a:cubicBezTo>
                  <a:cubicBezTo>
                    <a:pt x="253" y="262"/>
                    <a:pt x="248" y="264"/>
                    <a:pt x="243" y="266"/>
                  </a:cubicBezTo>
                  <a:cubicBezTo>
                    <a:pt x="238" y="268"/>
                    <a:pt x="233" y="272"/>
                    <a:pt x="229" y="276"/>
                  </a:cubicBezTo>
                  <a:cubicBezTo>
                    <a:pt x="225" y="281"/>
                    <a:pt x="221" y="287"/>
                    <a:pt x="219" y="294"/>
                  </a:cubicBezTo>
                  <a:cubicBezTo>
                    <a:pt x="216" y="303"/>
                    <a:pt x="215" y="310"/>
                    <a:pt x="215" y="318"/>
                  </a:cubicBezTo>
                  <a:cubicBezTo>
                    <a:pt x="215" y="325"/>
                    <a:pt x="215" y="332"/>
                    <a:pt x="216" y="338"/>
                  </a:cubicBezTo>
                  <a:cubicBezTo>
                    <a:pt x="217" y="344"/>
                    <a:pt x="218" y="349"/>
                    <a:pt x="219" y="353"/>
                  </a:cubicBezTo>
                  <a:cubicBezTo>
                    <a:pt x="220" y="357"/>
                    <a:pt x="220" y="360"/>
                    <a:pt x="220" y="362"/>
                  </a:cubicBezTo>
                  <a:cubicBezTo>
                    <a:pt x="219" y="363"/>
                    <a:pt x="219" y="363"/>
                    <a:pt x="218" y="364"/>
                  </a:cubicBezTo>
                  <a:cubicBezTo>
                    <a:pt x="217" y="365"/>
                    <a:pt x="216" y="365"/>
                    <a:pt x="215" y="365"/>
                  </a:cubicBezTo>
                  <a:cubicBezTo>
                    <a:pt x="213" y="365"/>
                    <a:pt x="212" y="365"/>
                    <a:pt x="210" y="364"/>
                  </a:cubicBezTo>
                  <a:cubicBezTo>
                    <a:pt x="208" y="364"/>
                    <a:pt x="205" y="363"/>
                    <a:pt x="202" y="362"/>
                  </a:cubicBezTo>
                  <a:cubicBezTo>
                    <a:pt x="200" y="362"/>
                    <a:pt x="199" y="361"/>
                    <a:pt x="197" y="360"/>
                  </a:cubicBezTo>
                  <a:cubicBezTo>
                    <a:pt x="196" y="360"/>
                    <a:pt x="195" y="359"/>
                    <a:pt x="194" y="358"/>
                  </a:cubicBezTo>
                  <a:cubicBezTo>
                    <a:pt x="193" y="358"/>
                    <a:pt x="192" y="357"/>
                    <a:pt x="191" y="356"/>
                  </a:cubicBezTo>
                  <a:cubicBezTo>
                    <a:pt x="190" y="355"/>
                    <a:pt x="190" y="354"/>
                    <a:pt x="189" y="352"/>
                  </a:cubicBezTo>
                  <a:cubicBezTo>
                    <a:pt x="188" y="350"/>
                    <a:pt x="187" y="346"/>
                    <a:pt x="186" y="341"/>
                  </a:cubicBezTo>
                  <a:cubicBezTo>
                    <a:pt x="185" y="337"/>
                    <a:pt x="184" y="331"/>
                    <a:pt x="184" y="324"/>
                  </a:cubicBezTo>
                  <a:cubicBezTo>
                    <a:pt x="184" y="317"/>
                    <a:pt x="184" y="310"/>
                    <a:pt x="185" y="303"/>
                  </a:cubicBezTo>
                  <a:cubicBezTo>
                    <a:pt x="186" y="295"/>
                    <a:pt x="188" y="287"/>
                    <a:pt x="190" y="279"/>
                  </a:cubicBezTo>
                  <a:cubicBezTo>
                    <a:pt x="195" y="267"/>
                    <a:pt x="200" y="257"/>
                    <a:pt x="207" y="248"/>
                  </a:cubicBezTo>
                  <a:cubicBezTo>
                    <a:pt x="214" y="240"/>
                    <a:pt x="221" y="234"/>
                    <a:pt x="229" y="230"/>
                  </a:cubicBezTo>
                  <a:cubicBezTo>
                    <a:pt x="238" y="226"/>
                    <a:pt x="246" y="224"/>
                    <a:pt x="255" y="224"/>
                  </a:cubicBezTo>
                  <a:cubicBezTo>
                    <a:pt x="265" y="223"/>
                    <a:pt x="274" y="225"/>
                    <a:pt x="283" y="228"/>
                  </a:cubicBezTo>
                  <a:cubicBezTo>
                    <a:pt x="291" y="231"/>
                    <a:pt x="299" y="234"/>
                    <a:pt x="307" y="239"/>
                  </a:cubicBezTo>
                  <a:cubicBezTo>
                    <a:pt x="315" y="243"/>
                    <a:pt x="322" y="249"/>
                    <a:pt x="330" y="257"/>
                  </a:cubicBezTo>
                  <a:cubicBezTo>
                    <a:pt x="338" y="265"/>
                    <a:pt x="346" y="276"/>
                    <a:pt x="355" y="289"/>
                  </a:cubicBezTo>
                  <a:cubicBezTo>
                    <a:pt x="363" y="301"/>
                    <a:pt x="373" y="318"/>
                    <a:pt x="383" y="338"/>
                  </a:cubicBezTo>
                  <a:lnTo>
                    <a:pt x="411" y="394"/>
                  </a:lnTo>
                  <a:lnTo>
                    <a:pt x="450" y="281"/>
                  </a:lnTo>
                  <a:cubicBezTo>
                    <a:pt x="450" y="280"/>
                    <a:pt x="451" y="279"/>
                    <a:pt x="452" y="279"/>
                  </a:cubicBezTo>
                  <a:cubicBezTo>
                    <a:pt x="453" y="278"/>
                    <a:pt x="454" y="277"/>
                    <a:pt x="456" y="277"/>
                  </a:cubicBezTo>
                  <a:cubicBezTo>
                    <a:pt x="457" y="277"/>
                    <a:pt x="459" y="277"/>
                    <a:pt x="461" y="277"/>
                  </a:cubicBezTo>
                  <a:cubicBezTo>
                    <a:pt x="463" y="277"/>
                    <a:pt x="465" y="278"/>
                    <a:pt x="467" y="279"/>
                  </a:cubicBezTo>
                  <a:close/>
                  <a:moveTo>
                    <a:pt x="428" y="19"/>
                  </a:moveTo>
                  <a:cubicBezTo>
                    <a:pt x="448" y="25"/>
                    <a:pt x="466" y="33"/>
                    <a:pt x="481" y="42"/>
                  </a:cubicBezTo>
                  <a:cubicBezTo>
                    <a:pt x="496" y="51"/>
                    <a:pt x="509" y="61"/>
                    <a:pt x="518" y="72"/>
                  </a:cubicBezTo>
                  <a:cubicBezTo>
                    <a:pt x="527" y="83"/>
                    <a:pt x="533" y="96"/>
                    <a:pt x="535" y="110"/>
                  </a:cubicBezTo>
                  <a:cubicBezTo>
                    <a:pt x="538" y="124"/>
                    <a:pt x="536" y="139"/>
                    <a:pt x="530" y="157"/>
                  </a:cubicBezTo>
                  <a:cubicBezTo>
                    <a:pt x="524" y="173"/>
                    <a:pt x="517" y="185"/>
                    <a:pt x="507" y="195"/>
                  </a:cubicBezTo>
                  <a:cubicBezTo>
                    <a:pt x="498" y="204"/>
                    <a:pt x="486" y="210"/>
                    <a:pt x="472" y="213"/>
                  </a:cubicBezTo>
                  <a:cubicBezTo>
                    <a:pt x="459" y="215"/>
                    <a:pt x="443" y="215"/>
                    <a:pt x="426" y="213"/>
                  </a:cubicBezTo>
                  <a:cubicBezTo>
                    <a:pt x="409" y="210"/>
                    <a:pt x="389" y="205"/>
                    <a:pt x="368" y="197"/>
                  </a:cubicBezTo>
                  <a:cubicBezTo>
                    <a:pt x="348" y="191"/>
                    <a:pt x="331" y="183"/>
                    <a:pt x="315" y="174"/>
                  </a:cubicBezTo>
                  <a:cubicBezTo>
                    <a:pt x="300" y="165"/>
                    <a:pt x="288" y="155"/>
                    <a:pt x="279" y="144"/>
                  </a:cubicBezTo>
                  <a:cubicBezTo>
                    <a:pt x="269" y="132"/>
                    <a:pt x="263" y="120"/>
                    <a:pt x="261" y="106"/>
                  </a:cubicBezTo>
                  <a:cubicBezTo>
                    <a:pt x="259" y="92"/>
                    <a:pt x="260" y="76"/>
                    <a:pt x="266" y="59"/>
                  </a:cubicBezTo>
                  <a:cubicBezTo>
                    <a:pt x="272" y="43"/>
                    <a:pt x="280" y="30"/>
                    <a:pt x="289" y="21"/>
                  </a:cubicBezTo>
                  <a:cubicBezTo>
                    <a:pt x="299" y="12"/>
                    <a:pt x="310" y="6"/>
                    <a:pt x="324" y="3"/>
                  </a:cubicBezTo>
                  <a:cubicBezTo>
                    <a:pt x="338" y="0"/>
                    <a:pt x="353" y="0"/>
                    <a:pt x="370" y="3"/>
                  </a:cubicBezTo>
                  <a:cubicBezTo>
                    <a:pt x="388" y="6"/>
                    <a:pt x="407" y="11"/>
                    <a:pt x="428" y="19"/>
                  </a:cubicBezTo>
                  <a:close/>
                  <a:moveTo>
                    <a:pt x="419" y="54"/>
                  </a:moveTo>
                  <a:cubicBezTo>
                    <a:pt x="406" y="50"/>
                    <a:pt x="394" y="46"/>
                    <a:pt x="384" y="44"/>
                  </a:cubicBezTo>
                  <a:cubicBezTo>
                    <a:pt x="373" y="41"/>
                    <a:pt x="363" y="39"/>
                    <a:pt x="355" y="39"/>
                  </a:cubicBezTo>
                  <a:cubicBezTo>
                    <a:pt x="347" y="38"/>
                    <a:pt x="339" y="38"/>
                    <a:pt x="332" y="38"/>
                  </a:cubicBezTo>
                  <a:cubicBezTo>
                    <a:pt x="326" y="39"/>
                    <a:pt x="320" y="41"/>
                    <a:pt x="315" y="44"/>
                  </a:cubicBezTo>
                  <a:cubicBezTo>
                    <a:pt x="310" y="47"/>
                    <a:pt x="306" y="50"/>
                    <a:pt x="302" y="55"/>
                  </a:cubicBezTo>
                  <a:cubicBezTo>
                    <a:pt x="299" y="59"/>
                    <a:pt x="296" y="65"/>
                    <a:pt x="294" y="71"/>
                  </a:cubicBezTo>
                  <a:cubicBezTo>
                    <a:pt x="290" y="83"/>
                    <a:pt x="289" y="93"/>
                    <a:pt x="292" y="101"/>
                  </a:cubicBezTo>
                  <a:cubicBezTo>
                    <a:pt x="295" y="110"/>
                    <a:pt x="300" y="118"/>
                    <a:pt x="308" y="126"/>
                  </a:cubicBezTo>
                  <a:cubicBezTo>
                    <a:pt x="316" y="133"/>
                    <a:pt x="326" y="140"/>
                    <a:pt x="338" y="145"/>
                  </a:cubicBezTo>
                  <a:cubicBezTo>
                    <a:pt x="350" y="151"/>
                    <a:pt x="363" y="156"/>
                    <a:pt x="378" y="161"/>
                  </a:cubicBezTo>
                  <a:cubicBezTo>
                    <a:pt x="397" y="168"/>
                    <a:pt x="414" y="173"/>
                    <a:pt x="428" y="175"/>
                  </a:cubicBezTo>
                  <a:cubicBezTo>
                    <a:pt x="442" y="178"/>
                    <a:pt x="454" y="179"/>
                    <a:pt x="464" y="177"/>
                  </a:cubicBezTo>
                  <a:cubicBezTo>
                    <a:pt x="474" y="176"/>
                    <a:pt x="482" y="173"/>
                    <a:pt x="488" y="167"/>
                  </a:cubicBezTo>
                  <a:cubicBezTo>
                    <a:pt x="495" y="162"/>
                    <a:pt x="499" y="154"/>
                    <a:pt x="503" y="145"/>
                  </a:cubicBezTo>
                  <a:cubicBezTo>
                    <a:pt x="505" y="137"/>
                    <a:pt x="506" y="130"/>
                    <a:pt x="506" y="124"/>
                  </a:cubicBezTo>
                  <a:cubicBezTo>
                    <a:pt x="505" y="117"/>
                    <a:pt x="504" y="111"/>
                    <a:pt x="501" y="106"/>
                  </a:cubicBezTo>
                  <a:cubicBezTo>
                    <a:pt x="498" y="100"/>
                    <a:pt x="493" y="95"/>
                    <a:pt x="488" y="90"/>
                  </a:cubicBezTo>
                  <a:cubicBezTo>
                    <a:pt x="483" y="85"/>
                    <a:pt x="477" y="81"/>
                    <a:pt x="470" y="77"/>
                  </a:cubicBezTo>
                  <a:cubicBezTo>
                    <a:pt x="462" y="72"/>
                    <a:pt x="455" y="69"/>
                    <a:pt x="446" y="65"/>
                  </a:cubicBezTo>
                  <a:cubicBezTo>
                    <a:pt x="437" y="61"/>
                    <a:pt x="428" y="58"/>
                    <a:pt x="419" y="54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29"/>
            <p:cNvSpPr/>
            <p:nvPr/>
          </p:nvSpPr>
          <p:spPr>
            <a:xfrm>
              <a:off x="3784680" y="3017880"/>
              <a:ext cx="330120" cy="29376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293760"/>
                <a:gd name="textAreaBottom" fmla="*/ 294120 h 293760"/>
              </a:gdLst>
              <a:ahLst/>
              <a:rect l="textAreaLeft" t="textAreaTop" r="textAreaRight" b="textAreaBottom"/>
              <a:pathLst>
                <a:path w="876" h="785">
                  <a:moveTo>
                    <a:pt x="740" y="499"/>
                  </a:moveTo>
                  <a:cubicBezTo>
                    <a:pt x="742" y="497"/>
                    <a:pt x="743" y="496"/>
                    <a:pt x="745" y="494"/>
                  </a:cubicBezTo>
                  <a:cubicBezTo>
                    <a:pt x="747" y="493"/>
                    <a:pt x="748" y="492"/>
                    <a:pt x="749" y="491"/>
                  </a:cubicBezTo>
                  <a:cubicBezTo>
                    <a:pt x="751" y="491"/>
                    <a:pt x="752" y="491"/>
                    <a:pt x="753" y="491"/>
                  </a:cubicBezTo>
                  <a:cubicBezTo>
                    <a:pt x="754" y="491"/>
                    <a:pt x="755" y="492"/>
                    <a:pt x="756" y="492"/>
                  </a:cubicBezTo>
                  <a:lnTo>
                    <a:pt x="871" y="590"/>
                  </a:lnTo>
                  <a:cubicBezTo>
                    <a:pt x="873" y="591"/>
                    <a:pt x="874" y="593"/>
                    <a:pt x="875" y="594"/>
                  </a:cubicBezTo>
                  <a:cubicBezTo>
                    <a:pt x="876" y="595"/>
                    <a:pt x="876" y="597"/>
                    <a:pt x="876" y="598"/>
                  </a:cubicBezTo>
                  <a:cubicBezTo>
                    <a:pt x="876" y="600"/>
                    <a:pt x="876" y="601"/>
                    <a:pt x="875" y="603"/>
                  </a:cubicBezTo>
                  <a:cubicBezTo>
                    <a:pt x="874" y="605"/>
                    <a:pt x="872" y="607"/>
                    <a:pt x="870" y="610"/>
                  </a:cubicBezTo>
                  <a:cubicBezTo>
                    <a:pt x="869" y="612"/>
                    <a:pt x="867" y="614"/>
                    <a:pt x="865" y="615"/>
                  </a:cubicBezTo>
                  <a:cubicBezTo>
                    <a:pt x="864" y="617"/>
                    <a:pt x="862" y="618"/>
                    <a:pt x="861" y="619"/>
                  </a:cubicBezTo>
                  <a:cubicBezTo>
                    <a:pt x="859" y="619"/>
                    <a:pt x="857" y="620"/>
                    <a:pt x="855" y="621"/>
                  </a:cubicBezTo>
                  <a:cubicBezTo>
                    <a:pt x="854" y="621"/>
                    <a:pt x="851" y="621"/>
                    <a:pt x="849" y="622"/>
                  </a:cubicBezTo>
                  <a:lnTo>
                    <a:pt x="771" y="629"/>
                  </a:lnTo>
                  <a:cubicBezTo>
                    <a:pt x="753" y="631"/>
                    <a:pt x="738" y="633"/>
                    <a:pt x="725" y="636"/>
                  </a:cubicBezTo>
                  <a:cubicBezTo>
                    <a:pt x="713" y="639"/>
                    <a:pt x="702" y="642"/>
                    <a:pt x="694" y="646"/>
                  </a:cubicBezTo>
                  <a:cubicBezTo>
                    <a:pt x="685" y="650"/>
                    <a:pt x="678" y="654"/>
                    <a:pt x="673" y="658"/>
                  </a:cubicBezTo>
                  <a:cubicBezTo>
                    <a:pt x="667" y="663"/>
                    <a:pt x="662" y="667"/>
                    <a:pt x="659" y="672"/>
                  </a:cubicBezTo>
                  <a:cubicBezTo>
                    <a:pt x="655" y="676"/>
                    <a:pt x="652" y="682"/>
                    <a:pt x="650" y="687"/>
                  </a:cubicBezTo>
                  <a:cubicBezTo>
                    <a:pt x="648" y="692"/>
                    <a:pt x="647" y="698"/>
                    <a:pt x="647" y="704"/>
                  </a:cubicBezTo>
                  <a:cubicBezTo>
                    <a:pt x="648" y="709"/>
                    <a:pt x="649" y="715"/>
                    <a:pt x="652" y="720"/>
                  </a:cubicBezTo>
                  <a:cubicBezTo>
                    <a:pt x="655" y="726"/>
                    <a:pt x="659" y="731"/>
                    <a:pt x="665" y="736"/>
                  </a:cubicBezTo>
                  <a:cubicBezTo>
                    <a:pt x="672" y="742"/>
                    <a:pt x="679" y="746"/>
                    <a:pt x="685" y="749"/>
                  </a:cubicBezTo>
                  <a:cubicBezTo>
                    <a:pt x="692" y="751"/>
                    <a:pt x="699" y="753"/>
                    <a:pt x="705" y="755"/>
                  </a:cubicBezTo>
                  <a:cubicBezTo>
                    <a:pt x="710" y="756"/>
                    <a:pt x="716" y="757"/>
                    <a:pt x="720" y="757"/>
                  </a:cubicBezTo>
                  <a:cubicBezTo>
                    <a:pt x="724" y="758"/>
                    <a:pt x="727" y="759"/>
                    <a:pt x="728" y="760"/>
                  </a:cubicBezTo>
                  <a:cubicBezTo>
                    <a:pt x="729" y="760"/>
                    <a:pt x="729" y="761"/>
                    <a:pt x="730" y="762"/>
                  </a:cubicBezTo>
                  <a:cubicBezTo>
                    <a:pt x="730" y="763"/>
                    <a:pt x="730" y="764"/>
                    <a:pt x="729" y="766"/>
                  </a:cubicBezTo>
                  <a:cubicBezTo>
                    <a:pt x="729" y="767"/>
                    <a:pt x="728" y="768"/>
                    <a:pt x="727" y="770"/>
                  </a:cubicBezTo>
                  <a:cubicBezTo>
                    <a:pt x="726" y="772"/>
                    <a:pt x="724" y="774"/>
                    <a:pt x="722" y="776"/>
                  </a:cubicBezTo>
                  <a:cubicBezTo>
                    <a:pt x="721" y="778"/>
                    <a:pt x="720" y="779"/>
                    <a:pt x="719" y="780"/>
                  </a:cubicBezTo>
                  <a:cubicBezTo>
                    <a:pt x="718" y="781"/>
                    <a:pt x="717" y="782"/>
                    <a:pt x="716" y="783"/>
                  </a:cubicBezTo>
                  <a:cubicBezTo>
                    <a:pt x="715" y="783"/>
                    <a:pt x="714" y="784"/>
                    <a:pt x="713" y="784"/>
                  </a:cubicBezTo>
                  <a:cubicBezTo>
                    <a:pt x="711" y="785"/>
                    <a:pt x="710" y="785"/>
                    <a:pt x="708" y="785"/>
                  </a:cubicBezTo>
                  <a:cubicBezTo>
                    <a:pt x="705" y="785"/>
                    <a:pt x="702" y="785"/>
                    <a:pt x="697" y="784"/>
                  </a:cubicBezTo>
                  <a:cubicBezTo>
                    <a:pt x="692" y="783"/>
                    <a:pt x="687" y="782"/>
                    <a:pt x="680" y="780"/>
                  </a:cubicBezTo>
                  <a:cubicBezTo>
                    <a:pt x="674" y="777"/>
                    <a:pt x="667" y="774"/>
                    <a:pt x="660" y="771"/>
                  </a:cubicBezTo>
                  <a:cubicBezTo>
                    <a:pt x="654" y="767"/>
                    <a:pt x="647" y="763"/>
                    <a:pt x="641" y="757"/>
                  </a:cubicBezTo>
                  <a:cubicBezTo>
                    <a:pt x="631" y="749"/>
                    <a:pt x="623" y="740"/>
                    <a:pt x="618" y="731"/>
                  </a:cubicBezTo>
                  <a:cubicBezTo>
                    <a:pt x="613" y="721"/>
                    <a:pt x="610" y="712"/>
                    <a:pt x="609" y="703"/>
                  </a:cubicBezTo>
                  <a:cubicBezTo>
                    <a:pt x="608" y="694"/>
                    <a:pt x="609" y="685"/>
                    <a:pt x="612" y="676"/>
                  </a:cubicBezTo>
                  <a:cubicBezTo>
                    <a:pt x="615" y="668"/>
                    <a:pt x="620" y="660"/>
                    <a:pt x="626" y="652"/>
                  </a:cubicBezTo>
                  <a:cubicBezTo>
                    <a:pt x="632" y="646"/>
                    <a:pt x="638" y="640"/>
                    <a:pt x="645" y="634"/>
                  </a:cubicBezTo>
                  <a:cubicBezTo>
                    <a:pt x="652" y="628"/>
                    <a:pt x="660" y="623"/>
                    <a:pt x="671" y="619"/>
                  </a:cubicBezTo>
                  <a:cubicBezTo>
                    <a:pt x="681" y="615"/>
                    <a:pt x="694" y="611"/>
                    <a:pt x="709" y="607"/>
                  </a:cubicBezTo>
                  <a:cubicBezTo>
                    <a:pt x="724" y="604"/>
                    <a:pt x="743" y="601"/>
                    <a:pt x="765" y="599"/>
                  </a:cubicBezTo>
                  <a:lnTo>
                    <a:pt x="827" y="593"/>
                  </a:lnTo>
                  <a:lnTo>
                    <a:pt x="737" y="516"/>
                  </a:lnTo>
                  <a:cubicBezTo>
                    <a:pt x="736" y="515"/>
                    <a:pt x="735" y="514"/>
                    <a:pt x="735" y="513"/>
                  </a:cubicBezTo>
                  <a:cubicBezTo>
                    <a:pt x="734" y="512"/>
                    <a:pt x="734" y="511"/>
                    <a:pt x="735" y="509"/>
                  </a:cubicBezTo>
                  <a:cubicBezTo>
                    <a:pt x="735" y="508"/>
                    <a:pt x="735" y="506"/>
                    <a:pt x="736" y="505"/>
                  </a:cubicBezTo>
                  <a:cubicBezTo>
                    <a:pt x="737" y="503"/>
                    <a:pt x="739" y="501"/>
                    <a:pt x="740" y="499"/>
                  </a:cubicBezTo>
                  <a:close/>
                  <a:moveTo>
                    <a:pt x="649" y="441"/>
                  </a:moveTo>
                  <a:cubicBezTo>
                    <a:pt x="652" y="437"/>
                    <a:pt x="655" y="434"/>
                    <a:pt x="657" y="432"/>
                  </a:cubicBezTo>
                  <a:cubicBezTo>
                    <a:pt x="660" y="429"/>
                    <a:pt x="663" y="427"/>
                    <a:pt x="666" y="425"/>
                  </a:cubicBezTo>
                  <a:cubicBezTo>
                    <a:pt x="668" y="424"/>
                    <a:pt x="671" y="422"/>
                    <a:pt x="675" y="421"/>
                  </a:cubicBezTo>
                  <a:cubicBezTo>
                    <a:pt x="678" y="419"/>
                    <a:pt x="682" y="418"/>
                    <a:pt x="686" y="417"/>
                  </a:cubicBezTo>
                  <a:lnTo>
                    <a:pt x="736" y="402"/>
                  </a:lnTo>
                  <a:cubicBezTo>
                    <a:pt x="737" y="402"/>
                    <a:pt x="738" y="402"/>
                    <a:pt x="739" y="402"/>
                  </a:cubicBezTo>
                  <a:cubicBezTo>
                    <a:pt x="741" y="402"/>
                    <a:pt x="742" y="402"/>
                    <a:pt x="743" y="403"/>
                  </a:cubicBezTo>
                  <a:cubicBezTo>
                    <a:pt x="745" y="403"/>
                    <a:pt x="746" y="404"/>
                    <a:pt x="748" y="405"/>
                  </a:cubicBezTo>
                  <a:cubicBezTo>
                    <a:pt x="749" y="406"/>
                    <a:pt x="751" y="407"/>
                    <a:pt x="753" y="409"/>
                  </a:cubicBezTo>
                  <a:cubicBezTo>
                    <a:pt x="755" y="411"/>
                    <a:pt x="756" y="412"/>
                    <a:pt x="757" y="413"/>
                  </a:cubicBezTo>
                  <a:cubicBezTo>
                    <a:pt x="758" y="414"/>
                    <a:pt x="759" y="415"/>
                    <a:pt x="759" y="416"/>
                  </a:cubicBezTo>
                  <a:cubicBezTo>
                    <a:pt x="759" y="417"/>
                    <a:pt x="759" y="418"/>
                    <a:pt x="759" y="419"/>
                  </a:cubicBezTo>
                  <a:cubicBezTo>
                    <a:pt x="758" y="419"/>
                    <a:pt x="757" y="420"/>
                    <a:pt x="756" y="420"/>
                  </a:cubicBezTo>
                  <a:lnTo>
                    <a:pt x="697" y="446"/>
                  </a:lnTo>
                  <a:lnTo>
                    <a:pt x="680" y="467"/>
                  </a:lnTo>
                  <a:cubicBezTo>
                    <a:pt x="677" y="470"/>
                    <a:pt x="675" y="472"/>
                    <a:pt x="673" y="473"/>
                  </a:cubicBezTo>
                  <a:cubicBezTo>
                    <a:pt x="671" y="474"/>
                    <a:pt x="669" y="475"/>
                    <a:pt x="667" y="475"/>
                  </a:cubicBezTo>
                  <a:cubicBezTo>
                    <a:pt x="665" y="474"/>
                    <a:pt x="663" y="474"/>
                    <a:pt x="661" y="472"/>
                  </a:cubicBezTo>
                  <a:cubicBezTo>
                    <a:pt x="658" y="471"/>
                    <a:pt x="656" y="469"/>
                    <a:pt x="653" y="467"/>
                  </a:cubicBezTo>
                  <a:cubicBezTo>
                    <a:pt x="651" y="464"/>
                    <a:pt x="648" y="462"/>
                    <a:pt x="647" y="460"/>
                  </a:cubicBezTo>
                  <a:cubicBezTo>
                    <a:pt x="645" y="458"/>
                    <a:pt x="644" y="456"/>
                    <a:pt x="643" y="455"/>
                  </a:cubicBezTo>
                  <a:cubicBezTo>
                    <a:pt x="643" y="453"/>
                    <a:pt x="643" y="451"/>
                    <a:pt x="644" y="448"/>
                  </a:cubicBezTo>
                  <a:cubicBezTo>
                    <a:pt x="645" y="446"/>
                    <a:pt x="647" y="444"/>
                    <a:pt x="649" y="441"/>
                  </a:cubicBezTo>
                  <a:close/>
                  <a:moveTo>
                    <a:pt x="399" y="368"/>
                  </a:moveTo>
                  <a:cubicBezTo>
                    <a:pt x="412" y="352"/>
                    <a:pt x="426" y="339"/>
                    <a:pt x="439" y="328"/>
                  </a:cubicBezTo>
                  <a:cubicBezTo>
                    <a:pt x="453" y="317"/>
                    <a:pt x="467" y="309"/>
                    <a:pt x="481" y="305"/>
                  </a:cubicBezTo>
                  <a:cubicBezTo>
                    <a:pt x="495" y="300"/>
                    <a:pt x="509" y="299"/>
                    <a:pt x="522" y="302"/>
                  </a:cubicBezTo>
                  <a:cubicBezTo>
                    <a:pt x="536" y="305"/>
                    <a:pt x="550" y="312"/>
                    <a:pt x="564" y="324"/>
                  </a:cubicBezTo>
                  <a:cubicBezTo>
                    <a:pt x="577" y="335"/>
                    <a:pt x="586" y="347"/>
                    <a:pt x="591" y="359"/>
                  </a:cubicBezTo>
                  <a:cubicBezTo>
                    <a:pt x="596" y="371"/>
                    <a:pt x="597" y="384"/>
                    <a:pt x="595" y="398"/>
                  </a:cubicBezTo>
                  <a:cubicBezTo>
                    <a:pt x="593" y="411"/>
                    <a:pt x="587" y="426"/>
                    <a:pt x="579" y="441"/>
                  </a:cubicBezTo>
                  <a:cubicBezTo>
                    <a:pt x="570" y="456"/>
                    <a:pt x="558" y="472"/>
                    <a:pt x="543" y="490"/>
                  </a:cubicBezTo>
                  <a:cubicBezTo>
                    <a:pt x="530" y="505"/>
                    <a:pt x="516" y="519"/>
                    <a:pt x="502" y="530"/>
                  </a:cubicBezTo>
                  <a:cubicBezTo>
                    <a:pt x="489" y="541"/>
                    <a:pt x="475" y="549"/>
                    <a:pt x="461" y="553"/>
                  </a:cubicBezTo>
                  <a:cubicBezTo>
                    <a:pt x="447" y="558"/>
                    <a:pt x="433" y="559"/>
                    <a:pt x="419" y="556"/>
                  </a:cubicBezTo>
                  <a:cubicBezTo>
                    <a:pt x="405" y="553"/>
                    <a:pt x="392" y="546"/>
                    <a:pt x="378" y="534"/>
                  </a:cubicBezTo>
                  <a:cubicBezTo>
                    <a:pt x="365" y="523"/>
                    <a:pt x="356" y="511"/>
                    <a:pt x="351" y="499"/>
                  </a:cubicBezTo>
                  <a:cubicBezTo>
                    <a:pt x="346" y="487"/>
                    <a:pt x="344" y="474"/>
                    <a:pt x="347" y="460"/>
                  </a:cubicBezTo>
                  <a:cubicBezTo>
                    <a:pt x="349" y="447"/>
                    <a:pt x="354" y="432"/>
                    <a:pt x="363" y="417"/>
                  </a:cubicBezTo>
                  <a:cubicBezTo>
                    <a:pt x="372" y="402"/>
                    <a:pt x="384" y="386"/>
                    <a:pt x="399" y="368"/>
                  </a:cubicBezTo>
                  <a:close/>
                  <a:moveTo>
                    <a:pt x="428" y="391"/>
                  </a:moveTo>
                  <a:cubicBezTo>
                    <a:pt x="420" y="401"/>
                    <a:pt x="412" y="411"/>
                    <a:pt x="406" y="419"/>
                  </a:cubicBezTo>
                  <a:cubicBezTo>
                    <a:pt x="400" y="428"/>
                    <a:pt x="395" y="437"/>
                    <a:pt x="391" y="444"/>
                  </a:cubicBezTo>
                  <a:cubicBezTo>
                    <a:pt x="387" y="452"/>
                    <a:pt x="384" y="459"/>
                    <a:pt x="382" y="465"/>
                  </a:cubicBezTo>
                  <a:cubicBezTo>
                    <a:pt x="381" y="472"/>
                    <a:pt x="380" y="478"/>
                    <a:pt x="381" y="483"/>
                  </a:cubicBezTo>
                  <a:cubicBezTo>
                    <a:pt x="382" y="489"/>
                    <a:pt x="384" y="494"/>
                    <a:pt x="387" y="499"/>
                  </a:cubicBezTo>
                  <a:cubicBezTo>
                    <a:pt x="390" y="504"/>
                    <a:pt x="394" y="509"/>
                    <a:pt x="399" y="513"/>
                  </a:cubicBezTo>
                  <a:cubicBezTo>
                    <a:pt x="408" y="521"/>
                    <a:pt x="417" y="525"/>
                    <a:pt x="426" y="526"/>
                  </a:cubicBezTo>
                  <a:cubicBezTo>
                    <a:pt x="436" y="526"/>
                    <a:pt x="445" y="524"/>
                    <a:pt x="455" y="519"/>
                  </a:cubicBezTo>
                  <a:cubicBezTo>
                    <a:pt x="465" y="514"/>
                    <a:pt x="474" y="508"/>
                    <a:pt x="484" y="499"/>
                  </a:cubicBezTo>
                  <a:cubicBezTo>
                    <a:pt x="494" y="489"/>
                    <a:pt x="504" y="479"/>
                    <a:pt x="513" y="468"/>
                  </a:cubicBezTo>
                  <a:cubicBezTo>
                    <a:pt x="527" y="452"/>
                    <a:pt x="537" y="438"/>
                    <a:pt x="545" y="426"/>
                  </a:cubicBezTo>
                  <a:cubicBezTo>
                    <a:pt x="552" y="414"/>
                    <a:pt x="557" y="403"/>
                    <a:pt x="560" y="393"/>
                  </a:cubicBezTo>
                  <a:cubicBezTo>
                    <a:pt x="562" y="383"/>
                    <a:pt x="562" y="374"/>
                    <a:pt x="559" y="366"/>
                  </a:cubicBezTo>
                  <a:cubicBezTo>
                    <a:pt x="556" y="359"/>
                    <a:pt x="551" y="352"/>
                    <a:pt x="543" y="345"/>
                  </a:cubicBezTo>
                  <a:cubicBezTo>
                    <a:pt x="537" y="340"/>
                    <a:pt x="531" y="336"/>
                    <a:pt x="525" y="335"/>
                  </a:cubicBezTo>
                  <a:cubicBezTo>
                    <a:pt x="519" y="333"/>
                    <a:pt x="512" y="332"/>
                    <a:pt x="506" y="333"/>
                  </a:cubicBezTo>
                  <a:cubicBezTo>
                    <a:pt x="500" y="334"/>
                    <a:pt x="493" y="336"/>
                    <a:pt x="487" y="339"/>
                  </a:cubicBezTo>
                  <a:cubicBezTo>
                    <a:pt x="481" y="342"/>
                    <a:pt x="474" y="346"/>
                    <a:pt x="468" y="351"/>
                  </a:cubicBezTo>
                  <a:cubicBezTo>
                    <a:pt x="461" y="356"/>
                    <a:pt x="455" y="362"/>
                    <a:pt x="448" y="369"/>
                  </a:cubicBezTo>
                  <a:cubicBezTo>
                    <a:pt x="442" y="376"/>
                    <a:pt x="435" y="383"/>
                    <a:pt x="428" y="391"/>
                  </a:cubicBezTo>
                  <a:close/>
                  <a:moveTo>
                    <a:pt x="313" y="137"/>
                  </a:moveTo>
                  <a:cubicBezTo>
                    <a:pt x="315" y="135"/>
                    <a:pt x="317" y="133"/>
                    <a:pt x="318" y="132"/>
                  </a:cubicBezTo>
                  <a:cubicBezTo>
                    <a:pt x="320" y="131"/>
                    <a:pt x="321" y="130"/>
                    <a:pt x="322" y="129"/>
                  </a:cubicBezTo>
                  <a:cubicBezTo>
                    <a:pt x="324" y="128"/>
                    <a:pt x="325" y="128"/>
                    <a:pt x="326" y="128"/>
                  </a:cubicBezTo>
                  <a:cubicBezTo>
                    <a:pt x="327" y="129"/>
                    <a:pt x="329" y="129"/>
                    <a:pt x="330" y="130"/>
                  </a:cubicBezTo>
                  <a:lnTo>
                    <a:pt x="445" y="228"/>
                  </a:lnTo>
                  <a:cubicBezTo>
                    <a:pt x="446" y="229"/>
                    <a:pt x="447" y="230"/>
                    <a:pt x="448" y="231"/>
                  </a:cubicBezTo>
                  <a:cubicBezTo>
                    <a:pt x="449" y="233"/>
                    <a:pt x="449" y="234"/>
                    <a:pt x="449" y="236"/>
                  </a:cubicBezTo>
                  <a:cubicBezTo>
                    <a:pt x="449" y="237"/>
                    <a:pt x="449" y="239"/>
                    <a:pt x="448" y="241"/>
                  </a:cubicBezTo>
                  <a:cubicBezTo>
                    <a:pt x="447" y="243"/>
                    <a:pt x="445" y="245"/>
                    <a:pt x="443" y="247"/>
                  </a:cubicBezTo>
                  <a:cubicBezTo>
                    <a:pt x="442" y="250"/>
                    <a:pt x="440" y="251"/>
                    <a:pt x="438" y="253"/>
                  </a:cubicBezTo>
                  <a:cubicBezTo>
                    <a:pt x="437" y="254"/>
                    <a:pt x="435" y="255"/>
                    <a:pt x="434" y="256"/>
                  </a:cubicBezTo>
                  <a:cubicBezTo>
                    <a:pt x="432" y="257"/>
                    <a:pt x="430" y="258"/>
                    <a:pt x="429" y="258"/>
                  </a:cubicBezTo>
                  <a:cubicBezTo>
                    <a:pt x="427" y="259"/>
                    <a:pt x="424" y="259"/>
                    <a:pt x="422" y="259"/>
                  </a:cubicBezTo>
                  <a:lnTo>
                    <a:pt x="344" y="267"/>
                  </a:lnTo>
                  <a:cubicBezTo>
                    <a:pt x="326" y="268"/>
                    <a:pt x="311" y="271"/>
                    <a:pt x="298" y="274"/>
                  </a:cubicBezTo>
                  <a:cubicBezTo>
                    <a:pt x="286" y="277"/>
                    <a:pt x="275" y="280"/>
                    <a:pt x="267" y="284"/>
                  </a:cubicBezTo>
                  <a:cubicBezTo>
                    <a:pt x="258" y="287"/>
                    <a:pt x="251" y="292"/>
                    <a:pt x="246" y="296"/>
                  </a:cubicBezTo>
                  <a:cubicBezTo>
                    <a:pt x="240" y="300"/>
                    <a:pt x="236" y="305"/>
                    <a:pt x="232" y="309"/>
                  </a:cubicBezTo>
                  <a:cubicBezTo>
                    <a:pt x="228" y="314"/>
                    <a:pt x="225" y="319"/>
                    <a:pt x="223" y="325"/>
                  </a:cubicBezTo>
                  <a:cubicBezTo>
                    <a:pt x="221" y="330"/>
                    <a:pt x="220" y="336"/>
                    <a:pt x="220" y="341"/>
                  </a:cubicBezTo>
                  <a:cubicBezTo>
                    <a:pt x="221" y="347"/>
                    <a:pt x="222" y="352"/>
                    <a:pt x="225" y="358"/>
                  </a:cubicBezTo>
                  <a:cubicBezTo>
                    <a:pt x="228" y="363"/>
                    <a:pt x="232" y="369"/>
                    <a:pt x="238" y="374"/>
                  </a:cubicBezTo>
                  <a:cubicBezTo>
                    <a:pt x="245" y="379"/>
                    <a:pt x="252" y="384"/>
                    <a:pt x="259" y="386"/>
                  </a:cubicBezTo>
                  <a:cubicBezTo>
                    <a:pt x="265" y="389"/>
                    <a:pt x="272" y="391"/>
                    <a:pt x="278" y="392"/>
                  </a:cubicBezTo>
                  <a:cubicBezTo>
                    <a:pt x="284" y="394"/>
                    <a:pt x="289" y="394"/>
                    <a:pt x="293" y="395"/>
                  </a:cubicBezTo>
                  <a:cubicBezTo>
                    <a:pt x="297" y="395"/>
                    <a:pt x="300" y="396"/>
                    <a:pt x="301" y="397"/>
                  </a:cubicBezTo>
                  <a:cubicBezTo>
                    <a:pt x="302" y="398"/>
                    <a:pt x="303" y="399"/>
                    <a:pt x="303" y="400"/>
                  </a:cubicBezTo>
                  <a:cubicBezTo>
                    <a:pt x="303" y="401"/>
                    <a:pt x="303" y="402"/>
                    <a:pt x="303" y="403"/>
                  </a:cubicBezTo>
                  <a:cubicBezTo>
                    <a:pt x="302" y="404"/>
                    <a:pt x="301" y="406"/>
                    <a:pt x="300" y="408"/>
                  </a:cubicBezTo>
                  <a:cubicBezTo>
                    <a:pt x="299" y="410"/>
                    <a:pt x="297" y="412"/>
                    <a:pt x="296" y="414"/>
                  </a:cubicBezTo>
                  <a:cubicBezTo>
                    <a:pt x="294" y="415"/>
                    <a:pt x="293" y="417"/>
                    <a:pt x="292" y="418"/>
                  </a:cubicBezTo>
                  <a:cubicBezTo>
                    <a:pt x="291" y="419"/>
                    <a:pt x="290" y="420"/>
                    <a:pt x="289" y="420"/>
                  </a:cubicBezTo>
                  <a:cubicBezTo>
                    <a:pt x="288" y="421"/>
                    <a:pt x="287" y="422"/>
                    <a:pt x="286" y="422"/>
                  </a:cubicBezTo>
                  <a:cubicBezTo>
                    <a:pt x="285" y="422"/>
                    <a:pt x="283" y="423"/>
                    <a:pt x="281" y="423"/>
                  </a:cubicBezTo>
                  <a:cubicBezTo>
                    <a:pt x="278" y="423"/>
                    <a:pt x="275" y="422"/>
                    <a:pt x="270" y="421"/>
                  </a:cubicBezTo>
                  <a:cubicBezTo>
                    <a:pt x="265" y="421"/>
                    <a:pt x="260" y="419"/>
                    <a:pt x="253" y="417"/>
                  </a:cubicBezTo>
                  <a:cubicBezTo>
                    <a:pt x="247" y="415"/>
                    <a:pt x="240" y="412"/>
                    <a:pt x="234" y="408"/>
                  </a:cubicBezTo>
                  <a:cubicBezTo>
                    <a:pt x="227" y="405"/>
                    <a:pt x="220" y="400"/>
                    <a:pt x="214" y="395"/>
                  </a:cubicBezTo>
                  <a:cubicBezTo>
                    <a:pt x="204" y="386"/>
                    <a:pt x="196" y="378"/>
                    <a:pt x="191" y="368"/>
                  </a:cubicBezTo>
                  <a:cubicBezTo>
                    <a:pt x="186" y="359"/>
                    <a:pt x="183" y="350"/>
                    <a:pt x="182" y="341"/>
                  </a:cubicBezTo>
                  <a:cubicBezTo>
                    <a:pt x="181" y="332"/>
                    <a:pt x="182" y="323"/>
                    <a:pt x="185" y="314"/>
                  </a:cubicBezTo>
                  <a:cubicBezTo>
                    <a:pt x="189" y="305"/>
                    <a:pt x="193" y="297"/>
                    <a:pt x="200" y="290"/>
                  </a:cubicBezTo>
                  <a:cubicBezTo>
                    <a:pt x="205" y="283"/>
                    <a:pt x="211" y="277"/>
                    <a:pt x="218" y="272"/>
                  </a:cubicBezTo>
                  <a:cubicBezTo>
                    <a:pt x="225" y="266"/>
                    <a:pt x="233" y="261"/>
                    <a:pt x="244" y="257"/>
                  </a:cubicBezTo>
                  <a:cubicBezTo>
                    <a:pt x="254" y="252"/>
                    <a:pt x="267" y="248"/>
                    <a:pt x="282" y="245"/>
                  </a:cubicBezTo>
                  <a:cubicBezTo>
                    <a:pt x="297" y="242"/>
                    <a:pt x="316" y="239"/>
                    <a:pt x="338" y="237"/>
                  </a:cubicBezTo>
                  <a:lnTo>
                    <a:pt x="400" y="230"/>
                  </a:lnTo>
                  <a:lnTo>
                    <a:pt x="310" y="154"/>
                  </a:lnTo>
                  <a:cubicBezTo>
                    <a:pt x="309" y="153"/>
                    <a:pt x="308" y="152"/>
                    <a:pt x="308" y="151"/>
                  </a:cubicBezTo>
                  <a:cubicBezTo>
                    <a:pt x="307" y="150"/>
                    <a:pt x="307" y="148"/>
                    <a:pt x="308" y="147"/>
                  </a:cubicBezTo>
                  <a:cubicBezTo>
                    <a:pt x="308" y="145"/>
                    <a:pt x="308" y="144"/>
                    <a:pt x="309" y="142"/>
                  </a:cubicBezTo>
                  <a:cubicBezTo>
                    <a:pt x="310" y="140"/>
                    <a:pt x="312" y="139"/>
                    <a:pt x="313" y="137"/>
                  </a:cubicBezTo>
                  <a:close/>
                  <a:moveTo>
                    <a:pt x="94" y="32"/>
                  </a:moveTo>
                  <a:cubicBezTo>
                    <a:pt x="97" y="28"/>
                    <a:pt x="99" y="26"/>
                    <a:pt x="102" y="25"/>
                  </a:cubicBezTo>
                  <a:cubicBezTo>
                    <a:pt x="105" y="23"/>
                    <a:pt x="107" y="24"/>
                    <a:pt x="109" y="25"/>
                  </a:cubicBezTo>
                  <a:lnTo>
                    <a:pt x="133" y="45"/>
                  </a:lnTo>
                  <a:lnTo>
                    <a:pt x="170" y="1"/>
                  </a:lnTo>
                  <a:cubicBezTo>
                    <a:pt x="171" y="1"/>
                    <a:pt x="172" y="0"/>
                    <a:pt x="172" y="0"/>
                  </a:cubicBezTo>
                  <a:cubicBezTo>
                    <a:pt x="173" y="0"/>
                    <a:pt x="175" y="0"/>
                    <a:pt x="176" y="0"/>
                  </a:cubicBezTo>
                  <a:cubicBezTo>
                    <a:pt x="178" y="1"/>
                    <a:pt x="179" y="2"/>
                    <a:pt x="181" y="3"/>
                  </a:cubicBezTo>
                  <a:cubicBezTo>
                    <a:pt x="183" y="4"/>
                    <a:pt x="186" y="6"/>
                    <a:pt x="188" y="8"/>
                  </a:cubicBezTo>
                  <a:cubicBezTo>
                    <a:pt x="191" y="11"/>
                    <a:pt x="193" y="13"/>
                    <a:pt x="195" y="14"/>
                  </a:cubicBezTo>
                  <a:cubicBezTo>
                    <a:pt x="196" y="16"/>
                    <a:pt x="197" y="18"/>
                    <a:pt x="198" y="19"/>
                  </a:cubicBezTo>
                  <a:cubicBezTo>
                    <a:pt x="199" y="20"/>
                    <a:pt x="199" y="21"/>
                    <a:pt x="199" y="22"/>
                  </a:cubicBezTo>
                  <a:cubicBezTo>
                    <a:pt x="199" y="23"/>
                    <a:pt x="198" y="24"/>
                    <a:pt x="198" y="25"/>
                  </a:cubicBezTo>
                  <a:lnTo>
                    <a:pt x="161" y="69"/>
                  </a:lnTo>
                  <a:lnTo>
                    <a:pt x="246" y="141"/>
                  </a:lnTo>
                  <a:cubicBezTo>
                    <a:pt x="247" y="142"/>
                    <a:pt x="248" y="143"/>
                    <a:pt x="248" y="144"/>
                  </a:cubicBezTo>
                  <a:cubicBezTo>
                    <a:pt x="249" y="145"/>
                    <a:pt x="249" y="146"/>
                    <a:pt x="249" y="148"/>
                  </a:cubicBezTo>
                  <a:cubicBezTo>
                    <a:pt x="249" y="149"/>
                    <a:pt x="249" y="151"/>
                    <a:pt x="248" y="153"/>
                  </a:cubicBezTo>
                  <a:cubicBezTo>
                    <a:pt x="246" y="155"/>
                    <a:pt x="245" y="157"/>
                    <a:pt x="243" y="159"/>
                  </a:cubicBezTo>
                  <a:cubicBezTo>
                    <a:pt x="241" y="161"/>
                    <a:pt x="239" y="163"/>
                    <a:pt x="238" y="165"/>
                  </a:cubicBezTo>
                  <a:cubicBezTo>
                    <a:pt x="236" y="166"/>
                    <a:pt x="235" y="168"/>
                    <a:pt x="233" y="169"/>
                  </a:cubicBezTo>
                  <a:cubicBezTo>
                    <a:pt x="232" y="170"/>
                    <a:pt x="230" y="171"/>
                    <a:pt x="229" y="171"/>
                  </a:cubicBezTo>
                  <a:cubicBezTo>
                    <a:pt x="227" y="172"/>
                    <a:pt x="226" y="173"/>
                    <a:pt x="224" y="174"/>
                  </a:cubicBezTo>
                  <a:lnTo>
                    <a:pt x="42" y="237"/>
                  </a:lnTo>
                  <a:cubicBezTo>
                    <a:pt x="41" y="238"/>
                    <a:pt x="39" y="238"/>
                    <a:pt x="38" y="237"/>
                  </a:cubicBezTo>
                  <a:cubicBezTo>
                    <a:pt x="36" y="237"/>
                    <a:pt x="34" y="237"/>
                    <a:pt x="32" y="236"/>
                  </a:cubicBezTo>
                  <a:cubicBezTo>
                    <a:pt x="30" y="235"/>
                    <a:pt x="28" y="233"/>
                    <a:pt x="26" y="231"/>
                  </a:cubicBezTo>
                  <a:cubicBezTo>
                    <a:pt x="23" y="229"/>
                    <a:pt x="20" y="227"/>
                    <a:pt x="17" y="224"/>
                  </a:cubicBezTo>
                  <a:cubicBezTo>
                    <a:pt x="13" y="221"/>
                    <a:pt x="10" y="218"/>
                    <a:pt x="8" y="216"/>
                  </a:cubicBezTo>
                  <a:cubicBezTo>
                    <a:pt x="5" y="213"/>
                    <a:pt x="4" y="211"/>
                    <a:pt x="2" y="209"/>
                  </a:cubicBezTo>
                  <a:cubicBezTo>
                    <a:pt x="1" y="208"/>
                    <a:pt x="0" y="206"/>
                    <a:pt x="0" y="204"/>
                  </a:cubicBezTo>
                  <a:cubicBezTo>
                    <a:pt x="0" y="203"/>
                    <a:pt x="0" y="202"/>
                    <a:pt x="1" y="201"/>
                  </a:cubicBezTo>
                  <a:lnTo>
                    <a:pt x="113" y="68"/>
                  </a:lnTo>
                  <a:lnTo>
                    <a:pt x="90" y="48"/>
                  </a:lnTo>
                  <a:cubicBezTo>
                    <a:pt x="88" y="47"/>
                    <a:pt x="87" y="44"/>
                    <a:pt x="88" y="42"/>
                  </a:cubicBezTo>
                  <a:cubicBezTo>
                    <a:pt x="88" y="39"/>
                    <a:pt x="90" y="35"/>
                    <a:pt x="94" y="32"/>
                  </a:cubicBezTo>
                  <a:close/>
                  <a:moveTo>
                    <a:pt x="44" y="206"/>
                  </a:moveTo>
                  <a:lnTo>
                    <a:pt x="45" y="206"/>
                  </a:lnTo>
                  <a:lnTo>
                    <a:pt x="208" y="149"/>
                  </a:lnTo>
                  <a:lnTo>
                    <a:pt x="141" y="92"/>
                  </a:lnTo>
                  <a:lnTo>
                    <a:pt x="44" y="206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30"/>
            <p:cNvSpPr/>
            <p:nvPr/>
          </p:nvSpPr>
          <p:spPr>
            <a:xfrm>
              <a:off x="4481640" y="3063960"/>
              <a:ext cx="314280" cy="299880"/>
            </a:xfrm>
            <a:custGeom>
              <a:avLst/>
              <a:gdLst>
                <a:gd name="textAreaLeft" fmla="*/ 0 w 314280"/>
                <a:gd name="textAreaRight" fmla="*/ 314640 w 314280"/>
                <a:gd name="textAreaTop" fmla="*/ 0 h 299880"/>
                <a:gd name="textAreaBottom" fmla="*/ 300240 h 299880"/>
              </a:gdLst>
              <a:ahLst/>
              <a:rect l="textAreaLeft" t="textAreaTop" r="textAreaRight" b="textAreaBottom"/>
              <a:pathLst>
                <a:path w="836" h="802">
                  <a:moveTo>
                    <a:pt x="599" y="168"/>
                  </a:moveTo>
                  <a:cubicBezTo>
                    <a:pt x="590" y="157"/>
                    <a:pt x="583" y="146"/>
                    <a:pt x="579" y="134"/>
                  </a:cubicBezTo>
                  <a:cubicBezTo>
                    <a:pt x="575" y="122"/>
                    <a:pt x="574" y="111"/>
                    <a:pt x="575" y="99"/>
                  </a:cubicBezTo>
                  <a:cubicBezTo>
                    <a:pt x="577" y="87"/>
                    <a:pt x="581" y="75"/>
                    <a:pt x="588" y="64"/>
                  </a:cubicBezTo>
                  <a:cubicBezTo>
                    <a:pt x="594" y="53"/>
                    <a:pt x="603" y="42"/>
                    <a:pt x="615" y="32"/>
                  </a:cubicBezTo>
                  <a:cubicBezTo>
                    <a:pt x="621" y="26"/>
                    <a:pt x="627" y="22"/>
                    <a:pt x="634" y="17"/>
                  </a:cubicBezTo>
                  <a:cubicBezTo>
                    <a:pt x="640" y="13"/>
                    <a:pt x="646" y="10"/>
                    <a:pt x="652" y="7"/>
                  </a:cubicBezTo>
                  <a:cubicBezTo>
                    <a:pt x="657" y="5"/>
                    <a:pt x="662" y="3"/>
                    <a:pt x="666" y="1"/>
                  </a:cubicBezTo>
                  <a:cubicBezTo>
                    <a:pt x="670" y="0"/>
                    <a:pt x="673" y="0"/>
                    <a:pt x="674" y="0"/>
                  </a:cubicBezTo>
                  <a:cubicBezTo>
                    <a:pt x="676" y="0"/>
                    <a:pt x="677" y="0"/>
                    <a:pt x="678" y="0"/>
                  </a:cubicBezTo>
                  <a:cubicBezTo>
                    <a:pt x="679" y="1"/>
                    <a:pt x="680" y="1"/>
                    <a:pt x="681" y="2"/>
                  </a:cubicBezTo>
                  <a:cubicBezTo>
                    <a:pt x="682" y="2"/>
                    <a:pt x="683" y="3"/>
                    <a:pt x="684" y="5"/>
                  </a:cubicBezTo>
                  <a:cubicBezTo>
                    <a:pt x="685" y="6"/>
                    <a:pt x="687" y="7"/>
                    <a:pt x="689" y="9"/>
                  </a:cubicBezTo>
                  <a:cubicBezTo>
                    <a:pt x="690" y="11"/>
                    <a:pt x="692" y="13"/>
                    <a:pt x="693" y="14"/>
                  </a:cubicBezTo>
                  <a:cubicBezTo>
                    <a:pt x="694" y="16"/>
                    <a:pt x="695" y="17"/>
                    <a:pt x="695" y="19"/>
                  </a:cubicBezTo>
                  <a:cubicBezTo>
                    <a:pt x="695" y="20"/>
                    <a:pt x="695" y="21"/>
                    <a:pt x="695" y="22"/>
                  </a:cubicBezTo>
                  <a:cubicBezTo>
                    <a:pt x="695" y="23"/>
                    <a:pt x="694" y="24"/>
                    <a:pt x="694" y="24"/>
                  </a:cubicBezTo>
                  <a:cubicBezTo>
                    <a:pt x="693" y="25"/>
                    <a:pt x="690" y="26"/>
                    <a:pt x="687" y="27"/>
                  </a:cubicBezTo>
                  <a:cubicBezTo>
                    <a:pt x="684" y="27"/>
                    <a:pt x="679" y="29"/>
                    <a:pt x="674" y="30"/>
                  </a:cubicBezTo>
                  <a:cubicBezTo>
                    <a:pt x="669" y="32"/>
                    <a:pt x="663" y="35"/>
                    <a:pt x="657" y="38"/>
                  </a:cubicBezTo>
                  <a:cubicBezTo>
                    <a:pt x="650" y="42"/>
                    <a:pt x="643" y="47"/>
                    <a:pt x="635" y="54"/>
                  </a:cubicBezTo>
                  <a:cubicBezTo>
                    <a:pt x="628" y="60"/>
                    <a:pt x="622" y="67"/>
                    <a:pt x="618" y="74"/>
                  </a:cubicBezTo>
                  <a:cubicBezTo>
                    <a:pt x="614" y="80"/>
                    <a:pt x="611" y="88"/>
                    <a:pt x="610" y="95"/>
                  </a:cubicBezTo>
                  <a:cubicBezTo>
                    <a:pt x="609" y="102"/>
                    <a:pt x="609" y="110"/>
                    <a:pt x="612" y="117"/>
                  </a:cubicBezTo>
                  <a:cubicBezTo>
                    <a:pt x="614" y="125"/>
                    <a:pt x="619" y="133"/>
                    <a:pt x="626" y="140"/>
                  </a:cubicBezTo>
                  <a:cubicBezTo>
                    <a:pt x="632" y="147"/>
                    <a:pt x="638" y="152"/>
                    <a:pt x="644" y="155"/>
                  </a:cubicBezTo>
                  <a:cubicBezTo>
                    <a:pt x="651" y="158"/>
                    <a:pt x="658" y="159"/>
                    <a:pt x="665" y="159"/>
                  </a:cubicBezTo>
                  <a:cubicBezTo>
                    <a:pt x="672" y="158"/>
                    <a:pt x="680" y="156"/>
                    <a:pt x="687" y="152"/>
                  </a:cubicBezTo>
                  <a:cubicBezTo>
                    <a:pt x="695" y="148"/>
                    <a:pt x="704" y="142"/>
                    <a:pt x="713" y="134"/>
                  </a:cubicBezTo>
                  <a:cubicBezTo>
                    <a:pt x="719" y="128"/>
                    <a:pt x="725" y="123"/>
                    <a:pt x="729" y="118"/>
                  </a:cubicBezTo>
                  <a:cubicBezTo>
                    <a:pt x="733" y="113"/>
                    <a:pt x="737" y="109"/>
                    <a:pt x="741" y="106"/>
                  </a:cubicBezTo>
                  <a:cubicBezTo>
                    <a:pt x="744" y="103"/>
                    <a:pt x="746" y="102"/>
                    <a:pt x="749" y="102"/>
                  </a:cubicBezTo>
                  <a:cubicBezTo>
                    <a:pt x="751" y="102"/>
                    <a:pt x="754" y="104"/>
                    <a:pt x="758" y="108"/>
                  </a:cubicBezTo>
                  <a:lnTo>
                    <a:pt x="832" y="191"/>
                  </a:lnTo>
                  <a:cubicBezTo>
                    <a:pt x="835" y="195"/>
                    <a:pt x="836" y="198"/>
                    <a:pt x="836" y="201"/>
                  </a:cubicBezTo>
                  <a:cubicBezTo>
                    <a:pt x="836" y="204"/>
                    <a:pt x="834" y="207"/>
                    <a:pt x="831" y="210"/>
                  </a:cubicBezTo>
                  <a:lnTo>
                    <a:pt x="741" y="290"/>
                  </a:lnTo>
                  <a:cubicBezTo>
                    <a:pt x="740" y="291"/>
                    <a:pt x="739" y="291"/>
                    <a:pt x="738" y="292"/>
                  </a:cubicBezTo>
                  <a:cubicBezTo>
                    <a:pt x="737" y="292"/>
                    <a:pt x="735" y="292"/>
                    <a:pt x="734" y="291"/>
                  </a:cubicBezTo>
                  <a:cubicBezTo>
                    <a:pt x="733" y="291"/>
                    <a:pt x="731" y="290"/>
                    <a:pt x="730" y="289"/>
                  </a:cubicBezTo>
                  <a:cubicBezTo>
                    <a:pt x="728" y="287"/>
                    <a:pt x="726" y="286"/>
                    <a:pt x="725" y="284"/>
                  </a:cubicBezTo>
                  <a:cubicBezTo>
                    <a:pt x="721" y="280"/>
                    <a:pt x="719" y="277"/>
                    <a:pt x="718" y="274"/>
                  </a:cubicBezTo>
                  <a:cubicBezTo>
                    <a:pt x="717" y="271"/>
                    <a:pt x="718" y="268"/>
                    <a:pt x="720" y="267"/>
                  </a:cubicBezTo>
                  <a:lnTo>
                    <a:pt x="793" y="202"/>
                  </a:lnTo>
                  <a:lnTo>
                    <a:pt x="742" y="145"/>
                  </a:lnTo>
                  <a:cubicBezTo>
                    <a:pt x="739" y="148"/>
                    <a:pt x="735" y="152"/>
                    <a:pt x="732" y="155"/>
                  </a:cubicBezTo>
                  <a:cubicBezTo>
                    <a:pt x="728" y="159"/>
                    <a:pt x="724" y="163"/>
                    <a:pt x="719" y="167"/>
                  </a:cubicBezTo>
                  <a:cubicBezTo>
                    <a:pt x="708" y="177"/>
                    <a:pt x="697" y="184"/>
                    <a:pt x="686" y="189"/>
                  </a:cubicBezTo>
                  <a:cubicBezTo>
                    <a:pt x="675" y="194"/>
                    <a:pt x="664" y="196"/>
                    <a:pt x="654" y="196"/>
                  </a:cubicBezTo>
                  <a:cubicBezTo>
                    <a:pt x="644" y="196"/>
                    <a:pt x="634" y="193"/>
                    <a:pt x="625" y="189"/>
                  </a:cubicBezTo>
                  <a:cubicBezTo>
                    <a:pt x="616" y="184"/>
                    <a:pt x="607" y="177"/>
                    <a:pt x="599" y="168"/>
                  </a:cubicBezTo>
                  <a:close/>
                  <a:moveTo>
                    <a:pt x="480" y="197"/>
                  </a:moveTo>
                  <a:cubicBezTo>
                    <a:pt x="477" y="194"/>
                    <a:pt x="474" y="191"/>
                    <a:pt x="472" y="188"/>
                  </a:cubicBezTo>
                  <a:cubicBezTo>
                    <a:pt x="470" y="185"/>
                    <a:pt x="469" y="182"/>
                    <a:pt x="467" y="179"/>
                  </a:cubicBezTo>
                  <a:cubicBezTo>
                    <a:pt x="466" y="176"/>
                    <a:pt x="465" y="173"/>
                    <a:pt x="464" y="169"/>
                  </a:cubicBezTo>
                  <a:cubicBezTo>
                    <a:pt x="463" y="166"/>
                    <a:pt x="462" y="162"/>
                    <a:pt x="461" y="158"/>
                  </a:cubicBezTo>
                  <a:lnTo>
                    <a:pt x="454" y="106"/>
                  </a:lnTo>
                  <a:cubicBezTo>
                    <a:pt x="454" y="105"/>
                    <a:pt x="454" y="104"/>
                    <a:pt x="454" y="102"/>
                  </a:cubicBezTo>
                  <a:cubicBezTo>
                    <a:pt x="455" y="101"/>
                    <a:pt x="455" y="100"/>
                    <a:pt x="456" y="99"/>
                  </a:cubicBezTo>
                  <a:cubicBezTo>
                    <a:pt x="456" y="98"/>
                    <a:pt x="457" y="96"/>
                    <a:pt x="458" y="95"/>
                  </a:cubicBezTo>
                  <a:cubicBezTo>
                    <a:pt x="459" y="94"/>
                    <a:pt x="461" y="92"/>
                    <a:pt x="463" y="90"/>
                  </a:cubicBezTo>
                  <a:cubicBezTo>
                    <a:pt x="465" y="89"/>
                    <a:pt x="466" y="87"/>
                    <a:pt x="468" y="86"/>
                  </a:cubicBezTo>
                  <a:cubicBezTo>
                    <a:pt x="469" y="86"/>
                    <a:pt x="470" y="85"/>
                    <a:pt x="471" y="85"/>
                  </a:cubicBezTo>
                  <a:cubicBezTo>
                    <a:pt x="472" y="85"/>
                    <a:pt x="473" y="85"/>
                    <a:pt x="473" y="86"/>
                  </a:cubicBezTo>
                  <a:cubicBezTo>
                    <a:pt x="474" y="86"/>
                    <a:pt x="474" y="87"/>
                    <a:pt x="475" y="88"/>
                  </a:cubicBezTo>
                  <a:lnTo>
                    <a:pt x="492" y="150"/>
                  </a:lnTo>
                  <a:lnTo>
                    <a:pt x="510" y="171"/>
                  </a:lnTo>
                  <a:cubicBezTo>
                    <a:pt x="513" y="173"/>
                    <a:pt x="514" y="176"/>
                    <a:pt x="515" y="178"/>
                  </a:cubicBezTo>
                  <a:cubicBezTo>
                    <a:pt x="516" y="180"/>
                    <a:pt x="516" y="182"/>
                    <a:pt x="516" y="184"/>
                  </a:cubicBezTo>
                  <a:cubicBezTo>
                    <a:pt x="515" y="186"/>
                    <a:pt x="514" y="188"/>
                    <a:pt x="513" y="190"/>
                  </a:cubicBezTo>
                  <a:cubicBezTo>
                    <a:pt x="511" y="192"/>
                    <a:pt x="509" y="194"/>
                    <a:pt x="506" y="197"/>
                  </a:cubicBezTo>
                  <a:cubicBezTo>
                    <a:pt x="504" y="199"/>
                    <a:pt x="501" y="201"/>
                    <a:pt x="499" y="202"/>
                  </a:cubicBezTo>
                  <a:cubicBezTo>
                    <a:pt x="497" y="204"/>
                    <a:pt x="495" y="205"/>
                    <a:pt x="493" y="205"/>
                  </a:cubicBezTo>
                  <a:cubicBezTo>
                    <a:pt x="491" y="205"/>
                    <a:pt x="489" y="205"/>
                    <a:pt x="487" y="203"/>
                  </a:cubicBezTo>
                  <a:cubicBezTo>
                    <a:pt x="485" y="202"/>
                    <a:pt x="482" y="200"/>
                    <a:pt x="480" y="197"/>
                  </a:cubicBezTo>
                  <a:close/>
                  <a:moveTo>
                    <a:pt x="373" y="435"/>
                  </a:moveTo>
                  <a:cubicBezTo>
                    <a:pt x="359" y="420"/>
                    <a:pt x="348" y="404"/>
                    <a:pt x="339" y="389"/>
                  </a:cubicBezTo>
                  <a:cubicBezTo>
                    <a:pt x="330" y="374"/>
                    <a:pt x="324" y="359"/>
                    <a:pt x="322" y="345"/>
                  </a:cubicBezTo>
                  <a:cubicBezTo>
                    <a:pt x="319" y="330"/>
                    <a:pt x="320" y="317"/>
                    <a:pt x="325" y="303"/>
                  </a:cubicBezTo>
                  <a:cubicBezTo>
                    <a:pt x="329" y="290"/>
                    <a:pt x="339" y="277"/>
                    <a:pt x="352" y="265"/>
                  </a:cubicBezTo>
                  <a:cubicBezTo>
                    <a:pt x="365" y="254"/>
                    <a:pt x="378" y="247"/>
                    <a:pt x="391" y="243"/>
                  </a:cubicBezTo>
                  <a:cubicBezTo>
                    <a:pt x="404" y="240"/>
                    <a:pt x="417" y="240"/>
                    <a:pt x="430" y="245"/>
                  </a:cubicBezTo>
                  <a:cubicBezTo>
                    <a:pt x="443" y="249"/>
                    <a:pt x="457" y="256"/>
                    <a:pt x="470" y="267"/>
                  </a:cubicBezTo>
                  <a:cubicBezTo>
                    <a:pt x="484" y="278"/>
                    <a:pt x="499" y="292"/>
                    <a:pt x="514" y="309"/>
                  </a:cubicBezTo>
                  <a:cubicBezTo>
                    <a:pt x="527" y="324"/>
                    <a:pt x="539" y="340"/>
                    <a:pt x="548" y="355"/>
                  </a:cubicBezTo>
                  <a:cubicBezTo>
                    <a:pt x="557" y="370"/>
                    <a:pt x="563" y="385"/>
                    <a:pt x="565" y="399"/>
                  </a:cubicBezTo>
                  <a:cubicBezTo>
                    <a:pt x="568" y="414"/>
                    <a:pt x="567" y="428"/>
                    <a:pt x="562" y="441"/>
                  </a:cubicBezTo>
                  <a:cubicBezTo>
                    <a:pt x="557" y="454"/>
                    <a:pt x="548" y="467"/>
                    <a:pt x="535" y="479"/>
                  </a:cubicBezTo>
                  <a:cubicBezTo>
                    <a:pt x="522" y="490"/>
                    <a:pt x="509" y="498"/>
                    <a:pt x="496" y="501"/>
                  </a:cubicBezTo>
                  <a:cubicBezTo>
                    <a:pt x="483" y="504"/>
                    <a:pt x="470" y="504"/>
                    <a:pt x="457" y="500"/>
                  </a:cubicBezTo>
                  <a:cubicBezTo>
                    <a:pt x="444" y="495"/>
                    <a:pt x="430" y="488"/>
                    <a:pt x="416" y="477"/>
                  </a:cubicBezTo>
                  <a:cubicBezTo>
                    <a:pt x="403" y="466"/>
                    <a:pt x="388" y="452"/>
                    <a:pt x="373" y="435"/>
                  </a:cubicBezTo>
                  <a:close/>
                  <a:moveTo>
                    <a:pt x="399" y="409"/>
                  </a:moveTo>
                  <a:cubicBezTo>
                    <a:pt x="408" y="419"/>
                    <a:pt x="417" y="428"/>
                    <a:pt x="425" y="435"/>
                  </a:cubicBezTo>
                  <a:cubicBezTo>
                    <a:pt x="433" y="443"/>
                    <a:pt x="440" y="449"/>
                    <a:pt x="447" y="454"/>
                  </a:cubicBezTo>
                  <a:cubicBezTo>
                    <a:pt x="454" y="459"/>
                    <a:pt x="461" y="462"/>
                    <a:pt x="467" y="465"/>
                  </a:cubicBezTo>
                  <a:cubicBezTo>
                    <a:pt x="473" y="467"/>
                    <a:pt x="479" y="469"/>
                    <a:pt x="485" y="469"/>
                  </a:cubicBezTo>
                  <a:cubicBezTo>
                    <a:pt x="490" y="469"/>
                    <a:pt x="496" y="468"/>
                    <a:pt x="501" y="465"/>
                  </a:cubicBezTo>
                  <a:cubicBezTo>
                    <a:pt x="506" y="463"/>
                    <a:pt x="512" y="460"/>
                    <a:pt x="517" y="455"/>
                  </a:cubicBezTo>
                  <a:cubicBezTo>
                    <a:pt x="525" y="447"/>
                    <a:pt x="531" y="439"/>
                    <a:pt x="533" y="430"/>
                  </a:cubicBezTo>
                  <a:cubicBezTo>
                    <a:pt x="535" y="420"/>
                    <a:pt x="534" y="411"/>
                    <a:pt x="530" y="401"/>
                  </a:cubicBezTo>
                  <a:cubicBezTo>
                    <a:pt x="527" y="390"/>
                    <a:pt x="522" y="380"/>
                    <a:pt x="514" y="369"/>
                  </a:cubicBezTo>
                  <a:cubicBezTo>
                    <a:pt x="506" y="358"/>
                    <a:pt x="498" y="347"/>
                    <a:pt x="487" y="335"/>
                  </a:cubicBezTo>
                  <a:cubicBezTo>
                    <a:pt x="474" y="320"/>
                    <a:pt x="462" y="308"/>
                    <a:pt x="451" y="299"/>
                  </a:cubicBezTo>
                  <a:cubicBezTo>
                    <a:pt x="439" y="289"/>
                    <a:pt x="429" y="283"/>
                    <a:pt x="420" y="279"/>
                  </a:cubicBezTo>
                  <a:cubicBezTo>
                    <a:pt x="410" y="276"/>
                    <a:pt x="402" y="275"/>
                    <a:pt x="394" y="276"/>
                  </a:cubicBezTo>
                  <a:cubicBezTo>
                    <a:pt x="386" y="278"/>
                    <a:pt x="378" y="282"/>
                    <a:pt x="370" y="289"/>
                  </a:cubicBezTo>
                  <a:cubicBezTo>
                    <a:pt x="364" y="294"/>
                    <a:pt x="360" y="300"/>
                    <a:pt x="357" y="305"/>
                  </a:cubicBezTo>
                  <a:cubicBezTo>
                    <a:pt x="355" y="311"/>
                    <a:pt x="353" y="317"/>
                    <a:pt x="353" y="324"/>
                  </a:cubicBezTo>
                  <a:cubicBezTo>
                    <a:pt x="353" y="330"/>
                    <a:pt x="354" y="337"/>
                    <a:pt x="356" y="344"/>
                  </a:cubicBezTo>
                  <a:cubicBezTo>
                    <a:pt x="359" y="350"/>
                    <a:pt x="362" y="357"/>
                    <a:pt x="366" y="364"/>
                  </a:cubicBezTo>
                  <a:cubicBezTo>
                    <a:pt x="370" y="372"/>
                    <a:pt x="375" y="379"/>
                    <a:pt x="381" y="386"/>
                  </a:cubicBezTo>
                  <a:cubicBezTo>
                    <a:pt x="386" y="394"/>
                    <a:pt x="393" y="401"/>
                    <a:pt x="399" y="409"/>
                  </a:cubicBezTo>
                  <a:close/>
                  <a:moveTo>
                    <a:pt x="164" y="541"/>
                  </a:moveTo>
                  <a:cubicBezTo>
                    <a:pt x="161" y="538"/>
                    <a:pt x="159" y="535"/>
                    <a:pt x="159" y="532"/>
                  </a:cubicBezTo>
                  <a:cubicBezTo>
                    <a:pt x="158" y="529"/>
                    <a:pt x="159" y="526"/>
                    <a:pt x="160" y="525"/>
                  </a:cubicBezTo>
                  <a:lnTo>
                    <a:pt x="183" y="504"/>
                  </a:lnTo>
                  <a:lnTo>
                    <a:pt x="145" y="461"/>
                  </a:lnTo>
                  <a:cubicBezTo>
                    <a:pt x="145" y="461"/>
                    <a:pt x="144" y="460"/>
                    <a:pt x="144" y="459"/>
                  </a:cubicBezTo>
                  <a:cubicBezTo>
                    <a:pt x="144" y="458"/>
                    <a:pt x="144" y="457"/>
                    <a:pt x="145" y="455"/>
                  </a:cubicBezTo>
                  <a:cubicBezTo>
                    <a:pt x="146" y="454"/>
                    <a:pt x="147" y="452"/>
                    <a:pt x="148" y="451"/>
                  </a:cubicBezTo>
                  <a:cubicBezTo>
                    <a:pt x="150" y="449"/>
                    <a:pt x="152" y="447"/>
                    <a:pt x="155" y="444"/>
                  </a:cubicBezTo>
                  <a:cubicBezTo>
                    <a:pt x="157" y="442"/>
                    <a:pt x="160" y="440"/>
                    <a:pt x="162" y="439"/>
                  </a:cubicBezTo>
                  <a:cubicBezTo>
                    <a:pt x="164" y="438"/>
                    <a:pt x="165" y="437"/>
                    <a:pt x="167" y="436"/>
                  </a:cubicBezTo>
                  <a:cubicBezTo>
                    <a:pt x="168" y="436"/>
                    <a:pt x="169" y="435"/>
                    <a:pt x="170" y="436"/>
                  </a:cubicBezTo>
                  <a:cubicBezTo>
                    <a:pt x="171" y="436"/>
                    <a:pt x="172" y="437"/>
                    <a:pt x="172" y="437"/>
                  </a:cubicBezTo>
                  <a:lnTo>
                    <a:pt x="211" y="480"/>
                  </a:lnTo>
                  <a:lnTo>
                    <a:pt x="294" y="406"/>
                  </a:lnTo>
                  <a:cubicBezTo>
                    <a:pt x="295" y="405"/>
                    <a:pt x="296" y="404"/>
                    <a:pt x="298" y="404"/>
                  </a:cubicBezTo>
                  <a:cubicBezTo>
                    <a:pt x="299" y="403"/>
                    <a:pt x="300" y="403"/>
                    <a:pt x="301" y="403"/>
                  </a:cubicBezTo>
                  <a:cubicBezTo>
                    <a:pt x="303" y="404"/>
                    <a:pt x="304" y="404"/>
                    <a:pt x="306" y="406"/>
                  </a:cubicBezTo>
                  <a:cubicBezTo>
                    <a:pt x="308" y="407"/>
                    <a:pt x="310" y="409"/>
                    <a:pt x="312" y="412"/>
                  </a:cubicBezTo>
                  <a:cubicBezTo>
                    <a:pt x="314" y="414"/>
                    <a:pt x="315" y="415"/>
                    <a:pt x="317" y="417"/>
                  </a:cubicBezTo>
                  <a:cubicBezTo>
                    <a:pt x="318" y="419"/>
                    <a:pt x="319" y="420"/>
                    <a:pt x="320" y="422"/>
                  </a:cubicBezTo>
                  <a:cubicBezTo>
                    <a:pt x="321" y="424"/>
                    <a:pt x="321" y="425"/>
                    <a:pt x="322" y="427"/>
                  </a:cubicBezTo>
                  <a:cubicBezTo>
                    <a:pt x="322" y="429"/>
                    <a:pt x="323" y="430"/>
                    <a:pt x="323" y="432"/>
                  </a:cubicBezTo>
                  <a:lnTo>
                    <a:pt x="361" y="621"/>
                  </a:lnTo>
                  <a:cubicBezTo>
                    <a:pt x="361" y="622"/>
                    <a:pt x="361" y="624"/>
                    <a:pt x="360" y="625"/>
                  </a:cubicBezTo>
                  <a:cubicBezTo>
                    <a:pt x="360" y="627"/>
                    <a:pt x="359" y="629"/>
                    <a:pt x="358" y="630"/>
                  </a:cubicBezTo>
                  <a:cubicBezTo>
                    <a:pt x="357" y="632"/>
                    <a:pt x="355" y="634"/>
                    <a:pt x="353" y="637"/>
                  </a:cubicBezTo>
                  <a:cubicBezTo>
                    <a:pt x="351" y="639"/>
                    <a:pt x="348" y="641"/>
                    <a:pt x="345" y="644"/>
                  </a:cubicBezTo>
                  <a:cubicBezTo>
                    <a:pt x="341" y="647"/>
                    <a:pt x="338" y="650"/>
                    <a:pt x="335" y="652"/>
                  </a:cubicBezTo>
                  <a:cubicBezTo>
                    <a:pt x="332" y="654"/>
                    <a:pt x="330" y="656"/>
                    <a:pt x="328" y="657"/>
                  </a:cubicBezTo>
                  <a:cubicBezTo>
                    <a:pt x="326" y="658"/>
                    <a:pt x="324" y="658"/>
                    <a:pt x="323" y="658"/>
                  </a:cubicBezTo>
                  <a:cubicBezTo>
                    <a:pt x="321" y="658"/>
                    <a:pt x="320" y="658"/>
                    <a:pt x="319" y="657"/>
                  </a:cubicBezTo>
                  <a:lnTo>
                    <a:pt x="203" y="527"/>
                  </a:lnTo>
                  <a:lnTo>
                    <a:pt x="180" y="547"/>
                  </a:lnTo>
                  <a:cubicBezTo>
                    <a:pt x="179" y="549"/>
                    <a:pt x="176" y="549"/>
                    <a:pt x="174" y="548"/>
                  </a:cubicBezTo>
                  <a:cubicBezTo>
                    <a:pt x="171" y="547"/>
                    <a:pt x="168" y="545"/>
                    <a:pt x="164" y="541"/>
                  </a:cubicBezTo>
                  <a:close/>
                  <a:moveTo>
                    <a:pt x="330" y="615"/>
                  </a:moveTo>
                  <a:lnTo>
                    <a:pt x="330" y="614"/>
                  </a:lnTo>
                  <a:lnTo>
                    <a:pt x="296" y="444"/>
                  </a:lnTo>
                  <a:lnTo>
                    <a:pt x="230" y="503"/>
                  </a:lnTo>
                  <a:lnTo>
                    <a:pt x="330" y="615"/>
                  </a:lnTo>
                  <a:close/>
                  <a:moveTo>
                    <a:pt x="25" y="679"/>
                  </a:moveTo>
                  <a:cubicBezTo>
                    <a:pt x="16" y="668"/>
                    <a:pt x="9" y="656"/>
                    <a:pt x="5" y="644"/>
                  </a:cubicBezTo>
                  <a:cubicBezTo>
                    <a:pt x="1" y="633"/>
                    <a:pt x="0" y="621"/>
                    <a:pt x="1" y="609"/>
                  </a:cubicBezTo>
                  <a:cubicBezTo>
                    <a:pt x="3" y="597"/>
                    <a:pt x="7" y="586"/>
                    <a:pt x="14" y="574"/>
                  </a:cubicBezTo>
                  <a:cubicBezTo>
                    <a:pt x="20" y="563"/>
                    <a:pt x="29" y="552"/>
                    <a:pt x="40" y="542"/>
                  </a:cubicBezTo>
                  <a:cubicBezTo>
                    <a:pt x="47" y="537"/>
                    <a:pt x="53" y="532"/>
                    <a:pt x="60" y="528"/>
                  </a:cubicBezTo>
                  <a:cubicBezTo>
                    <a:pt x="66" y="523"/>
                    <a:pt x="72" y="520"/>
                    <a:pt x="78" y="517"/>
                  </a:cubicBezTo>
                  <a:cubicBezTo>
                    <a:pt x="83" y="515"/>
                    <a:pt x="88" y="513"/>
                    <a:pt x="92" y="512"/>
                  </a:cubicBezTo>
                  <a:cubicBezTo>
                    <a:pt x="96" y="510"/>
                    <a:pt x="99" y="510"/>
                    <a:pt x="100" y="510"/>
                  </a:cubicBezTo>
                  <a:cubicBezTo>
                    <a:pt x="102" y="510"/>
                    <a:pt x="103" y="510"/>
                    <a:pt x="104" y="510"/>
                  </a:cubicBezTo>
                  <a:cubicBezTo>
                    <a:pt x="104" y="511"/>
                    <a:pt x="105" y="511"/>
                    <a:pt x="107" y="512"/>
                  </a:cubicBezTo>
                  <a:cubicBezTo>
                    <a:pt x="108" y="513"/>
                    <a:pt x="109" y="514"/>
                    <a:pt x="110" y="515"/>
                  </a:cubicBezTo>
                  <a:cubicBezTo>
                    <a:pt x="111" y="516"/>
                    <a:pt x="113" y="518"/>
                    <a:pt x="115" y="520"/>
                  </a:cubicBezTo>
                  <a:cubicBezTo>
                    <a:pt x="116" y="521"/>
                    <a:pt x="118" y="523"/>
                    <a:pt x="119" y="525"/>
                  </a:cubicBezTo>
                  <a:cubicBezTo>
                    <a:pt x="120" y="526"/>
                    <a:pt x="120" y="528"/>
                    <a:pt x="121" y="529"/>
                  </a:cubicBezTo>
                  <a:cubicBezTo>
                    <a:pt x="121" y="530"/>
                    <a:pt x="121" y="531"/>
                    <a:pt x="121" y="532"/>
                  </a:cubicBezTo>
                  <a:cubicBezTo>
                    <a:pt x="121" y="533"/>
                    <a:pt x="120" y="534"/>
                    <a:pt x="120" y="535"/>
                  </a:cubicBezTo>
                  <a:cubicBezTo>
                    <a:pt x="119" y="535"/>
                    <a:pt x="116" y="536"/>
                    <a:pt x="113" y="537"/>
                  </a:cubicBezTo>
                  <a:cubicBezTo>
                    <a:pt x="110" y="538"/>
                    <a:pt x="105" y="539"/>
                    <a:pt x="100" y="541"/>
                  </a:cubicBezTo>
                  <a:cubicBezTo>
                    <a:pt x="95" y="542"/>
                    <a:pt x="89" y="545"/>
                    <a:pt x="83" y="549"/>
                  </a:cubicBezTo>
                  <a:cubicBezTo>
                    <a:pt x="76" y="552"/>
                    <a:pt x="69" y="557"/>
                    <a:pt x="61" y="564"/>
                  </a:cubicBezTo>
                  <a:cubicBezTo>
                    <a:pt x="54" y="570"/>
                    <a:pt x="48" y="577"/>
                    <a:pt x="44" y="584"/>
                  </a:cubicBezTo>
                  <a:cubicBezTo>
                    <a:pt x="40" y="591"/>
                    <a:pt x="37" y="598"/>
                    <a:pt x="36" y="605"/>
                  </a:cubicBezTo>
                  <a:cubicBezTo>
                    <a:pt x="35" y="612"/>
                    <a:pt x="35" y="620"/>
                    <a:pt x="38" y="627"/>
                  </a:cubicBezTo>
                  <a:cubicBezTo>
                    <a:pt x="40" y="635"/>
                    <a:pt x="45" y="643"/>
                    <a:pt x="52" y="650"/>
                  </a:cubicBezTo>
                  <a:cubicBezTo>
                    <a:pt x="58" y="657"/>
                    <a:pt x="64" y="662"/>
                    <a:pt x="70" y="665"/>
                  </a:cubicBezTo>
                  <a:cubicBezTo>
                    <a:pt x="77" y="668"/>
                    <a:pt x="83" y="670"/>
                    <a:pt x="91" y="669"/>
                  </a:cubicBezTo>
                  <a:cubicBezTo>
                    <a:pt x="98" y="669"/>
                    <a:pt x="105" y="666"/>
                    <a:pt x="113" y="662"/>
                  </a:cubicBezTo>
                  <a:cubicBezTo>
                    <a:pt x="121" y="658"/>
                    <a:pt x="130" y="652"/>
                    <a:pt x="139" y="644"/>
                  </a:cubicBezTo>
                  <a:cubicBezTo>
                    <a:pt x="145" y="638"/>
                    <a:pt x="151" y="633"/>
                    <a:pt x="155" y="628"/>
                  </a:cubicBezTo>
                  <a:cubicBezTo>
                    <a:pt x="159" y="623"/>
                    <a:pt x="163" y="619"/>
                    <a:pt x="167" y="616"/>
                  </a:cubicBezTo>
                  <a:cubicBezTo>
                    <a:pt x="170" y="613"/>
                    <a:pt x="172" y="612"/>
                    <a:pt x="175" y="612"/>
                  </a:cubicBezTo>
                  <a:cubicBezTo>
                    <a:pt x="177" y="612"/>
                    <a:pt x="180" y="614"/>
                    <a:pt x="184" y="618"/>
                  </a:cubicBezTo>
                  <a:lnTo>
                    <a:pt x="258" y="701"/>
                  </a:lnTo>
                  <a:cubicBezTo>
                    <a:pt x="261" y="705"/>
                    <a:pt x="262" y="708"/>
                    <a:pt x="262" y="711"/>
                  </a:cubicBezTo>
                  <a:cubicBezTo>
                    <a:pt x="262" y="714"/>
                    <a:pt x="260" y="717"/>
                    <a:pt x="257" y="720"/>
                  </a:cubicBezTo>
                  <a:lnTo>
                    <a:pt x="167" y="800"/>
                  </a:lnTo>
                  <a:cubicBezTo>
                    <a:pt x="166" y="801"/>
                    <a:pt x="165" y="802"/>
                    <a:pt x="164" y="802"/>
                  </a:cubicBezTo>
                  <a:cubicBezTo>
                    <a:pt x="163" y="802"/>
                    <a:pt x="161" y="802"/>
                    <a:pt x="160" y="801"/>
                  </a:cubicBezTo>
                  <a:cubicBezTo>
                    <a:pt x="159" y="801"/>
                    <a:pt x="157" y="800"/>
                    <a:pt x="156" y="799"/>
                  </a:cubicBezTo>
                  <a:cubicBezTo>
                    <a:pt x="154" y="798"/>
                    <a:pt x="152" y="796"/>
                    <a:pt x="151" y="794"/>
                  </a:cubicBezTo>
                  <a:cubicBezTo>
                    <a:pt x="147" y="790"/>
                    <a:pt x="145" y="787"/>
                    <a:pt x="144" y="784"/>
                  </a:cubicBezTo>
                  <a:cubicBezTo>
                    <a:pt x="143" y="781"/>
                    <a:pt x="144" y="779"/>
                    <a:pt x="146" y="777"/>
                  </a:cubicBezTo>
                  <a:lnTo>
                    <a:pt x="219" y="712"/>
                  </a:lnTo>
                  <a:lnTo>
                    <a:pt x="168" y="655"/>
                  </a:lnTo>
                  <a:cubicBezTo>
                    <a:pt x="165" y="659"/>
                    <a:pt x="161" y="662"/>
                    <a:pt x="158" y="666"/>
                  </a:cubicBezTo>
                  <a:cubicBezTo>
                    <a:pt x="154" y="669"/>
                    <a:pt x="150" y="673"/>
                    <a:pt x="145" y="677"/>
                  </a:cubicBezTo>
                  <a:cubicBezTo>
                    <a:pt x="134" y="687"/>
                    <a:pt x="123" y="694"/>
                    <a:pt x="112" y="699"/>
                  </a:cubicBezTo>
                  <a:cubicBezTo>
                    <a:pt x="101" y="704"/>
                    <a:pt x="90" y="706"/>
                    <a:pt x="80" y="706"/>
                  </a:cubicBezTo>
                  <a:cubicBezTo>
                    <a:pt x="70" y="706"/>
                    <a:pt x="60" y="703"/>
                    <a:pt x="51" y="699"/>
                  </a:cubicBezTo>
                  <a:cubicBezTo>
                    <a:pt x="42" y="694"/>
                    <a:pt x="33" y="687"/>
                    <a:pt x="25" y="679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31"/>
            <p:cNvSpPr/>
            <p:nvPr/>
          </p:nvSpPr>
          <p:spPr>
            <a:xfrm>
              <a:off x="4784760" y="2400480"/>
              <a:ext cx="190440" cy="360360"/>
            </a:xfrm>
            <a:custGeom>
              <a:avLst/>
              <a:gdLst>
                <a:gd name="textAreaLeft" fmla="*/ 0 w 190440"/>
                <a:gd name="textAreaRight" fmla="*/ 190800 w 190440"/>
                <a:gd name="textAreaTop" fmla="*/ 0 h 360360"/>
                <a:gd name="textAreaBottom" fmla="*/ 360720 h 360360"/>
              </a:gdLst>
              <a:ahLst/>
              <a:rect l="textAreaLeft" t="textAreaTop" r="textAreaRight" b="textAreaBottom"/>
              <a:pathLst>
                <a:path w="505" h="965">
                  <a:moveTo>
                    <a:pt x="63" y="220"/>
                  </a:moveTo>
                  <a:cubicBezTo>
                    <a:pt x="61" y="221"/>
                    <a:pt x="59" y="221"/>
                    <a:pt x="57" y="221"/>
                  </a:cubicBezTo>
                  <a:cubicBezTo>
                    <a:pt x="55" y="222"/>
                    <a:pt x="53" y="221"/>
                    <a:pt x="51" y="221"/>
                  </a:cubicBezTo>
                  <a:cubicBezTo>
                    <a:pt x="50" y="221"/>
                    <a:pt x="49" y="220"/>
                    <a:pt x="48" y="220"/>
                  </a:cubicBezTo>
                  <a:cubicBezTo>
                    <a:pt x="47" y="219"/>
                    <a:pt x="46" y="218"/>
                    <a:pt x="46" y="216"/>
                  </a:cubicBezTo>
                  <a:lnTo>
                    <a:pt x="7" y="71"/>
                  </a:lnTo>
                  <a:cubicBezTo>
                    <a:pt x="6" y="69"/>
                    <a:pt x="6" y="67"/>
                    <a:pt x="6" y="66"/>
                  </a:cubicBezTo>
                  <a:cubicBezTo>
                    <a:pt x="6" y="64"/>
                    <a:pt x="6" y="63"/>
                    <a:pt x="7" y="61"/>
                  </a:cubicBezTo>
                  <a:cubicBezTo>
                    <a:pt x="8" y="60"/>
                    <a:pt x="9" y="59"/>
                    <a:pt x="11" y="58"/>
                  </a:cubicBezTo>
                  <a:cubicBezTo>
                    <a:pt x="13" y="57"/>
                    <a:pt x="16" y="56"/>
                    <a:pt x="19" y="55"/>
                  </a:cubicBezTo>
                  <a:cubicBezTo>
                    <a:pt x="21" y="54"/>
                    <a:pt x="24" y="54"/>
                    <a:pt x="26" y="54"/>
                  </a:cubicBezTo>
                  <a:cubicBezTo>
                    <a:pt x="28" y="53"/>
                    <a:pt x="30" y="53"/>
                    <a:pt x="32" y="53"/>
                  </a:cubicBezTo>
                  <a:cubicBezTo>
                    <a:pt x="33" y="54"/>
                    <a:pt x="35" y="54"/>
                    <a:pt x="37" y="55"/>
                  </a:cubicBezTo>
                  <a:cubicBezTo>
                    <a:pt x="39" y="55"/>
                    <a:pt x="41" y="56"/>
                    <a:pt x="43" y="57"/>
                  </a:cubicBezTo>
                  <a:lnTo>
                    <a:pt x="112" y="95"/>
                  </a:lnTo>
                  <a:cubicBezTo>
                    <a:pt x="127" y="104"/>
                    <a:pt x="141" y="111"/>
                    <a:pt x="153" y="116"/>
                  </a:cubicBezTo>
                  <a:cubicBezTo>
                    <a:pt x="165" y="120"/>
                    <a:pt x="176" y="123"/>
                    <a:pt x="185" y="125"/>
                  </a:cubicBezTo>
                  <a:cubicBezTo>
                    <a:pt x="194" y="127"/>
                    <a:pt x="202" y="128"/>
                    <a:pt x="209" y="127"/>
                  </a:cubicBezTo>
                  <a:cubicBezTo>
                    <a:pt x="216" y="127"/>
                    <a:pt x="222" y="125"/>
                    <a:pt x="228" y="124"/>
                  </a:cubicBezTo>
                  <a:cubicBezTo>
                    <a:pt x="234" y="122"/>
                    <a:pt x="239" y="120"/>
                    <a:pt x="244" y="116"/>
                  </a:cubicBezTo>
                  <a:cubicBezTo>
                    <a:pt x="249" y="113"/>
                    <a:pt x="253" y="109"/>
                    <a:pt x="256" y="104"/>
                  </a:cubicBezTo>
                  <a:cubicBezTo>
                    <a:pt x="258" y="99"/>
                    <a:pt x="260" y="94"/>
                    <a:pt x="261" y="88"/>
                  </a:cubicBezTo>
                  <a:cubicBezTo>
                    <a:pt x="262" y="81"/>
                    <a:pt x="261" y="75"/>
                    <a:pt x="259" y="67"/>
                  </a:cubicBezTo>
                  <a:cubicBezTo>
                    <a:pt x="257" y="59"/>
                    <a:pt x="254" y="52"/>
                    <a:pt x="250" y="45"/>
                  </a:cubicBezTo>
                  <a:cubicBezTo>
                    <a:pt x="245" y="39"/>
                    <a:pt x="241" y="34"/>
                    <a:pt x="237" y="30"/>
                  </a:cubicBezTo>
                  <a:cubicBezTo>
                    <a:pt x="233" y="25"/>
                    <a:pt x="229" y="22"/>
                    <a:pt x="226" y="19"/>
                  </a:cubicBezTo>
                  <a:cubicBezTo>
                    <a:pt x="223" y="16"/>
                    <a:pt x="221" y="14"/>
                    <a:pt x="221" y="12"/>
                  </a:cubicBezTo>
                  <a:cubicBezTo>
                    <a:pt x="220" y="11"/>
                    <a:pt x="220" y="10"/>
                    <a:pt x="221" y="9"/>
                  </a:cubicBezTo>
                  <a:cubicBezTo>
                    <a:pt x="221" y="8"/>
                    <a:pt x="222" y="7"/>
                    <a:pt x="223" y="7"/>
                  </a:cubicBezTo>
                  <a:cubicBezTo>
                    <a:pt x="224" y="6"/>
                    <a:pt x="226" y="5"/>
                    <a:pt x="227" y="4"/>
                  </a:cubicBezTo>
                  <a:cubicBezTo>
                    <a:pt x="229" y="3"/>
                    <a:pt x="232" y="2"/>
                    <a:pt x="235" y="2"/>
                  </a:cubicBezTo>
                  <a:cubicBezTo>
                    <a:pt x="237" y="1"/>
                    <a:pt x="239" y="1"/>
                    <a:pt x="240" y="0"/>
                  </a:cubicBezTo>
                  <a:cubicBezTo>
                    <a:pt x="242" y="0"/>
                    <a:pt x="243" y="0"/>
                    <a:pt x="244" y="0"/>
                  </a:cubicBezTo>
                  <a:cubicBezTo>
                    <a:pt x="245" y="0"/>
                    <a:pt x="246" y="0"/>
                    <a:pt x="248" y="1"/>
                  </a:cubicBezTo>
                  <a:cubicBezTo>
                    <a:pt x="249" y="1"/>
                    <a:pt x="250" y="2"/>
                    <a:pt x="252" y="3"/>
                  </a:cubicBezTo>
                  <a:cubicBezTo>
                    <a:pt x="254" y="4"/>
                    <a:pt x="257" y="6"/>
                    <a:pt x="260" y="10"/>
                  </a:cubicBezTo>
                  <a:cubicBezTo>
                    <a:pt x="264" y="13"/>
                    <a:pt x="267" y="17"/>
                    <a:pt x="271" y="23"/>
                  </a:cubicBezTo>
                  <a:cubicBezTo>
                    <a:pt x="275" y="28"/>
                    <a:pt x="279" y="34"/>
                    <a:pt x="283" y="41"/>
                  </a:cubicBezTo>
                  <a:cubicBezTo>
                    <a:pt x="286" y="48"/>
                    <a:pt x="289" y="55"/>
                    <a:pt x="291" y="63"/>
                  </a:cubicBezTo>
                  <a:cubicBezTo>
                    <a:pt x="295" y="76"/>
                    <a:pt x="296" y="88"/>
                    <a:pt x="295" y="98"/>
                  </a:cubicBezTo>
                  <a:cubicBezTo>
                    <a:pt x="294" y="109"/>
                    <a:pt x="291" y="118"/>
                    <a:pt x="287" y="126"/>
                  </a:cubicBezTo>
                  <a:cubicBezTo>
                    <a:pt x="282" y="134"/>
                    <a:pt x="276" y="141"/>
                    <a:pt x="269" y="146"/>
                  </a:cubicBezTo>
                  <a:cubicBezTo>
                    <a:pt x="262" y="152"/>
                    <a:pt x="253" y="156"/>
                    <a:pt x="244" y="158"/>
                  </a:cubicBezTo>
                  <a:cubicBezTo>
                    <a:pt x="235" y="160"/>
                    <a:pt x="227" y="162"/>
                    <a:pt x="218" y="163"/>
                  </a:cubicBezTo>
                  <a:cubicBezTo>
                    <a:pt x="209" y="164"/>
                    <a:pt x="199" y="163"/>
                    <a:pt x="188" y="161"/>
                  </a:cubicBezTo>
                  <a:cubicBezTo>
                    <a:pt x="177" y="158"/>
                    <a:pt x="165" y="154"/>
                    <a:pt x="150" y="149"/>
                  </a:cubicBezTo>
                  <a:cubicBezTo>
                    <a:pt x="136" y="143"/>
                    <a:pt x="119" y="134"/>
                    <a:pt x="99" y="123"/>
                  </a:cubicBezTo>
                  <a:lnTo>
                    <a:pt x="45" y="94"/>
                  </a:lnTo>
                  <a:lnTo>
                    <a:pt x="76" y="208"/>
                  </a:lnTo>
                  <a:cubicBezTo>
                    <a:pt x="76" y="209"/>
                    <a:pt x="76" y="210"/>
                    <a:pt x="76" y="212"/>
                  </a:cubicBezTo>
                  <a:cubicBezTo>
                    <a:pt x="75" y="213"/>
                    <a:pt x="75" y="214"/>
                    <a:pt x="74" y="215"/>
                  </a:cubicBezTo>
                  <a:cubicBezTo>
                    <a:pt x="73" y="216"/>
                    <a:pt x="71" y="217"/>
                    <a:pt x="69" y="218"/>
                  </a:cubicBezTo>
                  <a:cubicBezTo>
                    <a:pt x="68" y="219"/>
                    <a:pt x="66" y="219"/>
                    <a:pt x="63" y="220"/>
                  </a:cubicBezTo>
                  <a:close/>
                  <a:moveTo>
                    <a:pt x="105" y="320"/>
                  </a:moveTo>
                  <a:cubicBezTo>
                    <a:pt x="101" y="321"/>
                    <a:pt x="97" y="322"/>
                    <a:pt x="94" y="322"/>
                  </a:cubicBezTo>
                  <a:cubicBezTo>
                    <a:pt x="90" y="323"/>
                    <a:pt x="86" y="323"/>
                    <a:pt x="83" y="323"/>
                  </a:cubicBezTo>
                  <a:cubicBezTo>
                    <a:pt x="80" y="323"/>
                    <a:pt x="76" y="323"/>
                    <a:pt x="73" y="322"/>
                  </a:cubicBezTo>
                  <a:cubicBezTo>
                    <a:pt x="69" y="321"/>
                    <a:pt x="66" y="320"/>
                    <a:pt x="62" y="319"/>
                  </a:cubicBezTo>
                  <a:lnTo>
                    <a:pt x="12" y="302"/>
                  </a:lnTo>
                  <a:cubicBezTo>
                    <a:pt x="11" y="302"/>
                    <a:pt x="10" y="301"/>
                    <a:pt x="9" y="300"/>
                  </a:cubicBezTo>
                  <a:cubicBezTo>
                    <a:pt x="8" y="300"/>
                    <a:pt x="7" y="299"/>
                    <a:pt x="6" y="298"/>
                  </a:cubicBezTo>
                  <a:cubicBezTo>
                    <a:pt x="5" y="297"/>
                    <a:pt x="5" y="295"/>
                    <a:pt x="4" y="294"/>
                  </a:cubicBezTo>
                  <a:cubicBezTo>
                    <a:pt x="3" y="292"/>
                    <a:pt x="3" y="290"/>
                    <a:pt x="2" y="287"/>
                  </a:cubicBezTo>
                  <a:cubicBezTo>
                    <a:pt x="1" y="285"/>
                    <a:pt x="1" y="283"/>
                    <a:pt x="1" y="281"/>
                  </a:cubicBezTo>
                  <a:cubicBezTo>
                    <a:pt x="0" y="280"/>
                    <a:pt x="0" y="278"/>
                    <a:pt x="1" y="278"/>
                  </a:cubicBezTo>
                  <a:cubicBezTo>
                    <a:pt x="1" y="277"/>
                    <a:pt x="2" y="276"/>
                    <a:pt x="2" y="276"/>
                  </a:cubicBezTo>
                  <a:cubicBezTo>
                    <a:pt x="3" y="276"/>
                    <a:pt x="4" y="276"/>
                    <a:pt x="5" y="276"/>
                  </a:cubicBezTo>
                  <a:lnTo>
                    <a:pt x="69" y="288"/>
                  </a:lnTo>
                  <a:lnTo>
                    <a:pt x="95" y="281"/>
                  </a:lnTo>
                  <a:cubicBezTo>
                    <a:pt x="98" y="280"/>
                    <a:pt x="101" y="279"/>
                    <a:pt x="104" y="280"/>
                  </a:cubicBezTo>
                  <a:cubicBezTo>
                    <a:pt x="106" y="280"/>
                    <a:pt x="108" y="280"/>
                    <a:pt x="110" y="282"/>
                  </a:cubicBezTo>
                  <a:cubicBezTo>
                    <a:pt x="111" y="283"/>
                    <a:pt x="113" y="285"/>
                    <a:pt x="114" y="287"/>
                  </a:cubicBezTo>
                  <a:cubicBezTo>
                    <a:pt x="115" y="290"/>
                    <a:pt x="116" y="293"/>
                    <a:pt x="117" y="296"/>
                  </a:cubicBezTo>
                  <a:cubicBezTo>
                    <a:pt x="118" y="299"/>
                    <a:pt x="118" y="302"/>
                    <a:pt x="118" y="305"/>
                  </a:cubicBezTo>
                  <a:cubicBezTo>
                    <a:pt x="119" y="308"/>
                    <a:pt x="118" y="310"/>
                    <a:pt x="118" y="312"/>
                  </a:cubicBezTo>
                  <a:cubicBezTo>
                    <a:pt x="117" y="313"/>
                    <a:pt x="116" y="315"/>
                    <a:pt x="114" y="316"/>
                  </a:cubicBezTo>
                  <a:cubicBezTo>
                    <a:pt x="112" y="318"/>
                    <a:pt x="109" y="319"/>
                    <a:pt x="105" y="320"/>
                  </a:cubicBezTo>
                  <a:close/>
                  <a:moveTo>
                    <a:pt x="214" y="539"/>
                  </a:moveTo>
                  <a:cubicBezTo>
                    <a:pt x="210" y="540"/>
                    <a:pt x="206" y="541"/>
                    <a:pt x="203" y="540"/>
                  </a:cubicBezTo>
                  <a:cubicBezTo>
                    <a:pt x="200" y="539"/>
                    <a:pt x="198" y="538"/>
                    <a:pt x="198" y="535"/>
                  </a:cubicBezTo>
                  <a:lnTo>
                    <a:pt x="190" y="506"/>
                  </a:lnTo>
                  <a:lnTo>
                    <a:pt x="134" y="521"/>
                  </a:lnTo>
                  <a:cubicBezTo>
                    <a:pt x="133" y="521"/>
                    <a:pt x="132" y="521"/>
                    <a:pt x="131" y="521"/>
                  </a:cubicBezTo>
                  <a:cubicBezTo>
                    <a:pt x="130" y="520"/>
                    <a:pt x="129" y="520"/>
                    <a:pt x="128" y="518"/>
                  </a:cubicBezTo>
                  <a:cubicBezTo>
                    <a:pt x="128" y="517"/>
                    <a:pt x="127" y="515"/>
                    <a:pt x="126" y="513"/>
                  </a:cubicBezTo>
                  <a:cubicBezTo>
                    <a:pt x="125" y="511"/>
                    <a:pt x="124" y="508"/>
                    <a:pt x="123" y="505"/>
                  </a:cubicBezTo>
                  <a:cubicBezTo>
                    <a:pt x="122" y="501"/>
                    <a:pt x="121" y="498"/>
                    <a:pt x="121" y="496"/>
                  </a:cubicBezTo>
                  <a:cubicBezTo>
                    <a:pt x="121" y="494"/>
                    <a:pt x="121" y="492"/>
                    <a:pt x="121" y="490"/>
                  </a:cubicBezTo>
                  <a:cubicBezTo>
                    <a:pt x="121" y="489"/>
                    <a:pt x="121" y="488"/>
                    <a:pt x="122" y="487"/>
                  </a:cubicBezTo>
                  <a:cubicBezTo>
                    <a:pt x="123" y="487"/>
                    <a:pt x="124" y="486"/>
                    <a:pt x="125" y="486"/>
                  </a:cubicBezTo>
                  <a:lnTo>
                    <a:pt x="180" y="471"/>
                  </a:lnTo>
                  <a:lnTo>
                    <a:pt x="151" y="363"/>
                  </a:lnTo>
                  <a:cubicBezTo>
                    <a:pt x="150" y="361"/>
                    <a:pt x="150" y="360"/>
                    <a:pt x="150" y="359"/>
                  </a:cubicBezTo>
                  <a:cubicBezTo>
                    <a:pt x="150" y="358"/>
                    <a:pt x="151" y="356"/>
                    <a:pt x="152" y="355"/>
                  </a:cubicBezTo>
                  <a:cubicBezTo>
                    <a:pt x="153" y="354"/>
                    <a:pt x="154" y="353"/>
                    <a:pt x="156" y="352"/>
                  </a:cubicBezTo>
                  <a:cubicBezTo>
                    <a:pt x="158" y="351"/>
                    <a:pt x="160" y="350"/>
                    <a:pt x="164" y="349"/>
                  </a:cubicBezTo>
                  <a:cubicBezTo>
                    <a:pt x="166" y="349"/>
                    <a:pt x="169" y="348"/>
                    <a:pt x="171" y="348"/>
                  </a:cubicBezTo>
                  <a:cubicBezTo>
                    <a:pt x="173" y="347"/>
                    <a:pt x="175" y="347"/>
                    <a:pt x="176" y="347"/>
                  </a:cubicBezTo>
                  <a:cubicBezTo>
                    <a:pt x="178" y="347"/>
                    <a:pt x="180" y="347"/>
                    <a:pt x="182" y="347"/>
                  </a:cubicBezTo>
                  <a:cubicBezTo>
                    <a:pt x="184" y="348"/>
                    <a:pt x="185" y="348"/>
                    <a:pt x="187" y="348"/>
                  </a:cubicBezTo>
                  <a:lnTo>
                    <a:pt x="373" y="399"/>
                  </a:lnTo>
                  <a:cubicBezTo>
                    <a:pt x="374" y="399"/>
                    <a:pt x="375" y="400"/>
                    <a:pt x="377" y="401"/>
                  </a:cubicBezTo>
                  <a:cubicBezTo>
                    <a:pt x="378" y="402"/>
                    <a:pt x="379" y="404"/>
                    <a:pt x="380" y="406"/>
                  </a:cubicBezTo>
                  <a:cubicBezTo>
                    <a:pt x="381" y="408"/>
                    <a:pt x="382" y="410"/>
                    <a:pt x="383" y="413"/>
                  </a:cubicBezTo>
                  <a:cubicBezTo>
                    <a:pt x="384" y="416"/>
                    <a:pt x="385" y="420"/>
                    <a:pt x="386" y="424"/>
                  </a:cubicBezTo>
                  <a:cubicBezTo>
                    <a:pt x="388" y="428"/>
                    <a:pt x="389" y="432"/>
                    <a:pt x="389" y="436"/>
                  </a:cubicBezTo>
                  <a:cubicBezTo>
                    <a:pt x="390" y="439"/>
                    <a:pt x="390" y="442"/>
                    <a:pt x="390" y="444"/>
                  </a:cubicBezTo>
                  <a:cubicBezTo>
                    <a:pt x="390" y="447"/>
                    <a:pt x="390" y="448"/>
                    <a:pt x="389" y="450"/>
                  </a:cubicBezTo>
                  <a:cubicBezTo>
                    <a:pt x="389" y="451"/>
                    <a:pt x="388" y="452"/>
                    <a:pt x="387" y="452"/>
                  </a:cubicBezTo>
                  <a:lnTo>
                    <a:pt x="218" y="498"/>
                  </a:lnTo>
                  <a:lnTo>
                    <a:pt x="227" y="528"/>
                  </a:lnTo>
                  <a:cubicBezTo>
                    <a:pt x="227" y="530"/>
                    <a:pt x="226" y="532"/>
                    <a:pt x="224" y="534"/>
                  </a:cubicBezTo>
                  <a:cubicBezTo>
                    <a:pt x="222" y="536"/>
                    <a:pt x="219" y="538"/>
                    <a:pt x="214" y="539"/>
                  </a:cubicBezTo>
                  <a:close/>
                  <a:moveTo>
                    <a:pt x="353" y="424"/>
                  </a:moveTo>
                  <a:lnTo>
                    <a:pt x="353" y="423"/>
                  </a:lnTo>
                  <a:lnTo>
                    <a:pt x="186" y="378"/>
                  </a:lnTo>
                  <a:lnTo>
                    <a:pt x="209" y="463"/>
                  </a:lnTo>
                  <a:lnTo>
                    <a:pt x="353" y="424"/>
                  </a:lnTo>
                  <a:close/>
                  <a:moveTo>
                    <a:pt x="444" y="701"/>
                  </a:moveTo>
                  <a:cubicBezTo>
                    <a:pt x="442" y="702"/>
                    <a:pt x="440" y="702"/>
                    <a:pt x="438" y="702"/>
                  </a:cubicBezTo>
                  <a:cubicBezTo>
                    <a:pt x="436" y="703"/>
                    <a:pt x="434" y="703"/>
                    <a:pt x="432" y="703"/>
                  </a:cubicBezTo>
                  <a:cubicBezTo>
                    <a:pt x="430" y="703"/>
                    <a:pt x="428" y="703"/>
                    <a:pt x="426" y="703"/>
                  </a:cubicBezTo>
                  <a:cubicBezTo>
                    <a:pt x="424" y="703"/>
                    <a:pt x="422" y="703"/>
                    <a:pt x="420" y="703"/>
                  </a:cubicBezTo>
                  <a:lnTo>
                    <a:pt x="176" y="667"/>
                  </a:lnTo>
                  <a:cubicBezTo>
                    <a:pt x="174" y="667"/>
                    <a:pt x="172" y="666"/>
                    <a:pt x="171" y="666"/>
                  </a:cubicBezTo>
                  <a:cubicBezTo>
                    <a:pt x="170" y="665"/>
                    <a:pt x="169" y="664"/>
                    <a:pt x="167" y="662"/>
                  </a:cubicBezTo>
                  <a:cubicBezTo>
                    <a:pt x="166" y="661"/>
                    <a:pt x="166" y="659"/>
                    <a:pt x="165" y="657"/>
                  </a:cubicBezTo>
                  <a:cubicBezTo>
                    <a:pt x="164" y="654"/>
                    <a:pt x="163" y="651"/>
                    <a:pt x="162" y="648"/>
                  </a:cubicBezTo>
                  <a:cubicBezTo>
                    <a:pt x="161" y="643"/>
                    <a:pt x="160" y="640"/>
                    <a:pt x="160" y="637"/>
                  </a:cubicBezTo>
                  <a:cubicBezTo>
                    <a:pt x="159" y="634"/>
                    <a:pt x="159" y="632"/>
                    <a:pt x="160" y="631"/>
                  </a:cubicBezTo>
                  <a:cubicBezTo>
                    <a:pt x="161" y="629"/>
                    <a:pt x="162" y="629"/>
                    <a:pt x="163" y="628"/>
                  </a:cubicBezTo>
                  <a:cubicBezTo>
                    <a:pt x="164" y="628"/>
                    <a:pt x="166" y="628"/>
                    <a:pt x="168" y="629"/>
                  </a:cubicBezTo>
                  <a:lnTo>
                    <a:pt x="418" y="668"/>
                  </a:lnTo>
                  <a:lnTo>
                    <a:pt x="384" y="541"/>
                  </a:lnTo>
                  <a:cubicBezTo>
                    <a:pt x="383" y="539"/>
                    <a:pt x="384" y="536"/>
                    <a:pt x="387" y="534"/>
                  </a:cubicBezTo>
                  <a:cubicBezTo>
                    <a:pt x="389" y="532"/>
                    <a:pt x="393" y="531"/>
                    <a:pt x="397" y="529"/>
                  </a:cubicBezTo>
                  <a:cubicBezTo>
                    <a:pt x="400" y="529"/>
                    <a:pt x="402" y="528"/>
                    <a:pt x="404" y="528"/>
                  </a:cubicBezTo>
                  <a:cubicBezTo>
                    <a:pt x="406" y="528"/>
                    <a:pt x="408" y="528"/>
                    <a:pt x="409" y="528"/>
                  </a:cubicBezTo>
                  <a:cubicBezTo>
                    <a:pt x="411" y="528"/>
                    <a:pt x="412" y="529"/>
                    <a:pt x="413" y="530"/>
                  </a:cubicBezTo>
                  <a:cubicBezTo>
                    <a:pt x="414" y="531"/>
                    <a:pt x="414" y="532"/>
                    <a:pt x="415" y="533"/>
                  </a:cubicBezTo>
                  <a:lnTo>
                    <a:pt x="456" y="686"/>
                  </a:lnTo>
                  <a:cubicBezTo>
                    <a:pt x="457" y="688"/>
                    <a:pt x="457" y="690"/>
                    <a:pt x="457" y="691"/>
                  </a:cubicBezTo>
                  <a:cubicBezTo>
                    <a:pt x="457" y="693"/>
                    <a:pt x="457" y="694"/>
                    <a:pt x="456" y="695"/>
                  </a:cubicBezTo>
                  <a:cubicBezTo>
                    <a:pt x="455" y="696"/>
                    <a:pt x="453" y="697"/>
                    <a:pt x="451" y="698"/>
                  </a:cubicBezTo>
                  <a:cubicBezTo>
                    <a:pt x="450" y="699"/>
                    <a:pt x="447" y="700"/>
                    <a:pt x="444" y="701"/>
                  </a:cubicBezTo>
                  <a:close/>
                  <a:moveTo>
                    <a:pt x="388" y="954"/>
                  </a:moveTo>
                  <a:cubicBezTo>
                    <a:pt x="368" y="959"/>
                    <a:pt x="349" y="962"/>
                    <a:pt x="332" y="964"/>
                  </a:cubicBezTo>
                  <a:cubicBezTo>
                    <a:pt x="314" y="965"/>
                    <a:pt x="298" y="964"/>
                    <a:pt x="284" y="960"/>
                  </a:cubicBezTo>
                  <a:cubicBezTo>
                    <a:pt x="270" y="956"/>
                    <a:pt x="258" y="948"/>
                    <a:pt x="249" y="938"/>
                  </a:cubicBezTo>
                  <a:cubicBezTo>
                    <a:pt x="239" y="928"/>
                    <a:pt x="231" y="914"/>
                    <a:pt x="227" y="897"/>
                  </a:cubicBezTo>
                  <a:cubicBezTo>
                    <a:pt x="222" y="880"/>
                    <a:pt x="221" y="865"/>
                    <a:pt x="224" y="852"/>
                  </a:cubicBezTo>
                  <a:cubicBezTo>
                    <a:pt x="227" y="840"/>
                    <a:pt x="233" y="828"/>
                    <a:pt x="243" y="818"/>
                  </a:cubicBezTo>
                  <a:cubicBezTo>
                    <a:pt x="252" y="808"/>
                    <a:pt x="265" y="799"/>
                    <a:pt x="281" y="792"/>
                  </a:cubicBezTo>
                  <a:cubicBezTo>
                    <a:pt x="297" y="784"/>
                    <a:pt x="316" y="778"/>
                    <a:pt x="338" y="772"/>
                  </a:cubicBezTo>
                  <a:cubicBezTo>
                    <a:pt x="358" y="766"/>
                    <a:pt x="377" y="763"/>
                    <a:pt x="394" y="762"/>
                  </a:cubicBezTo>
                  <a:cubicBezTo>
                    <a:pt x="412" y="760"/>
                    <a:pt x="428" y="762"/>
                    <a:pt x="442" y="766"/>
                  </a:cubicBezTo>
                  <a:cubicBezTo>
                    <a:pt x="456" y="770"/>
                    <a:pt x="468" y="777"/>
                    <a:pt x="477" y="787"/>
                  </a:cubicBezTo>
                  <a:cubicBezTo>
                    <a:pt x="487" y="797"/>
                    <a:pt x="495" y="811"/>
                    <a:pt x="499" y="828"/>
                  </a:cubicBezTo>
                  <a:cubicBezTo>
                    <a:pt x="504" y="845"/>
                    <a:pt x="505" y="860"/>
                    <a:pt x="502" y="873"/>
                  </a:cubicBezTo>
                  <a:cubicBezTo>
                    <a:pt x="499" y="886"/>
                    <a:pt x="493" y="897"/>
                    <a:pt x="483" y="907"/>
                  </a:cubicBezTo>
                  <a:cubicBezTo>
                    <a:pt x="474" y="917"/>
                    <a:pt x="461" y="926"/>
                    <a:pt x="445" y="934"/>
                  </a:cubicBezTo>
                  <a:cubicBezTo>
                    <a:pt x="429" y="941"/>
                    <a:pt x="410" y="948"/>
                    <a:pt x="388" y="954"/>
                  </a:cubicBezTo>
                  <a:close/>
                  <a:moveTo>
                    <a:pt x="376" y="918"/>
                  </a:moveTo>
                  <a:cubicBezTo>
                    <a:pt x="389" y="915"/>
                    <a:pt x="401" y="911"/>
                    <a:pt x="411" y="907"/>
                  </a:cubicBezTo>
                  <a:cubicBezTo>
                    <a:pt x="421" y="904"/>
                    <a:pt x="430" y="900"/>
                    <a:pt x="438" y="896"/>
                  </a:cubicBezTo>
                  <a:cubicBezTo>
                    <a:pt x="445" y="892"/>
                    <a:pt x="451" y="887"/>
                    <a:pt x="456" y="883"/>
                  </a:cubicBezTo>
                  <a:cubicBezTo>
                    <a:pt x="461" y="878"/>
                    <a:pt x="465" y="874"/>
                    <a:pt x="468" y="869"/>
                  </a:cubicBezTo>
                  <a:cubicBezTo>
                    <a:pt x="470" y="863"/>
                    <a:pt x="472" y="858"/>
                    <a:pt x="472" y="852"/>
                  </a:cubicBezTo>
                  <a:cubicBezTo>
                    <a:pt x="472" y="847"/>
                    <a:pt x="472" y="841"/>
                    <a:pt x="470" y="834"/>
                  </a:cubicBezTo>
                  <a:cubicBezTo>
                    <a:pt x="467" y="823"/>
                    <a:pt x="462" y="814"/>
                    <a:pt x="454" y="808"/>
                  </a:cubicBezTo>
                  <a:cubicBezTo>
                    <a:pt x="447" y="803"/>
                    <a:pt x="438" y="799"/>
                    <a:pt x="427" y="797"/>
                  </a:cubicBezTo>
                  <a:cubicBezTo>
                    <a:pt x="417" y="796"/>
                    <a:pt x="405" y="796"/>
                    <a:pt x="392" y="798"/>
                  </a:cubicBezTo>
                  <a:cubicBezTo>
                    <a:pt x="378" y="800"/>
                    <a:pt x="364" y="803"/>
                    <a:pt x="350" y="807"/>
                  </a:cubicBezTo>
                  <a:cubicBezTo>
                    <a:pt x="330" y="812"/>
                    <a:pt x="314" y="818"/>
                    <a:pt x="300" y="824"/>
                  </a:cubicBezTo>
                  <a:cubicBezTo>
                    <a:pt x="287" y="829"/>
                    <a:pt x="277" y="836"/>
                    <a:pt x="269" y="842"/>
                  </a:cubicBezTo>
                  <a:cubicBezTo>
                    <a:pt x="262" y="849"/>
                    <a:pt x="257" y="856"/>
                    <a:pt x="255" y="864"/>
                  </a:cubicBezTo>
                  <a:cubicBezTo>
                    <a:pt x="253" y="872"/>
                    <a:pt x="253" y="881"/>
                    <a:pt x="256" y="891"/>
                  </a:cubicBezTo>
                  <a:cubicBezTo>
                    <a:pt x="258" y="899"/>
                    <a:pt x="261" y="905"/>
                    <a:pt x="265" y="910"/>
                  </a:cubicBezTo>
                  <a:cubicBezTo>
                    <a:pt x="269" y="915"/>
                    <a:pt x="274" y="919"/>
                    <a:pt x="280" y="922"/>
                  </a:cubicBezTo>
                  <a:cubicBezTo>
                    <a:pt x="285" y="925"/>
                    <a:pt x="292" y="927"/>
                    <a:pt x="299" y="928"/>
                  </a:cubicBezTo>
                  <a:cubicBezTo>
                    <a:pt x="306" y="929"/>
                    <a:pt x="313" y="929"/>
                    <a:pt x="322" y="929"/>
                  </a:cubicBezTo>
                  <a:cubicBezTo>
                    <a:pt x="330" y="928"/>
                    <a:pt x="339" y="927"/>
                    <a:pt x="348" y="925"/>
                  </a:cubicBezTo>
                  <a:cubicBezTo>
                    <a:pt x="357" y="923"/>
                    <a:pt x="366" y="921"/>
                    <a:pt x="376" y="918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2"/>
            <p:cNvSpPr/>
            <p:nvPr/>
          </p:nvSpPr>
          <p:spPr>
            <a:xfrm>
              <a:off x="4270320" y="2052720"/>
              <a:ext cx="2523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68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33"/>
            <p:cNvSpPr/>
            <p:nvPr/>
          </p:nvSpPr>
          <p:spPr>
            <a:xfrm>
              <a:off x="3858840" y="808200"/>
              <a:ext cx="540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usarium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4"/>
            <p:cNvSpPr/>
            <p:nvPr/>
          </p:nvSpPr>
          <p:spPr>
            <a:xfrm>
              <a:off x="4446720" y="808200"/>
              <a:ext cx="801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raminearum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35"/>
            <p:cNvSpPr/>
            <p:nvPr/>
          </p:nvSpPr>
          <p:spPr>
            <a:xfrm>
              <a:off x="5202000" y="1820880"/>
              <a:ext cx="540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usarium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6"/>
            <p:cNvSpPr/>
            <p:nvPr/>
          </p:nvSpPr>
          <p:spPr>
            <a:xfrm>
              <a:off x="5783400" y="1820880"/>
              <a:ext cx="7185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virguliform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7"/>
            <p:cNvSpPr/>
            <p:nvPr/>
          </p:nvSpPr>
          <p:spPr>
            <a:xfrm>
              <a:off x="2505600" y="1725480"/>
              <a:ext cx="425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ectri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38"/>
            <p:cNvSpPr/>
            <p:nvPr/>
          </p:nvSpPr>
          <p:spPr>
            <a:xfrm>
              <a:off x="2982960" y="1725480"/>
              <a:ext cx="852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aematococc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9"/>
            <p:cNvSpPr/>
            <p:nvPr/>
          </p:nvSpPr>
          <p:spPr>
            <a:xfrm>
              <a:off x="4824000" y="4208400"/>
              <a:ext cx="540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usarium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0"/>
            <p:cNvSpPr/>
            <p:nvPr/>
          </p:nvSpPr>
          <p:spPr>
            <a:xfrm>
              <a:off x="5444640" y="4208400"/>
              <a:ext cx="645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oxysporum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1"/>
            <p:cNvSpPr/>
            <p:nvPr/>
          </p:nvSpPr>
          <p:spPr>
            <a:xfrm>
              <a:off x="2748960" y="4208400"/>
              <a:ext cx="540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usarium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2"/>
            <p:cNvSpPr/>
            <p:nvPr/>
          </p:nvSpPr>
          <p:spPr>
            <a:xfrm>
              <a:off x="3335760" y="4208400"/>
              <a:ext cx="736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verticilliode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Bhattacharyya, Madan K [AGRON]</dc:creator>
  <dc:description/>
  <dc:language>en-US</dc:language>
  <cp:lastModifiedBy>Bhattacharyya, Madan K [AGRON]</cp:lastModifiedBy>
  <dcterms:modified xsi:type="dcterms:W3CDTF">2013-06-09T00:35:48Z</dcterms:modified>
  <cp:revision>466</cp:revision>
  <dc:subject/>
  <dc:title>Slide 1</dc:title>
</cp:coreProperties>
</file>